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8"/>
    <p:restoredTop sz="94666"/>
  </p:normalViewPr>
  <p:slideViewPr>
    <p:cSldViewPr snapToGrid="0" snapToObjects="1" showGuides="1">
      <p:cViewPr varScale="1">
        <p:scale>
          <a:sx n="81" d="100"/>
          <a:sy n="81" d="100"/>
        </p:scale>
        <p:origin x="2552" y="19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1618B-BF02-5C4F-B6C1-7B45FBCE991E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BFE1F-7E7D-BA43-8573-B91571A85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85683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1618B-BF02-5C4F-B6C1-7B45FBCE991E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BFE1F-7E7D-BA43-8573-B91571A85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60837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1618B-BF02-5C4F-B6C1-7B45FBCE991E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BFE1F-7E7D-BA43-8573-B91571A85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1031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1618B-BF02-5C4F-B6C1-7B45FBCE991E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BFE1F-7E7D-BA43-8573-B91571A85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58944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1618B-BF02-5C4F-B6C1-7B45FBCE991E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BFE1F-7E7D-BA43-8573-B91571A85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75741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1618B-BF02-5C4F-B6C1-7B45FBCE991E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BFE1F-7E7D-BA43-8573-B91571A85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72550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1618B-BF02-5C4F-B6C1-7B45FBCE991E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BFE1F-7E7D-BA43-8573-B91571A85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36761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1618B-BF02-5C4F-B6C1-7B45FBCE991E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BFE1F-7E7D-BA43-8573-B91571A85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64258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1618B-BF02-5C4F-B6C1-7B45FBCE991E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BFE1F-7E7D-BA43-8573-B91571A85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6791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1618B-BF02-5C4F-B6C1-7B45FBCE991E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BFE1F-7E7D-BA43-8573-B91571A85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545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1618B-BF02-5C4F-B6C1-7B45FBCE991E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BFE1F-7E7D-BA43-8573-B91571A85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61795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F1618B-BF02-5C4F-B6C1-7B45FBCE991E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5BFE1F-7E7D-BA43-8573-B91571A85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440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4" Type="http://schemas.openxmlformats.org/officeDocument/2006/relationships/image" Target="../media/image2.png"/><Relationship Id="rId5" Type="http://schemas.microsoft.com/office/2007/relationships/hdphoto" Target="../media/hdphoto2.wdp"/><Relationship Id="rId6" Type="http://schemas.openxmlformats.org/officeDocument/2006/relationships/image" Target="../media/image3.png"/><Relationship Id="rId7" Type="http://schemas.microsoft.com/office/2007/relationships/hdphoto" Target="../media/hdphoto3.wdp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658538" y="879536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Model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003356" y="866836"/>
            <a:ext cx="1073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Model 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1" name="Group 40"/>
          <p:cNvGrpSpPr/>
          <p:nvPr/>
        </p:nvGrpSpPr>
        <p:grpSpPr>
          <a:xfrm>
            <a:off x="3735809" y="1300780"/>
            <a:ext cx="2277641" cy="2532789"/>
            <a:chOff x="2891259" y="1262681"/>
            <a:chExt cx="2277641" cy="2532789"/>
          </a:xfrm>
        </p:grpSpPr>
        <p:sp>
          <p:nvSpPr>
            <p:cNvPr id="5" name="TextBox 4"/>
            <p:cNvSpPr txBox="1"/>
            <p:nvPr/>
          </p:nvSpPr>
          <p:spPr>
            <a:xfrm>
              <a:off x="4263945" y="3163345"/>
              <a:ext cx="7208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pen </a:t>
              </a:r>
              <a:r>
                <a:rPr lang="en-US" sz="1400" b="1" dirty="0" err="1" smtClean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rimer</a:t>
              </a:r>
              <a:endParaRPr lang="en-US" sz="14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4079795" y="1537488"/>
              <a:ext cx="10891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losed </a:t>
              </a:r>
              <a:r>
                <a:rPr lang="en-US" sz="1400" b="1" dirty="0" err="1" smtClean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rimer</a:t>
              </a:r>
              <a:endParaRPr lang="en-US" sz="14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" name="Picture 4" descr="http://image.marginup.com/u/u132/medium_MAB%283%29.jpg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ackgroundRemoval t="5729" b="85938" l="0" r="1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1024615" flipH="1">
              <a:off x="3466574" y="2814168"/>
              <a:ext cx="236751" cy="307135"/>
            </a:xfrm>
            <a:prstGeom prst="rect">
              <a:avLst/>
            </a:prstGeom>
            <a:noFill/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" name="Picture 2" descr="http://1degreebio.org/blog/files/blog/antibody.png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0" b="99167" l="0" r="1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2664011">
              <a:off x="3928598" y="1707030"/>
              <a:ext cx="221048" cy="265258"/>
            </a:xfrm>
            <a:prstGeom prst="rect">
              <a:avLst/>
            </a:prstGeom>
            <a:noFill/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9" name="Group 8"/>
            <p:cNvGrpSpPr/>
            <p:nvPr/>
          </p:nvGrpSpPr>
          <p:grpSpPr>
            <a:xfrm>
              <a:off x="3125958" y="3167819"/>
              <a:ext cx="793344" cy="627651"/>
              <a:chOff x="4109652" y="2571182"/>
              <a:chExt cx="955835" cy="756206"/>
            </a:xfrm>
          </p:grpSpPr>
          <p:pic>
            <p:nvPicPr>
              <p:cNvPr id="28" name="Picture 2" descr="http://1degreebio.org/blog/files/blog/antibody.png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ackgroundRemoval t="0" b="99167" l="0" r="10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rot="14140229">
                <a:off x="4301560" y="2719324"/>
                <a:ext cx="266323" cy="31958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grpSp>
            <p:nvGrpSpPr>
              <p:cNvPr id="29" name="Group 28"/>
              <p:cNvGrpSpPr/>
              <p:nvPr/>
            </p:nvGrpSpPr>
            <p:grpSpPr>
              <a:xfrm>
                <a:off x="4109652" y="2571182"/>
                <a:ext cx="955835" cy="756206"/>
                <a:chOff x="3769728" y="3448911"/>
                <a:chExt cx="1274447" cy="1008274"/>
              </a:xfrm>
              <a:solidFill>
                <a:schemeClr val="tx1">
                  <a:lumMod val="50000"/>
                  <a:lumOff val="50000"/>
                </a:schemeClr>
              </a:solidFill>
            </p:grpSpPr>
            <p:sp>
              <p:nvSpPr>
                <p:cNvPr id="30" name="Block Arc 15"/>
                <p:cNvSpPr/>
                <p:nvPr/>
              </p:nvSpPr>
              <p:spPr>
                <a:xfrm rot="5400000">
                  <a:off x="4065666" y="3660215"/>
                  <a:ext cx="753061" cy="377420"/>
                </a:xfrm>
                <a:custGeom>
                  <a:avLst/>
                  <a:gdLst>
                    <a:gd name="connsiteX0" fmla="*/ 627 w 745516"/>
                    <a:gd name="connsiteY0" fmla="*/ 369014 h 697590"/>
                    <a:gd name="connsiteX1" fmla="*/ 184209 w 745516"/>
                    <a:gd name="connsiteY1" fmla="*/ 47911 h 697590"/>
                    <a:gd name="connsiteX2" fmla="*/ 544181 w 745516"/>
                    <a:gd name="connsiteY2" fmla="*/ 39071 h 697590"/>
                    <a:gd name="connsiteX3" fmla="*/ 745515 w 745516"/>
                    <a:gd name="connsiteY3" fmla="*/ 348795 h 697590"/>
                    <a:gd name="connsiteX4" fmla="*/ 571119 w 745516"/>
                    <a:gd name="connsiteY4" fmla="*/ 348795 h 697590"/>
                    <a:gd name="connsiteX5" fmla="*/ 459552 w 745516"/>
                    <a:gd name="connsiteY5" fmla="*/ 191978 h 697590"/>
                    <a:gd name="connsiteX6" fmla="*/ 277038 w 745516"/>
                    <a:gd name="connsiteY6" fmla="*/ 196046 h 697590"/>
                    <a:gd name="connsiteX7" fmla="*/ 174775 w 745516"/>
                    <a:gd name="connsiteY7" fmla="*/ 359552 h 697590"/>
                    <a:gd name="connsiteX8" fmla="*/ 627 w 745516"/>
                    <a:gd name="connsiteY8" fmla="*/ 369014 h 697590"/>
                    <a:gd name="connsiteX0" fmla="*/ 629 w 745517"/>
                    <a:gd name="connsiteY0" fmla="*/ 369014 h 369014"/>
                    <a:gd name="connsiteX1" fmla="*/ 184211 w 745517"/>
                    <a:gd name="connsiteY1" fmla="*/ 47911 h 369014"/>
                    <a:gd name="connsiteX2" fmla="*/ 544183 w 745517"/>
                    <a:gd name="connsiteY2" fmla="*/ 39071 h 369014"/>
                    <a:gd name="connsiteX3" fmla="*/ 745517 w 745517"/>
                    <a:gd name="connsiteY3" fmla="*/ 348795 h 369014"/>
                    <a:gd name="connsiteX4" fmla="*/ 668191 w 745517"/>
                    <a:gd name="connsiteY4" fmla="*/ 363523 h 369014"/>
                    <a:gd name="connsiteX5" fmla="*/ 459554 w 745517"/>
                    <a:gd name="connsiteY5" fmla="*/ 191978 h 369014"/>
                    <a:gd name="connsiteX6" fmla="*/ 277040 w 745517"/>
                    <a:gd name="connsiteY6" fmla="*/ 196046 h 369014"/>
                    <a:gd name="connsiteX7" fmla="*/ 174777 w 745517"/>
                    <a:gd name="connsiteY7" fmla="*/ 359552 h 369014"/>
                    <a:gd name="connsiteX8" fmla="*/ 629 w 745517"/>
                    <a:gd name="connsiteY8" fmla="*/ 369014 h 369014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59554 w 745517"/>
                    <a:gd name="connsiteY5" fmla="*/ 191978 h 425833"/>
                    <a:gd name="connsiteX6" fmla="*/ 277040 w 745517"/>
                    <a:gd name="connsiteY6" fmla="*/ 196046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48149 w 745517"/>
                    <a:gd name="connsiteY5" fmla="*/ 197842 h 425833"/>
                    <a:gd name="connsiteX6" fmla="*/ 277040 w 745517"/>
                    <a:gd name="connsiteY6" fmla="*/ 196046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277040 w 745517"/>
                    <a:gd name="connsiteY6" fmla="*/ 196046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387239 w 745517"/>
                    <a:gd name="connsiteY6" fmla="*/ 147341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387239 w 745517"/>
                    <a:gd name="connsiteY6" fmla="*/ 147341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387239 w 745517"/>
                    <a:gd name="connsiteY6" fmla="*/ 147341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396919 w 745517"/>
                    <a:gd name="connsiteY6" fmla="*/ 199046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396919 w 745517"/>
                    <a:gd name="connsiteY5" fmla="*/ 199046 h 425833"/>
                    <a:gd name="connsiteX6" fmla="*/ 174777 w 745517"/>
                    <a:gd name="connsiteY6" fmla="*/ 359552 h 425833"/>
                    <a:gd name="connsiteX7" fmla="*/ 629 w 745517"/>
                    <a:gd name="connsiteY7" fmla="*/ 369014 h 425833"/>
                    <a:gd name="connsiteX0" fmla="*/ 629 w 777485"/>
                    <a:gd name="connsiteY0" fmla="*/ 364465 h 421284"/>
                    <a:gd name="connsiteX1" fmla="*/ 184211 w 777485"/>
                    <a:gd name="connsiteY1" fmla="*/ 43362 h 421284"/>
                    <a:gd name="connsiteX2" fmla="*/ 544183 w 777485"/>
                    <a:gd name="connsiteY2" fmla="*/ 34522 h 421284"/>
                    <a:gd name="connsiteX3" fmla="*/ 777485 w 777485"/>
                    <a:gd name="connsiteY3" fmla="*/ 302949 h 421284"/>
                    <a:gd name="connsiteX4" fmla="*/ 666916 w 777485"/>
                    <a:gd name="connsiteY4" fmla="*/ 421284 h 421284"/>
                    <a:gd name="connsiteX5" fmla="*/ 396919 w 777485"/>
                    <a:gd name="connsiteY5" fmla="*/ 194497 h 421284"/>
                    <a:gd name="connsiteX6" fmla="*/ 174777 w 777485"/>
                    <a:gd name="connsiteY6" fmla="*/ 355003 h 421284"/>
                    <a:gd name="connsiteX7" fmla="*/ 629 w 777485"/>
                    <a:gd name="connsiteY7" fmla="*/ 364465 h 421284"/>
                    <a:gd name="connsiteX0" fmla="*/ 629 w 777485"/>
                    <a:gd name="connsiteY0" fmla="*/ 364465 h 421284"/>
                    <a:gd name="connsiteX1" fmla="*/ 184211 w 777485"/>
                    <a:gd name="connsiteY1" fmla="*/ 43362 h 421284"/>
                    <a:gd name="connsiteX2" fmla="*/ 544183 w 777485"/>
                    <a:gd name="connsiteY2" fmla="*/ 34522 h 421284"/>
                    <a:gd name="connsiteX3" fmla="*/ 777485 w 777485"/>
                    <a:gd name="connsiteY3" fmla="*/ 302949 h 421284"/>
                    <a:gd name="connsiteX4" fmla="*/ 666916 w 777485"/>
                    <a:gd name="connsiteY4" fmla="*/ 421284 h 421284"/>
                    <a:gd name="connsiteX5" fmla="*/ 396919 w 777485"/>
                    <a:gd name="connsiteY5" fmla="*/ 194497 h 421284"/>
                    <a:gd name="connsiteX6" fmla="*/ 174777 w 777485"/>
                    <a:gd name="connsiteY6" fmla="*/ 355003 h 421284"/>
                    <a:gd name="connsiteX7" fmla="*/ 629 w 777485"/>
                    <a:gd name="connsiteY7" fmla="*/ 364465 h 421284"/>
                    <a:gd name="connsiteX0" fmla="*/ 629 w 777485"/>
                    <a:gd name="connsiteY0" fmla="*/ 364465 h 421284"/>
                    <a:gd name="connsiteX1" fmla="*/ 184211 w 777485"/>
                    <a:gd name="connsiteY1" fmla="*/ 43362 h 421284"/>
                    <a:gd name="connsiteX2" fmla="*/ 544183 w 777485"/>
                    <a:gd name="connsiteY2" fmla="*/ 34522 h 421284"/>
                    <a:gd name="connsiteX3" fmla="*/ 777485 w 777485"/>
                    <a:gd name="connsiteY3" fmla="*/ 302949 h 421284"/>
                    <a:gd name="connsiteX4" fmla="*/ 666916 w 777485"/>
                    <a:gd name="connsiteY4" fmla="*/ 421284 h 421284"/>
                    <a:gd name="connsiteX5" fmla="*/ 396919 w 777485"/>
                    <a:gd name="connsiteY5" fmla="*/ 194497 h 421284"/>
                    <a:gd name="connsiteX6" fmla="*/ 102409 w 777485"/>
                    <a:gd name="connsiteY6" fmla="*/ 373814 h 421284"/>
                    <a:gd name="connsiteX7" fmla="*/ 629 w 777485"/>
                    <a:gd name="connsiteY7" fmla="*/ 364465 h 421284"/>
                    <a:gd name="connsiteX0" fmla="*/ 329 w 828090"/>
                    <a:gd name="connsiteY0" fmla="*/ 354833 h 418791"/>
                    <a:gd name="connsiteX1" fmla="*/ 234816 w 828090"/>
                    <a:gd name="connsiteY1" fmla="*/ 40869 h 418791"/>
                    <a:gd name="connsiteX2" fmla="*/ 594788 w 828090"/>
                    <a:gd name="connsiteY2" fmla="*/ 32029 h 418791"/>
                    <a:gd name="connsiteX3" fmla="*/ 828090 w 828090"/>
                    <a:gd name="connsiteY3" fmla="*/ 300456 h 418791"/>
                    <a:gd name="connsiteX4" fmla="*/ 717521 w 828090"/>
                    <a:gd name="connsiteY4" fmla="*/ 418791 h 418791"/>
                    <a:gd name="connsiteX5" fmla="*/ 447524 w 828090"/>
                    <a:gd name="connsiteY5" fmla="*/ 192004 h 418791"/>
                    <a:gd name="connsiteX6" fmla="*/ 153014 w 828090"/>
                    <a:gd name="connsiteY6" fmla="*/ 371321 h 418791"/>
                    <a:gd name="connsiteX7" fmla="*/ 329 w 828090"/>
                    <a:gd name="connsiteY7" fmla="*/ 354833 h 418791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476599 w 857165"/>
                    <a:gd name="connsiteY5" fmla="*/ 191739 h 418526"/>
                    <a:gd name="connsiteX6" fmla="*/ 182089 w 857165"/>
                    <a:gd name="connsiteY6" fmla="*/ 371056 h 418526"/>
                    <a:gd name="connsiteX7" fmla="*/ 283 w 857165"/>
                    <a:gd name="connsiteY7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476599 w 857165"/>
                    <a:gd name="connsiteY5" fmla="*/ 191739 h 418526"/>
                    <a:gd name="connsiteX6" fmla="*/ 182089 w 857165"/>
                    <a:gd name="connsiteY6" fmla="*/ 371056 h 418526"/>
                    <a:gd name="connsiteX7" fmla="*/ 283 w 857165"/>
                    <a:gd name="connsiteY7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476599 w 857165"/>
                    <a:gd name="connsiteY5" fmla="*/ 191739 h 418526"/>
                    <a:gd name="connsiteX6" fmla="*/ 182089 w 857165"/>
                    <a:gd name="connsiteY6" fmla="*/ 371056 h 418526"/>
                    <a:gd name="connsiteX7" fmla="*/ 283 w 857165"/>
                    <a:gd name="connsiteY7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476599 w 857165"/>
                    <a:gd name="connsiteY5" fmla="*/ 191739 h 418526"/>
                    <a:gd name="connsiteX6" fmla="*/ 182089 w 857165"/>
                    <a:gd name="connsiteY6" fmla="*/ 371056 h 418526"/>
                    <a:gd name="connsiteX7" fmla="*/ 283 w 857165"/>
                    <a:gd name="connsiteY7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596226 w 857165"/>
                    <a:gd name="connsiteY5" fmla="*/ 269798 h 418526"/>
                    <a:gd name="connsiteX6" fmla="*/ 476599 w 857165"/>
                    <a:gd name="connsiteY6" fmla="*/ 191739 h 418526"/>
                    <a:gd name="connsiteX7" fmla="*/ 182089 w 857165"/>
                    <a:gd name="connsiteY7" fmla="*/ 371056 h 418526"/>
                    <a:gd name="connsiteX8" fmla="*/ 283 w 857165"/>
                    <a:gd name="connsiteY8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631337 w 857165"/>
                    <a:gd name="connsiteY5" fmla="*/ 261689 h 418526"/>
                    <a:gd name="connsiteX6" fmla="*/ 476599 w 857165"/>
                    <a:gd name="connsiteY6" fmla="*/ 191739 h 418526"/>
                    <a:gd name="connsiteX7" fmla="*/ 182089 w 857165"/>
                    <a:gd name="connsiteY7" fmla="*/ 371056 h 418526"/>
                    <a:gd name="connsiteX8" fmla="*/ 283 w 857165"/>
                    <a:gd name="connsiteY8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623229 w 857165"/>
                    <a:gd name="connsiteY5" fmla="*/ 226578 h 418526"/>
                    <a:gd name="connsiteX6" fmla="*/ 476599 w 857165"/>
                    <a:gd name="connsiteY6" fmla="*/ 191739 h 418526"/>
                    <a:gd name="connsiteX7" fmla="*/ 182089 w 857165"/>
                    <a:gd name="connsiteY7" fmla="*/ 371056 h 418526"/>
                    <a:gd name="connsiteX8" fmla="*/ 283 w 857165"/>
                    <a:gd name="connsiteY8" fmla="*/ 350149 h 418526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623229 w 857165"/>
                    <a:gd name="connsiteY5" fmla="*/ 226578 h 418077"/>
                    <a:gd name="connsiteX6" fmla="*/ 476599 w 857165"/>
                    <a:gd name="connsiteY6" fmla="*/ 191739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623229 w 857165"/>
                    <a:gd name="connsiteY5" fmla="*/ 226578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623229 w 857165"/>
                    <a:gd name="connsiteY5" fmla="*/ 226578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91288 w 857165"/>
                    <a:gd name="connsiteY5" fmla="*/ 217643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91288 w 857165"/>
                    <a:gd name="connsiteY5" fmla="*/ 217643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91288 w 857165"/>
                    <a:gd name="connsiteY5" fmla="*/ 217643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13122 w 857165"/>
                    <a:gd name="connsiteY6" fmla="*/ 233528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13122 w 857165"/>
                    <a:gd name="connsiteY6" fmla="*/ 233528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23181 w 857165"/>
                    <a:gd name="connsiteY6" fmla="*/ 213440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23181 w 857165"/>
                    <a:gd name="connsiteY6" fmla="*/ 213440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23181 w 857165"/>
                    <a:gd name="connsiteY6" fmla="*/ 213440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71599"/>
                    <a:gd name="connsiteX1" fmla="*/ 263891 w 857165"/>
                    <a:gd name="connsiteY1" fmla="*/ 40604 h 471599"/>
                    <a:gd name="connsiteX2" fmla="*/ 623863 w 857165"/>
                    <a:gd name="connsiteY2" fmla="*/ 31764 h 471599"/>
                    <a:gd name="connsiteX3" fmla="*/ 857165 w 857165"/>
                    <a:gd name="connsiteY3" fmla="*/ 300191 h 471599"/>
                    <a:gd name="connsiteX4" fmla="*/ 768237 w 857165"/>
                    <a:gd name="connsiteY4" fmla="*/ 471599 h 471599"/>
                    <a:gd name="connsiteX5" fmla="*/ 588791 w 857165"/>
                    <a:gd name="connsiteY5" fmla="*/ 241798 h 471599"/>
                    <a:gd name="connsiteX6" fmla="*/ 323181 w 857165"/>
                    <a:gd name="connsiteY6" fmla="*/ 213440 h 471599"/>
                    <a:gd name="connsiteX7" fmla="*/ 182089 w 857165"/>
                    <a:gd name="connsiteY7" fmla="*/ 371056 h 471599"/>
                    <a:gd name="connsiteX8" fmla="*/ 283 w 857165"/>
                    <a:gd name="connsiteY8" fmla="*/ 350149 h 471599"/>
                    <a:gd name="connsiteX0" fmla="*/ 283 w 922080"/>
                    <a:gd name="connsiteY0" fmla="*/ 359002 h 486990"/>
                    <a:gd name="connsiteX1" fmla="*/ 263891 w 922080"/>
                    <a:gd name="connsiteY1" fmla="*/ 49457 h 486990"/>
                    <a:gd name="connsiteX2" fmla="*/ 623863 w 922080"/>
                    <a:gd name="connsiteY2" fmla="*/ 40617 h 486990"/>
                    <a:gd name="connsiteX3" fmla="*/ 922080 w 922080"/>
                    <a:gd name="connsiteY3" fmla="*/ 440612 h 486990"/>
                    <a:gd name="connsiteX4" fmla="*/ 768237 w 922080"/>
                    <a:gd name="connsiteY4" fmla="*/ 480452 h 486990"/>
                    <a:gd name="connsiteX5" fmla="*/ 588791 w 922080"/>
                    <a:gd name="connsiteY5" fmla="*/ 250651 h 486990"/>
                    <a:gd name="connsiteX6" fmla="*/ 323181 w 922080"/>
                    <a:gd name="connsiteY6" fmla="*/ 222293 h 486990"/>
                    <a:gd name="connsiteX7" fmla="*/ 182089 w 922080"/>
                    <a:gd name="connsiteY7" fmla="*/ 379909 h 486990"/>
                    <a:gd name="connsiteX8" fmla="*/ 283 w 922080"/>
                    <a:gd name="connsiteY8" fmla="*/ 359002 h 486990"/>
                    <a:gd name="connsiteX0" fmla="*/ 283 w 925272"/>
                    <a:gd name="connsiteY0" fmla="*/ 357772 h 480085"/>
                    <a:gd name="connsiteX1" fmla="*/ 263891 w 925272"/>
                    <a:gd name="connsiteY1" fmla="*/ 48227 h 480085"/>
                    <a:gd name="connsiteX2" fmla="*/ 623863 w 925272"/>
                    <a:gd name="connsiteY2" fmla="*/ 39387 h 480085"/>
                    <a:gd name="connsiteX3" fmla="*/ 925272 w 925272"/>
                    <a:gd name="connsiteY3" fmla="*/ 421509 h 480085"/>
                    <a:gd name="connsiteX4" fmla="*/ 768237 w 925272"/>
                    <a:gd name="connsiteY4" fmla="*/ 479222 h 480085"/>
                    <a:gd name="connsiteX5" fmla="*/ 588791 w 925272"/>
                    <a:gd name="connsiteY5" fmla="*/ 249421 h 480085"/>
                    <a:gd name="connsiteX6" fmla="*/ 323181 w 925272"/>
                    <a:gd name="connsiteY6" fmla="*/ 221063 h 480085"/>
                    <a:gd name="connsiteX7" fmla="*/ 182089 w 925272"/>
                    <a:gd name="connsiteY7" fmla="*/ 378679 h 480085"/>
                    <a:gd name="connsiteX8" fmla="*/ 283 w 925272"/>
                    <a:gd name="connsiteY8" fmla="*/ 357772 h 480085"/>
                    <a:gd name="connsiteX0" fmla="*/ 283 w 925272"/>
                    <a:gd name="connsiteY0" fmla="*/ 357772 h 479899"/>
                    <a:gd name="connsiteX1" fmla="*/ 263891 w 925272"/>
                    <a:gd name="connsiteY1" fmla="*/ 48227 h 479899"/>
                    <a:gd name="connsiteX2" fmla="*/ 623863 w 925272"/>
                    <a:gd name="connsiteY2" fmla="*/ 39387 h 479899"/>
                    <a:gd name="connsiteX3" fmla="*/ 925272 w 925272"/>
                    <a:gd name="connsiteY3" fmla="*/ 421509 h 479899"/>
                    <a:gd name="connsiteX4" fmla="*/ 768237 w 925272"/>
                    <a:gd name="connsiteY4" fmla="*/ 479222 h 479899"/>
                    <a:gd name="connsiteX5" fmla="*/ 588791 w 925272"/>
                    <a:gd name="connsiteY5" fmla="*/ 249421 h 479899"/>
                    <a:gd name="connsiteX6" fmla="*/ 323181 w 925272"/>
                    <a:gd name="connsiteY6" fmla="*/ 221063 h 479899"/>
                    <a:gd name="connsiteX7" fmla="*/ 182089 w 925272"/>
                    <a:gd name="connsiteY7" fmla="*/ 378679 h 479899"/>
                    <a:gd name="connsiteX8" fmla="*/ 283 w 925272"/>
                    <a:gd name="connsiteY8" fmla="*/ 357772 h 479899"/>
                    <a:gd name="connsiteX0" fmla="*/ 283 w 925272"/>
                    <a:gd name="connsiteY0" fmla="*/ 357772 h 479899"/>
                    <a:gd name="connsiteX1" fmla="*/ 263891 w 925272"/>
                    <a:gd name="connsiteY1" fmla="*/ 48227 h 479899"/>
                    <a:gd name="connsiteX2" fmla="*/ 623863 w 925272"/>
                    <a:gd name="connsiteY2" fmla="*/ 39387 h 479899"/>
                    <a:gd name="connsiteX3" fmla="*/ 925272 w 925272"/>
                    <a:gd name="connsiteY3" fmla="*/ 421509 h 479899"/>
                    <a:gd name="connsiteX4" fmla="*/ 768237 w 925272"/>
                    <a:gd name="connsiteY4" fmla="*/ 479222 h 479899"/>
                    <a:gd name="connsiteX5" fmla="*/ 588791 w 925272"/>
                    <a:gd name="connsiteY5" fmla="*/ 249421 h 479899"/>
                    <a:gd name="connsiteX6" fmla="*/ 323181 w 925272"/>
                    <a:gd name="connsiteY6" fmla="*/ 221063 h 479899"/>
                    <a:gd name="connsiteX7" fmla="*/ 182089 w 925272"/>
                    <a:gd name="connsiteY7" fmla="*/ 378679 h 479899"/>
                    <a:gd name="connsiteX8" fmla="*/ 283 w 925272"/>
                    <a:gd name="connsiteY8" fmla="*/ 357772 h 479899"/>
                    <a:gd name="connsiteX0" fmla="*/ 283 w 925272"/>
                    <a:gd name="connsiteY0" fmla="*/ 357772 h 479899"/>
                    <a:gd name="connsiteX1" fmla="*/ 263891 w 925272"/>
                    <a:gd name="connsiteY1" fmla="*/ 48227 h 479899"/>
                    <a:gd name="connsiteX2" fmla="*/ 623863 w 925272"/>
                    <a:gd name="connsiteY2" fmla="*/ 39387 h 479899"/>
                    <a:gd name="connsiteX3" fmla="*/ 925272 w 925272"/>
                    <a:gd name="connsiteY3" fmla="*/ 421509 h 479899"/>
                    <a:gd name="connsiteX4" fmla="*/ 768237 w 925272"/>
                    <a:gd name="connsiteY4" fmla="*/ 479222 h 479899"/>
                    <a:gd name="connsiteX5" fmla="*/ 614360 w 925272"/>
                    <a:gd name="connsiteY5" fmla="*/ 239373 h 479899"/>
                    <a:gd name="connsiteX6" fmla="*/ 323181 w 925272"/>
                    <a:gd name="connsiteY6" fmla="*/ 221063 h 479899"/>
                    <a:gd name="connsiteX7" fmla="*/ 182089 w 925272"/>
                    <a:gd name="connsiteY7" fmla="*/ 378679 h 479899"/>
                    <a:gd name="connsiteX8" fmla="*/ 283 w 925272"/>
                    <a:gd name="connsiteY8" fmla="*/ 357772 h 479899"/>
                    <a:gd name="connsiteX0" fmla="*/ 283 w 925272"/>
                    <a:gd name="connsiteY0" fmla="*/ 357772 h 478527"/>
                    <a:gd name="connsiteX1" fmla="*/ 263891 w 925272"/>
                    <a:gd name="connsiteY1" fmla="*/ 48227 h 478527"/>
                    <a:gd name="connsiteX2" fmla="*/ 623863 w 925272"/>
                    <a:gd name="connsiteY2" fmla="*/ 39387 h 478527"/>
                    <a:gd name="connsiteX3" fmla="*/ 925272 w 925272"/>
                    <a:gd name="connsiteY3" fmla="*/ 421509 h 478527"/>
                    <a:gd name="connsiteX4" fmla="*/ 784939 w 925272"/>
                    <a:gd name="connsiteY4" fmla="*/ 477575 h 478527"/>
                    <a:gd name="connsiteX5" fmla="*/ 614360 w 925272"/>
                    <a:gd name="connsiteY5" fmla="*/ 239373 h 478527"/>
                    <a:gd name="connsiteX6" fmla="*/ 323181 w 925272"/>
                    <a:gd name="connsiteY6" fmla="*/ 221063 h 478527"/>
                    <a:gd name="connsiteX7" fmla="*/ 182089 w 925272"/>
                    <a:gd name="connsiteY7" fmla="*/ 378679 h 478527"/>
                    <a:gd name="connsiteX8" fmla="*/ 283 w 925272"/>
                    <a:gd name="connsiteY8" fmla="*/ 357772 h 478527"/>
                    <a:gd name="connsiteX0" fmla="*/ 283 w 925272"/>
                    <a:gd name="connsiteY0" fmla="*/ 357772 h 478527"/>
                    <a:gd name="connsiteX1" fmla="*/ 263891 w 925272"/>
                    <a:gd name="connsiteY1" fmla="*/ 48227 h 478527"/>
                    <a:gd name="connsiteX2" fmla="*/ 623863 w 925272"/>
                    <a:gd name="connsiteY2" fmla="*/ 39387 h 478527"/>
                    <a:gd name="connsiteX3" fmla="*/ 925272 w 925272"/>
                    <a:gd name="connsiteY3" fmla="*/ 421509 h 478527"/>
                    <a:gd name="connsiteX4" fmla="*/ 784939 w 925272"/>
                    <a:gd name="connsiteY4" fmla="*/ 477575 h 478527"/>
                    <a:gd name="connsiteX5" fmla="*/ 614360 w 925272"/>
                    <a:gd name="connsiteY5" fmla="*/ 239373 h 478527"/>
                    <a:gd name="connsiteX6" fmla="*/ 323181 w 925272"/>
                    <a:gd name="connsiteY6" fmla="*/ 221063 h 478527"/>
                    <a:gd name="connsiteX7" fmla="*/ 182089 w 925272"/>
                    <a:gd name="connsiteY7" fmla="*/ 378679 h 478527"/>
                    <a:gd name="connsiteX8" fmla="*/ 283 w 925272"/>
                    <a:gd name="connsiteY8" fmla="*/ 357772 h 478527"/>
                    <a:gd name="connsiteX0" fmla="*/ 283 w 925272"/>
                    <a:gd name="connsiteY0" fmla="*/ 357772 h 557834"/>
                    <a:gd name="connsiteX1" fmla="*/ 263891 w 925272"/>
                    <a:gd name="connsiteY1" fmla="*/ 48227 h 557834"/>
                    <a:gd name="connsiteX2" fmla="*/ 623863 w 925272"/>
                    <a:gd name="connsiteY2" fmla="*/ 39387 h 557834"/>
                    <a:gd name="connsiteX3" fmla="*/ 925272 w 925272"/>
                    <a:gd name="connsiteY3" fmla="*/ 421509 h 557834"/>
                    <a:gd name="connsiteX4" fmla="*/ 784939 w 925272"/>
                    <a:gd name="connsiteY4" fmla="*/ 477575 h 557834"/>
                    <a:gd name="connsiteX5" fmla="*/ 614360 w 925272"/>
                    <a:gd name="connsiteY5" fmla="*/ 239373 h 557834"/>
                    <a:gd name="connsiteX6" fmla="*/ 323181 w 925272"/>
                    <a:gd name="connsiteY6" fmla="*/ 221063 h 557834"/>
                    <a:gd name="connsiteX7" fmla="*/ 137577 w 925272"/>
                    <a:gd name="connsiteY7" fmla="*/ 551149 h 557834"/>
                    <a:gd name="connsiteX8" fmla="*/ 283 w 925272"/>
                    <a:gd name="connsiteY8" fmla="*/ 357772 h 557834"/>
                    <a:gd name="connsiteX0" fmla="*/ 283 w 925272"/>
                    <a:gd name="connsiteY0" fmla="*/ 357772 h 505215"/>
                    <a:gd name="connsiteX1" fmla="*/ 263891 w 925272"/>
                    <a:gd name="connsiteY1" fmla="*/ 48227 h 505215"/>
                    <a:gd name="connsiteX2" fmla="*/ 623863 w 925272"/>
                    <a:gd name="connsiteY2" fmla="*/ 39387 h 505215"/>
                    <a:gd name="connsiteX3" fmla="*/ 925272 w 925272"/>
                    <a:gd name="connsiteY3" fmla="*/ 421509 h 505215"/>
                    <a:gd name="connsiteX4" fmla="*/ 784939 w 925272"/>
                    <a:gd name="connsiteY4" fmla="*/ 477575 h 505215"/>
                    <a:gd name="connsiteX5" fmla="*/ 614360 w 925272"/>
                    <a:gd name="connsiteY5" fmla="*/ 239373 h 505215"/>
                    <a:gd name="connsiteX6" fmla="*/ 323181 w 925272"/>
                    <a:gd name="connsiteY6" fmla="*/ 221063 h 505215"/>
                    <a:gd name="connsiteX7" fmla="*/ 132607 w 925272"/>
                    <a:gd name="connsiteY7" fmla="*/ 496450 h 505215"/>
                    <a:gd name="connsiteX8" fmla="*/ 283 w 925272"/>
                    <a:gd name="connsiteY8" fmla="*/ 357772 h 505215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344909 w 947000"/>
                    <a:gd name="connsiteY6" fmla="*/ 227109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296839 w 947000"/>
                    <a:gd name="connsiteY6" fmla="*/ 254428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296839 w 947000"/>
                    <a:gd name="connsiteY6" fmla="*/ 254428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296839 w 947000"/>
                    <a:gd name="connsiteY6" fmla="*/ 254428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295554 w 947000"/>
                    <a:gd name="connsiteY6" fmla="*/ 372286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2261 w 947000"/>
                    <a:gd name="connsiteY5" fmla="*/ 503987 h 523249"/>
                    <a:gd name="connsiteX6" fmla="*/ 295554 w 947000"/>
                    <a:gd name="connsiteY6" fmla="*/ 372286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9 w 947002"/>
                    <a:gd name="connsiteY0" fmla="*/ 433331 h 487762"/>
                    <a:gd name="connsiteX1" fmla="*/ 285621 w 947002"/>
                    <a:gd name="connsiteY1" fmla="*/ 18786 h 487762"/>
                    <a:gd name="connsiteX2" fmla="*/ 655110 w 947002"/>
                    <a:gd name="connsiteY2" fmla="*/ 103264 h 487762"/>
                    <a:gd name="connsiteX3" fmla="*/ 947002 w 947002"/>
                    <a:gd name="connsiteY3" fmla="*/ 392068 h 487762"/>
                    <a:gd name="connsiteX4" fmla="*/ 806669 w 947002"/>
                    <a:gd name="connsiteY4" fmla="*/ 448134 h 487762"/>
                    <a:gd name="connsiteX5" fmla="*/ 632263 w 947002"/>
                    <a:gd name="connsiteY5" fmla="*/ 468500 h 487762"/>
                    <a:gd name="connsiteX6" fmla="*/ 295556 w 947002"/>
                    <a:gd name="connsiteY6" fmla="*/ 336799 h 487762"/>
                    <a:gd name="connsiteX7" fmla="*/ 154337 w 947002"/>
                    <a:gd name="connsiteY7" fmla="*/ 467009 h 487762"/>
                    <a:gd name="connsiteX8" fmla="*/ 259 w 947002"/>
                    <a:gd name="connsiteY8" fmla="*/ 433331 h 487762"/>
                    <a:gd name="connsiteX0" fmla="*/ 243 w 946986"/>
                    <a:gd name="connsiteY0" fmla="*/ 412146 h 466577"/>
                    <a:gd name="connsiteX1" fmla="*/ 298890 w 946986"/>
                    <a:gd name="connsiteY1" fmla="*/ 22384 h 466577"/>
                    <a:gd name="connsiteX2" fmla="*/ 655094 w 946986"/>
                    <a:gd name="connsiteY2" fmla="*/ 82079 h 466577"/>
                    <a:gd name="connsiteX3" fmla="*/ 946986 w 946986"/>
                    <a:gd name="connsiteY3" fmla="*/ 370883 h 466577"/>
                    <a:gd name="connsiteX4" fmla="*/ 806653 w 946986"/>
                    <a:gd name="connsiteY4" fmla="*/ 426949 h 466577"/>
                    <a:gd name="connsiteX5" fmla="*/ 632247 w 946986"/>
                    <a:gd name="connsiteY5" fmla="*/ 447315 h 466577"/>
                    <a:gd name="connsiteX6" fmla="*/ 295540 w 946986"/>
                    <a:gd name="connsiteY6" fmla="*/ 315614 h 466577"/>
                    <a:gd name="connsiteX7" fmla="*/ 154321 w 946986"/>
                    <a:gd name="connsiteY7" fmla="*/ 445824 h 466577"/>
                    <a:gd name="connsiteX8" fmla="*/ 243 w 946986"/>
                    <a:gd name="connsiteY8" fmla="*/ 412146 h 466577"/>
                    <a:gd name="connsiteX0" fmla="*/ 243 w 946986"/>
                    <a:gd name="connsiteY0" fmla="*/ 412146 h 466577"/>
                    <a:gd name="connsiteX1" fmla="*/ 298890 w 946986"/>
                    <a:gd name="connsiteY1" fmla="*/ 22384 h 466577"/>
                    <a:gd name="connsiteX2" fmla="*/ 655094 w 946986"/>
                    <a:gd name="connsiteY2" fmla="*/ 82079 h 466577"/>
                    <a:gd name="connsiteX3" fmla="*/ 946986 w 946986"/>
                    <a:gd name="connsiteY3" fmla="*/ 370883 h 466577"/>
                    <a:gd name="connsiteX4" fmla="*/ 806653 w 946986"/>
                    <a:gd name="connsiteY4" fmla="*/ 426949 h 466577"/>
                    <a:gd name="connsiteX5" fmla="*/ 559793 w 946986"/>
                    <a:gd name="connsiteY5" fmla="*/ 347102 h 466577"/>
                    <a:gd name="connsiteX6" fmla="*/ 295540 w 946986"/>
                    <a:gd name="connsiteY6" fmla="*/ 315614 h 466577"/>
                    <a:gd name="connsiteX7" fmla="*/ 154321 w 946986"/>
                    <a:gd name="connsiteY7" fmla="*/ 445824 h 466577"/>
                    <a:gd name="connsiteX8" fmla="*/ 243 w 946986"/>
                    <a:gd name="connsiteY8" fmla="*/ 412146 h 466577"/>
                    <a:gd name="connsiteX0" fmla="*/ 243 w 946986"/>
                    <a:gd name="connsiteY0" fmla="*/ 412146 h 466577"/>
                    <a:gd name="connsiteX1" fmla="*/ 298890 w 946986"/>
                    <a:gd name="connsiteY1" fmla="*/ 22384 h 466577"/>
                    <a:gd name="connsiteX2" fmla="*/ 655094 w 946986"/>
                    <a:gd name="connsiteY2" fmla="*/ 82079 h 466577"/>
                    <a:gd name="connsiteX3" fmla="*/ 946986 w 946986"/>
                    <a:gd name="connsiteY3" fmla="*/ 370883 h 466577"/>
                    <a:gd name="connsiteX4" fmla="*/ 806653 w 946986"/>
                    <a:gd name="connsiteY4" fmla="*/ 426949 h 466577"/>
                    <a:gd name="connsiteX5" fmla="*/ 662849 w 946986"/>
                    <a:gd name="connsiteY5" fmla="*/ 369624 h 466577"/>
                    <a:gd name="connsiteX6" fmla="*/ 295540 w 946986"/>
                    <a:gd name="connsiteY6" fmla="*/ 315614 h 466577"/>
                    <a:gd name="connsiteX7" fmla="*/ 154321 w 946986"/>
                    <a:gd name="connsiteY7" fmla="*/ 445824 h 466577"/>
                    <a:gd name="connsiteX8" fmla="*/ 243 w 946986"/>
                    <a:gd name="connsiteY8" fmla="*/ 412146 h 466577"/>
                    <a:gd name="connsiteX0" fmla="*/ 243 w 946986"/>
                    <a:gd name="connsiteY0" fmla="*/ 412146 h 427901"/>
                    <a:gd name="connsiteX1" fmla="*/ 298890 w 946986"/>
                    <a:gd name="connsiteY1" fmla="*/ 22384 h 427901"/>
                    <a:gd name="connsiteX2" fmla="*/ 655094 w 946986"/>
                    <a:gd name="connsiteY2" fmla="*/ 82079 h 427901"/>
                    <a:gd name="connsiteX3" fmla="*/ 946986 w 946986"/>
                    <a:gd name="connsiteY3" fmla="*/ 370883 h 427901"/>
                    <a:gd name="connsiteX4" fmla="*/ 806653 w 946986"/>
                    <a:gd name="connsiteY4" fmla="*/ 426949 h 427901"/>
                    <a:gd name="connsiteX5" fmla="*/ 662849 w 946986"/>
                    <a:gd name="connsiteY5" fmla="*/ 369624 h 427901"/>
                    <a:gd name="connsiteX6" fmla="*/ 295540 w 946986"/>
                    <a:gd name="connsiteY6" fmla="*/ 315614 h 427901"/>
                    <a:gd name="connsiteX7" fmla="*/ 156720 w 946986"/>
                    <a:gd name="connsiteY7" fmla="*/ 355738 h 427901"/>
                    <a:gd name="connsiteX8" fmla="*/ 243 w 946986"/>
                    <a:gd name="connsiteY8" fmla="*/ 412146 h 427901"/>
                    <a:gd name="connsiteX0" fmla="*/ 272 w 920653"/>
                    <a:gd name="connsiteY0" fmla="*/ 209335 h 414265"/>
                    <a:gd name="connsiteX1" fmla="*/ 272557 w 920653"/>
                    <a:gd name="connsiteY1" fmla="*/ 8748 h 414265"/>
                    <a:gd name="connsiteX2" fmla="*/ 628761 w 920653"/>
                    <a:gd name="connsiteY2" fmla="*/ 68443 h 414265"/>
                    <a:gd name="connsiteX3" fmla="*/ 920653 w 920653"/>
                    <a:gd name="connsiteY3" fmla="*/ 357247 h 414265"/>
                    <a:gd name="connsiteX4" fmla="*/ 780320 w 920653"/>
                    <a:gd name="connsiteY4" fmla="*/ 413313 h 414265"/>
                    <a:gd name="connsiteX5" fmla="*/ 636516 w 920653"/>
                    <a:gd name="connsiteY5" fmla="*/ 355988 h 414265"/>
                    <a:gd name="connsiteX6" fmla="*/ 269207 w 920653"/>
                    <a:gd name="connsiteY6" fmla="*/ 301978 h 414265"/>
                    <a:gd name="connsiteX7" fmla="*/ 130387 w 920653"/>
                    <a:gd name="connsiteY7" fmla="*/ 342102 h 414265"/>
                    <a:gd name="connsiteX8" fmla="*/ 272 w 920653"/>
                    <a:gd name="connsiteY8" fmla="*/ 209335 h 414265"/>
                    <a:gd name="connsiteX0" fmla="*/ 272 w 920653"/>
                    <a:gd name="connsiteY0" fmla="*/ 209335 h 414265"/>
                    <a:gd name="connsiteX1" fmla="*/ 272557 w 920653"/>
                    <a:gd name="connsiteY1" fmla="*/ 8748 h 414265"/>
                    <a:gd name="connsiteX2" fmla="*/ 628761 w 920653"/>
                    <a:gd name="connsiteY2" fmla="*/ 68443 h 414265"/>
                    <a:gd name="connsiteX3" fmla="*/ 920653 w 920653"/>
                    <a:gd name="connsiteY3" fmla="*/ 357247 h 414265"/>
                    <a:gd name="connsiteX4" fmla="*/ 780320 w 920653"/>
                    <a:gd name="connsiteY4" fmla="*/ 413313 h 414265"/>
                    <a:gd name="connsiteX5" fmla="*/ 636516 w 920653"/>
                    <a:gd name="connsiteY5" fmla="*/ 355988 h 414265"/>
                    <a:gd name="connsiteX6" fmla="*/ 269207 w 920653"/>
                    <a:gd name="connsiteY6" fmla="*/ 301978 h 414265"/>
                    <a:gd name="connsiteX7" fmla="*/ 130387 w 920653"/>
                    <a:gd name="connsiteY7" fmla="*/ 342102 h 414265"/>
                    <a:gd name="connsiteX8" fmla="*/ 272 w 920653"/>
                    <a:gd name="connsiteY8" fmla="*/ 209335 h 414265"/>
                    <a:gd name="connsiteX0" fmla="*/ 272 w 920653"/>
                    <a:gd name="connsiteY0" fmla="*/ 209335 h 414265"/>
                    <a:gd name="connsiteX1" fmla="*/ 272557 w 920653"/>
                    <a:gd name="connsiteY1" fmla="*/ 8748 h 414265"/>
                    <a:gd name="connsiteX2" fmla="*/ 628761 w 920653"/>
                    <a:gd name="connsiteY2" fmla="*/ 68443 h 414265"/>
                    <a:gd name="connsiteX3" fmla="*/ 920653 w 920653"/>
                    <a:gd name="connsiteY3" fmla="*/ 357247 h 414265"/>
                    <a:gd name="connsiteX4" fmla="*/ 780320 w 920653"/>
                    <a:gd name="connsiteY4" fmla="*/ 413313 h 414265"/>
                    <a:gd name="connsiteX5" fmla="*/ 636516 w 920653"/>
                    <a:gd name="connsiteY5" fmla="*/ 355988 h 414265"/>
                    <a:gd name="connsiteX6" fmla="*/ 269207 w 920653"/>
                    <a:gd name="connsiteY6" fmla="*/ 301978 h 414265"/>
                    <a:gd name="connsiteX7" fmla="*/ 130387 w 920653"/>
                    <a:gd name="connsiteY7" fmla="*/ 342102 h 414265"/>
                    <a:gd name="connsiteX8" fmla="*/ 272 w 920653"/>
                    <a:gd name="connsiteY8" fmla="*/ 209335 h 414265"/>
                    <a:gd name="connsiteX0" fmla="*/ 0 w 920381"/>
                    <a:gd name="connsiteY0" fmla="*/ 209335 h 414265"/>
                    <a:gd name="connsiteX1" fmla="*/ 272285 w 920381"/>
                    <a:gd name="connsiteY1" fmla="*/ 8748 h 414265"/>
                    <a:gd name="connsiteX2" fmla="*/ 628489 w 920381"/>
                    <a:gd name="connsiteY2" fmla="*/ 68443 h 414265"/>
                    <a:gd name="connsiteX3" fmla="*/ 920381 w 920381"/>
                    <a:gd name="connsiteY3" fmla="*/ 357247 h 414265"/>
                    <a:gd name="connsiteX4" fmla="*/ 780048 w 920381"/>
                    <a:gd name="connsiteY4" fmla="*/ 413313 h 414265"/>
                    <a:gd name="connsiteX5" fmla="*/ 636244 w 920381"/>
                    <a:gd name="connsiteY5" fmla="*/ 355988 h 414265"/>
                    <a:gd name="connsiteX6" fmla="*/ 268935 w 920381"/>
                    <a:gd name="connsiteY6" fmla="*/ 301978 h 414265"/>
                    <a:gd name="connsiteX7" fmla="*/ 130115 w 920381"/>
                    <a:gd name="connsiteY7" fmla="*/ 342102 h 414265"/>
                    <a:gd name="connsiteX8" fmla="*/ 0 w 920381"/>
                    <a:gd name="connsiteY8" fmla="*/ 209335 h 414265"/>
                    <a:gd name="connsiteX0" fmla="*/ 0 w 920381"/>
                    <a:gd name="connsiteY0" fmla="*/ 209335 h 414265"/>
                    <a:gd name="connsiteX1" fmla="*/ 272285 w 920381"/>
                    <a:gd name="connsiteY1" fmla="*/ 8748 h 414265"/>
                    <a:gd name="connsiteX2" fmla="*/ 628489 w 920381"/>
                    <a:gd name="connsiteY2" fmla="*/ 68443 h 414265"/>
                    <a:gd name="connsiteX3" fmla="*/ 920381 w 920381"/>
                    <a:gd name="connsiteY3" fmla="*/ 357247 h 414265"/>
                    <a:gd name="connsiteX4" fmla="*/ 780048 w 920381"/>
                    <a:gd name="connsiteY4" fmla="*/ 413313 h 414265"/>
                    <a:gd name="connsiteX5" fmla="*/ 636244 w 920381"/>
                    <a:gd name="connsiteY5" fmla="*/ 355988 h 414265"/>
                    <a:gd name="connsiteX6" fmla="*/ 268935 w 920381"/>
                    <a:gd name="connsiteY6" fmla="*/ 301978 h 414265"/>
                    <a:gd name="connsiteX7" fmla="*/ 130115 w 920381"/>
                    <a:gd name="connsiteY7" fmla="*/ 342102 h 414265"/>
                    <a:gd name="connsiteX8" fmla="*/ 0 w 920381"/>
                    <a:gd name="connsiteY8" fmla="*/ 209335 h 414265"/>
                    <a:gd name="connsiteX0" fmla="*/ 0 w 826914"/>
                    <a:gd name="connsiteY0" fmla="*/ 146725 h 410211"/>
                    <a:gd name="connsiteX1" fmla="*/ 178818 w 826914"/>
                    <a:gd name="connsiteY1" fmla="*/ 4694 h 410211"/>
                    <a:gd name="connsiteX2" fmla="*/ 535022 w 826914"/>
                    <a:gd name="connsiteY2" fmla="*/ 64389 h 410211"/>
                    <a:gd name="connsiteX3" fmla="*/ 826914 w 826914"/>
                    <a:gd name="connsiteY3" fmla="*/ 353193 h 410211"/>
                    <a:gd name="connsiteX4" fmla="*/ 686581 w 826914"/>
                    <a:gd name="connsiteY4" fmla="*/ 409259 h 410211"/>
                    <a:gd name="connsiteX5" fmla="*/ 542777 w 826914"/>
                    <a:gd name="connsiteY5" fmla="*/ 351934 h 410211"/>
                    <a:gd name="connsiteX6" fmla="*/ 175468 w 826914"/>
                    <a:gd name="connsiteY6" fmla="*/ 297924 h 410211"/>
                    <a:gd name="connsiteX7" fmla="*/ 36648 w 826914"/>
                    <a:gd name="connsiteY7" fmla="*/ 338048 h 410211"/>
                    <a:gd name="connsiteX8" fmla="*/ 0 w 826914"/>
                    <a:gd name="connsiteY8" fmla="*/ 146725 h 410211"/>
                    <a:gd name="connsiteX0" fmla="*/ 6906 w 833820"/>
                    <a:gd name="connsiteY0" fmla="*/ 146725 h 410211"/>
                    <a:gd name="connsiteX1" fmla="*/ 185724 w 833820"/>
                    <a:gd name="connsiteY1" fmla="*/ 4694 h 410211"/>
                    <a:gd name="connsiteX2" fmla="*/ 541928 w 833820"/>
                    <a:gd name="connsiteY2" fmla="*/ 64389 h 410211"/>
                    <a:gd name="connsiteX3" fmla="*/ 833820 w 833820"/>
                    <a:gd name="connsiteY3" fmla="*/ 353193 h 410211"/>
                    <a:gd name="connsiteX4" fmla="*/ 693487 w 833820"/>
                    <a:gd name="connsiteY4" fmla="*/ 409259 h 410211"/>
                    <a:gd name="connsiteX5" fmla="*/ 549683 w 833820"/>
                    <a:gd name="connsiteY5" fmla="*/ 351934 h 410211"/>
                    <a:gd name="connsiteX6" fmla="*/ 182374 w 833820"/>
                    <a:gd name="connsiteY6" fmla="*/ 297924 h 410211"/>
                    <a:gd name="connsiteX7" fmla="*/ 43554 w 833820"/>
                    <a:gd name="connsiteY7" fmla="*/ 338048 h 410211"/>
                    <a:gd name="connsiteX8" fmla="*/ 6906 w 833820"/>
                    <a:gd name="connsiteY8" fmla="*/ 146725 h 410211"/>
                    <a:gd name="connsiteX0" fmla="*/ 6906 w 833820"/>
                    <a:gd name="connsiteY0" fmla="*/ 146725 h 410211"/>
                    <a:gd name="connsiteX1" fmla="*/ 185724 w 833820"/>
                    <a:gd name="connsiteY1" fmla="*/ 4694 h 410211"/>
                    <a:gd name="connsiteX2" fmla="*/ 541928 w 833820"/>
                    <a:gd name="connsiteY2" fmla="*/ 64389 h 410211"/>
                    <a:gd name="connsiteX3" fmla="*/ 833820 w 833820"/>
                    <a:gd name="connsiteY3" fmla="*/ 353193 h 410211"/>
                    <a:gd name="connsiteX4" fmla="*/ 693487 w 833820"/>
                    <a:gd name="connsiteY4" fmla="*/ 409259 h 410211"/>
                    <a:gd name="connsiteX5" fmla="*/ 549683 w 833820"/>
                    <a:gd name="connsiteY5" fmla="*/ 351934 h 410211"/>
                    <a:gd name="connsiteX6" fmla="*/ 247082 w 833820"/>
                    <a:gd name="connsiteY6" fmla="*/ 302428 h 410211"/>
                    <a:gd name="connsiteX7" fmla="*/ 43554 w 833820"/>
                    <a:gd name="connsiteY7" fmla="*/ 338048 h 410211"/>
                    <a:gd name="connsiteX8" fmla="*/ 6906 w 833820"/>
                    <a:gd name="connsiteY8" fmla="*/ 146725 h 410211"/>
                    <a:gd name="connsiteX0" fmla="*/ 6906 w 833820"/>
                    <a:gd name="connsiteY0" fmla="*/ 146725 h 410211"/>
                    <a:gd name="connsiteX1" fmla="*/ 185724 w 833820"/>
                    <a:gd name="connsiteY1" fmla="*/ 4694 h 410211"/>
                    <a:gd name="connsiteX2" fmla="*/ 541928 w 833820"/>
                    <a:gd name="connsiteY2" fmla="*/ 64389 h 410211"/>
                    <a:gd name="connsiteX3" fmla="*/ 833820 w 833820"/>
                    <a:gd name="connsiteY3" fmla="*/ 353193 h 410211"/>
                    <a:gd name="connsiteX4" fmla="*/ 693487 w 833820"/>
                    <a:gd name="connsiteY4" fmla="*/ 409259 h 410211"/>
                    <a:gd name="connsiteX5" fmla="*/ 549683 w 833820"/>
                    <a:gd name="connsiteY5" fmla="*/ 351934 h 410211"/>
                    <a:gd name="connsiteX6" fmla="*/ 247082 w 833820"/>
                    <a:gd name="connsiteY6" fmla="*/ 302428 h 410211"/>
                    <a:gd name="connsiteX7" fmla="*/ 43554 w 833820"/>
                    <a:gd name="connsiteY7" fmla="*/ 338048 h 410211"/>
                    <a:gd name="connsiteX8" fmla="*/ 6906 w 833820"/>
                    <a:gd name="connsiteY8" fmla="*/ 146725 h 410211"/>
                    <a:gd name="connsiteX0" fmla="*/ 6906 w 749939"/>
                    <a:gd name="connsiteY0" fmla="*/ 144724 h 407258"/>
                    <a:gd name="connsiteX1" fmla="*/ 185724 w 749939"/>
                    <a:gd name="connsiteY1" fmla="*/ 2693 h 407258"/>
                    <a:gd name="connsiteX2" fmla="*/ 541928 w 749939"/>
                    <a:gd name="connsiteY2" fmla="*/ 62388 h 407258"/>
                    <a:gd name="connsiteX3" fmla="*/ 749939 w 749939"/>
                    <a:gd name="connsiteY3" fmla="*/ 193545 h 407258"/>
                    <a:gd name="connsiteX4" fmla="*/ 693487 w 749939"/>
                    <a:gd name="connsiteY4" fmla="*/ 407258 h 407258"/>
                    <a:gd name="connsiteX5" fmla="*/ 549683 w 749939"/>
                    <a:gd name="connsiteY5" fmla="*/ 349933 h 407258"/>
                    <a:gd name="connsiteX6" fmla="*/ 247082 w 749939"/>
                    <a:gd name="connsiteY6" fmla="*/ 300427 h 407258"/>
                    <a:gd name="connsiteX7" fmla="*/ 43554 w 749939"/>
                    <a:gd name="connsiteY7" fmla="*/ 336047 h 407258"/>
                    <a:gd name="connsiteX8" fmla="*/ 6906 w 749939"/>
                    <a:gd name="connsiteY8" fmla="*/ 144724 h 407258"/>
                    <a:gd name="connsiteX0" fmla="*/ 2856 w 745889"/>
                    <a:gd name="connsiteY0" fmla="*/ 144724 h 407258"/>
                    <a:gd name="connsiteX1" fmla="*/ 181674 w 745889"/>
                    <a:gd name="connsiteY1" fmla="*/ 2693 h 407258"/>
                    <a:gd name="connsiteX2" fmla="*/ 537878 w 745889"/>
                    <a:gd name="connsiteY2" fmla="*/ 62388 h 407258"/>
                    <a:gd name="connsiteX3" fmla="*/ 745889 w 745889"/>
                    <a:gd name="connsiteY3" fmla="*/ 193545 h 407258"/>
                    <a:gd name="connsiteX4" fmla="*/ 689437 w 745889"/>
                    <a:gd name="connsiteY4" fmla="*/ 407258 h 407258"/>
                    <a:gd name="connsiteX5" fmla="*/ 545633 w 745889"/>
                    <a:gd name="connsiteY5" fmla="*/ 349933 h 407258"/>
                    <a:gd name="connsiteX6" fmla="*/ 243032 w 745889"/>
                    <a:gd name="connsiteY6" fmla="*/ 300427 h 407258"/>
                    <a:gd name="connsiteX7" fmla="*/ 46695 w 745889"/>
                    <a:gd name="connsiteY7" fmla="*/ 254971 h 407258"/>
                    <a:gd name="connsiteX8" fmla="*/ 2856 w 745889"/>
                    <a:gd name="connsiteY8" fmla="*/ 144724 h 407258"/>
                    <a:gd name="connsiteX0" fmla="*/ 2855 w 745888"/>
                    <a:gd name="connsiteY0" fmla="*/ 144724 h 407258"/>
                    <a:gd name="connsiteX1" fmla="*/ 181673 w 745888"/>
                    <a:gd name="connsiteY1" fmla="*/ 2693 h 407258"/>
                    <a:gd name="connsiteX2" fmla="*/ 537877 w 745888"/>
                    <a:gd name="connsiteY2" fmla="*/ 62388 h 407258"/>
                    <a:gd name="connsiteX3" fmla="*/ 745888 w 745888"/>
                    <a:gd name="connsiteY3" fmla="*/ 193545 h 407258"/>
                    <a:gd name="connsiteX4" fmla="*/ 689436 w 745888"/>
                    <a:gd name="connsiteY4" fmla="*/ 407258 h 407258"/>
                    <a:gd name="connsiteX5" fmla="*/ 545632 w 745888"/>
                    <a:gd name="connsiteY5" fmla="*/ 349933 h 407258"/>
                    <a:gd name="connsiteX6" fmla="*/ 243031 w 745888"/>
                    <a:gd name="connsiteY6" fmla="*/ 300427 h 407258"/>
                    <a:gd name="connsiteX7" fmla="*/ 46696 w 745888"/>
                    <a:gd name="connsiteY7" fmla="*/ 327038 h 407258"/>
                    <a:gd name="connsiteX8" fmla="*/ 2855 w 745888"/>
                    <a:gd name="connsiteY8" fmla="*/ 144724 h 407258"/>
                    <a:gd name="connsiteX0" fmla="*/ 0 w 752619"/>
                    <a:gd name="connsiteY0" fmla="*/ 115489 h 423064"/>
                    <a:gd name="connsiteX1" fmla="*/ 188404 w 752619"/>
                    <a:gd name="connsiteY1" fmla="*/ 18499 h 423064"/>
                    <a:gd name="connsiteX2" fmla="*/ 544608 w 752619"/>
                    <a:gd name="connsiteY2" fmla="*/ 78194 h 423064"/>
                    <a:gd name="connsiteX3" fmla="*/ 752619 w 752619"/>
                    <a:gd name="connsiteY3" fmla="*/ 209351 h 423064"/>
                    <a:gd name="connsiteX4" fmla="*/ 696167 w 752619"/>
                    <a:gd name="connsiteY4" fmla="*/ 423064 h 423064"/>
                    <a:gd name="connsiteX5" fmla="*/ 552363 w 752619"/>
                    <a:gd name="connsiteY5" fmla="*/ 365739 h 423064"/>
                    <a:gd name="connsiteX6" fmla="*/ 249762 w 752619"/>
                    <a:gd name="connsiteY6" fmla="*/ 316233 h 423064"/>
                    <a:gd name="connsiteX7" fmla="*/ 53427 w 752619"/>
                    <a:gd name="connsiteY7" fmla="*/ 342844 h 423064"/>
                    <a:gd name="connsiteX8" fmla="*/ 0 w 752619"/>
                    <a:gd name="connsiteY8" fmla="*/ 115489 h 423064"/>
                    <a:gd name="connsiteX0" fmla="*/ 14527 w 767146"/>
                    <a:gd name="connsiteY0" fmla="*/ 115489 h 423064"/>
                    <a:gd name="connsiteX1" fmla="*/ 202931 w 767146"/>
                    <a:gd name="connsiteY1" fmla="*/ 18499 h 423064"/>
                    <a:gd name="connsiteX2" fmla="*/ 559135 w 767146"/>
                    <a:gd name="connsiteY2" fmla="*/ 78194 h 423064"/>
                    <a:gd name="connsiteX3" fmla="*/ 767146 w 767146"/>
                    <a:gd name="connsiteY3" fmla="*/ 209351 h 423064"/>
                    <a:gd name="connsiteX4" fmla="*/ 710694 w 767146"/>
                    <a:gd name="connsiteY4" fmla="*/ 423064 h 423064"/>
                    <a:gd name="connsiteX5" fmla="*/ 566890 w 767146"/>
                    <a:gd name="connsiteY5" fmla="*/ 365739 h 423064"/>
                    <a:gd name="connsiteX6" fmla="*/ 264289 w 767146"/>
                    <a:gd name="connsiteY6" fmla="*/ 316233 h 423064"/>
                    <a:gd name="connsiteX7" fmla="*/ 39195 w 767146"/>
                    <a:gd name="connsiteY7" fmla="*/ 279787 h 423064"/>
                    <a:gd name="connsiteX8" fmla="*/ 14527 w 767146"/>
                    <a:gd name="connsiteY8" fmla="*/ 115489 h 423064"/>
                    <a:gd name="connsiteX0" fmla="*/ 14527 w 767146"/>
                    <a:gd name="connsiteY0" fmla="*/ 115489 h 423064"/>
                    <a:gd name="connsiteX1" fmla="*/ 202931 w 767146"/>
                    <a:gd name="connsiteY1" fmla="*/ 18499 h 423064"/>
                    <a:gd name="connsiteX2" fmla="*/ 559135 w 767146"/>
                    <a:gd name="connsiteY2" fmla="*/ 78194 h 423064"/>
                    <a:gd name="connsiteX3" fmla="*/ 767146 w 767146"/>
                    <a:gd name="connsiteY3" fmla="*/ 209351 h 423064"/>
                    <a:gd name="connsiteX4" fmla="*/ 710694 w 767146"/>
                    <a:gd name="connsiteY4" fmla="*/ 423064 h 423064"/>
                    <a:gd name="connsiteX5" fmla="*/ 566890 w 767146"/>
                    <a:gd name="connsiteY5" fmla="*/ 365739 h 423064"/>
                    <a:gd name="connsiteX6" fmla="*/ 264289 w 767146"/>
                    <a:gd name="connsiteY6" fmla="*/ 316233 h 423064"/>
                    <a:gd name="connsiteX7" fmla="*/ 39195 w 767146"/>
                    <a:gd name="connsiteY7" fmla="*/ 279787 h 423064"/>
                    <a:gd name="connsiteX8" fmla="*/ 14527 w 767146"/>
                    <a:gd name="connsiteY8" fmla="*/ 115489 h 423064"/>
                    <a:gd name="connsiteX0" fmla="*/ 9839 w 762458"/>
                    <a:gd name="connsiteY0" fmla="*/ 115489 h 423064"/>
                    <a:gd name="connsiteX1" fmla="*/ 198243 w 762458"/>
                    <a:gd name="connsiteY1" fmla="*/ 18499 h 423064"/>
                    <a:gd name="connsiteX2" fmla="*/ 554447 w 762458"/>
                    <a:gd name="connsiteY2" fmla="*/ 78194 h 423064"/>
                    <a:gd name="connsiteX3" fmla="*/ 762458 w 762458"/>
                    <a:gd name="connsiteY3" fmla="*/ 209351 h 423064"/>
                    <a:gd name="connsiteX4" fmla="*/ 706006 w 762458"/>
                    <a:gd name="connsiteY4" fmla="*/ 423064 h 423064"/>
                    <a:gd name="connsiteX5" fmla="*/ 562202 w 762458"/>
                    <a:gd name="connsiteY5" fmla="*/ 365739 h 423064"/>
                    <a:gd name="connsiteX6" fmla="*/ 259601 w 762458"/>
                    <a:gd name="connsiteY6" fmla="*/ 316233 h 423064"/>
                    <a:gd name="connsiteX7" fmla="*/ 41697 w 762458"/>
                    <a:gd name="connsiteY7" fmla="*/ 302307 h 423064"/>
                    <a:gd name="connsiteX8" fmla="*/ 9839 w 762458"/>
                    <a:gd name="connsiteY8" fmla="*/ 115489 h 423064"/>
                    <a:gd name="connsiteX0" fmla="*/ 0 w 752619"/>
                    <a:gd name="connsiteY0" fmla="*/ 115489 h 423064"/>
                    <a:gd name="connsiteX1" fmla="*/ 188404 w 752619"/>
                    <a:gd name="connsiteY1" fmla="*/ 18499 h 423064"/>
                    <a:gd name="connsiteX2" fmla="*/ 544608 w 752619"/>
                    <a:gd name="connsiteY2" fmla="*/ 78194 h 423064"/>
                    <a:gd name="connsiteX3" fmla="*/ 752619 w 752619"/>
                    <a:gd name="connsiteY3" fmla="*/ 209351 h 423064"/>
                    <a:gd name="connsiteX4" fmla="*/ 696167 w 752619"/>
                    <a:gd name="connsiteY4" fmla="*/ 423064 h 423064"/>
                    <a:gd name="connsiteX5" fmla="*/ 552363 w 752619"/>
                    <a:gd name="connsiteY5" fmla="*/ 365739 h 423064"/>
                    <a:gd name="connsiteX6" fmla="*/ 249762 w 752619"/>
                    <a:gd name="connsiteY6" fmla="*/ 316233 h 423064"/>
                    <a:gd name="connsiteX7" fmla="*/ 31858 w 752619"/>
                    <a:gd name="connsiteY7" fmla="*/ 302307 h 423064"/>
                    <a:gd name="connsiteX8" fmla="*/ 0 w 752619"/>
                    <a:gd name="connsiteY8" fmla="*/ 115489 h 423064"/>
                    <a:gd name="connsiteX0" fmla="*/ 0 w 752619"/>
                    <a:gd name="connsiteY0" fmla="*/ 115489 h 423064"/>
                    <a:gd name="connsiteX1" fmla="*/ 188404 w 752619"/>
                    <a:gd name="connsiteY1" fmla="*/ 18499 h 423064"/>
                    <a:gd name="connsiteX2" fmla="*/ 544608 w 752619"/>
                    <a:gd name="connsiteY2" fmla="*/ 78194 h 423064"/>
                    <a:gd name="connsiteX3" fmla="*/ 752619 w 752619"/>
                    <a:gd name="connsiteY3" fmla="*/ 209351 h 423064"/>
                    <a:gd name="connsiteX4" fmla="*/ 696167 w 752619"/>
                    <a:gd name="connsiteY4" fmla="*/ 423064 h 423064"/>
                    <a:gd name="connsiteX5" fmla="*/ 427741 w 752619"/>
                    <a:gd name="connsiteY5" fmla="*/ 307185 h 423064"/>
                    <a:gd name="connsiteX6" fmla="*/ 249762 w 752619"/>
                    <a:gd name="connsiteY6" fmla="*/ 316233 h 423064"/>
                    <a:gd name="connsiteX7" fmla="*/ 31858 w 752619"/>
                    <a:gd name="connsiteY7" fmla="*/ 302307 h 423064"/>
                    <a:gd name="connsiteX8" fmla="*/ 0 w 752619"/>
                    <a:gd name="connsiteY8" fmla="*/ 115489 h 423064"/>
                    <a:gd name="connsiteX0" fmla="*/ 0 w 752619"/>
                    <a:gd name="connsiteY0" fmla="*/ 124349 h 431924"/>
                    <a:gd name="connsiteX1" fmla="*/ 188404 w 752619"/>
                    <a:gd name="connsiteY1" fmla="*/ 27359 h 431924"/>
                    <a:gd name="connsiteX2" fmla="*/ 525436 w 752619"/>
                    <a:gd name="connsiteY2" fmla="*/ 14987 h 431924"/>
                    <a:gd name="connsiteX3" fmla="*/ 752619 w 752619"/>
                    <a:gd name="connsiteY3" fmla="*/ 218211 h 431924"/>
                    <a:gd name="connsiteX4" fmla="*/ 696167 w 752619"/>
                    <a:gd name="connsiteY4" fmla="*/ 431924 h 431924"/>
                    <a:gd name="connsiteX5" fmla="*/ 427741 w 752619"/>
                    <a:gd name="connsiteY5" fmla="*/ 316045 h 431924"/>
                    <a:gd name="connsiteX6" fmla="*/ 249762 w 752619"/>
                    <a:gd name="connsiteY6" fmla="*/ 325093 h 431924"/>
                    <a:gd name="connsiteX7" fmla="*/ 31858 w 752619"/>
                    <a:gd name="connsiteY7" fmla="*/ 311167 h 431924"/>
                    <a:gd name="connsiteX8" fmla="*/ 0 w 752619"/>
                    <a:gd name="connsiteY8" fmla="*/ 124349 h 431924"/>
                    <a:gd name="connsiteX0" fmla="*/ 0 w 752619"/>
                    <a:gd name="connsiteY0" fmla="*/ 124349 h 431924"/>
                    <a:gd name="connsiteX1" fmla="*/ 188404 w 752619"/>
                    <a:gd name="connsiteY1" fmla="*/ 27359 h 431924"/>
                    <a:gd name="connsiteX2" fmla="*/ 525436 w 752619"/>
                    <a:gd name="connsiteY2" fmla="*/ 14987 h 431924"/>
                    <a:gd name="connsiteX3" fmla="*/ 752619 w 752619"/>
                    <a:gd name="connsiteY3" fmla="*/ 218211 h 431924"/>
                    <a:gd name="connsiteX4" fmla="*/ 696167 w 752619"/>
                    <a:gd name="connsiteY4" fmla="*/ 431924 h 431924"/>
                    <a:gd name="connsiteX5" fmla="*/ 427741 w 752619"/>
                    <a:gd name="connsiteY5" fmla="*/ 316045 h 431924"/>
                    <a:gd name="connsiteX6" fmla="*/ 230589 w 752619"/>
                    <a:gd name="connsiteY6" fmla="*/ 253025 h 431924"/>
                    <a:gd name="connsiteX7" fmla="*/ 31858 w 752619"/>
                    <a:gd name="connsiteY7" fmla="*/ 311167 h 431924"/>
                    <a:gd name="connsiteX8" fmla="*/ 0 w 752619"/>
                    <a:gd name="connsiteY8" fmla="*/ 124349 h 431924"/>
                    <a:gd name="connsiteX0" fmla="*/ 0 w 752619"/>
                    <a:gd name="connsiteY0" fmla="*/ 124349 h 431924"/>
                    <a:gd name="connsiteX1" fmla="*/ 188404 w 752619"/>
                    <a:gd name="connsiteY1" fmla="*/ 27359 h 431924"/>
                    <a:gd name="connsiteX2" fmla="*/ 525436 w 752619"/>
                    <a:gd name="connsiteY2" fmla="*/ 14987 h 431924"/>
                    <a:gd name="connsiteX3" fmla="*/ 752619 w 752619"/>
                    <a:gd name="connsiteY3" fmla="*/ 218211 h 431924"/>
                    <a:gd name="connsiteX4" fmla="*/ 696167 w 752619"/>
                    <a:gd name="connsiteY4" fmla="*/ 431924 h 431924"/>
                    <a:gd name="connsiteX5" fmla="*/ 480465 w 752619"/>
                    <a:gd name="connsiteY5" fmla="*/ 275508 h 431924"/>
                    <a:gd name="connsiteX6" fmla="*/ 230589 w 752619"/>
                    <a:gd name="connsiteY6" fmla="*/ 253025 h 431924"/>
                    <a:gd name="connsiteX7" fmla="*/ 31858 w 752619"/>
                    <a:gd name="connsiteY7" fmla="*/ 311167 h 431924"/>
                    <a:gd name="connsiteX8" fmla="*/ 0 w 752619"/>
                    <a:gd name="connsiteY8" fmla="*/ 124349 h 431924"/>
                    <a:gd name="connsiteX0" fmla="*/ 0 w 752619"/>
                    <a:gd name="connsiteY0" fmla="*/ 154146 h 461721"/>
                    <a:gd name="connsiteX1" fmla="*/ 209973 w 752619"/>
                    <a:gd name="connsiteY1" fmla="*/ 7609 h 461721"/>
                    <a:gd name="connsiteX2" fmla="*/ 525436 w 752619"/>
                    <a:gd name="connsiteY2" fmla="*/ 44784 h 461721"/>
                    <a:gd name="connsiteX3" fmla="*/ 752619 w 752619"/>
                    <a:gd name="connsiteY3" fmla="*/ 248008 h 461721"/>
                    <a:gd name="connsiteX4" fmla="*/ 696167 w 752619"/>
                    <a:gd name="connsiteY4" fmla="*/ 461721 h 461721"/>
                    <a:gd name="connsiteX5" fmla="*/ 480465 w 752619"/>
                    <a:gd name="connsiteY5" fmla="*/ 305305 h 461721"/>
                    <a:gd name="connsiteX6" fmla="*/ 230589 w 752619"/>
                    <a:gd name="connsiteY6" fmla="*/ 282822 h 461721"/>
                    <a:gd name="connsiteX7" fmla="*/ 31858 w 752619"/>
                    <a:gd name="connsiteY7" fmla="*/ 340964 h 461721"/>
                    <a:gd name="connsiteX8" fmla="*/ 0 w 752619"/>
                    <a:gd name="connsiteY8" fmla="*/ 154146 h 461721"/>
                    <a:gd name="connsiteX0" fmla="*/ 38821 w 726730"/>
                    <a:gd name="connsiteY0" fmla="*/ 129995 h 460091"/>
                    <a:gd name="connsiteX1" fmla="*/ 184084 w 726730"/>
                    <a:gd name="connsiteY1" fmla="*/ 5979 h 460091"/>
                    <a:gd name="connsiteX2" fmla="*/ 499547 w 726730"/>
                    <a:gd name="connsiteY2" fmla="*/ 43154 h 460091"/>
                    <a:gd name="connsiteX3" fmla="*/ 726730 w 726730"/>
                    <a:gd name="connsiteY3" fmla="*/ 246378 h 460091"/>
                    <a:gd name="connsiteX4" fmla="*/ 670278 w 726730"/>
                    <a:gd name="connsiteY4" fmla="*/ 460091 h 460091"/>
                    <a:gd name="connsiteX5" fmla="*/ 454576 w 726730"/>
                    <a:gd name="connsiteY5" fmla="*/ 303675 h 460091"/>
                    <a:gd name="connsiteX6" fmla="*/ 204700 w 726730"/>
                    <a:gd name="connsiteY6" fmla="*/ 281192 h 460091"/>
                    <a:gd name="connsiteX7" fmla="*/ 5969 w 726730"/>
                    <a:gd name="connsiteY7" fmla="*/ 339334 h 460091"/>
                    <a:gd name="connsiteX8" fmla="*/ 38821 w 726730"/>
                    <a:gd name="connsiteY8" fmla="*/ 129995 h 460091"/>
                    <a:gd name="connsiteX0" fmla="*/ 0 w 687909"/>
                    <a:gd name="connsiteY0" fmla="*/ 129995 h 460091"/>
                    <a:gd name="connsiteX1" fmla="*/ 145263 w 687909"/>
                    <a:gd name="connsiteY1" fmla="*/ 5979 h 460091"/>
                    <a:gd name="connsiteX2" fmla="*/ 460726 w 687909"/>
                    <a:gd name="connsiteY2" fmla="*/ 43154 h 460091"/>
                    <a:gd name="connsiteX3" fmla="*/ 687909 w 687909"/>
                    <a:gd name="connsiteY3" fmla="*/ 246378 h 460091"/>
                    <a:gd name="connsiteX4" fmla="*/ 631457 w 687909"/>
                    <a:gd name="connsiteY4" fmla="*/ 460091 h 460091"/>
                    <a:gd name="connsiteX5" fmla="*/ 415755 w 687909"/>
                    <a:gd name="connsiteY5" fmla="*/ 303675 h 460091"/>
                    <a:gd name="connsiteX6" fmla="*/ 165879 w 687909"/>
                    <a:gd name="connsiteY6" fmla="*/ 281192 h 460091"/>
                    <a:gd name="connsiteX7" fmla="*/ 12683 w 687909"/>
                    <a:gd name="connsiteY7" fmla="*/ 307806 h 460091"/>
                    <a:gd name="connsiteX8" fmla="*/ 0 w 687909"/>
                    <a:gd name="connsiteY8" fmla="*/ 129995 h 460091"/>
                    <a:gd name="connsiteX0" fmla="*/ 0 w 687909"/>
                    <a:gd name="connsiteY0" fmla="*/ 129995 h 460091"/>
                    <a:gd name="connsiteX1" fmla="*/ 145263 w 687909"/>
                    <a:gd name="connsiteY1" fmla="*/ 5979 h 460091"/>
                    <a:gd name="connsiteX2" fmla="*/ 460726 w 687909"/>
                    <a:gd name="connsiteY2" fmla="*/ 43154 h 460091"/>
                    <a:gd name="connsiteX3" fmla="*/ 687909 w 687909"/>
                    <a:gd name="connsiteY3" fmla="*/ 246378 h 460091"/>
                    <a:gd name="connsiteX4" fmla="*/ 631457 w 687909"/>
                    <a:gd name="connsiteY4" fmla="*/ 460091 h 460091"/>
                    <a:gd name="connsiteX5" fmla="*/ 415755 w 687909"/>
                    <a:gd name="connsiteY5" fmla="*/ 303675 h 460091"/>
                    <a:gd name="connsiteX6" fmla="*/ 165879 w 687909"/>
                    <a:gd name="connsiteY6" fmla="*/ 281192 h 460091"/>
                    <a:gd name="connsiteX7" fmla="*/ 39048 w 687909"/>
                    <a:gd name="connsiteY7" fmla="*/ 312309 h 460091"/>
                    <a:gd name="connsiteX8" fmla="*/ 0 w 687909"/>
                    <a:gd name="connsiteY8" fmla="*/ 129995 h 460091"/>
                    <a:gd name="connsiteX0" fmla="*/ 0 w 687909"/>
                    <a:gd name="connsiteY0" fmla="*/ 129995 h 460091"/>
                    <a:gd name="connsiteX1" fmla="*/ 145263 w 687909"/>
                    <a:gd name="connsiteY1" fmla="*/ 5979 h 460091"/>
                    <a:gd name="connsiteX2" fmla="*/ 460726 w 687909"/>
                    <a:gd name="connsiteY2" fmla="*/ 43154 h 460091"/>
                    <a:gd name="connsiteX3" fmla="*/ 687909 w 687909"/>
                    <a:gd name="connsiteY3" fmla="*/ 246378 h 460091"/>
                    <a:gd name="connsiteX4" fmla="*/ 631457 w 687909"/>
                    <a:gd name="connsiteY4" fmla="*/ 460091 h 460091"/>
                    <a:gd name="connsiteX5" fmla="*/ 415755 w 687909"/>
                    <a:gd name="connsiteY5" fmla="*/ 303675 h 460091"/>
                    <a:gd name="connsiteX6" fmla="*/ 165879 w 687909"/>
                    <a:gd name="connsiteY6" fmla="*/ 281192 h 460091"/>
                    <a:gd name="connsiteX7" fmla="*/ 12688 w 687909"/>
                    <a:gd name="connsiteY7" fmla="*/ 330326 h 460091"/>
                    <a:gd name="connsiteX8" fmla="*/ 0 w 687909"/>
                    <a:gd name="connsiteY8" fmla="*/ 129995 h 460091"/>
                    <a:gd name="connsiteX0" fmla="*/ 0 w 687909"/>
                    <a:gd name="connsiteY0" fmla="*/ 129995 h 460091"/>
                    <a:gd name="connsiteX1" fmla="*/ 145263 w 687909"/>
                    <a:gd name="connsiteY1" fmla="*/ 5979 h 460091"/>
                    <a:gd name="connsiteX2" fmla="*/ 460726 w 687909"/>
                    <a:gd name="connsiteY2" fmla="*/ 43154 h 460091"/>
                    <a:gd name="connsiteX3" fmla="*/ 687909 w 687909"/>
                    <a:gd name="connsiteY3" fmla="*/ 246378 h 460091"/>
                    <a:gd name="connsiteX4" fmla="*/ 631457 w 687909"/>
                    <a:gd name="connsiteY4" fmla="*/ 460091 h 460091"/>
                    <a:gd name="connsiteX5" fmla="*/ 415755 w 687909"/>
                    <a:gd name="connsiteY5" fmla="*/ 303675 h 460091"/>
                    <a:gd name="connsiteX6" fmla="*/ 194640 w 687909"/>
                    <a:gd name="connsiteY6" fmla="*/ 285695 h 460091"/>
                    <a:gd name="connsiteX7" fmla="*/ 12688 w 687909"/>
                    <a:gd name="connsiteY7" fmla="*/ 330326 h 460091"/>
                    <a:gd name="connsiteX8" fmla="*/ 0 w 687909"/>
                    <a:gd name="connsiteY8" fmla="*/ 129995 h 460091"/>
                    <a:gd name="connsiteX0" fmla="*/ 0 w 687909"/>
                    <a:gd name="connsiteY0" fmla="*/ 129995 h 460091"/>
                    <a:gd name="connsiteX1" fmla="*/ 145263 w 687909"/>
                    <a:gd name="connsiteY1" fmla="*/ 5979 h 460091"/>
                    <a:gd name="connsiteX2" fmla="*/ 460726 w 687909"/>
                    <a:gd name="connsiteY2" fmla="*/ 43154 h 460091"/>
                    <a:gd name="connsiteX3" fmla="*/ 687909 w 687909"/>
                    <a:gd name="connsiteY3" fmla="*/ 246378 h 460091"/>
                    <a:gd name="connsiteX4" fmla="*/ 631457 w 687909"/>
                    <a:gd name="connsiteY4" fmla="*/ 460091 h 460091"/>
                    <a:gd name="connsiteX5" fmla="*/ 466086 w 687909"/>
                    <a:gd name="connsiteY5" fmla="*/ 321691 h 460091"/>
                    <a:gd name="connsiteX6" fmla="*/ 194640 w 687909"/>
                    <a:gd name="connsiteY6" fmla="*/ 285695 h 460091"/>
                    <a:gd name="connsiteX7" fmla="*/ 12688 w 687909"/>
                    <a:gd name="connsiteY7" fmla="*/ 330326 h 460091"/>
                    <a:gd name="connsiteX8" fmla="*/ 0 w 687909"/>
                    <a:gd name="connsiteY8" fmla="*/ 129995 h 460091"/>
                    <a:gd name="connsiteX0" fmla="*/ 0 w 687909"/>
                    <a:gd name="connsiteY0" fmla="*/ 129995 h 460091"/>
                    <a:gd name="connsiteX1" fmla="*/ 145263 w 687909"/>
                    <a:gd name="connsiteY1" fmla="*/ 5979 h 460091"/>
                    <a:gd name="connsiteX2" fmla="*/ 460726 w 687909"/>
                    <a:gd name="connsiteY2" fmla="*/ 43154 h 460091"/>
                    <a:gd name="connsiteX3" fmla="*/ 687909 w 687909"/>
                    <a:gd name="connsiteY3" fmla="*/ 246378 h 460091"/>
                    <a:gd name="connsiteX4" fmla="*/ 631457 w 687909"/>
                    <a:gd name="connsiteY4" fmla="*/ 460091 h 460091"/>
                    <a:gd name="connsiteX5" fmla="*/ 456502 w 687909"/>
                    <a:gd name="connsiteY5" fmla="*/ 420784 h 460091"/>
                    <a:gd name="connsiteX6" fmla="*/ 194640 w 687909"/>
                    <a:gd name="connsiteY6" fmla="*/ 285695 h 460091"/>
                    <a:gd name="connsiteX7" fmla="*/ 12688 w 687909"/>
                    <a:gd name="connsiteY7" fmla="*/ 330326 h 460091"/>
                    <a:gd name="connsiteX8" fmla="*/ 0 w 687909"/>
                    <a:gd name="connsiteY8" fmla="*/ 129995 h 460091"/>
                    <a:gd name="connsiteX0" fmla="*/ 0 w 687909"/>
                    <a:gd name="connsiteY0" fmla="*/ 317928 h 648024"/>
                    <a:gd name="connsiteX1" fmla="*/ 145263 w 687909"/>
                    <a:gd name="connsiteY1" fmla="*/ 193912 h 648024"/>
                    <a:gd name="connsiteX2" fmla="*/ 400814 w 687909"/>
                    <a:gd name="connsiteY2" fmla="*/ 5875 h 648024"/>
                    <a:gd name="connsiteX3" fmla="*/ 687909 w 687909"/>
                    <a:gd name="connsiteY3" fmla="*/ 434311 h 648024"/>
                    <a:gd name="connsiteX4" fmla="*/ 631457 w 687909"/>
                    <a:gd name="connsiteY4" fmla="*/ 648024 h 648024"/>
                    <a:gd name="connsiteX5" fmla="*/ 456502 w 687909"/>
                    <a:gd name="connsiteY5" fmla="*/ 608717 h 648024"/>
                    <a:gd name="connsiteX6" fmla="*/ 194640 w 687909"/>
                    <a:gd name="connsiteY6" fmla="*/ 473628 h 648024"/>
                    <a:gd name="connsiteX7" fmla="*/ 12688 w 687909"/>
                    <a:gd name="connsiteY7" fmla="*/ 518259 h 648024"/>
                    <a:gd name="connsiteX8" fmla="*/ 0 w 687909"/>
                    <a:gd name="connsiteY8" fmla="*/ 317928 h 648024"/>
                    <a:gd name="connsiteX0" fmla="*/ 0 w 687909"/>
                    <a:gd name="connsiteY0" fmla="*/ 352694 h 682790"/>
                    <a:gd name="connsiteX1" fmla="*/ 121298 w 687909"/>
                    <a:gd name="connsiteY1" fmla="*/ 53014 h 682790"/>
                    <a:gd name="connsiteX2" fmla="*/ 400814 w 687909"/>
                    <a:gd name="connsiteY2" fmla="*/ 40641 h 682790"/>
                    <a:gd name="connsiteX3" fmla="*/ 687909 w 687909"/>
                    <a:gd name="connsiteY3" fmla="*/ 469077 h 682790"/>
                    <a:gd name="connsiteX4" fmla="*/ 631457 w 687909"/>
                    <a:gd name="connsiteY4" fmla="*/ 682790 h 682790"/>
                    <a:gd name="connsiteX5" fmla="*/ 456502 w 687909"/>
                    <a:gd name="connsiteY5" fmla="*/ 643483 h 682790"/>
                    <a:gd name="connsiteX6" fmla="*/ 194640 w 687909"/>
                    <a:gd name="connsiteY6" fmla="*/ 508394 h 682790"/>
                    <a:gd name="connsiteX7" fmla="*/ 12688 w 687909"/>
                    <a:gd name="connsiteY7" fmla="*/ 553025 h 682790"/>
                    <a:gd name="connsiteX8" fmla="*/ 0 w 687909"/>
                    <a:gd name="connsiteY8" fmla="*/ 352694 h 682790"/>
                    <a:gd name="connsiteX0" fmla="*/ 0 w 687909"/>
                    <a:gd name="connsiteY0" fmla="*/ 352696 h 682792"/>
                    <a:gd name="connsiteX1" fmla="*/ 121298 w 687909"/>
                    <a:gd name="connsiteY1" fmla="*/ 53016 h 682792"/>
                    <a:gd name="connsiteX2" fmla="*/ 400814 w 687909"/>
                    <a:gd name="connsiteY2" fmla="*/ 40643 h 682792"/>
                    <a:gd name="connsiteX3" fmla="*/ 687909 w 687909"/>
                    <a:gd name="connsiteY3" fmla="*/ 469079 h 682792"/>
                    <a:gd name="connsiteX4" fmla="*/ 631457 w 687909"/>
                    <a:gd name="connsiteY4" fmla="*/ 682792 h 682792"/>
                    <a:gd name="connsiteX5" fmla="*/ 456502 w 687909"/>
                    <a:gd name="connsiteY5" fmla="*/ 643485 h 682792"/>
                    <a:gd name="connsiteX6" fmla="*/ 192244 w 687909"/>
                    <a:gd name="connsiteY6" fmla="*/ 287690 h 682792"/>
                    <a:gd name="connsiteX7" fmla="*/ 12688 w 687909"/>
                    <a:gd name="connsiteY7" fmla="*/ 553027 h 682792"/>
                    <a:gd name="connsiteX8" fmla="*/ 0 w 687909"/>
                    <a:gd name="connsiteY8" fmla="*/ 352696 h 682792"/>
                    <a:gd name="connsiteX0" fmla="*/ 0 w 687909"/>
                    <a:gd name="connsiteY0" fmla="*/ 352696 h 682792"/>
                    <a:gd name="connsiteX1" fmla="*/ 121298 w 687909"/>
                    <a:gd name="connsiteY1" fmla="*/ 53016 h 682792"/>
                    <a:gd name="connsiteX2" fmla="*/ 400814 w 687909"/>
                    <a:gd name="connsiteY2" fmla="*/ 40643 h 682792"/>
                    <a:gd name="connsiteX3" fmla="*/ 687909 w 687909"/>
                    <a:gd name="connsiteY3" fmla="*/ 469079 h 682792"/>
                    <a:gd name="connsiteX4" fmla="*/ 631457 w 687909"/>
                    <a:gd name="connsiteY4" fmla="*/ 682792 h 682792"/>
                    <a:gd name="connsiteX5" fmla="*/ 446918 w 687909"/>
                    <a:gd name="connsiteY5" fmla="*/ 323685 h 682792"/>
                    <a:gd name="connsiteX6" fmla="*/ 192244 w 687909"/>
                    <a:gd name="connsiteY6" fmla="*/ 287690 h 682792"/>
                    <a:gd name="connsiteX7" fmla="*/ 12688 w 687909"/>
                    <a:gd name="connsiteY7" fmla="*/ 553027 h 682792"/>
                    <a:gd name="connsiteX8" fmla="*/ 0 w 687909"/>
                    <a:gd name="connsiteY8" fmla="*/ 352696 h 682792"/>
                    <a:gd name="connsiteX0" fmla="*/ 0 w 711872"/>
                    <a:gd name="connsiteY0" fmla="*/ 206591 h 676319"/>
                    <a:gd name="connsiteX1" fmla="*/ 145261 w 711872"/>
                    <a:gd name="connsiteY1" fmla="*/ 46543 h 676319"/>
                    <a:gd name="connsiteX2" fmla="*/ 424777 w 711872"/>
                    <a:gd name="connsiteY2" fmla="*/ 34170 h 676319"/>
                    <a:gd name="connsiteX3" fmla="*/ 711872 w 711872"/>
                    <a:gd name="connsiteY3" fmla="*/ 462606 h 676319"/>
                    <a:gd name="connsiteX4" fmla="*/ 655420 w 711872"/>
                    <a:gd name="connsiteY4" fmla="*/ 676319 h 676319"/>
                    <a:gd name="connsiteX5" fmla="*/ 470881 w 711872"/>
                    <a:gd name="connsiteY5" fmla="*/ 317212 h 676319"/>
                    <a:gd name="connsiteX6" fmla="*/ 216207 w 711872"/>
                    <a:gd name="connsiteY6" fmla="*/ 281217 h 676319"/>
                    <a:gd name="connsiteX7" fmla="*/ 36651 w 711872"/>
                    <a:gd name="connsiteY7" fmla="*/ 546554 h 676319"/>
                    <a:gd name="connsiteX8" fmla="*/ 0 w 711872"/>
                    <a:gd name="connsiteY8" fmla="*/ 206591 h 676319"/>
                    <a:gd name="connsiteX0" fmla="*/ 0 w 711872"/>
                    <a:gd name="connsiteY0" fmla="*/ 206591 h 676319"/>
                    <a:gd name="connsiteX1" fmla="*/ 145261 w 711872"/>
                    <a:gd name="connsiteY1" fmla="*/ 46543 h 676319"/>
                    <a:gd name="connsiteX2" fmla="*/ 424777 w 711872"/>
                    <a:gd name="connsiteY2" fmla="*/ 34170 h 676319"/>
                    <a:gd name="connsiteX3" fmla="*/ 711872 w 711872"/>
                    <a:gd name="connsiteY3" fmla="*/ 462606 h 676319"/>
                    <a:gd name="connsiteX4" fmla="*/ 655420 w 711872"/>
                    <a:gd name="connsiteY4" fmla="*/ 676319 h 676319"/>
                    <a:gd name="connsiteX5" fmla="*/ 470881 w 711872"/>
                    <a:gd name="connsiteY5" fmla="*/ 317212 h 676319"/>
                    <a:gd name="connsiteX6" fmla="*/ 216207 w 711872"/>
                    <a:gd name="connsiteY6" fmla="*/ 281217 h 676319"/>
                    <a:gd name="connsiteX7" fmla="*/ 19879 w 711872"/>
                    <a:gd name="connsiteY7" fmla="*/ 330352 h 676319"/>
                    <a:gd name="connsiteX8" fmla="*/ 0 w 711872"/>
                    <a:gd name="connsiteY8" fmla="*/ 206591 h 676319"/>
                    <a:gd name="connsiteX0" fmla="*/ 0 w 711872"/>
                    <a:gd name="connsiteY0" fmla="*/ 206591 h 676319"/>
                    <a:gd name="connsiteX1" fmla="*/ 145261 w 711872"/>
                    <a:gd name="connsiteY1" fmla="*/ 46543 h 676319"/>
                    <a:gd name="connsiteX2" fmla="*/ 424777 w 711872"/>
                    <a:gd name="connsiteY2" fmla="*/ 34170 h 676319"/>
                    <a:gd name="connsiteX3" fmla="*/ 711872 w 711872"/>
                    <a:gd name="connsiteY3" fmla="*/ 462606 h 676319"/>
                    <a:gd name="connsiteX4" fmla="*/ 655420 w 711872"/>
                    <a:gd name="connsiteY4" fmla="*/ 676319 h 676319"/>
                    <a:gd name="connsiteX5" fmla="*/ 458901 w 711872"/>
                    <a:gd name="connsiteY5" fmla="*/ 380270 h 676319"/>
                    <a:gd name="connsiteX6" fmla="*/ 216207 w 711872"/>
                    <a:gd name="connsiteY6" fmla="*/ 281217 h 676319"/>
                    <a:gd name="connsiteX7" fmla="*/ 19879 w 711872"/>
                    <a:gd name="connsiteY7" fmla="*/ 330352 h 676319"/>
                    <a:gd name="connsiteX8" fmla="*/ 0 w 711872"/>
                    <a:gd name="connsiteY8" fmla="*/ 206591 h 676319"/>
                    <a:gd name="connsiteX0" fmla="*/ 0 w 711872"/>
                    <a:gd name="connsiteY0" fmla="*/ 225890 h 695618"/>
                    <a:gd name="connsiteX1" fmla="*/ 154850 w 711872"/>
                    <a:gd name="connsiteY1" fmla="*/ 25304 h 695618"/>
                    <a:gd name="connsiteX2" fmla="*/ 424777 w 711872"/>
                    <a:gd name="connsiteY2" fmla="*/ 53469 h 695618"/>
                    <a:gd name="connsiteX3" fmla="*/ 711872 w 711872"/>
                    <a:gd name="connsiteY3" fmla="*/ 481905 h 695618"/>
                    <a:gd name="connsiteX4" fmla="*/ 655420 w 711872"/>
                    <a:gd name="connsiteY4" fmla="*/ 695618 h 695618"/>
                    <a:gd name="connsiteX5" fmla="*/ 458901 w 711872"/>
                    <a:gd name="connsiteY5" fmla="*/ 399569 h 695618"/>
                    <a:gd name="connsiteX6" fmla="*/ 216207 w 711872"/>
                    <a:gd name="connsiteY6" fmla="*/ 300516 h 695618"/>
                    <a:gd name="connsiteX7" fmla="*/ 19879 w 711872"/>
                    <a:gd name="connsiteY7" fmla="*/ 349651 h 695618"/>
                    <a:gd name="connsiteX8" fmla="*/ 0 w 711872"/>
                    <a:gd name="connsiteY8" fmla="*/ 225890 h 695618"/>
                    <a:gd name="connsiteX0" fmla="*/ 0 w 711872"/>
                    <a:gd name="connsiteY0" fmla="*/ 225890 h 695618"/>
                    <a:gd name="connsiteX1" fmla="*/ 154850 w 711872"/>
                    <a:gd name="connsiteY1" fmla="*/ 25304 h 695618"/>
                    <a:gd name="connsiteX2" fmla="*/ 424777 w 711872"/>
                    <a:gd name="connsiteY2" fmla="*/ 53469 h 695618"/>
                    <a:gd name="connsiteX3" fmla="*/ 711872 w 711872"/>
                    <a:gd name="connsiteY3" fmla="*/ 481905 h 695618"/>
                    <a:gd name="connsiteX4" fmla="*/ 655420 w 711872"/>
                    <a:gd name="connsiteY4" fmla="*/ 695618 h 695618"/>
                    <a:gd name="connsiteX5" fmla="*/ 458901 w 711872"/>
                    <a:gd name="connsiteY5" fmla="*/ 399569 h 695618"/>
                    <a:gd name="connsiteX6" fmla="*/ 189844 w 711872"/>
                    <a:gd name="connsiteY6" fmla="*/ 309524 h 695618"/>
                    <a:gd name="connsiteX7" fmla="*/ 19879 w 711872"/>
                    <a:gd name="connsiteY7" fmla="*/ 349651 h 695618"/>
                    <a:gd name="connsiteX8" fmla="*/ 0 w 711872"/>
                    <a:gd name="connsiteY8" fmla="*/ 225890 h 695618"/>
                    <a:gd name="connsiteX0" fmla="*/ 0 w 711872"/>
                    <a:gd name="connsiteY0" fmla="*/ 225890 h 695618"/>
                    <a:gd name="connsiteX1" fmla="*/ 154850 w 711872"/>
                    <a:gd name="connsiteY1" fmla="*/ 25304 h 695618"/>
                    <a:gd name="connsiteX2" fmla="*/ 424777 w 711872"/>
                    <a:gd name="connsiteY2" fmla="*/ 53469 h 695618"/>
                    <a:gd name="connsiteX3" fmla="*/ 711872 w 711872"/>
                    <a:gd name="connsiteY3" fmla="*/ 481905 h 695618"/>
                    <a:gd name="connsiteX4" fmla="*/ 655420 w 711872"/>
                    <a:gd name="connsiteY4" fmla="*/ 695618 h 695618"/>
                    <a:gd name="connsiteX5" fmla="*/ 494850 w 711872"/>
                    <a:gd name="connsiteY5" fmla="*/ 449116 h 695618"/>
                    <a:gd name="connsiteX6" fmla="*/ 189844 w 711872"/>
                    <a:gd name="connsiteY6" fmla="*/ 309524 h 695618"/>
                    <a:gd name="connsiteX7" fmla="*/ 19879 w 711872"/>
                    <a:gd name="connsiteY7" fmla="*/ 349651 h 695618"/>
                    <a:gd name="connsiteX8" fmla="*/ 0 w 711872"/>
                    <a:gd name="connsiteY8" fmla="*/ 225890 h 695618"/>
                    <a:gd name="connsiteX0" fmla="*/ 0 w 711872"/>
                    <a:gd name="connsiteY0" fmla="*/ 204849 h 674577"/>
                    <a:gd name="connsiteX1" fmla="*/ 154850 w 711872"/>
                    <a:gd name="connsiteY1" fmla="*/ 4263 h 674577"/>
                    <a:gd name="connsiteX2" fmla="*/ 556588 w 711872"/>
                    <a:gd name="connsiteY2" fmla="*/ 99992 h 674577"/>
                    <a:gd name="connsiteX3" fmla="*/ 711872 w 711872"/>
                    <a:gd name="connsiteY3" fmla="*/ 460864 h 674577"/>
                    <a:gd name="connsiteX4" fmla="*/ 655420 w 711872"/>
                    <a:gd name="connsiteY4" fmla="*/ 674577 h 674577"/>
                    <a:gd name="connsiteX5" fmla="*/ 494850 w 711872"/>
                    <a:gd name="connsiteY5" fmla="*/ 428075 h 674577"/>
                    <a:gd name="connsiteX6" fmla="*/ 189844 w 711872"/>
                    <a:gd name="connsiteY6" fmla="*/ 288483 h 674577"/>
                    <a:gd name="connsiteX7" fmla="*/ 19879 w 711872"/>
                    <a:gd name="connsiteY7" fmla="*/ 328610 h 674577"/>
                    <a:gd name="connsiteX8" fmla="*/ 0 w 711872"/>
                    <a:gd name="connsiteY8" fmla="*/ 204849 h 674577"/>
                    <a:gd name="connsiteX0" fmla="*/ 0 w 711872"/>
                    <a:gd name="connsiteY0" fmla="*/ 204849 h 674577"/>
                    <a:gd name="connsiteX1" fmla="*/ 154850 w 711872"/>
                    <a:gd name="connsiteY1" fmla="*/ 4263 h 674577"/>
                    <a:gd name="connsiteX2" fmla="*/ 556588 w 711872"/>
                    <a:gd name="connsiteY2" fmla="*/ 99992 h 674577"/>
                    <a:gd name="connsiteX3" fmla="*/ 711872 w 711872"/>
                    <a:gd name="connsiteY3" fmla="*/ 460864 h 674577"/>
                    <a:gd name="connsiteX4" fmla="*/ 655420 w 711872"/>
                    <a:gd name="connsiteY4" fmla="*/ 674577 h 674577"/>
                    <a:gd name="connsiteX5" fmla="*/ 497246 w 711872"/>
                    <a:gd name="connsiteY5" fmla="*/ 500142 h 674577"/>
                    <a:gd name="connsiteX6" fmla="*/ 189844 w 711872"/>
                    <a:gd name="connsiteY6" fmla="*/ 288483 h 674577"/>
                    <a:gd name="connsiteX7" fmla="*/ 19879 w 711872"/>
                    <a:gd name="connsiteY7" fmla="*/ 328610 h 674577"/>
                    <a:gd name="connsiteX8" fmla="*/ 0 w 711872"/>
                    <a:gd name="connsiteY8" fmla="*/ 204849 h 674577"/>
                    <a:gd name="connsiteX0" fmla="*/ 0 w 711872"/>
                    <a:gd name="connsiteY0" fmla="*/ 301393 h 771121"/>
                    <a:gd name="connsiteX1" fmla="*/ 169230 w 711872"/>
                    <a:gd name="connsiteY1" fmla="*/ 1716 h 771121"/>
                    <a:gd name="connsiteX2" fmla="*/ 556588 w 711872"/>
                    <a:gd name="connsiteY2" fmla="*/ 196536 h 771121"/>
                    <a:gd name="connsiteX3" fmla="*/ 711872 w 711872"/>
                    <a:gd name="connsiteY3" fmla="*/ 557408 h 771121"/>
                    <a:gd name="connsiteX4" fmla="*/ 655420 w 711872"/>
                    <a:gd name="connsiteY4" fmla="*/ 771121 h 771121"/>
                    <a:gd name="connsiteX5" fmla="*/ 497246 w 711872"/>
                    <a:gd name="connsiteY5" fmla="*/ 596686 h 771121"/>
                    <a:gd name="connsiteX6" fmla="*/ 189844 w 711872"/>
                    <a:gd name="connsiteY6" fmla="*/ 385027 h 771121"/>
                    <a:gd name="connsiteX7" fmla="*/ 19879 w 711872"/>
                    <a:gd name="connsiteY7" fmla="*/ 425154 h 771121"/>
                    <a:gd name="connsiteX8" fmla="*/ 0 w 711872"/>
                    <a:gd name="connsiteY8" fmla="*/ 301393 h 771121"/>
                    <a:gd name="connsiteX0" fmla="*/ 0 w 711872"/>
                    <a:gd name="connsiteY0" fmla="*/ 301393 h 771121"/>
                    <a:gd name="connsiteX1" fmla="*/ 169230 w 711872"/>
                    <a:gd name="connsiteY1" fmla="*/ 1716 h 771121"/>
                    <a:gd name="connsiteX2" fmla="*/ 556588 w 711872"/>
                    <a:gd name="connsiteY2" fmla="*/ 196536 h 771121"/>
                    <a:gd name="connsiteX3" fmla="*/ 711872 w 711872"/>
                    <a:gd name="connsiteY3" fmla="*/ 557408 h 771121"/>
                    <a:gd name="connsiteX4" fmla="*/ 655420 w 711872"/>
                    <a:gd name="connsiteY4" fmla="*/ 771121 h 771121"/>
                    <a:gd name="connsiteX5" fmla="*/ 497246 w 711872"/>
                    <a:gd name="connsiteY5" fmla="*/ 596686 h 771121"/>
                    <a:gd name="connsiteX6" fmla="*/ 170672 w 711872"/>
                    <a:gd name="connsiteY6" fmla="*/ 290437 h 771121"/>
                    <a:gd name="connsiteX7" fmla="*/ 19879 w 711872"/>
                    <a:gd name="connsiteY7" fmla="*/ 425154 h 771121"/>
                    <a:gd name="connsiteX8" fmla="*/ 0 w 711872"/>
                    <a:gd name="connsiteY8" fmla="*/ 301393 h 771121"/>
                    <a:gd name="connsiteX0" fmla="*/ 0 w 707079"/>
                    <a:gd name="connsiteY0" fmla="*/ 136103 h 786000"/>
                    <a:gd name="connsiteX1" fmla="*/ 164437 w 707079"/>
                    <a:gd name="connsiteY1" fmla="*/ 16595 h 786000"/>
                    <a:gd name="connsiteX2" fmla="*/ 551795 w 707079"/>
                    <a:gd name="connsiteY2" fmla="*/ 211415 h 786000"/>
                    <a:gd name="connsiteX3" fmla="*/ 707079 w 707079"/>
                    <a:gd name="connsiteY3" fmla="*/ 572287 h 786000"/>
                    <a:gd name="connsiteX4" fmla="*/ 650627 w 707079"/>
                    <a:gd name="connsiteY4" fmla="*/ 786000 h 786000"/>
                    <a:gd name="connsiteX5" fmla="*/ 492453 w 707079"/>
                    <a:gd name="connsiteY5" fmla="*/ 611565 h 786000"/>
                    <a:gd name="connsiteX6" fmla="*/ 165879 w 707079"/>
                    <a:gd name="connsiteY6" fmla="*/ 305316 h 786000"/>
                    <a:gd name="connsiteX7" fmla="*/ 15086 w 707079"/>
                    <a:gd name="connsiteY7" fmla="*/ 440033 h 786000"/>
                    <a:gd name="connsiteX8" fmla="*/ 0 w 707079"/>
                    <a:gd name="connsiteY8" fmla="*/ 136103 h 786000"/>
                    <a:gd name="connsiteX0" fmla="*/ 5982 w 713061"/>
                    <a:gd name="connsiteY0" fmla="*/ 136103 h 786000"/>
                    <a:gd name="connsiteX1" fmla="*/ 170419 w 713061"/>
                    <a:gd name="connsiteY1" fmla="*/ 16595 h 786000"/>
                    <a:gd name="connsiteX2" fmla="*/ 557777 w 713061"/>
                    <a:gd name="connsiteY2" fmla="*/ 211415 h 786000"/>
                    <a:gd name="connsiteX3" fmla="*/ 713061 w 713061"/>
                    <a:gd name="connsiteY3" fmla="*/ 572287 h 786000"/>
                    <a:gd name="connsiteX4" fmla="*/ 656609 w 713061"/>
                    <a:gd name="connsiteY4" fmla="*/ 786000 h 786000"/>
                    <a:gd name="connsiteX5" fmla="*/ 498435 w 713061"/>
                    <a:gd name="connsiteY5" fmla="*/ 611565 h 786000"/>
                    <a:gd name="connsiteX6" fmla="*/ 171861 w 713061"/>
                    <a:gd name="connsiteY6" fmla="*/ 305316 h 786000"/>
                    <a:gd name="connsiteX7" fmla="*/ 21068 w 713061"/>
                    <a:gd name="connsiteY7" fmla="*/ 440033 h 786000"/>
                    <a:gd name="connsiteX8" fmla="*/ 48821 w 713061"/>
                    <a:gd name="connsiteY8" fmla="*/ 278467 h 786000"/>
                    <a:gd name="connsiteX9" fmla="*/ 5982 w 713061"/>
                    <a:gd name="connsiteY9" fmla="*/ 136103 h 786000"/>
                    <a:gd name="connsiteX0" fmla="*/ 46027 w 753106"/>
                    <a:gd name="connsiteY0" fmla="*/ 136103 h 786000"/>
                    <a:gd name="connsiteX1" fmla="*/ 210464 w 753106"/>
                    <a:gd name="connsiteY1" fmla="*/ 16595 h 786000"/>
                    <a:gd name="connsiteX2" fmla="*/ 597822 w 753106"/>
                    <a:gd name="connsiteY2" fmla="*/ 211415 h 786000"/>
                    <a:gd name="connsiteX3" fmla="*/ 753106 w 753106"/>
                    <a:gd name="connsiteY3" fmla="*/ 572287 h 786000"/>
                    <a:gd name="connsiteX4" fmla="*/ 696654 w 753106"/>
                    <a:gd name="connsiteY4" fmla="*/ 786000 h 786000"/>
                    <a:gd name="connsiteX5" fmla="*/ 538480 w 753106"/>
                    <a:gd name="connsiteY5" fmla="*/ 611565 h 786000"/>
                    <a:gd name="connsiteX6" fmla="*/ 211906 w 753106"/>
                    <a:gd name="connsiteY6" fmla="*/ 305316 h 786000"/>
                    <a:gd name="connsiteX7" fmla="*/ 61113 w 753106"/>
                    <a:gd name="connsiteY7" fmla="*/ 440033 h 786000"/>
                    <a:gd name="connsiteX8" fmla="*/ 192 w 753106"/>
                    <a:gd name="connsiteY8" fmla="*/ 237928 h 786000"/>
                    <a:gd name="connsiteX9" fmla="*/ 46027 w 753106"/>
                    <a:gd name="connsiteY9" fmla="*/ 136103 h 786000"/>
                    <a:gd name="connsiteX0" fmla="*/ 46027 w 753106"/>
                    <a:gd name="connsiteY0" fmla="*/ 130485 h 780382"/>
                    <a:gd name="connsiteX1" fmla="*/ 351865 w 753106"/>
                    <a:gd name="connsiteY1" fmla="*/ 19985 h 780382"/>
                    <a:gd name="connsiteX2" fmla="*/ 597822 w 753106"/>
                    <a:gd name="connsiteY2" fmla="*/ 205797 h 780382"/>
                    <a:gd name="connsiteX3" fmla="*/ 753106 w 753106"/>
                    <a:gd name="connsiteY3" fmla="*/ 566669 h 780382"/>
                    <a:gd name="connsiteX4" fmla="*/ 696654 w 753106"/>
                    <a:gd name="connsiteY4" fmla="*/ 780382 h 780382"/>
                    <a:gd name="connsiteX5" fmla="*/ 538480 w 753106"/>
                    <a:gd name="connsiteY5" fmla="*/ 605947 h 780382"/>
                    <a:gd name="connsiteX6" fmla="*/ 211906 w 753106"/>
                    <a:gd name="connsiteY6" fmla="*/ 299698 h 780382"/>
                    <a:gd name="connsiteX7" fmla="*/ 61113 w 753106"/>
                    <a:gd name="connsiteY7" fmla="*/ 434415 h 780382"/>
                    <a:gd name="connsiteX8" fmla="*/ 192 w 753106"/>
                    <a:gd name="connsiteY8" fmla="*/ 232310 h 780382"/>
                    <a:gd name="connsiteX9" fmla="*/ 46027 w 753106"/>
                    <a:gd name="connsiteY9" fmla="*/ 130485 h 780382"/>
                    <a:gd name="connsiteX0" fmla="*/ 120181 w 752963"/>
                    <a:gd name="connsiteY0" fmla="*/ 92508 h 841499"/>
                    <a:gd name="connsiteX1" fmla="*/ 351722 w 752963"/>
                    <a:gd name="connsiteY1" fmla="*/ 81102 h 841499"/>
                    <a:gd name="connsiteX2" fmla="*/ 597679 w 752963"/>
                    <a:gd name="connsiteY2" fmla="*/ 266914 h 841499"/>
                    <a:gd name="connsiteX3" fmla="*/ 752963 w 752963"/>
                    <a:gd name="connsiteY3" fmla="*/ 627786 h 841499"/>
                    <a:gd name="connsiteX4" fmla="*/ 696511 w 752963"/>
                    <a:gd name="connsiteY4" fmla="*/ 841499 h 841499"/>
                    <a:gd name="connsiteX5" fmla="*/ 538337 w 752963"/>
                    <a:gd name="connsiteY5" fmla="*/ 667064 h 841499"/>
                    <a:gd name="connsiteX6" fmla="*/ 211763 w 752963"/>
                    <a:gd name="connsiteY6" fmla="*/ 360815 h 841499"/>
                    <a:gd name="connsiteX7" fmla="*/ 60970 w 752963"/>
                    <a:gd name="connsiteY7" fmla="*/ 495532 h 841499"/>
                    <a:gd name="connsiteX8" fmla="*/ 49 w 752963"/>
                    <a:gd name="connsiteY8" fmla="*/ 293427 h 841499"/>
                    <a:gd name="connsiteX9" fmla="*/ 120181 w 752963"/>
                    <a:gd name="connsiteY9" fmla="*/ 92508 h 841499"/>
                    <a:gd name="connsiteX0" fmla="*/ 120181 w 752963"/>
                    <a:gd name="connsiteY0" fmla="*/ 36946 h 785937"/>
                    <a:gd name="connsiteX1" fmla="*/ 351722 w 752963"/>
                    <a:gd name="connsiteY1" fmla="*/ 25540 h 785937"/>
                    <a:gd name="connsiteX2" fmla="*/ 597679 w 752963"/>
                    <a:gd name="connsiteY2" fmla="*/ 211352 h 785937"/>
                    <a:gd name="connsiteX3" fmla="*/ 752963 w 752963"/>
                    <a:gd name="connsiteY3" fmla="*/ 572224 h 785937"/>
                    <a:gd name="connsiteX4" fmla="*/ 696511 w 752963"/>
                    <a:gd name="connsiteY4" fmla="*/ 785937 h 785937"/>
                    <a:gd name="connsiteX5" fmla="*/ 538337 w 752963"/>
                    <a:gd name="connsiteY5" fmla="*/ 611502 h 785937"/>
                    <a:gd name="connsiteX6" fmla="*/ 211763 w 752963"/>
                    <a:gd name="connsiteY6" fmla="*/ 305253 h 785937"/>
                    <a:gd name="connsiteX7" fmla="*/ 60970 w 752963"/>
                    <a:gd name="connsiteY7" fmla="*/ 439970 h 785937"/>
                    <a:gd name="connsiteX8" fmla="*/ 49 w 752963"/>
                    <a:gd name="connsiteY8" fmla="*/ 237865 h 785937"/>
                    <a:gd name="connsiteX9" fmla="*/ 120181 w 752963"/>
                    <a:gd name="connsiteY9" fmla="*/ 36946 h 785937"/>
                    <a:gd name="connsiteX0" fmla="*/ 141740 w 752954"/>
                    <a:gd name="connsiteY0" fmla="*/ 20465 h 832516"/>
                    <a:gd name="connsiteX1" fmla="*/ 351713 w 752954"/>
                    <a:gd name="connsiteY1" fmla="*/ 72119 h 832516"/>
                    <a:gd name="connsiteX2" fmla="*/ 597670 w 752954"/>
                    <a:gd name="connsiteY2" fmla="*/ 257931 h 832516"/>
                    <a:gd name="connsiteX3" fmla="*/ 752954 w 752954"/>
                    <a:gd name="connsiteY3" fmla="*/ 618803 h 832516"/>
                    <a:gd name="connsiteX4" fmla="*/ 696502 w 752954"/>
                    <a:gd name="connsiteY4" fmla="*/ 832516 h 832516"/>
                    <a:gd name="connsiteX5" fmla="*/ 538328 w 752954"/>
                    <a:gd name="connsiteY5" fmla="*/ 658081 h 832516"/>
                    <a:gd name="connsiteX6" fmla="*/ 211754 w 752954"/>
                    <a:gd name="connsiteY6" fmla="*/ 351832 h 832516"/>
                    <a:gd name="connsiteX7" fmla="*/ 60961 w 752954"/>
                    <a:gd name="connsiteY7" fmla="*/ 486549 h 832516"/>
                    <a:gd name="connsiteX8" fmla="*/ 40 w 752954"/>
                    <a:gd name="connsiteY8" fmla="*/ 284444 h 832516"/>
                    <a:gd name="connsiteX9" fmla="*/ 141740 w 752954"/>
                    <a:gd name="connsiteY9" fmla="*/ 20465 h 832516"/>
                    <a:gd name="connsiteX0" fmla="*/ 144134 w 755348"/>
                    <a:gd name="connsiteY0" fmla="*/ 20465 h 832516"/>
                    <a:gd name="connsiteX1" fmla="*/ 354107 w 755348"/>
                    <a:gd name="connsiteY1" fmla="*/ 72119 h 832516"/>
                    <a:gd name="connsiteX2" fmla="*/ 600064 w 755348"/>
                    <a:gd name="connsiteY2" fmla="*/ 257931 h 832516"/>
                    <a:gd name="connsiteX3" fmla="*/ 755348 w 755348"/>
                    <a:gd name="connsiteY3" fmla="*/ 618803 h 832516"/>
                    <a:gd name="connsiteX4" fmla="*/ 698896 w 755348"/>
                    <a:gd name="connsiteY4" fmla="*/ 832516 h 832516"/>
                    <a:gd name="connsiteX5" fmla="*/ 540722 w 755348"/>
                    <a:gd name="connsiteY5" fmla="*/ 658081 h 832516"/>
                    <a:gd name="connsiteX6" fmla="*/ 214148 w 755348"/>
                    <a:gd name="connsiteY6" fmla="*/ 351832 h 832516"/>
                    <a:gd name="connsiteX7" fmla="*/ 63355 w 755348"/>
                    <a:gd name="connsiteY7" fmla="*/ 486549 h 832516"/>
                    <a:gd name="connsiteX8" fmla="*/ 38 w 755348"/>
                    <a:gd name="connsiteY8" fmla="*/ 189854 h 832516"/>
                    <a:gd name="connsiteX9" fmla="*/ 144134 w 755348"/>
                    <a:gd name="connsiteY9" fmla="*/ 20465 h 832516"/>
                    <a:gd name="connsiteX0" fmla="*/ 144134 w 755348"/>
                    <a:gd name="connsiteY0" fmla="*/ 20465 h 832516"/>
                    <a:gd name="connsiteX1" fmla="*/ 354107 w 755348"/>
                    <a:gd name="connsiteY1" fmla="*/ 72119 h 832516"/>
                    <a:gd name="connsiteX2" fmla="*/ 600064 w 755348"/>
                    <a:gd name="connsiteY2" fmla="*/ 257931 h 832516"/>
                    <a:gd name="connsiteX3" fmla="*/ 755348 w 755348"/>
                    <a:gd name="connsiteY3" fmla="*/ 618803 h 832516"/>
                    <a:gd name="connsiteX4" fmla="*/ 698896 w 755348"/>
                    <a:gd name="connsiteY4" fmla="*/ 832516 h 832516"/>
                    <a:gd name="connsiteX5" fmla="*/ 540722 w 755348"/>
                    <a:gd name="connsiteY5" fmla="*/ 658081 h 832516"/>
                    <a:gd name="connsiteX6" fmla="*/ 214148 w 755348"/>
                    <a:gd name="connsiteY6" fmla="*/ 351832 h 832516"/>
                    <a:gd name="connsiteX7" fmla="*/ 48979 w 755348"/>
                    <a:gd name="connsiteY7" fmla="*/ 432497 h 832516"/>
                    <a:gd name="connsiteX8" fmla="*/ 38 w 755348"/>
                    <a:gd name="connsiteY8" fmla="*/ 189854 h 832516"/>
                    <a:gd name="connsiteX9" fmla="*/ 144134 w 755348"/>
                    <a:gd name="connsiteY9" fmla="*/ 20465 h 832516"/>
                    <a:gd name="connsiteX0" fmla="*/ 144134 w 755348"/>
                    <a:gd name="connsiteY0" fmla="*/ 20465 h 832516"/>
                    <a:gd name="connsiteX1" fmla="*/ 354107 w 755348"/>
                    <a:gd name="connsiteY1" fmla="*/ 72119 h 832516"/>
                    <a:gd name="connsiteX2" fmla="*/ 600064 w 755348"/>
                    <a:gd name="connsiteY2" fmla="*/ 257931 h 832516"/>
                    <a:gd name="connsiteX3" fmla="*/ 755348 w 755348"/>
                    <a:gd name="connsiteY3" fmla="*/ 618803 h 832516"/>
                    <a:gd name="connsiteX4" fmla="*/ 698896 w 755348"/>
                    <a:gd name="connsiteY4" fmla="*/ 832516 h 832516"/>
                    <a:gd name="connsiteX5" fmla="*/ 540722 w 755348"/>
                    <a:gd name="connsiteY5" fmla="*/ 658081 h 832516"/>
                    <a:gd name="connsiteX6" fmla="*/ 214148 w 755348"/>
                    <a:gd name="connsiteY6" fmla="*/ 351832 h 832516"/>
                    <a:gd name="connsiteX7" fmla="*/ 249286 w 755348"/>
                    <a:gd name="connsiteY7" fmla="*/ 388044 h 832516"/>
                    <a:gd name="connsiteX8" fmla="*/ 48979 w 755348"/>
                    <a:gd name="connsiteY8" fmla="*/ 432497 h 832516"/>
                    <a:gd name="connsiteX9" fmla="*/ 38 w 755348"/>
                    <a:gd name="connsiteY9" fmla="*/ 189854 h 832516"/>
                    <a:gd name="connsiteX10" fmla="*/ 144134 w 755348"/>
                    <a:gd name="connsiteY10" fmla="*/ 20465 h 832516"/>
                    <a:gd name="connsiteX0" fmla="*/ 144134 w 755348"/>
                    <a:gd name="connsiteY0" fmla="*/ 20465 h 832516"/>
                    <a:gd name="connsiteX1" fmla="*/ 354107 w 755348"/>
                    <a:gd name="connsiteY1" fmla="*/ 72119 h 832516"/>
                    <a:gd name="connsiteX2" fmla="*/ 600064 w 755348"/>
                    <a:gd name="connsiteY2" fmla="*/ 257931 h 832516"/>
                    <a:gd name="connsiteX3" fmla="*/ 755348 w 755348"/>
                    <a:gd name="connsiteY3" fmla="*/ 618803 h 832516"/>
                    <a:gd name="connsiteX4" fmla="*/ 698896 w 755348"/>
                    <a:gd name="connsiteY4" fmla="*/ 832516 h 832516"/>
                    <a:gd name="connsiteX5" fmla="*/ 497586 w 755348"/>
                    <a:gd name="connsiteY5" fmla="*/ 491424 h 832516"/>
                    <a:gd name="connsiteX6" fmla="*/ 214148 w 755348"/>
                    <a:gd name="connsiteY6" fmla="*/ 351832 h 832516"/>
                    <a:gd name="connsiteX7" fmla="*/ 249286 w 755348"/>
                    <a:gd name="connsiteY7" fmla="*/ 388044 h 832516"/>
                    <a:gd name="connsiteX8" fmla="*/ 48979 w 755348"/>
                    <a:gd name="connsiteY8" fmla="*/ 432497 h 832516"/>
                    <a:gd name="connsiteX9" fmla="*/ 38 w 755348"/>
                    <a:gd name="connsiteY9" fmla="*/ 189854 h 832516"/>
                    <a:gd name="connsiteX10" fmla="*/ 144134 w 755348"/>
                    <a:gd name="connsiteY10" fmla="*/ 20465 h 832516"/>
                    <a:gd name="connsiteX0" fmla="*/ 144134 w 755348"/>
                    <a:gd name="connsiteY0" fmla="*/ 20465 h 832516"/>
                    <a:gd name="connsiteX1" fmla="*/ 354107 w 755348"/>
                    <a:gd name="connsiteY1" fmla="*/ 72119 h 832516"/>
                    <a:gd name="connsiteX2" fmla="*/ 600064 w 755348"/>
                    <a:gd name="connsiteY2" fmla="*/ 257931 h 832516"/>
                    <a:gd name="connsiteX3" fmla="*/ 755348 w 755348"/>
                    <a:gd name="connsiteY3" fmla="*/ 618803 h 832516"/>
                    <a:gd name="connsiteX4" fmla="*/ 698896 w 755348"/>
                    <a:gd name="connsiteY4" fmla="*/ 832516 h 832516"/>
                    <a:gd name="connsiteX5" fmla="*/ 497586 w 755348"/>
                    <a:gd name="connsiteY5" fmla="*/ 491424 h 832516"/>
                    <a:gd name="connsiteX6" fmla="*/ 214148 w 755348"/>
                    <a:gd name="connsiteY6" fmla="*/ 351832 h 832516"/>
                    <a:gd name="connsiteX7" fmla="*/ 48979 w 755348"/>
                    <a:gd name="connsiteY7" fmla="*/ 432497 h 832516"/>
                    <a:gd name="connsiteX8" fmla="*/ 38 w 755348"/>
                    <a:gd name="connsiteY8" fmla="*/ 189854 h 832516"/>
                    <a:gd name="connsiteX9" fmla="*/ 144134 w 755348"/>
                    <a:gd name="connsiteY9" fmla="*/ 20465 h 832516"/>
                    <a:gd name="connsiteX0" fmla="*/ 144134 w 755348"/>
                    <a:gd name="connsiteY0" fmla="*/ 20465 h 832516"/>
                    <a:gd name="connsiteX1" fmla="*/ 354107 w 755348"/>
                    <a:gd name="connsiteY1" fmla="*/ 72119 h 832516"/>
                    <a:gd name="connsiteX2" fmla="*/ 600064 w 755348"/>
                    <a:gd name="connsiteY2" fmla="*/ 257931 h 832516"/>
                    <a:gd name="connsiteX3" fmla="*/ 755348 w 755348"/>
                    <a:gd name="connsiteY3" fmla="*/ 618803 h 832516"/>
                    <a:gd name="connsiteX4" fmla="*/ 698896 w 755348"/>
                    <a:gd name="connsiteY4" fmla="*/ 832516 h 832516"/>
                    <a:gd name="connsiteX5" fmla="*/ 497586 w 755348"/>
                    <a:gd name="connsiteY5" fmla="*/ 491424 h 832516"/>
                    <a:gd name="connsiteX6" fmla="*/ 250099 w 755348"/>
                    <a:gd name="connsiteY6" fmla="*/ 329310 h 832516"/>
                    <a:gd name="connsiteX7" fmla="*/ 48979 w 755348"/>
                    <a:gd name="connsiteY7" fmla="*/ 432497 h 832516"/>
                    <a:gd name="connsiteX8" fmla="*/ 38 w 755348"/>
                    <a:gd name="connsiteY8" fmla="*/ 189854 h 832516"/>
                    <a:gd name="connsiteX9" fmla="*/ 144134 w 755348"/>
                    <a:gd name="connsiteY9" fmla="*/ 20465 h 832516"/>
                    <a:gd name="connsiteX0" fmla="*/ 144134 w 755348"/>
                    <a:gd name="connsiteY0" fmla="*/ 51817 h 863868"/>
                    <a:gd name="connsiteX1" fmla="*/ 248661 w 755348"/>
                    <a:gd name="connsiteY1" fmla="*/ 22395 h 863868"/>
                    <a:gd name="connsiteX2" fmla="*/ 600064 w 755348"/>
                    <a:gd name="connsiteY2" fmla="*/ 289283 h 863868"/>
                    <a:gd name="connsiteX3" fmla="*/ 755348 w 755348"/>
                    <a:gd name="connsiteY3" fmla="*/ 650155 h 863868"/>
                    <a:gd name="connsiteX4" fmla="*/ 698896 w 755348"/>
                    <a:gd name="connsiteY4" fmla="*/ 863868 h 863868"/>
                    <a:gd name="connsiteX5" fmla="*/ 497586 w 755348"/>
                    <a:gd name="connsiteY5" fmla="*/ 522776 h 863868"/>
                    <a:gd name="connsiteX6" fmla="*/ 250099 w 755348"/>
                    <a:gd name="connsiteY6" fmla="*/ 360662 h 863868"/>
                    <a:gd name="connsiteX7" fmla="*/ 48979 w 755348"/>
                    <a:gd name="connsiteY7" fmla="*/ 463849 h 863868"/>
                    <a:gd name="connsiteX8" fmla="*/ 38 w 755348"/>
                    <a:gd name="connsiteY8" fmla="*/ 221206 h 863868"/>
                    <a:gd name="connsiteX9" fmla="*/ 144134 w 755348"/>
                    <a:gd name="connsiteY9" fmla="*/ 51817 h 863868"/>
                    <a:gd name="connsiteX0" fmla="*/ 11423 w 766733"/>
                    <a:gd name="connsiteY0" fmla="*/ 199476 h 842138"/>
                    <a:gd name="connsiteX1" fmla="*/ 260046 w 766733"/>
                    <a:gd name="connsiteY1" fmla="*/ 665 h 842138"/>
                    <a:gd name="connsiteX2" fmla="*/ 611449 w 766733"/>
                    <a:gd name="connsiteY2" fmla="*/ 267553 h 842138"/>
                    <a:gd name="connsiteX3" fmla="*/ 766733 w 766733"/>
                    <a:gd name="connsiteY3" fmla="*/ 628425 h 842138"/>
                    <a:gd name="connsiteX4" fmla="*/ 710281 w 766733"/>
                    <a:gd name="connsiteY4" fmla="*/ 842138 h 842138"/>
                    <a:gd name="connsiteX5" fmla="*/ 508971 w 766733"/>
                    <a:gd name="connsiteY5" fmla="*/ 501046 h 842138"/>
                    <a:gd name="connsiteX6" fmla="*/ 261484 w 766733"/>
                    <a:gd name="connsiteY6" fmla="*/ 338932 h 842138"/>
                    <a:gd name="connsiteX7" fmla="*/ 60364 w 766733"/>
                    <a:gd name="connsiteY7" fmla="*/ 442119 h 842138"/>
                    <a:gd name="connsiteX8" fmla="*/ 11423 w 766733"/>
                    <a:gd name="connsiteY8" fmla="*/ 199476 h 842138"/>
                    <a:gd name="connsiteX0" fmla="*/ 11423 w 766733"/>
                    <a:gd name="connsiteY0" fmla="*/ 199476 h 842138"/>
                    <a:gd name="connsiteX1" fmla="*/ 260046 w 766733"/>
                    <a:gd name="connsiteY1" fmla="*/ 665 h 842138"/>
                    <a:gd name="connsiteX2" fmla="*/ 611449 w 766733"/>
                    <a:gd name="connsiteY2" fmla="*/ 267553 h 842138"/>
                    <a:gd name="connsiteX3" fmla="*/ 766733 w 766733"/>
                    <a:gd name="connsiteY3" fmla="*/ 628425 h 842138"/>
                    <a:gd name="connsiteX4" fmla="*/ 710281 w 766733"/>
                    <a:gd name="connsiteY4" fmla="*/ 842138 h 842138"/>
                    <a:gd name="connsiteX5" fmla="*/ 516160 w 766733"/>
                    <a:gd name="connsiteY5" fmla="*/ 568610 h 842138"/>
                    <a:gd name="connsiteX6" fmla="*/ 261484 w 766733"/>
                    <a:gd name="connsiteY6" fmla="*/ 338932 h 842138"/>
                    <a:gd name="connsiteX7" fmla="*/ 60364 w 766733"/>
                    <a:gd name="connsiteY7" fmla="*/ 442119 h 842138"/>
                    <a:gd name="connsiteX8" fmla="*/ 11423 w 766733"/>
                    <a:gd name="connsiteY8" fmla="*/ 199476 h 842138"/>
                    <a:gd name="connsiteX0" fmla="*/ 11423 w 766733"/>
                    <a:gd name="connsiteY0" fmla="*/ 199476 h 842138"/>
                    <a:gd name="connsiteX1" fmla="*/ 260046 w 766733"/>
                    <a:gd name="connsiteY1" fmla="*/ 665 h 842138"/>
                    <a:gd name="connsiteX2" fmla="*/ 611449 w 766733"/>
                    <a:gd name="connsiteY2" fmla="*/ 267553 h 842138"/>
                    <a:gd name="connsiteX3" fmla="*/ 766733 w 766733"/>
                    <a:gd name="connsiteY3" fmla="*/ 628425 h 842138"/>
                    <a:gd name="connsiteX4" fmla="*/ 710281 w 766733"/>
                    <a:gd name="connsiteY4" fmla="*/ 842138 h 842138"/>
                    <a:gd name="connsiteX5" fmla="*/ 516160 w 766733"/>
                    <a:gd name="connsiteY5" fmla="*/ 568610 h 842138"/>
                    <a:gd name="connsiteX6" fmla="*/ 235122 w 766733"/>
                    <a:gd name="connsiteY6" fmla="*/ 284881 h 842138"/>
                    <a:gd name="connsiteX7" fmla="*/ 60364 w 766733"/>
                    <a:gd name="connsiteY7" fmla="*/ 442119 h 842138"/>
                    <a:gd name="connsiteX8" fmla="*/ 11423 w 766733"/>
                    <a:gd name="connsiteY8" fmla="*/ 199476 h 842138"/>
                    <a:gd name="connsiteX0" fmla="*/ 13469 w 768779"/>
                    <a:gd name="connsiteY0" fmla="*/ 199476 h 842138"/>
                    <a:gd name="connsiteX1" fmla="*/ 262092 w 768779"/>
                    <a:gd name="connsiteY1" fmla="*/ 665 h 842138"/>
                    <a:gd name="connsiteX2" fmla="*/ 613495 w 768779"/>
                    <a:gd name="connsiteY2" fmla="*/ 267553 h 842138"/>
                    <a:gd name="connsiteX3" fmla="*/ 768779 w 768779"/>
                    <a:gd name="connsiteY3" fmla="*/ 628425 h 842138"/>
                    <a:gd name="connsiteX4" fmla="*/ 712327 w 768779"/>
                    <a:gd name="connsiteY4" fmla="*/ 842138 h 842138"/>
                    <a:gd name="connsiteX5" fmla="*/ 518206 w 768779"/>
                    <a:gd name="connsiteY5" fmla="*/ 568610 h 842138"/>
                    <a:gd name="connsiteX6" fmla="*/ 237168 w 768779"/>
                    <a:gd name="connsiteY6" fmla="*/ 284881 h 842138"/>
                    <a:gd name="connsiteX7" fmla="*/ 50427 w 768779"/>
                    <a:gd name="connsiteY7" fmla="*/ 270961 h 842138"/>
                    <a:gd name="connsiteX8" fmla="*/ 13469 w 768779"/>
                    <a:gd name="connsiteY8" fmla="*/ 199476 h 842138"/>
                    <a:gd name="connsiteX0" fmla="*/ 15035 w 763152"/>
                    <a:gd name="connsiteY0" fmla="*/ 72571 h 859368"/>
                    <a:gd name="connsiteX1" fmla="*/ 256465 w 763152"/>
                    <a:gd name="connsiteY1" fmla="*/ 17895 h 859368"/>
                    <a:gd name="connsiteX2" fmla="*/ 607868 w 763152"/>
                    <a:gd name="connsiteY2" fmla="*/ 284783 h 859368"/>
                    <a:gd name="connsiteX3" fmla="*/ 763152 w 763152"/>
                    <a:gd name="connsiteY3" fmla="*/ 645655 h 859368"/>
                    <a:gd name="connsiteX4" fmla="*/ 706700 w 763152"/>
                    <a:gd name="connsiteY4" fmla="*/ 859368 h 859368"/>
                    <a:gd name="connsiteX5" fmla="*/ 512579 w 763152"/>
                    <a:gd name="connsiteY5" fmla="*/ 585840 h 859368"/>
                    <a:gd name="connsiteX6" fmla="*/ 231541 w 763152"/>
                    <a:gd name="connsiteY6" fmla="*/ 302111 h 859368"/>
                    <a:gd name="connsiteX7" fmla="*/ 44800 w 763152"/>
                    <a:gd name="connsiteY7" fmla="*/ 288191 h 859368"/>
                    <a:gd name="connsiteX8" fmla="*/ 15035 w 763152"/>
                    <a:gd name="connsiteY8" fmla="*/ 72571 h 859368"/>
                    <a:gd name="connsiteX0" fmla="*/ 15035 w 775138"/>
                    <a:gd name="connsiteY0" fmla="*/ 72571 h 859368"/>
                    <a:gd name="connsiteX1" fmla="*/ 256465 w 775138"/>
                    <a:gd name="connsiteY1" fmla="*/ 17895 h 859368"/>
                    <a:gd name="connsiteX2" fmla="*/ 607868 w 775138"/>
                    <a:gd name="connsiteY2" fmla="*/ 284783 h 859368"/>
                    <a:gd name="connsiteX3" fmla="*/ 775138 w 775138"/>
                    <a:gd name="connsiteY3" fmla="*/ 406933 h 859368"/>
                    <a:gd name="connsiteX4" fmla="*/ 706700 w 775138"/>
                    <a:gd name="connsiteY4" fmla="*/ 859368 h 859368"/>
                    <a:gd name="connsiteX5" fmla="*/ 512579 w 775138"/>
                    <a:gd name="connsiteY5" fmla="*/ 585840 h 859368"/>
                    <a:gd name="connsiteX6" fmla="*/ 231541 w 775138"/>
                    <a:gd name="connsiteY6" fmla="*/ 302111 h 859368"/>
                    <a:gd name="connsiteX7" fmla="*/ 44800 w 775138"/>
                    <a:gd name="connsiteY7" fmla="*/ 288191 h 859368"/>
                    <a:gd name="connsiteX8" fmla="*/ 15035 w 775138"/>
                    <a:gd name="connsiteY8" fmla="*/ 72571 h 859368"/>
                    <a:gd name="connsiteX0" fmla="*/ 15035 w 775138"/>
                    <a:gd name="connsiteY0" fmla="*/ 72571 h 724243"/>
                    <a:gd name="connsiteX1" fmla="*/ 256465 w 775138"/>
                    <a:gd name="connsiteY1" fmla="*/ 17895 h 724243"/>
                    <a:gd name="connsiteX2" fmla="*/ 607868 w 775138"/>
                    <a:gd name="connsiteY2" fmla="*/ 284783 h 724243"/>
                    <a:gd name="connsiteX3" fmla="*/ 775138 w 775138"/>
                    <a:gd name="connsiteY3" fmla="*/ 406933 h 724243"/>
                    <a:gd name="connsiteX4" fmla="*/ 728270 w 775138"/>
                    <a:gd name="connsiteY4" fmla="*/ 724243 h 724243"/>
                    <a:gd name="connsiteX5" fmla="*/ 512579 w 775138"/>
                    <a:gd name="connsiteY5" fmla="*/ 585840 h 724243"/>
                    <a:gd name="connsiteX6" fmla="*/ 231541 w 775138"/>
                    <a:gd name="connsiteY6" fmla="*/ 302111 h 724243"/>
                    <a:gd name="connsiteX7" fmla="*/ 44800 w 775138"/>
                    <a:gd name="connsiteY7" fmla="*/ 288191 h 724243"/>
                    <a:gd name="connsiteX8" fmla="*/ 15035 w 775138"/>
                    <a:gd name="connsiteY8" fmla="*/ 72571 h 724243"/>
                    <a:gd name="connsiteX0" fmla="*/ 15035 w 757908"/>
                    <a:gd name="connsiteY0" fmla="*/ 72571 h 724243"/>
                    <a:gd name="connsiteX1" fmla="*/ 256465 w 757908"/>
                    <a:gd name="connsiteY1" fmla="*/ 17895 h 724243"/>
                    <a:gd name="connsiteX2" fmla="*/ 607868 w 757908"/>
                    <a:gd name="connsiteY2" fmla="*/ 284783 h 724243"/>
                    <a:gd name="connsiteX3" fmla="*/ 743985 w 757908"/>
                    <a:gd name="connsiteY3" fmla="*/ 213252 h 724243"/>
                    <a:gd name="connsiteX4" fmla="*/ 728270 w 757908"/>
                    <a:gd name="connsiteY4" fmla="*/ 724243 h 724243"/>
                    <a:gd name="connsiteX5" fmla="*/ 512579 w 757908"/>
                    <a:gd name="connsiteY5" fmla="*/ 585840 h 724243"/>
                    <a:gd name="connsiteX6" fmla="*/ 231541 w 757908"/>
                    <a:gd name="connsiteY6" fmla="*/ 302111 h 724243"/>
                    <a:gd name="connsiteX7" fmla="*/ 44800 w 757908"/>
                    <a:gd name="connsiteY7" fmla="*/ 288191 h 724243"/>
                    <a:gd name="connsiteX8" fmla="*/ 15035 w 757908"/>
                    <a:gd name="connsiteY8" fmla="*/ 72571 h 724243"/>
                    <a:gd name="connsiteX0" fmla="*/ 15035 w 757908"/>
                    <a:gd name="connsiteY0" fmla="*/ 62228 h 713900"/>
                    <a:gd name="connsiteX1" fmla="*/ 256465 w 757908"/>
                    <a:gd name="connsiteY1" fmla="*/ 7552 h 713900"/>
                    <a:gd name="connsiteX2" fmla="*/ 605475 w 757908"/>
                    <a:gd name="connsiteY2" fmla="*/ 134808 h 713900"/>
                    <a:gd name="connsiteX3" fmla="*/ 743985 w 757908"/>
                    <a:gd name="connsiteY3" fmla="*/ 202909 h 713900"/>
                    <a:gd name="connsiteX4" fmla="*/ 728270 w 757908"/>
                    <a:gd name="connsiteY4" fmla="*/ 713900 h 713900"/>
                    <a:gd name="connsiteX5" fmla="*/ 512579 w 757908"/>
                    <a:gd name="connsiteY5" fmla="*/ 575497 h 713900"/>
                    <a:gd name="connsiteX6" fmla="*/ 231541 w 757908"/>
                    <a:gd name="connsiteY6" fmla="*/ 291768 h 713900"/>
                    <a:gd name="connsiteX7" fmla="*/ 44800 w 757908"/>
                    <a:gd name="connsiteY7" fmla="*/ 277848 h 713900"/>
                    <a:gd name="connsiteX8" fmla="*/ 15035 w 757908"/>
                    <a:gd name="connsiteY8" fmla="*/ 62228 h 713900"/>
                    <a:gd name="connsiteX0" fmla="*/ 15035 w 757908"/>
                    <a:gd name="connsiteY0" fmla="*/ 62228 h 713900"/>
                    <a:gd name="connsiteX1" fmla="*/ 256465 w 757908"/>
                    <a:gd name="connsiteY1" fmla="*/ 7552 h 713900"/>
                    <a:gd name="connsiteX2" fmla="*/ 605475 w 757908"/>
                    <a:gd name="connsiteY2" fmla="*/ 134808 h 713900"/>
                    <a:gd name="connsiteX3" fmla="*/ 743985 w 757908"/>
                    <a:gd name="connsiteY3" fmla="*/ 202909 h 713900"/>
                    <a:gd name="connsiteX4" fmla="*/ 728270 w 757908"/>
                    <a:gd name="connsiteY4" fmla="*/ 713900 h 713900"/>
                    <a:gd name="connsiteX5" fmla="*/ 519771 w 757908"/>
                    <a:gd name="connsiteY5" fmla="*/ 471899 h 713900"/>
                    <a:gd name="connsiteX6" fmla="*/ 231541 w 757908"/>
                    <a:gd name="connsiteY6" fmla="*/ 291768 h 713900"/>
                    <a:gd name="connsiteX7" fmla="*/ 44800 w 757908"/>
                    <a:gd name="connsiteY7" fmla="*/ 277848 h 713900"/>
                    <a:gd name="connsiteX8" fmla="*/ 15035 w 757908"/>
                    <a:gd name="connsiteY8" fmla="*/ 62228 h 713900"/>
                    <a:gd name="connsiteX0" fmla="*/ 15035 w 757908"/>
                    <a:gd name="connsiteY0" fmla="*/ 62228 h 713900"/>
                    <a:gd name="connsiteX1" fmla="*/ 256465 w 757908"/>
                    <a:gd name="connsiteY1" fmla="*/ 7552 h 713900"/>
                    <a:gd name="connsiteX2" fmla="*/ 605475 w 757908"/>
                    <a:gd name="connsiteY2" fmla="*/ 134808 h 713900"/>
                    <a:gd name="connsiteX3" fmla="*/ 743985 w 757908"/>
                    <a:gd name="connsiteY3" fmla="*/ 202909 h 713900"/>
                    <a:gd name="connsiteX4" fmla="*/ 728270 w 757908"/>
                    <a:gd name="connsiteY4" fmla="*/ 713900 h 713900"/>
                    <a:gd name="connsiteX5" fmla="*/ 519774 w 757908"/>
                    <a:gd name="connsiteY5" fmla="*/ 440367 h 713900"/>
                    <a:gd name="connsiteX6" fmla="*/ 231541 w 757908"/>
                    <a:gd name="connsiteY6" fmla="*/ 291768 h 713900"/>
                    <a:gd name="connsiteX7" fmla="*/ 44800 w 757908"/>
                    <a:gd name="connsiteY7" fmla="*/ 277848 h 713900"/>
                    <a:gd name="connsiteX8" fmla="*/ 15035 w 757908"/>
                    <a:gd name="connsiteY8" fmla="*/ 62228 h 7139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757908" h="713900">
                      <a:moveTo>
                        <a:pt x="15035" y="62228"/>
                      </a:moveTo>
                      <a:cubicBezTo>
                        <a:pt x="48315" y="-11348"/>
                        <a:pt x="158058" y="-4545"/>
                        <a:pt x="256465" y="7552"/>
                      </a:cubicBezTo>
                      <a:cubicBezTo>
                        <a:pt x="354872" y="19649"/>
                        <a:pt x="524222" y="102249"/>
                        <a:pt x="605475" y="134808"/>
                      </a:cubicBezTo>
                      <a:cubicBezTo>
                        <a:pt x="686728" y="167367"/>
                        <a:pt x="731378" y="66297"/>
                        <a:pt x="743985" y="202909"/>
                      </a:cubicBezTo>
                      <a:cubicBezTo>
                        <a:pt x="740471" y="271851"/>
                        <a:pt x="786402" y="713900"/>
                        <a:pt x="728270" y="713900"/>
                      </a:cubicBezTo>
                      <a:cubicBezTo>
                        <a:pt x="675997" y="669379"/>
                        <a:pt x="582167" y="459774"/>
                        <a:pt x="519774" y="440367"/>
                      </a:cubicBezTo>
                      <a:cubicBezTo>
                        <a:pt x="474775" y="402569"/>
                        <a:pt x="376819" y="314039"/>
                        <a:pt x="231541" y="291768"/>
                      </a:cubicBezTo>
                      <a:cubicBezTo>
                        <a:pt x="156773" y="281947"/>
                        <a:pt x="80485" y="304844"/>
                        <a:pt x="44800" y="277848"/>
                      </a:cubicBezTo>
                      <a:cubicBezTo>
                        <a:pt x="9115" y="250852"/>
                        <a:pt x="-18245" y="135804"/>
                        <a:pt x="15035" y="62228"/>
                      </a:cubicBezTo>
                      <a:close/>
                    </a:path>
                  </a:pathLst>
                </a:custGeom>
                <a:grpFill/>
                <a:ln>
                  <a:solidFill>
                    <a:schemeClr val="tx2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350" b="1">
                    <a:solidFill>
                      <a:schemeClr val="bg2">
                        <a:lumMod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" name="Block Arc 15"/>
                <p:cNvSpPr/>
                <p:nvPr/>
              </p:nvSpPr>
              <p:spPr>
                <a:xfrm rot="7300022">
                  <a:off x="4287730" y="3693479"/>
                  <a:ext cx="1001014" cy="511877"/>
                </a:xfrm>
                <a:custGeom>
                  <a:avLst/>
                  <a:gdLst>
                    <a:gd name="connsiteX0" fmla="*/ 627 w 745516"/>
                    <a:gd name="connsiteY0" fmla="*/ 369014 h 697590"/>
                    <a:gd name="connsiteX1" fmla="*/ 184209 w 745516"/>
                    <a:gd name="connsiteY1" fmla="*/ 47911 h 697590"/>
                    <a:gd name="connsiteX2" fmla="*/ 544181 w 745516"/>
                    <a:gd name="connsiteY2" fmla="*/ 39071 h 697590"/>
                    <a:gd name="connsiteX3" fmla="*/ 745515 w 745516"/>
                    <a:gd name="connsiteY3" fmla="*/ 348795 h 697590"/>
                    <a:gd name="connsiteX4" fmla="*/ 571119 w 745516"/>
                    <a:gd name="connsiteY4" fmla="*/ 348795 h 697590"/>
                    <a:gd name="connsiteX5" fmla="*/ 459552 w 745516"/>
                    <a:gd name="connsiteY5" fmla="*/ 191978 h 697590"/>
                    <a:gd name="connsiteX6" fmla="*/ 277038 w 745516"/>
                    <a:gd name="connsiteY6" fmla="*/ 196046 h 697590"/>
                    <a:gd name="connsiteX7" fmla="*/ 174775 w 745516"/>
                    <a:gd name="connsiteY7" fmla="*/ 359552 h 697590"/>
                    <a:gd name="connsiteX8" fmla="*/ 627 w 745516"/>
                    <a:gd name="connsiteY8" fmla="*/ 369014 h 697590"/>
                    <a:gd name="connsiteX0" fmla="*/ 629 w 745517"/>
                    <a:gd name="connsiteY0" fmla="*/ 369014 h 369014"/>
                    <a:gd name="connsiteX1" fmla="*/ 184211 w 745517"/>
                    <a:gd name="connsiteY1" fmla="*/ 47911 h 369014"/>
                    <a:gd name="connsiteX2" fmla="*/ 544183 w 745517"/>
                    <a:gd name="connsiteY2" fmla="*/ 39071 h 369014"/>
                    <a:gd name="connsiteX3" fmla="*/ 745517 w 745517"/>
                    <a:gd name="connsiteY3" fmla="*/ 348795 h 369014"/>
                    <a:gd name="connsiteX4" fmla="*/ 668191 w 745517"/>
                    <a:gd name="connsiteY4" fmla="*/ 363523 h 369014"/>
                    <a:gd name="connsiteX5" fmla="*/ 459554 w 745517"/>
                    <a:gd name="connsiteY5" fmla="*/ 191978 h 369014"/>
                    <a:gd name="connsiteX6" fmla="*/ 277040 w 745517"/>
                    <a:gd name="connsiteY6" fmla="*/ 196046 h 369014"/>
                    <a:gd name="connsiteX7" fmla="*/ 174777 w 745517"/>
                    <a:gd name="connsiteY7" fmla="*/ 359552 h 369014"/>
                    <a:gd name="connsiteX8" fmla="*/ 629 w 745517"/>
                    <a:gd name="connsiteY8" fmla="*/ 369014 h 369014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59554 w 745517"/>
                    <a:gd name="connsiteY5" fmla="*/ 191978 h 425833"/>
                    <a:gd name="connsiteX6" fmla="*/ 277040 w 745517"/>
                    <a:gd name="connsiteY6" fmla="*/ 196046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48149 w 745517"/>
                    <a:gd name="connsiteY5" fmla="*/ 197842 h 425833"/>
                    <a:gd name="connsiteX6" fmla="*/ 277040 w 745517"/>
                    <a:gd name="connsiteY6" fmla="*/ 196046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277040 w 745517"/>
                    <a:gd name="connsiteY6" fmla="*/ 196046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387239 w 745517"/>
                    <a:gd name="connsiteY6" fmla="*/ 147341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387239 w 745517"/>
                    <a:gd name="connsiteY6" fmla="*/ 147341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387239 w 745517"/>
                    <a:gd name="connsiteY6" fmla="*/ 147341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396919 w 745517"/>
                    <a:gd name="connsiteY6" fmla="*/ 199046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396919 w 745517"/>
                    <a:gd name="connsiteY5" fmla="*/ 199046 h 425833"/>
                    <a:gd name="connsiteX6" fmla="*/ 174777 w 745517"/>
                    <a:gd name="connsiteY6" fmla="*/ 359552 h 425833"/>
                    <a:gd name="connsiteX7" fmla="*/ 629 w 745517"/>
                    <a:gd name="connsiteY7" fmla="*/ 369014 h 425833"/>
                    <a:gd name="connsiteX0" fmla="*/ 629 w 777485"/>
                    <a:gd name="connsiteY0" fmla="*/ 364465 h 421284"/>
                    <a:gd name="connsiteX1" fmla="*/ 184211 w 777485"/>
                    <a:gd name="connsiteY1" fmla="*/ 43362 h 421284"/>
                    <a:gd name="connsiteX2" fmla="*/ 544183 w 777485"/>
                    <a:gd name="connsiteY2" fmla="*/ 34522 h 421284"/>
                    <a:gd name="connsiteX3" fmla="*/ 777485 w 777485"/>
                    <a:gd name="connsiteY3" fmla="*/ 302949 h 421284"/>
                    <a:gd name="connsiteX4" fmla="*/ 666916 w 777485"/>
                    <a:gd name="connsiteY4" fmla="*/ 421284 h 421284"/>
                    <a:gd name="connsiteX5" fmla="*/ 396919 w 777485"/>
                    <a:gd name="connsiteY5" fmla="*/ 194497 h 421284"/>
                    <a:gd name="connsiteX6" fmla="*/ 174777 w 777485"/>
                    <a:gd name="connsiteY6" fmla="*/ 355003 h 421284"/>
                    <a:gd name="connsiteX7" fmla="*/ 629 w 777485"/>
                    <a:gd name="connsiteY7" fmla="*/ 364465 h 421284"/>
                    <a:gd name="connsiteX0" fmla="*/ 629 w 777485"/>
                    <a:gd name="connsiteY0" fmla="*/ 364465 h 421284"/>
                    <a:gd name="connsiteX1" fmla="*/ 184211 w 777485"/>
                    <a:gd name="connsiteY1" fmla="*/ 43362 h 421284"/>
                    <a:gd name="connsiteX2" fmla="*/ 544183 w 777485"/>
                    <a:gd name="connsiteY2" fmla="*/ 34522 h 421284"/>
                    <a:gd name="connsiteX3" fmla="*/ 777485 w 777485"/>
                    <a:gd name="connsiteY3" fmla="*/ 302949 h 421284"/>
                    <a:gd name="connsiteX4" fmla="*/ 666916 w 777485"/>
                    <a:gd name="connsiteY4" fmla="*/ 421284 h 421284"/>
                    <a:gd name="connsiteX5" fmla="*/ 396919 w 777485"/>
                    <a:gd name="connsiteY5" fmla="*/ 194497 h 421284"/>
                    <a:gd name="connsiteX6" fmla="*/ 174777 w 777485"/>
                    <a:gd name="connsiteY6" fmla="*/ 355003 h 421284"/>
                    <a:gd name="connsiteX7" fmla="*/ 629 w 777485"/>
                    <a:gd name="connsiteY7" fmla="*/ 364465 h 421284"/>
                    <a:gd name="connsiteX0" fmla="*/ 629 w 777485"/>
                    <a:gd name="connsiteY0" fmla="*/ 364465 h 421284"/>
                    <a:gd name="connsiteX1" fmla="*/ 184211 w 777485"/>
                    <a:gd name="connsiteY1" fmla="*/ 43362 h 421284"/>
                    <a:gd name="connsiteX2" fmla="*/ 544183 w 777485"/>
                    <a:gd name="connsiteY2" fmla="*/ 34522 h 421284"/>
                    <a:gd name="connsiteX3" fmla="*/ 777485 w 777485"/>
                    <a:gd name="connsiteY3" fmla="*/ 302949 h 421284"/>
                    <a:gd name="connsiteX4" fmla="*/ 666916 w 777485"/>
                    <a:gd name="connsiteY4" fmla="*/ 421284 h 421284"/>
                    <a:gd name="connsiteX5" fmla="*/ 396919 w 777485"/>
                    <a:gd name="connsiteY5" fmla="*/ 194497 h 421284"/>
                    <a:gd name="connsiteX6" fmla="*/ 102409 w 777485"/>
                    <a:gd name="connsiteY6" fmla="*/ 373814 h 421284"/>
                    <a:gd name="connsiteX7" fmla="*/ 629 w 777485"/>
                    <a:gd name="connsiteY7" fmla="*/ 364465 h 421284"/>
                    <a:gd name="connsiteX0" fmla="*/ 329 w 828090"/>
                    <a:gd name="connsiteY0" fmla="*/ 354833 h 418791"/>
                    <a:gd name="connsiteX1" fmla="*/ 234816 w 828090"/>
                    <a:gd name="connsiteY1" fmla="*/ 40869 h 418791"/>
                    <a:gd name="connsiteX2" fmla="*/ 594788 w 828090"/>
                    <a:gd name="connsiteY2" fmla="*/ 32029 h 418791"/>
                    <a:gd name="connsiteX3" fmla="*/ 828090 w 828090"/>
                    <a:gd name="connsiteY3" fmla="*/ 300456 h 418791"/>
                    <a:gd name="connsiteX4" fmla="*/ 717521 w 828090"/>
                    <a:gd name="connsiteY4" fmla="*/ 418791 h 418791"/>
                    <a:gd name="connsiteX5" fmla="*/ 447524 w 828090"/>
                    <a:gd name="connsiteY5" fmla="*/ 192004 h 418791"/>
                    <a:gd name="connsiteX6" fmla="*/ 153014 w 828090"/>
                    <a:gd name="connsiteY6" fmla="*/ 371321 h 418791"/>
                    <a:gd name="connsiteX7" fmla="*/ 329 w 828090"/>
                    <a:gd name="connsiteY7" fmla="*/ 354833 h 418791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476599 w 857165"/>
                    <a:gd name="connsiteY5" fmla="*/ 191739 h 418526"/>
                    <a:gd name="connsiteX6" fmla="*/ 182089 w 857165"/>
                    <a:gd name="connsiteY6" fmla="*/ 371056 h 418526"/>
                    <a:gd name="connsiteX7" fmla="*/ 283 w 857165"/>
                    <a:gd name="connsiteY7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476599 w 857165"/>
                    <a:gd name="connsiteY5" fmla="*/ 191739 h 418526"/>
                    <a:gd name="connsiteX6" fmla="*/ 182089 w 857165"/>
                    <a:gd name="connsiteY6" fmla="*/ 371056 h 418526"/>
                    <a:gd name="connsiteX7" fmla="*/ 283 w 857165"/>
                    <a:gd name="connsiteY7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476599 w 857165"/>
                    <a:gd name="connsiteY5" fmla="*/ 191739 h 418526"/>
                    <a:gd name="connsiteX6" fmla="*/ 182089 w 857165"/>
                    <a:gd name="connsiteY6" fmla="*/ 371056 h 418526"/>
                    <a:gd name="connsiteX7" fmla="*/ 283 w 857165"/>
                    <a:gd name="connsiteY7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476599 w 857165"/>
                    <a:gd name="connsiteY5" fmla="*/ 191739 h 418526"/>
                    <a:gd name="connsiteX6" fmla="*/ 182089 w 857165"/>
                    <a:gd name="connsiteY6" fmla="*/ 371056 h 418526"/>
                    <a:gd name="connsiteX7" fmla="*/ 283 w 857165"/>
                    <a:gd name="connsiteY7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596226 w 857165"/>
                    <a:gd name="connsiteY5" fmla="*/ 269798 h 418526"/>
                    <a:gd name="connsiteX6" fmla="*/ 476599 w 857165"/>
                    <a:gd name="connsiteY6" fmla="*/ 191739 h 418526"/>
                    <a:gd name="connsiteX7" fmla="*/ 182089 w 857165"/>
                    <a:gd name="connsiteY7" fmla="*/ 371056 h 418526"/>
                    <a:gd name="connsiteX8" fmla="*/ 283 w 857165"/>
                    <a:gd name="connsiteY8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631337 w 857165"/>
                    <a:gd name="connsiteY5" fmla="*/ 261689 h 418526"/>
                    <a:gd name="connsiteX6" fmla="*/ 476599 w 857165"/>
                    <a:gd name="connsiteY6" fmla="*/ 191739 h 418526"/>
                    <a:gd name="connsiteX7" fmla="*/ 182089 w 857165"/>
                    <a:gd name="connsiteY7" fmla="*/ 371056 h 418526"/>
                    <a:gd name="connsiteX8" fmla="*/ 283 w 857165"/>
                    <a:gd name="connsiteY8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623229 w 857165"/>
                    <a:gd name="connsiteY5" fmla="*/ 226578 h 418526"/>
                    <a:gd name="connsiteX6" fmla="*/ 476599 w 857165"/>
                    <a:gd name="connsiteY6" fmla="*/ 191739 h 418526"/>
                    <a:gd name="connsiteX7" fmla="*/ 182089 w 857165"/>
                    <a:gd name="connsiteY7" fmla="*/ 371056 h 418526"/>
                    <a:gd name="connsiteX8" fmla="*/ 283 w 857165"/>
                    <a:gd name="connsiteY8" fmla="*/ 350149 h 418526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623229 w 857165"/>
                    <a:gd name="connsiteY5" fmla="*/ 226578 h 418077"/>
                    <a:gd name="connsiteX6" fmla="*/ 476599 w 857165"/>
                    <a:gd name="connsiteY6" fmla="*/ 191739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623229 w 857165"/>
                    <a:gd name="connsiteY5" fmla="*/ 226578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623229 w 857165"/>
                    <a:gd name="connsiteY5" fmla="*/ 226578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91288 w 857165"/>
                    <a:gd name="connsiteY5" fmla="*/ 217643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91288 w 857165"/>
                    <a:gd name="connsiteY5" fmla="*/ 217643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91288 w 857165"/>
                    <a:gd name="connsiteY5" fmla="*/ 217643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13122 w 857165"/>
                    <a:gd name="connsiteY6" fmla="*/ 233528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13122 w 857165"/>
                    <a:gd name="connsiteY6" fmla="*/ 233528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23181 w 857165"/>
                    <a:gd name="connsiteY6" fmla="*/ 213440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23181 w 857165"/>
                    <a:gd name="connsiteY6" fmla="*/ 213440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23181 w 857165"/>
                    <a:gd name="connsiteY6" fmla="*/ 213440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71599"/>
                    <a:gd name="connsiteX1" fmla="*/ 263891 w 857165"/>
                    <a:gd name="connsiteY1" fmla="*/ 40604 h 471599"/>
                    <a:gd name="connsiteX2" fmla="*/ 623863 w 857165"/>
                    <a:gd name="connsiteY2" fmla="*/ 31764 h 471599"/>
                    <a:gd name="connsiteX3" fmla="*/ 857165 w 857165"/>
                    <a:gd name="connsiteY3" fmla="*/ 300191 h 471599"/>
                    <a:gd name="connsiteX4" fmla="*/ 768237 w 857165"/>
                    <a:gd name="connsiteY4" fmla="*/ 471599 h 471599"/>
                    <a:gd name="connsiteX5" fmla="*/ 588791 w 857165"/>
                    <a:gd name="connsiteY5" fmla="*/ 241798 h 471599"/>
                    <a:gd name="connsiteX6" fmla="*/ 323181 w 857165"/>
                    <a:gd name="connsiteY6" fmla="*/ 213440 h 471599"/>
                    <a:gd name="connsiteX7" fmla="*/ 182089 w 857165"/>
                    <a:gd name="connsiteY7" fmla="*/ 371056 h 471599"/>
                    <a:gd name="connsiteX8" fmla="*/ 283 w 857165"/>
                    <a:gd name="connsiteY8" fmla="*/ 350149 h 471599"/>
                    <a:gd name="connsiteX0" fmla="*/ 283 w 922080"/>
                    <a:gd name="connsiteY0" fmla="*/ 359002 h 486990"/>
                    <a:gd name="connsiteX1" fmla="*/ 263891 w 922080"/>
                    <a:gd name="connsiteY1" fmla="*/ 49457 h 486990"/>
                    <a:gd name="connsiteX2" fmla="*/ 623863 w 922080"/>
                    <a:gd name="connsiteY2" fmla="*/ 40617 h 486990"/>
                    <a:gd name="connsiteX3" fmla="*/ 922080 w 922080"/>
                    <a:gd name="connsiteY3" fmla="*/ 440612 h 486990"/>
                    <a:gd name="connsiteX4" fmla="*/ 768237 w 922080"/>
                    <a:gd name="connsiteY4" fmla="*/ 480452 h 486990"/>
                    <a:gd name="connsiteX5" fmla="*/ 588791 w 922080"/>
                    <a:gd name="connsiteY5" fmla="*/ 250651 h 486990"/>
                    <a:gd name="connsiteX6" fmla="*/ 323181 w 922080"/>
                    <a:gd name="connsiteY6" fmla="*/ 222293 h 486990"/>
                    <a:gd name="connsiteX7" fmla="*/ 182089 w 922080"/>
                    <a:gd name="connsiteY7" fmla="*/ 379909 h 486990"/>
                    <a:gd name="connsiteX8" fmla="*/ 283 w 922080"/>
                    <a:gd name="connsiteY8" fmla="*/ 359002 h 486990"/>
                    <a:gd name="connsiteX0" fmla="*/ 283 w 925272"/>
                    <a:gd name="connsiteY0" fmla="*/ 357772 h 480085"/>
                    <a:gd name="connsiteX1" fmla="*/ 263891 w 925272"/>
                    <a:gd name="connsiteY1" fmla="*/ 48227 h 480085"/>
                    <a:gd name="connsiteX2" fmla="*/ 623863 w 925272"/>
                    <a:gd name="connsiteY2" fmla="*/ 39387 h 480085"/>
                    <a:gd name="connsiteX3" fmla="*/ 925272 w 925272"/>
                    <a:gd name="connsiteY3" fmla="*/ 421509 h 480085"/>
                    <a:gd name="connsiteX4" fmla="*/ 768237 w 925272"/>
                    <a:gd name="connsiteY4" fmla="*/ 479222 h 480085"/>
                    <a:gd name="connsiteX5" fmla="*/ 588791 w 925272"/>
                    <a:gd name="connsiteY5" fmla="*/ 249421 h 480085"/>
                    <a:gd name="connsiteX6" fmla="*/ 323181 w 925272"/>
                    <a:gd name="connsiteY6" fmla="*/ 221063 h 480085"/>
                    <a:gd name="connsiteX7" fmla="*/ 182089 w 925272"/>
                    <a:gd name="connsiteY7" fmla="*/ 378679 h 480085"/>
                    <a:gd name="connsiteX8" fmla="*/ 283 w 925272"/>
                    <a:gd name="connsiteY8" fmla="*/ 357772 h 480085"/>
                    <a:gd name="connsiteX0" fmla="*/ 283 w 925272"/>
                    <a:gd name="connsiteY0" fmla="*/ 357772 h 479899"/>
                    <a:gd name="connsiteX1" fmla="*/ 263891 w 925272"/>
                    <a:gd name="connsiteY1" fmla="*/ 48227 h 479899"/>
                    <a:gd name="connsiteX2" fmla="*/ 623863 w 925272"/>
                    <a:gd name="connsiteY2" fmla="*/ 39387 h 479899"/>
                    <a:gd name="connsiteX3" fmla="*/ 925272 w 925272"/>
                    <a:gd name="connsiteY3" fmla="*/ 421509 h 479899"/>
                    <a:gd name="connsiteX4" fmla="*/ 768237 w 925272"/>
                    <a:gd name="connsiteY4" fmla="*/ 479222 h 479899"/>
                    <a:gd name="connsiteX5" fmla="*/ 588791 w 925272"/>
                    <a:gd name="connsiteY5" fmla="*/ 249421 h 479899"/>
                    <a:gd name="connsiteX6" fmla="*/ 323181 w 925272"/>
                    <a:gd name="connsiteY6" fmla="*/ 221063 h 479899"/>
                    <a:gd name="connsiteX7" fmla="*/ 182089 w 925272"/>
                    <a:gd name="connsiteY7" fmla="*/ 378679 h 479899"/>
                    <a:gd name="connsiteX8" fmla="*/ 283 w 925272"/>
                    <a:gd name="connsiteY8" fmla="*/ 357772 h 479899"/>
                    <a:gd name="connsiteX0" fmla="*/ 283 w 925272"/>
                    <a:gd name="connsiteY0" fmla="*/ 357772 h 479899"/>
                    <a:gd name="connsiteX1" fmla="*/ 263891 w 925272"/>
                    <a:gd name="connsiteY1" fmla="*/ 48227 h 479899"/>
                    <a:gd name="connsiteX2" fmla="*/ 623863 w 925272"/>
                    <a:gd name="connsiteY2" fmla="*/ 39387 h 479899"/>
                    <a:gd name="connsiteX3" fmla="*/ 925272 w 925272"/>
                    <a:gd name="connsiteY3" fmla="*/ 421509 h 479899"/>
                    <a:gd name="connsiteX4" fmla="*/ 768237 w 925272"/>
                    <a:gd name="connsiteY4" fmla="*/ 479222 h 479899"/>
                    <a:gd name="connsiteX5" fmla="*/ 588791 w 925272"/>
                    <a:gd name="connsiteY5" fmla="*/ 249421 h 479899"/>
                    <a:gd name="connsiteX6" fmla="*/ 323181 w 925272"/>
                    <a:gd name="connsiteY6" fmla="*/ 221063 h 479899"/>
                    <a:gd name="connsiteX7" fmla="*/ 182089 w 925272"/>
                    <a:gd name="connsiteY7" fmla="*/ 378679 h 479899"/>
                    <a:gd name="connsiteX8" fmla="*/ 283 w 925272"/>
                    <a:gd name="connsiteY8" fmla="*/ 357772 h 479899"/>
                    <a:gd name="connsiteX0" fmla="*/ 283 w 925272"/>
                    <a:gd name="connsiteY0" fmla="*/ 357772 h 479899"/>
                    <a:gd name="connsiteX1" fmla="*/ 263891 w 925272"/>
                    <a:gd name="connsiteY1" fmla="*/ 48227 h 479899"/>
                    <a:gd name="connsiteX2" fmla="*/ 623863 w 925272"/>
                    <a:gd name="connsiteY2" fmla="*/ 39387 h 479899"/>
                    <a:gd name="connsiteX3" fmla="*/ 925272 w 925272"/>
                    <a:gd name="connsiteY3" fmla="*/ 421509 h 479899"/>
                    <a:gd name="connsiteX4" fmla="*/ 768237 w 925272"/>
                    <a:gd name="connsiteY4" fmla="*/ 479222 h 479899"/>
                    <a:gd name="connsiteX5" fmla="*/ 614360 w 925272"/>
                    <a:gd name="connsiteY5" fmla="*/ 239373 h 479899"/>
                    <a:gd name="connsiteX6" fmla="*/ 323181 w 925272"/>
                    <a:gd name="connsiteY6" fmla="*/ 221063 h 479899"/>
                    <a:gd name="connsiteX7" fmla="*/ 182089 w 925272"/>
                    <a:gd name="connsiteY7" fmla="*/ 378679 h 479899"/>
                    <a:gd name="connsiteX8" fmla="*/ 283 w 925272"/>
                    <a:gd name="connsiteY8" fmla="*/ 357772 h 479899"/>
                    <a:gd name="connsiteX0" fmla="*/ 283 w 925272"/>
                    <a:gd name="connsiteY0" fmla="*/ 357772 h 478527"/>
                    <a:gd name="connsiteX1" fmla="*/ 263891 w 925272"/>
                    <a:gd name="connsiteY1" fmla="*/ 48227 h 478527"/>
                    <a:gd name="connsiteX2" fmla="*/ 623863 w 925272"/>
                    <a:gd name="connsiteY2" fmla="*/ 39387 h 478527"/>
                    <a:gd name="connsiteX3" fmla="*/ 925272 w 925272"/>
                    <a:gd name="connsiteY3" fmla="*/ 421509 h 478527"/>
                    <a:gd name="connsiteX4" fmla="*/ 784939 w 925272"/>
                    <a:gd name="connsiteY4" fmla="*/ 477575 h 478527"/>
                    <a:gd name="connsiteX5" fmla="*/ 614360 w 925272"/>
                    <a:gd name="connsiteY5" fmla="*/ 239373 h 478527"/>
                    <a:gd name="connsiteX6" fmla="*/ 323181 w 925272"/>
                    <a:gd name="connsiteY6" fmla="*/ 221063 h 478527"/>
                    <a:gd name="connsiteX7" fmla="*/ 182089 w 925272"/>
                    <a:gd name="connsiteY7" fmla="*/ 378679 h 478527"/>
                    <a:gd name="connsiteX8" fmla="*/ 283 w 925272"/>
                    <a:gd name="connsiteY8" fmla="*/ 357772 h 478527"/>
                    <a:gd name="connsiteX0" fmla="*/ 283 w 925272"/>
                    <a:gd name="connsiteY0" fmla="*/ 357772 h 478527"/>
                    <a:gd name="connsiteX1" fmla="*/ 263891 w 925272"/>
                    <a:gd name="connsiteY1" fmla="*/ 48227 h 478527"/>
                    <a:gd name="connsiteX2" fmla="*/ 623863 w 925272"/>
                    <a:gd name="connsiteY2" fmla="*/ 39387 h 478527"/>
                    <a:gd name="connsiteX3" fmla="*/ 925272 w 925272"/>
                    <a:gd name="connsiteY3" fmla="*/ 421509 h 478527"/>
                    <a:gd name="connsiteX4" fmla="*/ 784939 w 925272"/>
                    <a:gd name="connsiteY4" fmla="*/ 477575 h 478527"/>
                    <a:gd name="connsiteX5" fmla="*/ 614360 w 925272"/>
                    <a:gd name="connsiteY5" fmla="*/ 239373 h 478527"/>
                    <a:gd name="connsiteX6" fmla="*/ 323181 w 925272"/>
                    <a:gd name="connsiteY6" fmla="*/ 221063 h 478527"/>
                    <a:gd name="connsiteX7" fmla="*/ 182089 w 925272"/>
                    <a:gd name="connsiteY7" fmla="*/ 378679 h 478527"/>
                    <a:gd name="connsiteX8" fmla="*/ 283 w 925272"/>
                    <a:gd name="connsiteY8" fmla="*/ 357772 h 478527"/>
                    <a:gd name="connsiteX0" fmla="*/ 283 w 925272"/>
                    <a:gd name="connsiteY0" fmla="*/ 357772 h 557834"/>
                    <a:gd name="connsiteX1" fmla="*/ 263891 w 925272"/>
                    <a:gd name="connsiteY1" fmla="*/ 48227 h 557834"/>
                    <a:gd name="connsiteX2" fmla="*/ 623863 w 925272"/>
                    <a:gd name="connsiteY2" fmla="*/ 39387 h 557834"/>
                    <a:gd name="connsiteX3" fmla="*/ 925272 w 925272"/>
                    <a:gd name="connsiteY3" fmla="*/ 421509 h 557834"/>
                    <a:gd name="connsiteX4" fmla="*/ 784939 w 925272"/>
                    <a:gd name="connsiteY4" fmla="*/ 477575 h 557834"/>
                    <a:gd name="connsiteX5" fmla="*/ 614360 w 925272"/>
                    <a:gd name="connsiteY5" fmla="*/ 239373 h 557834"/>
                    <a:gd name="connsiteX6" fmla="*/ 323181 w 925272"/>
                    <a:gd name="connsiteY6" fmla="*/ 221063 h 557834"/>
                    <a:gd name="connsiteX7" fmla="*/ 137577 w 925272"/>
                    <a:gd name="connsiteY7" fmla="*/ 551149 h 557834"/>
                    <a:gd name="connsiteX8" fmla="*/ 283 w 925272"/>
                    <a:gd name="connsiteY8" fmla="*/ 357772 h 557834"/>
                    <a:gd name="connsiteX0" fmla="*/ 283 w 925272"/>
                    <a:gd name="connsiteY0" fmla="*/ 357772 h 505215"/>
                    <a:gd name="connsiteX1" fmla="*/ 263891 w 925272"/>
                    <a:gd name="connsiteY1" fmla="*/ 48227 h 505215"/>
                    <a:gd name="connsiteX2" fmla="*/ 623863 w 925272"/>
                    <a:gd name="connsiteY2" fmla="*/ 39387 h 505215"/>
                    <a:gd name="connsiteX3" fmla="*/ 925272 w 925272"/>
                    <a:gd name="connsiteY3" fmla="*/ 421509 h 505215"/>
                    <a:gd name="connsiteX4" fmla="*/ 784939 w 925272"/>
                    <a:gd name="connsiteY4" fmla="*/ 477575 h 505215"/>
                    <a:gd name="connsiteX5" fmla="*/ 614360 w 925272"/>
                    <a:gd name="connsiteY5" fmla="*/ 239373 h 505215"/>
                    <a:gd name="connsiteX6" fmla="*/ 323181 w 925272"/>
                    <a:gd name="connsiteY6" fmla="*/ 221063 h 505215"/>
                    <a:gd name="connsiteX7" fmla="*/ 132607 w 925272"/>
                    <a:gd name="connsiteY7" fmla="*/ 496450 h 505215"/>
                    <a:gd name="connsiteX8" fmla="*/ 283 w 925272"/>
                    <a:gd name="connsiteY8" fmla="*/ 357772 h 505215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344909 w 947000"/>
                    <a:gd name="connsiteY6" fmla="*/ 227109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296839 w 947000"/>
                    <a:gd name="connsiteY6" fmla="*/ 254428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296839 w 947000"/>
                    <a:gd name="connsiteY6" fmla="*/ 254428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296839 w 947000"/>
                    <a:gd name="connsiteY6" fmla="*/ 254428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53488 w 947000"/>
                    <a:gd name="connsiteY5" fmla="*/ 203309 h 523249"/>
                    <a:gd name="connsiteX6" fmla="*/ 296839 w 947000"/>
                    <a:gd name="connsiteY6" fmla="*/ 254428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52370 w 947000"/>
                    <a:gd name="connsiteY5" fmla="*/ 215990 h 523249"/>
                    <a:gd name="connsiteX6" fmla="*/ 296839 w 947000"/>
                    <a:gd name="connsiteY6" fmla="*/ 254428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70 w 947013"/>
                    <a:gd name="connsiteY0" fmla="*/ 483982 h 538413"/>
                    <a:gd name="connsiteX1" fmla="*/ 285632 w 947013"/>
                    <a:gd name="connsiteY1" fmla="*/ 69437 h 538413"/>
                    <a:gd name="connsiteX2" fmla="*/ 701029 w 947013"/>
                    <a:gd name="connsiteY2" fmla="*/ 36886 h 538413"/>
                    <a:gd name="connsiteX3" fmla="*/ 947013 w 947013"/>
                    <a:gd name="connsiteY3" fmla="*/ 442719 h 538413"/>
                    <a:gd name="connsiteX4" fmla="*/ 806680 w 947013"/>
                    <a:gd name="connsiteY4" fmla="*/ 498785 h 538413"/>
                    <a:gd name="connsiteX5" fmla="*/ 652383 w 947013"/>
                    <a:gd name="connsiteY5" fmla="*/ 231154 h 538413"/>
                    <a:gd name="connsiteX6" fmla="*/ 296852 w 947013"/>
                    <a:gd name="connsiteY6" fmla="*/ 269592 h 538413"/>
                    <a:gd name="connsiteX7" fmla="*/ 154348 w 947013"/>
                    <a:gd name="connsiteY7" fmla="*/ 517660 h 538413"/>
                    <a:gd name="connsiteX8" fmla="*/ 270 w 947013"/>
                    <a:gd name="connsiteY8" fmla="*/ 483982 h 538413"/>
                    <a:gd name="connsiteX0" fmla="*/ 270 w 947013"/>
                    <a:gd name="connsiteY0" fmla="*/ 483982 h 538413"/>
                    <a:gd name="connsiteX1" fmla="*/ 285632 w 947013"/>
                    <a:gd name="connsiteY1" fmla="*/ 69437 h 538413"/>
                    <a:gd name="connsiteX2" fmla="*/ 701029 w 947013"/>
                    <a:gd name="connsiteY2" fmla="*/ 36886 h 538413"/>
                    <a:gd name="connsiteX3" fmla="*/ 947013 w 947013"/>
                    <a:gd name="connsiteY3" fmla="*/ 442719 h 538413"/>
                    <a:gd name="connsiteX4" fmla="*/ 856579 w 947013"/>
                    <a:gd name="connsiteY4" fmla="*/ 468150 h 538413"/>
                    <a:gd name="connsiteX5" fmla="*/ 652383 w 947013"/>
                    <a:gd name="connsiteY5" fmla="*/ 231154 h 538413"/>
                    <a:gd name="connsiteX6" fmla="*/ 296852 w 947013"/>
                    <a:gd name="connsiteY6" fmla="*/ 269592 h 538413"/>
                    <a:gd name="connsiteX7" fmla="*/ 154348 w 947013"/>
                    <a:gd name="connsiteY7" fmla="*/ 517660 h 538413"/>
                    <a:gd name="connsiteX8" fmla="*/ 270 w 947013"/>
                    <a:gd name="connsiteY8" fmla="*/ 483982 h 538413"/>
                    <a:gd name="connsiteX0" fmla="*/ 270 w 1007459"/>
                    <a:gd name="connsiteY0" fmla="*/ 482425 h 536856"/>
                    <a:gd name="connsiteX1" fmla="*/ 285632 w 1007459"/>
                    <a:gd name="connsiteY1" fmla="*/ 67880 h 536856"/>
                    <a:gd name="connsiteX2" fmla="*/ 701029 w 1007459"/>
                    <a:gd name="connsiteY2" fmla="*/ 35329 h 536856"/>
                    <a:gd name="connsiteX3" fmla="*/ 1007459 w 1007459"/>
                    <a:gd name="connsiteY3" fmla="*/ 419406 h 536856"/>
                    <a:gd name="connsiteX4" fmla="*/ 856579 w 1007459"/>
                    <a:gd name="connsiteY4" fmla="*/ 466593 h 536856"/>
                    <a:gd name="connsiteX5" fmla="*/ 652383 w 1007459"/>
                    <a:gd name="connsiteY5" fmla="*/ 229597 h 536856"/>
                    <a:gd name="connsiteX6" fmla="*/ 296852 w 1007459"/>
                    <a:gd name="connsiteY6" fmla="*/ 268035 h 536856"/>
                    <a:gd name="connsiteX7" fmla="*/ 154348 w 1007459"/>
                    <a:gd name="connsiteY7" fmla="*/ 516103 h 536856"/>
                    <a:gd name="connsiteX8" fmla="*/ 270 w 1007459"/>
                    <a:gd name="connsiteY8" fmla="*/ 482425 h 536856"/>
                    <a:gd name="connsiteX0" fmla="*/ 270 w 1007459"/>
                    <a:gd name="connsiteY0" fmla="*/ 482425 h 536856"/>
                    <a:gd name="connsiteX1" fmla="*/ 285632 w 1007459"/>
                    <a:gd name="connsiteY1" fmla="*/ 67880 h 536856"/>
                    <a:gd name="connsiteX2" fmla="*/ 701029 w 1007459"/>
                    <a:gd name="connsiteY2" fmla="*/ 35329 h 536856"/>
                    <a:gd name="connsiteX3" fmla="*/ 1007459 w 1007459"/>
                    <a:gd name="connsiteY3" fmla="*/ 419406 h 536856"/>
                    <a:gd name="connsiteX4" fmla="*/ 893950 w 1007459"/>
                    <a:gd name="connsiteY4" fmla="*/ 454924 h 536856"/>
                    <a:gd name="connsiteX5" fmla="*/ 652383 w 1007459"/>
                    <a:gd name="connsiteY5" fmla="*/ 229597 h 536856"/>
                    <a:gd name="connsiteX6" fmla="*/ 296852 w 1007459"/>
                    <a:gd name="connsiteY6" fmla="*/ 268035 h 536856"/>
                    <a:gd name="connsiteX7" fmla="*/ 154348 w 1007459"/>
                    <a:gd name="connsiteY7" fmla="*/ 516103 h 536856"/>
                    <a:gd name="connsiteX8" fmla="*/ 270 w 1007459"/>
                    <a:gd name="connsiteY8" fmla="*/ 482425 h 536856"/>
                    <a:gd name="connsiteX0" fmla="*/ 270 w 1007459"/>
                    <a:gd name="connsiteY0" fmla="*/ 482425 h 536856"/>
                    <a:gd name="connsiteX1" fmla="*/ 285632 w 1007459"/>
                    <a:gd name="connsiteY1" fmla="*/ 67880 h 536856"/>
                    <a:gd name="connsiteX2" fmla="*/ 701029 w 1007459"/>
                    <a:gd name="connsiteY2" fmla="*/ 35329 h 536856"/>
                    <a:gd name="connsiteX3" fmla="*/ 1007459 w 1007459"/>
                    <a:gd name="connsiteY3" fmla="*/ 419406 h 536856"/>
                    <a:gd name="connsiteX4" fmla="*/ 893950 w 1007459"/>
                    <a:gd name="connsiteY4" fmla="*/ 454924 h 536856"/>
                    <a:gd name="connsiteX5" fmla="*/ 652383 w 1007459"/>
                    <a:gd name="connsiteY5" fmla="*/ 229597 h 536856"/>
                    <a:gd name="connsiteX6" fmla="*/ 296852 w 1007459"/>
                    <a:gd name="connsiteY6" fmla="*/ 268035 h 536856"/>
                    <a:gd name="connsiteX7" fmla="*/ 154348 w 1007459"/>
                    <a:gd name="connsiteY7" fmla="*/ 516103 h 536856"/>
                    <a:gd name="connsiteX8" fmla="*/ 270 w 1007459"/>
                    <a:gd name="connsiteY8" fmla="*/ 482425 h 536856"/>
                    <a:gd name="connsiteX0" fmla="*/ 270 w 1007459"/>
                    <a:gd name="connsiteY0" fmla="*/ 482425 h 536856"/>
                    <a:gd name="connsiteX1" fmla="*/ 285632 w 1007459"/>
                    <a:gd name="connsiteY1" fmla="*/ 67880 h 536856"/>
                    <a:gd name="connsiteX2" fmla="*/ 701029 w 1007459"/>
                    <a:gd name="connsiteY2" fmla="*/ 35329 h 536856"/>
                    <a:gd name="connsiteX3" fmla="*/ 1007459 w 1007459"/>
                    <a:gd name="connsiteY3" fmla="*/ 419406 h 536856"/>
                    <a:gd name="connsiteX4" fmla="*/ 865351 w 1007459"/>
                    <a:gd name="connsiteY4" fmla="*/ 458087 h 536856"/>
                    <a:gd name="connsiteX5" fmla="*/ 652383 w 1007459"/>
                    <a:gd name="connsiteY5" fmla="*/ 229597 h 536856"/>
                    <a:gd name="connsiteX6" fmla="*/ 296852 w 1007459"/>
                    <a:gd name="connsiteY6" fmla="*/ 268035 h 536856"/>
                    <a:gd name="connsiteX7" fmla="*/ 154348 w 1007459"/>
                    <a:gd name="connsiteY7" fmla="*/ 516103 h 536856"/>
                    <a:gd name="connsiteX8" fmla="*/ 270 w 1007459"/>
                    <a:gd name="connsiteY8" fmla="*/ 482425 h 536856"/>
                    <a:gd name="connsiteX0" fmla="*/ 270 w 1007459"/>
                    <a:gd name="connsiteY0" fmla="*/ 482425 h 536856"/>
                    <a:gd name="connsiteX1" fmla="*/ 285632 w 1007459"/>
                    <a:gd name="connsiteY1" fmla="*/ 67880 h 536856"/>
                    <a:gd name="connsiteX2" fmla="*/ 701029 w 1007459"/>
                    <a:gd name="connsiteY2" fmla="*/ 35329 h 536856"/>
                    <a:gd name="connsiteX3" fmla="*/ 1007459 w 1007459"/>
                    <a:gd name="connsiteY3" fmla="*/ 419406 h 536856"/>
                    <a:gd name="connsiteX4" fmla="*/ 865351 w 1007459"/>
                    <a:gd name="connsiteY4" fmla="*/ 458087 h 536856"/>
                    <a:gd name="connsiteX5" fmla="*/ 652383 w 1007459"/>
                    <a:gd name="connsiteY5" fmla="*/ 229597 h 536856"/>
                    <a:gd name="connsiteX6" fmla="*/ 296852 w 1007459"/>
                    <a:gd name="connsiteY6" fmla="*/ 268035 h 536856"/>
                    <a:gd name="connsiteX7" fmla="*/ 154348 w 1007459"/>
                    <a:gd name="connsiteY7" fmla="*/ 516103 h 536856"/>
                    <a:gd name="connsiteX8" fmla="*/ 270 w 1007459"/>
                    <a:gd name="connsiteY8" fmla="*/ 482425 h 536856"/>
                    <a:gd name="connsiteX0" fmla="*/ 270 w 1007459"/>
                    <a:gd name="connsiteY0" fmla="*/ 482425 h 536856"/>
                    <a:gd name="connsiteX1" fmla="*/ 285632 w 1007459"/>
                    <a:gd name="connsiteY1" fmla="*/ 67880 h 536856"/>
                    <a:gd name="connsiteX2" fmla="*/ 701029 w 1007459"/>
                    <a:gd name="connsiteY2" fmla="*/ 35329 h 536856"/>
                    <a:gd name="connsiteX3" fmla="*/ 1007459 w 1007459"/>
                    <a:gd name="connsiteY3" fmla="*/ 419406 h 536856"/>
                    <a:gd name="connsiteX4" fmla="*/ 865351 w 1007459"/>
                    <a:gd name="connsiteY4" fmla="*/ 458087 h 536856"/>
                    <a:gd name="connsiteX5" fmla="*/ 652383 w 1007459"/>
                    <a:gd name="connsiteY5" fmla="*/ 229597 h 536856"/>
                    <a:gd name="connsiteX6" fmla="*/ 296852 w 1007459"/>
                    <a:gd name="connsiteY6" fmla="*/ 268035 h 536856"/>
                    <a:gd name="connsiteX7" fmla="*/ 154348 w 1007459"/>
                    <a:gd name="connsiteY7" fmla="*/ 516103 h 536856"/>
                    <a:gd name="connsiteX8" fmla="*/ 270 w 1007459"/>
                    <a:gd name="connsiteY8" fmla="*/ 482425 h 53685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1007459" h="536856">
                      <a:moveTo>
                        <a:pt x="270" y="482425"/>
                      </a:moveTo>
                      <a:cubicBezTo>
                        <a:pt x="-7847" y="351622"/>
                        <a:pt x="168839" y="142396"/>
                        <a:pt x="285632" y="67880"/>
                      </a:cubicBezTo>
                      <a:cubicBezTo>
                        <a:pt x="402425" y="-6636"/>
                        <a:pt x="580725" y="-23259"/>
                        <a:pt x="701029" y="35329"/>
                      </a:cubicBezTo>
                      <a:cubicBezTo>
                        <a:pt x="821333" y="93917"/>
                        <a:pt x="994852" y="282794"/>
                        <a:pt x="1007459" y="419406"/>
                      </a:cubicBezTo>
                      <a:cubicBezTo>
                        <a:pt x="1003945" y="488348"/>
                        <a:pt x="923483" y="458087"/>
                        <a:pt x="865351" y="458087"/>
                      </a:cubicBezTo>
                      <a:cubicBezTo>
                        <a:pt x="769515" y="222490"/>
                        <a:pt x="704631" y="267706"/>
                        <a:pt x="652383" y="229597"/>
                      </a:cubicBezTo>
                      <a:cubicBezTo>
                        <a:pt x="607384" y="191799"/>
                        <a:pt x="408577" y="195719"/>
                        <a:pt x="296852" y="268035"/>
                      </a:cubicBezTo>
                      <a:cubicBezTo>
                        <a:pt x="206862" y="364036"/>
                        <a:pt x="190043" y="421055"/>
                        <a:pt x="154348" y="516103"/>
                      </a:cubicBezTo>
                      <a:cubicBezTo>
                        <a:pt x="74754" y="561162"/>
                        <a:pt x="64239" y="524952"/>
                        <a:pt x="270" y="482425"/>
                      </a:cubicBezTo>
                      <a:close/>
                    </a:path>
                  </a:pathLst>
                </a:custGeom>
                <a:grpFill/>
                <a:ln>
                  <a:solidFill>
                    <a:schemeClr val="tx2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350" b="1">
                    <a:solidFill>
                      <a:schemeClr val="bg2">
                        <a:lumMod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" name="Block Arc 15"/>
                <p:cNvSpPr/>
                <p:nvPr/>
              </p:nvSpPr>
              <p:spPr>
                <a:xfrm rot="14327119" flipH="1">
                  <a:off x="3525160" y="3700739"/>
                  <a:ext cx="1001014" cy="511877"/>
                </a:xfrm>
                <a:custGeom>
                  <a:avLst/>
                  <a:gdLst>
                    <a:gd name="connsiteX0" fmla="*/ 627 w 745516"/>
                    <a:gd name="connsiteY0" fmla="*/ 369014 h 697590"/>
                    <a:gd name="connsiteX1" fmla="*/ 184209 w 745516"/>
                    <a:gd name="connsiteY1" fmla="*/ 47911 h 697590"/>
                    <a:gd name="connsiteX2" fmla="*/ 544181 w 745516"/>
                    <a:gd name="connsiteY2" fmla="*/ 39071 h 697590"/>
                    <a:gd name="connsiteX3" fmla="*/ 745515 w 745516"/>
                    <a:gd name="connsiteY3" fmla="*/ 348795 h 697590"/>
                    <a:gd name="connsiteX4" fmla="*/ 571119 w 745516"/>
                    <a:gd name="connsiteY4" fmla="*/ 348795 h 697590"/>
                    <a:gd name="connsiteX5" fmla="*/ 459552 w 745516"/>
                    <a:gd name="connsiteY5" fmla="*/ 191978 h 697590"/>
                    <a:gd name="connsiteX6" fmla="*/ 277038 w 745516"/>
                    <a:gd name="connsiteY6" fmla="*/ 196046 h 697590"/>
                    <a:gd name="connsiteX7" fmla="*/ 174775 w 745516"/>
                    <a:gd name="connsiteY7" fmla="*/ 359552 h 697590"/>
                    <a:gd name="connsiteX8" fmla="*/ 627 w 745516"/>
                    <a:gd name="connsiteY8" fmla="*/ 369014 h 697590"/>
                    <a:gd name="connsiteX0" fmla="*/ 629 w 745517"/>
                    <a:gd name="connsiteY0" fmla="*/ 369014 h 369014"/>
                    <a:gd name="connsiteX1" fmla="*/ 184211 w 745517"/>
                    <a:gd name="connsiteY1" fmla="*/ 47911 h 369014"/>
                    <a:gd name="connsiteX2" fmla="*/ 544183 w 745517"/>
                    <a:gd name="connsiteY2" fmla="*/ 39071 h 369014"/>
                    <a:gd name="connsiteX3" fmla="*/ 745517 w 745517"/>
                    <a:gd name="connsiteY3" fmla="*/ 348795 h 369014"/>
                    <a:gd name="connsiteX4" fmla="*/ 668191 w 745517"/>
                    <a:gd name="connsiteY4" fmla="*/ 363523 h 369014"/>
                    <a:gd name="connsiteX5" fmla="*/ 459554 w 745517"/>
                    <a:gd name="connsiteY5" fmla="*/ 191978 h 369014"/>
                    <a:gd name="connsiteX6" fmla="*/ 277040 w 745517"/>
                    <a:gd name="connsiteY6" fmla="*/ 196046 h 369014"/>
                    <a:gd name="connsiteX7" fmla="*/ 174777 w 745517"/>
                    <a:gd name="connsiteY7" fmla="*/ 359552 h 369014"/>
                    <a:gd name="connsiteX8" fmla="*/ 629 w 745517"/>
                    <a:gd name="connsiteY8" fmla="*/ 369014 h 369014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59554 w 745517"/>
                    <a:gd name="connsiteY5" fmla="*/ 191978 h 425833"/>
                    <a:gd name="connsiteX6" fmla="*/ 277040 w 745517"/>
                    <a:gd name="connsiteY6" fmla="*/ 196046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48149 w 745517"/>
                    <a:gd name="connsiteY5" fmla="*/ 197842 h 425833"/>
                    <a:gd name="connsiteX6" fmla="*/ 277040 w 745517"/>
                    <a:gd name="connsiteY6" fmla="*/ 196046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277040 w 745517"/>
                    <a:gd name="connsiteY6" fmla="*/ 196046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387239 w 745517"/>
                    <a:gd name="connsiteY6" fmla="*/ 147341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387239 w 745517"/>
                    <a:gd name="connsiteY6" fmla="*/ 147341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387239 w 745517"/>
                    <a:gd name="connsiteY6" fmla="*/ 147341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396919 w 745517"/>
                    <a:gd name="connsiteY6" fmla="*/ 199046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396919 w 745517"/>
                    <a:gd name="connsiteY5" fmla="*/ 199046 h 425833"/>
                    <a:gd name="connsiteX6" fmla="*/ 174777 w 745517"/>
                    <a:gd name="connsiteY6" fmla="*/ 359552 h 425833"/>
                    <a:gd name="connsiteX7" fmla="*/ 629 w 745517"/>
                    <a:gd name="connsiteY7" fmla="*/ 369014 h 425833"/>
                    <a:gd name="connsiteX0" fmla="*/ 629 w 777485"/>
                    <a:gd name="connsiteY0" fmla="*/ 364465 h 421284"/>
                    <a:gd name="connsiteX1" fmla="*/ 184211 w 777485"/>
                    <a:gd name="connsiteY1" fmla="*/ 43362 h 421284"/>
                    <a:gd name="connsiteX2" fmla="*/ 544183 w 777485"/>
                    <a:gd name="connsiteY2" fmla="*/ 34522 h 421284"/>
                    <a:gd name="connsiteX3" fmla="*/ 777485 w 777485"/>
                    <a:gd name="connsiteY3" fmla="*/ 302949 h 421284"/>
                    <a:gd name="connsiteX4" fmla="*/ 666916 w 777485"/>
                    <a:gd name="connsiteY4" fmla="*/ 421284 h 421284"/>
                    <a:gd name="connsiteX5" fmla="*/ 396919 w 777485"/>
                    <a:gd name="connsiteY5" fmla="*/ 194497 h 421284"/>
                    <a:gd name="connsiteX6" fmla="*/ 174777 w 777485"/>
                    <a:gd name="connsiteY6" fmla="*/ 355003 h 421284"/>
                    <a:gd name="connsiteX7" fmla="*/ 629 w 777485"/>
                    <a:gd name="connsiteY7" fmla="*/ 364465 h 421284"/>
                    <a:gd name="connsiteX0" fmla="*/ 629 w 777485"/>
                    <a:gd name="connsiteY0" fmla="*/ 364465 h 421284"/>
                    <a:gd name="connsiteX1" fmla="*/ 184211 w 777485"/>
                    <a:gd name="connsiteY1" fmla="*/ 43362 h 421284"/>
                    <a:gd name="connsiteX2" fmla="*/ 544183 w 777485"/>
                    <a:gd name="connsiteY2" fmla="*/ 34522 h 421284"/>
                    <a:gd name="connsiteX3" fmla="*/ 777485 w 777485"/>
                    <a:gd name="connsiteY3" fmla="*/ 302949 h 421284"/>
                    <a:gd name="connsiteX4" fmla="*/ 666916 w 777485"/>
                    <a:gd name="connsiteY4" fmla="*/ 421284 h 421284"/>
                    <a:gd name="connsiteX5" fmla="*/ 396919 w 777485"/>
                    <a:gd name="connsiteY5" fmla="*/ 194497 h 421284"/>
                    <a:gd name="connsiteX6" fmla="*/ 174777 w 777485"/>
                    <a:gd name="connsiteY6" fmla="*/ 355003 h 421284"/>
                    <a:gd name="connsiteX7" fmla="*/ 629 w 777485"/>
                    <a:gd name="connsiteY7" fmla="*/ 364465 h 421284"/>
                    <a:gd name="connsiteX0" fmla="*/ 629 w 777485"/>
                    <a:gd name="connsiteY0" fmla="*/ 364465 h 421284"/>
                    <a:gd name="connsiteX1" fmla="*/ 184211 w 777485"/>
                    <a:gd name="connsiteY1" fmla="*/ 43362 h 421284"/>
                    <a:gd name="connsiteX2" fmla="*/ 544183 w 777485"/>
                    <a:gd name="connsiteY2" fmla="*/ 34522 h 421284"/>
                    <a:gd name="connsiteX3" fmla="*/ 777485 w 777485"/>
                    <a:gd name="connsiteY3" fmla="*/ 302949 h 421284"/>
                    <a:gd name="connsiteX4" fmla="*/ 666916 w 777485"/>
                    <a:gd name="connsiteY4" fmla="*/ 421284 h 421284"/>
                    <a:gd name="connsiteX5" fmla="*/ 396919 w 777485"/>
                    <a:gd name="connsiteY5" fmla="*/ 194497 h 421284"/>
                    <a:gd name="connsiteX6" fmla="*/ 102409 w 777485"/>
                    <a:gd name="connsiteY6" fmla="*/ 373814 h 421284"/>
                    <a:gd name="connsiteX7" fmla="*/ 629 w 777485"/>
                    <a:gd name="connsiteY7" fmla="*/ 364465 h 421284"/>
                    <a:gd name="connsiteX0" fmla="*/ 329 w 828090"/>
                    <a:gd name="connsiteY0" fmla="*/ 354833 h 418791"/>
                    <a:gd name="connsiteX1" fmla="*/ 234816 w 828090"/>
                    <a:gd name="connsiteY1" fmla="*/ 40869 h 418791"/>
                    <a:gd name="connsiteX2" fmla="*/ 594788 w 828090"/>
                    <a:gd name="connsiteY2" fmla="*/ 32029 h 418791"/>
                    <a:gd name="connsiteX3" fmla="*/ 828090 w 828090"/>
                    <a:gd name="connsiteY3" fmla="*/ 300456 h 418791"/>
                    <a:gd name="connsiteX4" fmla="*/ 717521 w 828090"/>
                    <a:gd name="connsiteY4" fmla="*/ 418791 h 418791"/>
                    <a:gd name="connsiteX5" fmla="*/ 447524 w 828090"/>
                    <a:gd name="connsiteY5" fmla="*/ 192004 h 418791"/>
                    <a:gd name="connsiteX6" fmla="*/ 153014 w 828090"/>
                    <a:gd name="connsiteY6" fmla="*/ 371321 h 418791"/>
                    <a:gd name="connsiteX7" fmla="*/ 329 w 828090"/>
                    <a:gd name="connsiteY7" fmla="*/ 354833 h 418791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476599 w 857165"/>
                    <a:gd name="connsiteY5" fmla="*/ 191739 h 418526"/>
                    <a:gd name="connsiteX6" fmla="*/ 182089 w 857165"/>
                    <a:gd name="connsiteY6" fmla="*/ 371056 h 418526"/>
                    <a:gd name="connsiteX7" fmla="*/ 283 w 857165"/>
                    <a:gd name="connsiteY7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476599 w 857165"/>
                    <a:gd name="connsiteY5" fmla="*/ 191739 h 418526"/>
                    <a:gd name="connsiteX6" fmla="*/ 182089 w 857165"/>
                    <a:gd name="connsiteY6" fmla="*/ 371056 h 418526"/>
                    <a:gd name="connsiteX7" fmla="*/ 283 w 857165"/>
                    <a:gd name="connsiteY7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476599 w 857165"/>
                    <a:gd name="connsiteY5" fmla="*/ 191739 h 418526"/>
                    <a:gd name="connsiteX6" fmla="*/ 182089 w 857165"/>
                    <a:gd name="connsiteY6" fmla="*/ 371056 h 418526"/>
                    <a:gd name="connsiteX7" fmla="*/ 283 w 857165"/>
                    <a:gd name="connsiteY7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476599 w 857165"/>
                    <a:gd name="connsiteY5" fmla="*/ 191739 h 418526"/>
                    <a:gd name="connsiteX6" fmla="*/ 182089 w 857165"/>
                    <a:gd name="connsiteY6" fmla="*/ 371056 h 418526"/>
                    <a:gd name="connsiteX7" fmla="*/ 283 w 857165"/>
                    <a:gd name="connsiteY7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596226 w 857165"/>
                    <a:gd name="connsiteY5" fmla="*/ 269798 h 418526"/>
                    <a:gd name="connsiteX6" fmla="*/ 476599 w 857165"/>
                    <a:gd name="connsiteY6" fmla="*/ 191739 h 418526"/>
                    <a:gd name="connsiteX7" fmla="*/ 182089 w 857165"/>
                    <a:gd name="connsiteY7" fmla="*/ 371056 h 418526"/>
                    <a:gd name="connsiteX8" fmla="*/ 283 w 857165"/>
                    <a:gd name="connsiteY8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631337 w 857165"/>
                    <a:gd name="connsiteY5" fmla="*/ 261689 h 418526"/>
                    <a:gd name="connsiteX6" fmla="*/ 476599 w 857165"/>
                    <a:gd name="connsiteY6" fmla="*/ 191739 h 418526"/>
                    <a:gd name="connsiteX7" fmla="*/ 182089 w 857165"/>
                    <a:gd name="connsiteY7" fmla="*/ 371056 h 418526"/>
                    <a:gd name="connsiteX8" fmla="*/ 283 w 857165"/>
                    <a:gd name="connsiteY8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623229 w 857165"/>
                    <a:gd name="connsiteY5" fmla="*/ 226578 h 418526"/>
                    <a:gd name="connsiteX6" fmla="*/ 476599 w 857165"/>
                    <a:gd name="connsiteY6" fmla="*/ 191739 h 418526"/>
                    <a:gd name="connsiteX7" fmla="*/ 182089 w 857165"/>
                    <a:gd name="connsiteY7" fmla="*/ 371056 h 418526"/>
                    <a:gd name="connsiteX8" fmla="*/ 283 w 857165"/>
                    <a:gd name="connsiteY8" fmla="*/ 350149 h 418526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623229 w 857165"/>
                    <a:gd name="connsiteY5" fmla="*/ 226578 h 418077"/>
                    <a:gd name="connsiteX6" fmla="*/ 476599 w 857165"/>
                    <a:gd name="connsiteY6" fmla="*/ 191739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623229 w 857165"/>
                    <a:gd name="connsiteY5" fmla="*/ 226578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623229 w 857165"/>
                    <a:gd name="connsiteY5" fmla="*/ 226578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91288 w 857165"/>
                    <a:gd name="connsiteY5" fmla="*/ 217643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91288 w 857165"/>
                    <a:gd name="connsiteY5" fmla="*/ 217643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91288 w 857165"/>
                    <a:gd name="connsiteY5" fmla="*/ 217643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13122 w 857165"/>
                    <a:gd name="connsiteY6" fmla="*/ 233528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13122 w 857165"/>
                    <a:gd name="connsiteY6" fmla="*/ 233528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23181 w 857165"/>
                    <a:gd name="connsiteY6" fmla="*/ 213440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23181 w 857165"/>
                    <a:gd name="connsiteY6" fmla="*/ 213440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23181 w 857165"/>
                    <a:gd name="connsiteY6" fmla="*/ 213440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71599"/>
                    <a:gd name="connsiteX1" fmla="*/ 263891 w 857165"/>
                    <a:gd name="connsiteY1" fmla="*/ 40604 h 471599"/>
                    <a:gd name="connsiteX2" fmla="*/ 623863 w 857165"/>
                    <a:gd name="connsiteY2" fmla="*/ 31764 h 471599"/>
                    <a:gd name="connsiteX3" fmla="*/ 857165 w 857165"/>
                    <a:gd name="connsiteY3" fmla="*/ 300191 h 471599"/>
                    <a:gd name="connsiteX4" fmla="*/ 768237 w 857165"/>
                    <a:gd name="connsiteY4" fmla="*/ 471599 h 471599"/>
                    <a:gd name="connsiteX5" fmla="*/ 588791 w 857165"/>
                    <a:gd name="connsiteY5" fmla="*/ 241798 h 471599"/>
                    <a:gd name="connsiteX6" fmla="*/ 323181 w 857165"/>
                    <a:gd name="connsiteY6" fmla="*/ 213440 h 471599"/>
                    <a:gd name="connsiteX7" fmla="*/ 182089 w 857165"/>
                    <a:gd name="connsiteY7" fmla="*/ 371056 h 471599"/>
                    <a:gd name="connsiteX8" fmla="*/ 283 w 857165"/>
                    <a:gd name="connsiteY8" fmla="*/ 350149 h 471599"/>
                    <a:gd name="connsiteX0" fmla="*/ 283 w 922080"/>
                    <a:gd name="connsiteY0" fmla="*/ 359002 h 486990"/>
                    <a:gd name="connsiteX1" fmla="*/ 263891 w 922080"/>
                    <a:gd name="connsiteY1" fmla="*/ 49457 h 486990"/>
                    <a:gd name="connsiteX2" fmla="*/ 623863 w 922080"/>
                    <a:gd name="connsiteY2" fmla="*/ 40617 h 486990"/>
                    <a:gd name="connsiteX3" fmla="*/ 922080 w 922080"/>
                    <a:gd name="connsiteY3" fmla="*/ 440612 h 486990"/>
                    <a:gd name="connsiteX4" fmla="*/ 768237 w 922080"/>
                    <a:gd name="connsiteY4" fmla="*/ 480452 h 486990"/>
                    <a:gd name="connsiteX5" fmla="*/ 588791 w 922080"/>
                    <a:gd name="connsiteY5" fmla="*/ 250651 h 486990"/>
                    <a:gd name="connsiteX6" fmla="*/ 323181 w 922080"/>
                    <a:gd name="connsiteY6" fmla="*/ 222293 h 486990"/>
                    <a:gd name="connsiteX7" fmla="*/ 182089 w 922080"/>
                    <a:gd name="connsiteY7" fmla="*/ 379909 h 486990"/>
                    <a:gd name="connsiteX8" fmla="*/ 283 w 922080"/>
                    <a:gd name="connsiteY8" fmla="*/ 359002 h 486990"/>
                    <a:gd name="connsiteX0" fmla="*/ 283 w 925272"/>
                    <a:gd name="connsiteY0" fmla="*/ 357772 h 480085"/>
                    <a:gd name="connsiteX1" fmla="*/ 263891 w 925272"/>
                    <a:gd name="connsiteY1" fmla="*/ 48227 h 480085"/>
                    <a:gd name="connsiteX2" fmla="*/ 623863 w 925272"/>
                    <a:gd name="connsiteY2" fmla="*/ 39387 h 480085"/>
                    <a:gd name="connsiteX3" fmla="*/ 925272 w 925272"/>
                    <a:gd name="connsiteY3" fmla="*/ 421509 h 480085"/>
                    <a:gd name="connsiteX4" fmla="*/ 768237 w 925272"/>
                    <a:gd name="connsiteY4" fmla="*/ 479222 h 480085"/>
                    <a:gd name="connsiteX5" fmla="*/ 588791 w 925272"/>
                    <a:gd name="connsiteY5" fmla="*/ 249421 h 480085"/>
                    <a:gd name="connsiteX6" fmla="*/ 323181 w 925272"/>
                    <a:gd name="connsiteY6" fmla="*/ 221063 h 480085"/>
                    <a:gd name="connsiteX7" fmla="*/ 182089 w 925272"/>
                    <a:gd name="connsiteY7" fmla="*/ 378679 h 480085"/>
                    <a:gd name="connsiteX8" fmla="*/ 283 w 925272"/>
                    <a:gd name="connsiteY8" fmla="*/ 357772 h 480085"/>
                    <a:gd name="connsiteX0" fmla="*/ 283 w 925272"/>
                    <a:gd name="connsiteY0" fmla="*/ 357772 h 479899"/>
                    <a:gd name="connsiteX1" fmla="*/ 263891 w 925272"/>
                    <a:gd name="connsiteY1" fmla="*/ 48227 h 479899"/>
                    <a:gd name="connsiteX2" fmla="*/ 623863 w 925272"/>
                    <a:gd name="connsiteY2" fmla="*/ 39387 h 479899"/>
                    <a:gd name="connsiteX3" fmla="*/ 925272 w 925272"/>
                    <a:gd name="connsiteY3" fmla="*/ 421509 h 479899"/>
                    <a:gd name="connsiteX4" fmla="*/ 768237 w 925272"/>
                    <a:gd name="connsiteY4" fmla="*/ 479222 h 479899"/>
                    <a:gd name="connsiteX5" fmla="*/ 588791 w 925272"/>
                    <a:gd name="connsiteY5" fmla="*/ 249421 h 479899"/>
                    <a:gd name="connsiteX6" fmla="*/ 323181 w 925272"/>
                    <a:gd name="connsiteY6" fmla="*/ 221063 h 479899"/>
                    <a:gd name="connsiteX7" fmla="*/ 182089 w 925272"/>
                    <a:gd name="connsiteY7" fmla="*/ 378679 h 479899"/>
                    <a:gd name="connsiteX8" fmla="*/ 283 w 925272"/>
                    <a:gd name="connsiteY8" fmla="*/ 357772 h 479899"/>
                    <a:gd name="connsiteX0" fmla="*/ 283 w 925272"/>
                    <a:gd name="connsiteY0" fmla="*/ 357772 h 479899"/>
                    <a:gd name="connsiteX1" fmla="*/ 263891 w 925272"/>
                    <a:gd name="connsiteY1" fmla="*/ 48227 h 479899"/>
                    <a:gd name="connsiteX2" fmla="*/ 623863 w 925272"/>
                    <a:gd name="connsiteY2" fmla="*/ 39387 h 479899"/>
                    <a:gd name="connsiteX3" fmla="*/ 925272 w 925272"/>
                    <a:gd name="connsiteY3" fmla="*/ 421509 h 479899"/>
                    <a:gd name="connsiteX4" fmla="*/ 768237 w 925272"/>
                    <a:gd name="connsiteY4" fmla="*/ 479222 h 479899"/>
                    <a:gd name="connsiteX5" fmla="*/ 588791 w 925272"/>
                    <a:gd name="connsiteY5" fmla="*/ 249421 h 479899"/>
                    <a:gd name="connsiteX6" fmla="*/ 323181 w 925272"/>
                    <a:gd name="connsiteY6" fmla="*/ 221063 h 479899"/>
                    <a:gd name="connsiteX7" fmla="*/ 182089 w 925272"/>
                    <a:gd name="connsiteY7" fmla="*/ 378679 h 479899"/>
                    <a:gd name="connsiteX8" fmla="*/ 283 w 925272"/>
                    <a:gd name="connsiteY8" fmla="*/ 357772 h 479899"/>
                    <a:gd name="connsiteX0" fmla="*/ 283 w 925272"/>
                    <a:gd name="connsiteY0" fmla="*/ 357772 h 479899"/>
                    <a:gd name="connsiteX1" fmla="*/ 263891 w 925272"/>
                    <a:gd name="connsiteY1" fmla="*/ 48227 h 479899"/>
                    <a:gd name="connsiteX2" fmla="*/ 623863 w 925272"/>
                    <a:gd name="connsiteY2" fmla="*/ 39387 h 479899"/>
                    <a:gd name="connsiteX3" fmla="*/ 925272 w 925272"/>
                    <a:gd name="connsiteY3" fmla="*/ 421509 h 479899"/>
                    <a:gd name="connsiteX4" fmla="*/ 768237 w 925272"/>
                    <a:gd name="connsiteY4" fmla="*/ 479222 h 479899"/>
                    <a:gd name="connsiteX5" fmla="*/ 614360 w 925272"/>
                    <a:gd name="connsiteY5" fmla="*/ 239373 h 479899"/>
                    <a:gd name="connsiteX6" fmla="*/ 323181 w 925272"/>
                    <a:gd name="connsiteY6" fmla="*/ 221063 h 479899"/>
                    <a:gd name="connsiteX7" fmla="*/ 182089 w 925272"/>
                    <a:gd name="connsiteY7" fmla="*/ 378679 h 479899"/>
                    <a:gd name="connsiteX8" fmla="*/ 283 w 925272"/>
                    <a:gd name="connsiteY8" fmla="*/ 357772 h 479899"/>
                    <a:gd name="connsiteX0" fmla="*/ 283 w 925272"/>
                    <a:gd name="connsiteY0" fmla="*/ 357772 h 478527"/>
                    <a:gd name="connsiteX1" fmla="*/ 263891 w 925272"/>
                    <a:gd name="connsiteY1" fmla="*/ 48227 h 478527"/>
                    <a:gd name="connsiteX2" fmla="*/ 623863 w 925272"/>
                    <a:gd name="connsiteY2" fmla="*/ 39387 h 478527"/>
                    <a:gd name="connsiteX3" fmla="*/ 925272 w 925272"/>
                    <a:gd name="connsiteY3" fmla="*/ 421509 h 478527"/>
                    <a:gd name="connsiteX4" fmla="*/ 784939 w 925272"/>
                    <a:gd name="connsiteY4" fmla="*/ 477575 h 478527"/>
                    <a:gd name="connsiteX5" fmla="*/ 614360 w 925272"/>
                    <a:gd name="connsiteY5" fmla="*/ 239373 h 478527"/>
                    <a:gd name="connsiteX6" fmla="*/ 323181 w 925272"/>
                    <a:gd name="connsiteY6" fmla="*/ 221063 h 478527"/>
                    <a:gd name="connsiteX7" fmla="*/ 182089 w 925272"/>
                    <a:gd name="connsiteY7" fmla="*/ 378679 h 478527"/>
                    <a:gd name="connsiteX8" fmla="*/ 283 w 925272"/>
                    <a:gd name="connsiteY8" fmla="*/ 357772 h 478527"/>
                    <a:gd name="connsiteX0" fmla="*/ 283 w 925272"/>
                    <a:gd name="connsiteY0" fmla="*/ 357772 h 478527"/>
                    <a:gd name="connsiteX1" fmla="*/ 263891 w 925272"/>
                    <a:gd name="connsiteY1" fmla="*/ 48227 h 478527"/>
                    <a:gd name="connsiteX2" fmla="*/ 623863 w 925272"/>
                    <a:gd name="connsiteY2" fmla="*/ 39387 h 478527"/>
                    <a:gd name="connsiteX3" fmla="*/ 925272 w 925272"/>
                    <a:gd name="connsiteY3" fmla="*/ 421509 h 478527"/>
                    <a:gd name="connsiteX4" fmla="*/ 784939 w 925272"/>
                    <a:gd name="connsiteY4" fmla="*/ 477575 h 478527"/>
                    <a:gd name="connsiteX5" fmla="*/ 614360 w 925272"/>
                    <a:gd name="connsiteY5" fmla="*/ 239373 h 478527"/>
                    <a:gd name="connsiteX6" fmla="*/ 323181 w 925272"/>
                    <a:gd name="connsiteY6" fmla="*/ 221063 h 478527"/>
                    <a:gd name="connsiteX7" fmla="*/ 182089 w 925272"/>
                    <a:gd name="connsiteY7" fmla="*/ 378679 h 478527"/>
                    <a:gd name="connsiteX8" fmla="*/ 283 w 925272"/>
                    <a:gd name="connsiteY8" fmla="*/ 357772 h 478527"/>
                    <a:gd name="connsiteX0" fmla="*/ 283 w 925272"/>
                    <a:gd name="connsiteY0" fmla="*/ 357772 h 557834"/>
                    <a:gd name="connsiteX1" fmla="*/ 263891 w 925272"/>
                    <a:gd name="connsiteY1" fmla="*/ 48227 h 557834"/>
                    <a:gd name="connsiteX2" fmla="*/ 623863 w 925272"/>
                    <a:gd name="connsiteY2" fmla="*/ 39387 h 557834"/>
                    <a:gd name="connsiteX3" fmla="*/ 925272 w 925272"/>
                    <a:gd name="connsiteY3" fmla="*/ 421509 h 557834"/>
                    <a:gd name="connsiteX4" fmla="*/ 784939 w 925272"/>
                    <a:gd name="connsiteY4" fmla="*/ 477575 h 557834"/>
                    <a:gd name="connsiteX5" fmla="*/ 614360 w 925272"/>
                    <a:gd name="connsiteY5" fmla="*/ 239373 h 557834"/>
                    <a:gd name="connsiteX6" fmla="*/ 323181 w 925272"/>
                    <a:gd name="connsiteY6" fmla="*/ 221063 h 557834"/>
                    <a:gd name="connsiteX7" fmla="*/ 137577 w 925272"/>
                    <a:gd name="connsiteY7" fmla="*/ 551149 h 557834"/>
                    <a:gd name="connsiteX8" fmla="*/ 283 w 925272"/>
                    <a:gd name="connsiteY8" fmla="*/ 357772 h 557834"/>
                    <a:gd name="connsiteX0" fmla="*/ 283 w 925272"/>
                    <a:gd name="connsiteY0" fmla="*/ 357772 h 505215"/>
                    <a:gd name="connsiteX1" fmla="*/ 263891 w 925272"/>
                    <a:gd name="connsiteY1" fmla="*/ 48227 h 505215"/>
                    <a:gd name="connsiteX2" fmla="*/ 623863 w 925272"/>
                    <a:gd name="connsiteY2" fmla="*/ 39387 h 505215"/>
                    <a:gd name="connsiteX3" fmla="*/ 925272 w 925272"/>
                    <a:gd name="connsiteY3" fmla="*/ 421509 h 505215"/>
                    <a:gd name="connsiteX4" fmla="*/ 784939 w 925272"/>
                    <a:gd name="connsiteY4" fmla="*/ 477575 h 505215"/>
                    <a:gd name="connsiteX5" fmla="*/ 614360 w 925272"/>
                    <a:gd name="connsiteY5" fmla="*/ 239373 h 505215"/>
                    <a:gd name="connsiteX6" fmla="*/ 323181 w 925272"/>
                    <a:gd name="connsiteY6" fmla="*/ 221063 h 505215"/>
                    <a:gd name="connsiteX7" fmla="*/ 132607 w 925272"/>
                    <a:gd name="connsiteY7" fmla="*/ 496450 h 505215"/>
                    <a:gd name="connsiteX8" fmla="*/ 283 w 925272"/>
                    <a:gd name="connsiteY8" fmla="*/ 357772 h 505215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344909 w 947000"/>
                    <a:gd name="connsiteY6" fmla="*/ 227109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296839 w 947000"/>
                    <a:gd name="connsiteY6" fmla="*/ 254428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296839 w 947000"/>
                    <a:gd name="connsiteY6" fmla="*/ 254428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296839 w 947000"/>
                    <a:gd name="connsiteY6" fmla="*/ 254428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53488 w 947000"/>
                    <a:gd name="connsiteY5" fmla="*/ 203309 h 523249"/>
                    <a:gd name="connsiteX6" fmla="*/ 296839 w 947000"/>
                    <a:gd name="connsiteY6" fmla="*/ 254428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52370 w 947000"/>
                    <a:gd name="connsiteY5" fmla="*/ 215990 h 523249"/>
                    <a:gd name="connsiteX6" fmla="*/ 296839 w 947000"/>
                    <a:gd name="connsiteY6" fmla="*/ 254428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70 w 947013"/>
                    <a:gd name="connsiteY0" fmla="*/ 483982 h 538413"/>
                    <a:gd name="connsiteX1" fmla="*/ 285632 w 947013"/>
                    <a:gd name="connsiteY1" fmla="*/ 69437 h 538413"/>
                    <a:gd name="connsiteX2" fmla="*/ 701029 w 947013"/>
                    <a:gd name="connsiteY2" fmla="*/ 36886 h 538413"/>
                    <a:gd name="connsiteX3" fmla="*/ 947013 w 947013"/>
                    <a:gd name="connsiteY3" fmla="*/ 442719 h 538413"/>
                    <a:gd name="connsiteX4" fmla="*/ 806680 w 947013"/>
                    <a:gd name="connsiteY4" fmla="*/ 498785 h 538413"/>
                    <a:gd name="connsiteX5" fmla="*/ 652383 w 947013"/>
                    <a:gd name="connsiteY5" fmla="*/ 231154 h 538413"/>
                    <a:gd name="connsiteX6" fmla="*/ 296852 w 947013"/>
                    <a:gd name="connsiteY6" fmla="*/ 269592 h 538413"/>
                    <a:gd name="connsiteX7" fmla="*/ 154348 w 947013"/>
                    <a:gd name="connsiteY7" fmla="*/ 517660 h 538413"/>
                    <a:gd name="connsiteX8" fmla="*/ 270 w 947013"/>
                    <a:gd name="connsiteY8" fmla="*/ 483982 h 538413"/>
                    <a:gd name="connsiteX0" fmla="*/ 270 w 947013"/>
                    <a:gd name="connsiteY0" fmla="*/ 483982 h 538413"/>
                    <a:gd name="connsiteX1" fmla="*/ 285632 w 947013"/>
                    <a:gd name="connsiteY1" fmla="*/ 69437 h 538413"/>
                    <a:gd name="connsiteX2" fmla="*/ 701029 w 947013"/>
                    <a:gd name="connsiteY2" fmla="*/ 36886 h 538413"/>
                    <a:gd name="connsiteX3" fmla="*/ 947013 w 947013"/>
                    <a:gd name="connsiteY3" fmla="*/ 442719 h 538413"/>
                    <a:gd name="connsiteX4" fmla="*/ 856579 w 947013"/>
                    <a:gd name="connsiteY4" fmla="*/ 468150 h 538413"/>
                    <a:gd name="connsiteX5" fmla="*/ 652383 w 947013"/>
                    <a:gd name="connsiteY5" fmla="*/ 231154 h 538413"/>
                    <a:gd name="connsiteX6" fmla="*/ 296852 w 947013"/>
                    <a:gd name="connsiteY6" fmla="*/ 269592 h 538413"/>
                    <a:gd name="connsiteX7" fmla="*/ 154348 w 947013"/>
                    <a:gd name="connsiteY7" fmla="*/ 517660 h 538413"/>
                    <a:gd name="connsiteX8" fmla="*/ 270 w 947013"/>
                    <a:gd name="connsiteY8" fmla="*/ 483982 h 538413"/>
                    <a:gd name="connsiteX0" fmla="*/ 270 w 1007459"/>
                    <a:gd name="connsiteY0" fmla="*/ 482425 h 536856"/>
                    <a:gd name="connsiteX1" fmla="*/ 285632 w 1007459"/>
                    <a:gd name="connsiteY1" fmla="*/ 67880 h 536856"/>
                    <a:gd name="connsiteX2" fmla="*/ 701029 w 1007459"/>
                    <a:gd name="connsiteY2" fmla="*/ 35329 h 536856"/>
                    <a:gd name="connsiteX3" fmla="*/ 1007459 w 1007459"/>
                    <a:gd name="connsiteY3" fmla="*/ 419406 h 536856"/>
                    <a:gd name="connsiteX4" fmla="*/ 856579 w 1007459"/>
                    <a:gd name="connsiteY4" fmla="*/ 466593 h 536856"/>
                    <a:gd name="connsiteX5" fmla="*/ 652383 w 1007459"/>
                    <a:gd name="connsiteY5" fmla="*/ 229597 h 536856"/>
                    <a:gd name="connsiteX6" fmla="*/ 296852 w 1007459"/>
                    <a:gd name="connsiteY6" fmla="*/ 268035 h 536856"/>
                    <a:gd name="connsiteX7" fmla="*/ 154348 w 1007459"/>
                    <a:gd name="connsiteY7" fmla="*/ 516103 h 536856"/>
                    <a:gd name="connsiteX8" fmla="*/ 270 w 1007459"/>
                    <a:gd name="connsiteY8" fmla="*/ 482425 h 536856"/>
                    <a:gd name="connsiteX0" fmla="*/ 270 w 1007459"/>
                    <a:gd name="connsiteY0" fmla="*/ 482425 h 536856"/>
                    <a:gd name="connsiteX1" fmla="*/ 285632 w 1007459"/>
                    <a:gd name="connsiteY1" fmla="*/ 67880 h 536856"/>
                    <a:gd name="connsiteX2" fmla="*/ 701029 w 1007459"/>
                    <a:gd name="connsiteY2" fmla="*/ 35329 h 536856"/>
                    <a:gd name="connsiteX3" fmla="*/ 1007459 w 1007459"/>
                    <a:gd name="connsiteY3" fmla="*/ 419406 h 536856"/>
                    <a:gd name="connsiteX4" fmla="*/ 893950 w 1007459"/>
                    <a:gd name="connsiteY4" fmla="*/ 454924 h 536856"/>
                    <a:gd name="connsiteX5" fmla="*/ 652383 w 1007459"/>
                    <a:gd name="connsiteY5" fmla="*/ 229597 h 536856"/>
                    <a:gd name="connsiteX6" fmla="*/ 296852 w 1007459"/>
                    <a:gd name="connsiteY6" fmla="*/ 268035 h 536856"/>
                    <a:gd name="connsiteX7" fmla="*/ 154348 w 1007459"/>
                    <a:gd name="connsiteY7" fmla="*/ 516103 h 536856"/>
                    <a:gd name="connsiteX8" fmla="*/ 270 w 1007459"/>
                    <a:gd name="connsiteY8" fmla="*/ 482425 h 536856"/>
                    <a:gd name="connsiteX0" fmla="*/ 270 w 1007459"/>
                    <a:gd name="connsiteY0" fmla="*/ 482425 h 536856"/>
                    <a:gd name="connsiteX1" fmla="*/ 285632 w 1007459"/>
                    <a:gd name="connsiteY1" fmla="*/ 67880 h 536856"/>
                    <a:gd name="connsiteX2" fmla="*/ 701029 w 1007459"/>
                    <a:gd name="connsiteY2" fmla="*/ 35329 h 536856"/>
                    <a:gd name="connsiteX3" fmla="*/ 1007459 w 1007459"/>
                    <a:gd name="connsiteY3" fmla="*/ 419406 h 536856"/>
                    <a:gd name="connsiteX4" fmla="*/ 893950 w 1007459"/>
                    <a:gd name="connsiteY4" fmla="*/ 454924 h 536856"/>
                    <a:gd name="connsiteX5" fmla="*/ 652383 w 1007459"/>
                    <a:gd name="connsiteY5" fmla="*/ 229597 h 536856"/>
                    <a:gd name="connsiteX6" fmla="*/ 296852 w 1007459"/>
                    <a:gd name="connsiteY6" fmla="*/ 268035 h 536856"/>
                    <a:gd name="connsiteX7" fmla="*/ 154348 w 1007459"/>
                    <a:gd name="connsiteY7" fmla="*/ 516103 h 536856"/>
                    <a:gd name="connsiteX8" fmla="*/ 270 w 1007459"/>
                    <a:gd name="connsiteY8" fmla="*/ 482425 h 536856"/>
                    <a:gd name="connsiteX0" fmla="*/ 270 w 1007459"/>
                    <a:gd name="connsiteY0" fmla="*/ 482425 h 536856"/>
                    <a:gd name="connsiteX1" fmla="*/ 285632 w 1007459"/>
                    <a:gd name="connsiteY1" fmla="*/ 67880 h 536856"/>
                    <a:gd name="connsiteX2" fmla="*/ 701029 w 1007459"/>
                    <a:gd name="connsiteY2" fmla="*/ 35329 h 536856"/>
                    <a:gd name="connsiteX3" fmla="*/ 1007459 w 1007459"/>
                    <a:gd name="connsiteY3" fmla="*/ 419406 h 536856"/>
                    <a:gd name="connsiteX4" fmla="*/ 865351 w 1007459"/>
                    <a:gd name="connsiteY4" fmla="*/ 458087 h 536856"/>
                    <a:gd name="connsiteX5" fmla="*/ 652383 w 1007459"/>
                    <a:gd name="connsiteY5" fmla="*/ 229597 h 536856"/>
                    <a:gd name="connsiteX6" fmla="*/ 296852 w 1007459"/>
                    <a:gd name="connsiteY6" fmla="*/ 268035 h 536856"/>
                    <a:gd name="connsiteX7" fmla="*/ 154348 w 1007459"/>
                    <a:gd name="connsiteY7" fmla="*/ 516103 h 536856"/>
                    <a:gd name="connsiteX8" fmla="*/ 270 w 1007459"/>
                    <a:gd name="connsiteY8" fmla="*/ 482425 h 536856"/>
                    <a:gd name="connsiteX0" fmla="*/ 270 w 1007459"/>
                    <a:gd name="connsiteY0" fmla="*/ 482425 h 536856"/>
                    <a:gd name="connsiteX1" fmla="*/ 285632 w 1007459"/>
                    <a:gd name="connsiteY1" fmla="*/ 67880 h 536856"/>
                    <a:gd name="connsiteX2" fmla="*/ 701029 w 1007459"/>
                    <a:gd name="connsiteY2" fmla="*/ 35329 h 536856"/>
                    <a:gd name="connsiteX3" fmla="*/ 1007459 w 1007459"/>
                    <a:gd name="connsiteY3" fmla="*/ 419406 h 536856"/>
                    <a:gd name="connsiteX4" fmla="*/ 865351 w 1007459"/>
                    <a:gd name="connsiteY4" fmla="*/ 458087 h 536856"/>
                    <a:gd name="connsiteX5" fmla="*/ 652383 w 1007459"/>
                    <a:gd name="connsiteY5" fmla="*/ 229597 h 536856"/>
                    <a:gd name="connsiteX6" fmla="*/ 296852 w 1007459"/>
                    <a:gd name="connsiteY6" fmla="*/ 268035 h 536856"/>
                    <a:gd name="connsiteX7" fmla="*/ 154348 w 1007459"/>
                    <a:gd name="connsiteY7" fmla="*/ 516103 h 536856"/>
                    <a:gd name="connsiteX8" fmla="*/ 270 w 1007459"/>
                    <a:gd name="connsiteY8" fmla="*/ 482425 h 536856"/>
                    <a:gd name="connsiteX0" fmla="*/ 270 w 1007459"/>
                    <a:gd name="connsiteY0" fmla="*/ 482425 h 536856"/>
                    <a:gd name="connsiteX1" fmla="*/ 285632 w 1007459"/>
                    <a:gd name="connsiteY1" fmla="*/ 67880 h 536856"/>
                    <a:gd name="connsiteX2" fmla="*/ 701029 w 1007459"/>
                    <a:gd name="connsiteY2" fmla="*/ 35329 h 536856"/>
                    <a:gd name="connsiteX3" fmla="*/ 1007459 w 1007459"/>
                    <a:gd name="connsiteY3" fmla="*/ 419406 h 536856"/>
                    <a:gd name="connsiteX4" fmla="*/ 865351 w 1007459"/>
                    <a:gd name="connsiteY4" fmla="*/ 458087 h 536856"/>
                    <a:gd name="connsiteX5" fmla="*/ 652383 w 1007459"/>
                    <a:gd name="connsiteY5" fmla="*/ 229597 h 536856"/>
                    <a:gd name="connsiteX6" fmla="*/ 296852 w 1007459"/>
                    <a:gd name="connsiteY6" fmla="*/ 268035 h 536856"/>
                    <a:gd name="connsiteX7" fmla="*/ 154348 w 1007459"/>
                    <a:gd name="connsiteY7" fmla="*/ 516103 h 536856"/>
                    <a:gd name="connsiteX8" fmla="*/ 270 w 1007459"/>
                    <a:gd name="connsiteY8" fmla="*/ 482425 h 53685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1007459" h="536856">
                      <a:moveTo>
                        <a:pt x="270" y="482425"/>
                      </a:moveTo>
                      <a:cubicBezTo>
                        <a:pt x="-7847" y="351622"/>
                        <a:pt x="168839" y="142396"/>
                        <a:pt x="285632" y="67880"/>
                      </a:cubicBezTo>
                      <a:cubicBezTo>
                        <a:pt x="402425" y="-6636"/>
                        <a:pt x="580725" y="-23259"/>
                        <a:pt x="701029" y="35329"/>
                      </a:cubicBezTo>
                      <a:cubicBezTo>
                        <a:pt x="821333" y="93917"/>
                        <a:pt x="994852" y="282794"/>
                        <a:pt x="1007459" y="419406"/>
                      </a:cubicBezTo>
                      <a:cubicBezTo>
                        <a:pt x="1003945" y="488348"/>
                        <a:pt x="923483" y="458087"/>
                        <a:pt x="865351" y="458087"/>
                      </a:cubicBezTo>
                      <a:cubicBezTo>
                        <a:pt x="769515" y="222490"/>
                        <a:pt x="704631" y="267706"/>
                        <a:pt x="652383" y="229597"/>
                      </a:cubicBezTo>
                      <a:cubicBezTo>
                        <a:pt x="607384" y="191799"/>
                        <a:pt x="408577" y="195719"/>
                        <a:pt x="296852" y="268035"/>
                      </a:cubicBezTo>
                      <a:cubicBezTo>
                        <a:pt x="206862" y="364036"/>
                        <a:pt x="190043" y="421055"/>
                        <a:pt x="154348" y="516103"/>
                      </a:cubicBezTo>
                      <a:cubicBezTo>
                        <a:pt x="74754" y="561162"/>
                        <a:pt x="64239" y="524952"/>
                        <a:pt x="270" y="482425"/>
                      </a:cubicBezTo>
                      <a:close/>
                    </a:path>
                  </a:pathLst>
                </a:custGeom>
                <a:grpFill/>
                <a:ln>
                  <a:solidFill>
                    <a:schemeClr val="tx2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350" b="1">
                    <a:solidFill>
                      <a:schemeClr val="bg2">
                        <a:lumMod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10" name="Group 9"/>
            <p:cNvGrpSpPr/>
            <p:nvPr/>
          </p:nvGrpSpPr>
          <p:grpSpPr>
            <a:xfrm>
              <a:off x="3191390" y="1262681"/>
              <a:ext cx="662483" cy="931213"/>
              <a:chOff x="4188483" y="275835"/>
              <a:chExt cx="798172" cy="1121943"/>
            </a:xfrm>
          </p:grpSpPr>
          <p:pic>
            <p:nvPicPr>
              <p:cNvPr id="23" name="Picture 4" descr="http://image.marginup.com/u/u132/medium_MAB%283%29.jpg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ackgroundRemoval t="5729" b="85938" l="0" r="10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rot="10638944" flipH="1">
                <a:off x="4452194" y="275835"/>
                <a:ext cx="285241" cy="37004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grpSp>
            <p:nvGrpSpPr>
              <p:cNvPr id="24" name="Group 23"/>
              <p:cNvGrpSpPr/>
              <p:nvPr/>
            </p:nvGrpSpPr>
            <p:grpSpPr>
              <a:xfrm>
                <a:off x="4188483" y="613666"/>
                <a:ext cx="798172" cy="784112"/>
                <a:chOff x="5081048" y="613666"/>
                <a:chExt cx="798172" cy="784112"/>
              </a:xfrm>
              <a:solidFill>
                <a:schemeClr val="tx1">
                  <a:lumMod val="50000"/>
                  <a:lumOff val="50000"/>
                </a:schemeClr>
              </a:solidFill>
            </p:grpSpPr>
            <p:sp>
              <p:nvSpPr>
                <p:cNvPr id="25" name="Block Arc 15"/>
                <p:cNvSpPr/>
                <p:nvPr/>
              </p:nvSpPr>
              <p:spPr>
                <a:xfrm rot="5400000">
                  <a:off x="5133292" y="851014"/>
                  <a:ext cx="662348" cy="187652"/>
                </a:xfrm>
                <a:custGeom>
                  <a:avLst/>
                  <a:gdLst>
                    <a:gd name="connsiteX0" fmla="*/ 627 w 745516"/>
                    <a:gd name="connsiteY0" fmla="*/ 369014 h 697590"/>
                    <a:gd name="connsiteX1" fmla="*/ 184209 w 745516"/>
                    <a:gd name="connsiteY1" fmla="*/ 47911 h 697590"/>
                    <a:gd name="connsiteX2" fmla="*/ 544181 w 745516"/>
                    <a:gd name="connsiteY2" fmla="*/ 39071 h 697590"/>
                    <a:gd name="connsiteX3" fmla="*/ 745515 w 745516"/>
                    <a:gd name="connsiteY3" fmla="*/ 348795 h 697590"/>
                    <a:gd name="connsiteX4" fmla="*/ 571119 w 745516"/>
                    <a:gd name="connsiteY4" fmla="*/ 348795 h 697590"/>
                    <a:gd name="connsiteX5" fmla="*/ 459552 w 745516"/>
                    <a:gd name="connsiteY5" fmla="*/ 191978 h 697590"/>
                    <a:gd name="connsiteX6" fmla="*/ 277038 w 745516"/>
                    <a:gd name="connsiteY6" fmla="*/ 196046 h 697590"/>
                    <a:gd name="connsiteX7" fmla="*/ 174775 w 745516"/>
                    <a:gd name="connsiteY7" fmla="*/ 359552 h 697590"/>
                    <a:gd name="connsiteX8" fmla="*/ 627 w 745516"/>
                    <a:gd name="connsiteY8" fmla="*/ 369014 h 697590"/>
                    <a:gd name="connsiteX0" fmla="*/ 629 w 745517"/>
                    <a:gd name="connsiteY0" fmla="*/ 369014 h 369014"/>
                    <a:gd name="connsiteX1" fmla="*/ 184211 w 745517"/>
                    <a:gd name="connsiteY1" fmla="*/ 47911 h 369014"/>
                    <a:gd name="connsiteX2" fmla="*/ 544183 w 745517"/>
                    <a:gd name="connsiteY2" fmla="*/ 39071 h 369014"/>
                    <a:gd name="connsiteX3" fmla="*/ 745517 w 745517"/>
                    <a:gd name="connsiteY3" fmla="*/ 348795 h 369014"/>
                    <a:gd name="connsiteX4" fmla="*/ 668191 w 745517"/>
                    <a:gd name="connsiteY4" fmla="*/ 363523 h 369014"/>
                    <a:gd name="connsiteX5" fmla="*/ 459554 w 745517"/>
                    <a:gd name="connsiteY5" fmla="*/ 191978 h 369014"/>
                    <a:gd name="connsiteX6" fmla="*/ 277040 w 745517"/>
                    <a:gd name="connsiteY6" fmla="*/ 196046 h 369014"/>
                    <a:gd name="connsiteX7" fmla="*/ 174777 w 745517"/>
                    <a:gd name="connsiteY7" fmla="*/ 359552 h 369014"/>
                    <a:gd name="connsiteX8" fmla="*/ 629 w 745517"/>
                    <a:gd name="connsiteY8" fmla="*/ 369014 h 369014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59554 w 745517"/>
                    <a:gd name="connsiteY5" fmla="*/ 191978 h 425833"/>
                    <a:gd name="connsiteX6" fmla="*/ 277040 w 745517"/>
                    <a:gd name="connsiteY6" fmla="*/ 196046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48149 w 745517"/>
                    <a:gd name="connsiteY5" fmla="*/ 197842 h 425833"/>
                    <a:gd name="connsiteX6" fmla="*/ 277040 w 745517"/>
                    <a:gd name="connsiteY6" fmla="*/ 196046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277040 w 745517"/>
                    <a:gd name="connsiteY6" fmla="*/ 196046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387239 w 745517"/>
                    <a:gd name="connsiteY6" fmla="*/ 147341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387239 w 745517"/>
                    <a:gd name="connsiteY6" fmla="*/ 147341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387239 w 745517"/>
                    <a:gd name="connsiteY6" fmla="*/ 147341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396919 w 745517"/>
                    <a:gd name="connsiteY6" fmla="*/ 199046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396919 w 745517"/>
                    <a:gd name="connsiteY5" fmla="*/ 199046 h 425833"/>
                    <a:gd name="connsiteX6" fmla="*/ 174777 w 745517"/>
                    <a:gd name="connsiteY6" fmla="*/ 359552 h 425833"/>
                    <a:gd name="connsiteX7" fmla="*/ 629 w 745517"/>
                    <a:gd name="connsiteY7" fmla="*/ 369014 h 425833"/>
                    <a:gd name="connsiteX0" fmla="*/ 629 w 777485"/>
                    <a:gd name="connsiteY0" fmla="*/ 364465 h 421284"/>
                    <a:gd name="connsiteX1" fmla="*/ 184211 w 777485"/>
                    <a:gd name="connsiteY1" fmla="*/ 43362 h 421284"/>
                    <a:gd name="connsiteX2" fmla="*/ 544183 w 777485"/>
                    <a:gd name="connsiteY2" fmla="*/ 34522 h 421284"/>
                    <a:gd name="connsiteX3" fmla="*/ 777485 w 777485"/>
                    <a:gd name="connsiteY3" fmla="*/ 302949 h 421284"/>
                    <a:gd name="connsiteX4" fmla="*/ 666916 w 777485"/>
                    <a:gd name="connsiteY4" fmla="*/ 421284 h 421284"/>
                    <a:gd name="connsiteX5" fmla="*/ 396919 w 777485"/>
                    <a:gd name="connsiteY5" fmla="*/ 194497 h 421284"/>
                    <a:gd name="connsiteX6" fmla="*/ 174777 w 777485"/>
                    <a:gd name="connsiteY6" fmla="*/ 355003 h 421284"/>
                    <a:gd name="connsiteX7" fmla="*/ 629 w 777485"/>
                    <a:gd name="connsiteY7" fmla="*/ 364465 h 421284"/>
                    <a:gd name="connsiteX0" fmla="*/ 629 w 777485"/>
                    <a:gd name="connsiteY0" fmla="*/ 364465 h 421284"/>
                    <a:gd name="connsiteX1" fmla="*/ 184211 w 777485"/>
                    <a:gd name="connsiteY1" fmla="*/ 43362 h 421284"/>
                    <a:gd name="connsiteX2" fmla="*/ 544183 w 777485"/>
                    <a:gd name="connsiteY2" fmla="*/ 34522 h 421284"/>
                    <a:gd name="connsiteX3" fmla="*/ 777485 w 777485"/>
                    <a:gd name="connsiteY3" fmla="*/ 302949 h 421284"/>
                    <a:gd name="connsiteX4" fmla="*/ 666916 w 777485"/>
                    <a:gd name="connsiteY4" fmla="*/ 421284 h 421284"/>
                    <a:gd name="connsiteX5" fmla="*/ 396919 w 777485"/>
                    <a:gd name="connsiteY5" fmla="*/ 194497 h 421284"/>
                    <a:gd name="connsiteX6" fmla="*/ 174777 w 777485"/>
                    <a:gd name="connsiteY6" fmla="*/ 355003 h 421284"/>
                    <a:gd name="connsiteX7" fmla="*/ 629 w 777485"/>
                    <a:gd name="connsiteY7" fmla="*/ 364465 h 421284"/>
                    <a:gd name="connsiteX0" fmla="*/ 629 w 777485"/>
                    <a:gd name="connsiteY0" fmla="*/ 364465 h 421284"/>
                    <a:gd name="connsiteX1" fmla="*/ 184211 w 777485"/>
                    <a:gd name="connsiteY1" fmla="*/ 43362 h 421284"/>
                    <a:gd name="connsiteX2" fmla="*/ 544183 w 777485"/>
                    <a:gd name="connsiteY2" fmla="*/ 34522 h 421284"/>
                    <a:gd name="connsiteX3" fmla="*/ 777485 w 777485"/>
                    <a:gd name="connsiteY3" fmla="*/ 302949 h 421284"/>
                    <a:gd name="connsiteX4" fmla="*/ 666916 w 777485"/>
                    <a:gd name="connsiteY4" fmla="*/ 421284 h 421284"/>
                    <a:gd name="connsiteX5" fmla="*/ 396919 w 777485"/>
                    <a:gd name="connsiteY5" fmla="*/ 194497 h 421284"/>
                    <a:gd name="connsiteX6" fmla="*/ 102409 w 777485"/>
                    <a:gd name="connsiteY6" fmla="*/ 373814 h 421284"/>
                    <a:gd name="connsiteX7" fmla="*/ 629 w 777485"/>
                    <a:gd name="connsiteY7" fmla="*/ 364465 h 421284"/>
                    <a:gd name="connsiteX0" fmla="*/ 329 w 828090"/>
                    <a:gd name="connsiteY0" fmla="*/ 354833 h 418791"/>
                    <a:gd name="connsiteX1" fmla="*/ 234816 w 828090"/>
                    <a:gd name="connsiteY1" fmla="*/ 40869 h 418791"/>
                    <a:gd name="connsiteX2" fmla="*/ 594788 w 828090"/>
                    <a:gd name="connsiteY2" fmla="*/ 32029 h 418791"/>
                    <a:gd name="connsiteX3" fmla="*/ 828090 w 828090"/>
                    <a:gd name="connsiteY3" fmla="*/ 300456 h 418791"/>
                    <a:gd name="connsiteX4" fmla="*/ 717521 w 828090"/>
                    <a:gd name="connsiteY4" fmla="*/ 418791 h 418791"/>
                    <a:gd name="connsiteX5" fmla="*/ 447524 w 828090"/>
                    <a:gd name="connsiteY5" fmla="*/ 192004 h 418791"/>
                    <a:gd name="connsiteX6" fmla="*/ 153014 w 828090"/>
                    <a:gd name="connsiteY6" fmla="*/ 371321 h 418791"/>
                    <a:gd name="connsiteX7" fmla="*/ 329 w 828090"/>
                    <a:gd name="connsiteY7" fmla="*/ 354833 h 418791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476599 w 857165"/>
                    <a:gd name="connsiteY5" fmla="*/ 191739 h 418526"/>
                    <a:gd name="connsiteX6" fmla="*/ 182089 w 857165"/>
                    <a:gd name="connsiteY6" fmla="*/ 371056 h 418526"/>
                    <a:gd name="connsiteX7" fmla="*/ 283 w 857165"/>
                    <a:gd name="connsiteY7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476599 w 857165"/>
                    <a:gd name="connsiteY5" fmla="*/ 191739 h 418526"/>
                    <a:gd name="connsiteX6" fmla="*/ 182089 w 857165"/>
                    <a:gd name="connsiteY6" fmla="*/ 371056 h 418526"/>
                    <a:gd name="connsiteX7" fmla="*/ 283 w 857165"/>
                    <a:gd name="connsiteY7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476599 w 857165"/>
                    <a:gd name="connsiteY5" fmla="*/ 191739 h 418526"/>
                    <a:gd name="connsiteX6" fmla="*/ 182089 w 857165"/>
                    <a:gd name="connsiteY6" fmla="*/ 371056 h 418526"/>
                    <a:gd name="connsiteX7" fmla="*/ 283 w 857165"/>
                    <a:gd name="connsiteY7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476599 w 857165"/>
                    <a:gd name="connsiteY5" fmla="*/ 191739 h 418526"/>
                    <a:gd name="connsiteX6" fmla="*/ 182089 w 857165"/>
                    <a:gd name="connsiteY6" fmla="*/ 371056 h 418526"/>
                    <a:gd name="connsiteX7" fmla="*/ 283 w 857165"/>
                    <a:gd name="connsiteY7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596226 w 857165"/>
                    <a:gd name="connsiteY5" fmla="*/ 269798 h 418526"/>
                    <a:gd name="connsiteX6" fmla="*/ 476599 w 857165"/>
                    <a:gd name="connsiteY6" fmla="*/ 191739 h 418526"/>
                    <a:gd name="connsiteX7" fmla="*/ 182089 w 857165"/>
                    <a:gd name="connsiteY7" fmla="*/ 371056 h 418526"/>
                    <a:gd name="connsiteX8" fmla="*/ 283 w 857165"/>
                    <a:gd name="connsiteY8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631337 w 857165"/>
                    <a:gd name="connsiteY5" fmla="*/ 261689 h 418526"/>
                    <a:gd name="connsiteX6" fmla="*/ 476599 w 857165"/>
                    <a:gd name="connsiteY6" fmla="*/ 191739 h 418526"/>
                    <a:gd name="connsiteX7" fmla="*/ 182089 w 857165"/>
                    <a:gd name="connsiteY7" fmla="*/ 371056 h 418526"/>
                    <a:gd name="connsiteX8" fmla="*/ 283 w 857165"/>
                    <a:gd name="connsiteY8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623229 w 857165"/>
                    <a:gd name="connsiteY5" fmla="*/ 226578 h 418526"/>
                    <a:gd name="connsiteX6" fmla="*/ 476599 w 857165"/>
                    <a:gd name="connsiteY6" fmla="*/ 191739 h 418526"/>
                    <a:gd name="connsiteX7" fmla="*/ 182089 w 857165"/>
                    <a:gd name="connsiteY7" fmla="*/ 371056 h 418526"/>
                    <a:gd name="connsiteX8" fmla="*/ 283 w 857165"/>
                    <a:gd name="connsiteY8" fmla="*/ 350149 h 418526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623229 w 857165"/>
                    <a:gd name="connsiteY5" fmla="*/ 226578 h 418077"/>
                    <a:gd name="connsiteX6" fmla="*/ 476599 w 857165"/>
                    <a:gd name="connsiteY6" fmla="*/ 191739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623229 w 857165"/>
                    <a:gd name="connsiteY5" fmla="*/ 226578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623229 w 857165"/>
                    <a:gd name="connsiteY5" fmla="*/ 226578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91288 w 857165"/>
                    <a:gd name="connsiteY5" fmla="*/ 217643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91288 w 857165"/>
                    <a:gd name="connsiteY5" fmla="*/ 217643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91288 w 857165"/>
                    <a:gd name="connsiteY5" fmla="*/ 217643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13122 w 857165"/>
                    <a:gd name="connsiteY6" fmla="*/ 233528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13122 w 857165"/>
                    <a:gd name="connsiteY6" fmla="*/ 233528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23181 w 857165"/>
                    <a:gd name="connsiteY6" fmla="*/ 213440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23181 w 857165"/>
                    <a:gd name="connsiteY6" fmla="*/ 213440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23181 w 857165"/>
                    <a:gd name="connsiteY6" fmla="*/ 213440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71599"/>
                    <a:gd name="connsiteX1" fmla="*/ 263891 w 857165"/>
                    <a:gd name="connsiteY1" fmla="*/ 40604 h 471599"/>
                    <a:gd name="connsiteX2" fmla="*/ 623863 w 857165"/>
                    <a:gd name="connsiteY2" fmla="*/ 31764 h 471599"/>
                    <a:gd name="connsiteX3" fmla="*/ 857165 w 857165"/>
                    <a:gd name="connsiteY3" fmla="*/ 300191 h 471599"/>
                    <a:gd name="connsiteX4" fmla="*/ 768237 w 857165"/>
                    <a:gd name="connsiteY4" fmla="*/ 471599 h 471599"/>
                    <a:gd name="connsiteX5" fmla="*/ 588791 w 857165"/>
                    <a:gd name="connsiteY5" fmla="*/ 241798 h 471599"/>
                    <a:gd name="connsiteX6" fmla="*/ 323181 w 857165"/>
                    <a:gd name="connsiteY6" fmla="*/ 213440 h 471599"/>
                    <a:gd name="connsiteX7" fmla="*/ 182089 w 857165"/>
                    <a:gd name="connsiteY7" fmla="*/ 371056 h 471599"/>
                    <a:gd name="connsiteX8" fmla="*/ 283 w 857165"/>
                    <a:gd name="connsiteY8" fmla="*/ 350149 h 471599"/>
                    <a:gd name="connsiteX0" fmla="*/ 283 w 922080"/>
                    <a:gd name="connsiteY0" fmla="*/ 359002 h 486990"/>
                    <a:gd name="connsiteX1" fmla="*/ 263891 w 922080"/>
                    <a:gd name="connsiteY1" fmla="*/ 49457 h 486990"/>
                    <a:gd name="connsiteX2" fmla="*/ 623863 w 922080"/>
                    <a:gd name="connsiteY2" fmla="*/ 40617 h 486990"/>
                    <a:gd name="connsiteX3" fmla="*/ 922080 w 922080"/>
                    <a:gd name="connsiteY3" fmla="*/ 440612 h 486990"/>
                    <a:gd name="connsiteX4" fmla="*/ 768237 w 922080"/>
                    <a:gd name="connsiteY4" fmla="*/ 480452 h 486990"/>
                    <a:gd name="connsiteX5" fmla="*/ 588791 w 922080"/>
                    <a:gd name="connsiteY5" fmla="*/ 250651 h 486990"/>
                    <a:gd name="connsiteX6" fmla="*/ 323181 w 922080"/>
                    <a:gd name="connsiteY6" fmla="*/ 222293 h 486990"/>
                    <a:gd name="connsiteX7" fmla="*/ 182089 w 922080"/>
                    <a:gd name="connsiteY7" fmla="*/ 379909 h 486990"/>
                    <a:gd name="connsiteX8" fmla="*/ 283 w 922080"/>
                    <a:gd name="connsiteY8" fmla="*/ 359002 h 486990"/>
                    <a:gd name="connsiteX0" fmla="*/ 283 w 925272"/>
                    <a:gd name="connsiteY0" fmla="*/ 357772 h 480085"/>
                    <a:gd name="connsiteX1" fmla="*/ 263891 w 925272"/>
                    <a:gd name="connsiteY1" fmla="*/ 48227 h 480085"/>
                    <a:gd name="connsiteX2" fmla="*/ 623863 w 925272"/>
                    <a:gd name="connsiteY2" fmla="*/ 39387 h 480085"/>
                    <a:gd name="connsiteX3" fmla="*/ 925272 w 925272"/>
                    <a:gd name="connsiteY3" fmla="*/ 421509 h 480085"/>
                    <a:gd name="connsiteX4" fmla="*/ 768237 w 925272"/>
                    <a:gd name="connsiteY4" fmla="*/ 479222 h 480085"/>
                    <a:gd name="connsiteX5" fmla="*/ 588791 w 925272"/>
                    <a:gd name="connsiteY5" fmla="*/ 249421 h 480085"/>
                    <a:gd name="connsiteX6" fmla="*/ 323181 w 925272"/>
                    <a:gd name="connsiteY6" fmla="*/ 221063 h 480085"/>
                    <a:gd name="connsiteX7" fmla="*/ 182089 w 925272"/>
                    <a:gd name="connsiteY7" fmla="*/ 378679 h 480085"/>
                    <a:gd name="connsiteX8" fmla="*/ 283 w 925272"/>
                    <a:gd name="connsiteY8" fmla="*/ 357772 h 480085"/>
                    <a:gd name="connsiteX0" fmla="*/ 283 w 925272"/>
                    <a:gd name="connsiteY0" fmla="*/ 357772 h 479899"/>
                    <a:gd name="connsiteX1" fmla="*/ 263891 w 925272"/>
                    <a:gd name="connsiteY1" fmla="*/ 48227 h 479899"/>
                    <a:gd name="connsiteX2" fmla="*/ 623863 w 925272"/>
                    <a:gd name="connsiteY2" fmla="*/ 39387 h 479899"/>
                    <a:gd name="connsiteX3" fmla="*/ 925272 w 925272"/>
                    <a:gd name="connsiteY3" fmla="*/ 421509 h 479899"/>
                    <a:gd name="connsiteX4" fmla="*/ 768237 w 925272"/>
                    <a:gd name="connsiteY4" fmla="*/ 479222 h 479899"/>
                    <a:gd name="connsiteX5" fmla="*/ 588791 w 925272"/>
                    <a:gd name="connsiteY5" fmla="*/ 249421 h 479899"/>
                    <a:gd name="connsiteX6" fmla="*/ 323181 w 925272"/>
                    <a:gd name="connsiteY6" fmla="*/ 221063 h 479899"/>
                    <a:gd name="connsiteX7" fmla="*/ 182089 w 925272"/>
                    <a:gd name="connsiteY7" fmla="*/ 378679 h 479899"/>
                    <a:gd name="connsiteX8" fmla="*/ 283 w 925272"/>
                    <a:gd name="connsiteY8" fmla="*/ 357772 h 479899"/>
                    <a:gd name="connsiteX0" fmla="*/ 283 w 925272"/>
                    <a:gd name="connsiteY0" fmla="*/ 357772 h 479899"/>
                    <a:gd name="connsiteX1" fmla="*/ 263891 w 925272"/>
                    <a:gd name="connsiteY1" fmla="*/ 48227 h 479899"/>
                    <a:gd name="connsiteX2" fmla="*/ 623863 w 925272"/>
                    <a:gd name="connsiteY2" fmla="*/ 39387 h 479899"/>
                    <a:gd name="connsiteX3" fmla="*/ 925272 w 925272"/>
                    <a:gd name="connsiteY3" fmla="*/ 421509 h 479899"/>
                    <a:gd name="connsiteX4" fmla="*/ 768237 w 925272"/>
                    <a:gd name="connsiteY4" fmla="*/ 479222 h 479899"/>
                    <a:gd name="connsiteX5" fmla="*/ 588791 w 925272"/>
                    <a:gd name="connsiteY5" fmla="*/ 249421 h 479899"/>
                    <a:gd name="connsiteX6" fmla="*/ 323181 w 925272"/>
                    <a:gd name="connsiteY6" fmla="*/ 221063 h 479899"/>
                    <a:gd name="connsiteX7" fmla="*/ 182089 w 925272"/>
                    <a:gd name="connsiteY7" fmla="*/ 378679 h 479899"/>
                    <a:gd name="connsiteX8" fmla="*/ 283 w 925272"/>
                    <a:gd name="connsiteY8" fmla="*/ 357772 h 479899"/>
                    <a:gd name="connsiteX0" fmla="*/ 283 w 925272"/>
                    <a:gd name="connsiteY0" fmla="*/ 357772 h 479899"/>
                    <a:gd name="connsiteX1" fmla="*/ 263891 w 925272"/>
                    <a:gd name="connsiteY1" fmla="*/ 48227 h 479899"/>
                    <a:gd name="connsiteX2" fmla="*/ 623863 w 925272"/>
                    <a:gd name="connsiteY2" fmla="*/ 39387 h 479899"/>
                    <a:gd name="connsiteX3" fmla="*/ 925272 w 925272"/>
                    <a:gd name="connsiteY3" fmla="*/ 421509 h 479899"/>
                    <a:gd name="connsiteX4" fmla="*/ 768237 w 925272"/>
                    <a:gd name="connsiteY4" fmla="*/ 479222 h 479899"/>
                    <a:gd name="connsiteX5" fmla="*/ 614360 w 925272"/>
                    <a:gd name="connsiteY5" fmla="*/ 239373 h 479899"/>
                    <a:gd name="connsiteX6" fmla="*/ 323181 w 925272"/>
                    <a:gd name="connsiteY6" fmla="*/ 221063 h 479899"/>
                    <a:gd name="connsiteX7" fmla="*/ 182089 w 925272"/>
                    <a:gd name="connsiteY7" fmla="*/ 378679 h 479899"/>
                    <a:gd name="connsiteX8" fmla="*/ 283 w 925272"/>
                    <a:gd name="connsiteY8" fmla="*/ 357772 h 479899"/>
                    <a:gd name="connsiteX0" fmla="*/ 283 w 925272"/>
                    <a:gd name="connsiteY0" fmla="*/ 357772 h 478527"/>
                    <a:gd name="connsiteX1" fmla="*/ 263891 w 925272"/>
                    <a:gd name="connsiteY1" fmla="*/ 48227 h 478527"/>
                    <a:gd name="connsiteX2" fmla="*/ 623863 w 925272"/>
                    <a:gd name="connsiteY2" fmla="*/ 39387 h 478527"/>
                    <a:gd name="connsiteX3" fmla="*/ 925272 w 925272"/>
                    <a:gd name="connsiteY3" fmla="*/ 421509 h 478527"/>
                    <a:gd name="connsiteX4" fmla="*/ 784939 w 925272"/>
                    <a:gd name="connsiteY4" fmla="*/ 477575 h 478527"/>
                    <a:gd name="connsiteX5" fmla="*/ 614360 w 925272"/>
                    <a:gd name="connsiteY5" fmla="*/ 239373 h 478527"/>
                    <a:gd name="connsiteX6" fmla="*/ 323181 w 925272"/>
                    <a:gd name="connsiteY6" fmla="*/ 221063 h 478527"/>
                    <a:gd name="connsiteX7" fmla="*/ 182089 w 925272"/>
                    <a:gd name="connsiteY7" fmla="*/ 378679 h 478527"/>
                    <a:gd name="connsiteX8" fmla="*/ 283 w 925272"/>
                    <a:gd name="connsiteY8" fmla="*/ 357772 h 478527"/>
                    <a:gd name="connsiteX0" fmla="*/ 283 w 925272"/>
                    <a:gd name="connsiteY0" fmla="*/ 357772 h 478527"/>
                    <a:gd name="connsiteX1" fmla="*/ 263891 w 925272"/>
                    <a:gd name="connsiteY1" fmla="*/ 48227 h 478527"/>
                    <a:gd name="connsiteX2" fmla="*/ 623863 w 925272"/>
                    <a:gd name="connsiteY2" fmla="*/ 39387 h 478527"/>
                    <a:gd name="connsiteX3" fmla="*/ 925272 w 925272"/>
                    <a:gd name="connsiteY3" fmla="*/ 421509 h 478527"/>
                    <a:gd name="connsiteX4" fmla="*/ 784939 w 925272"/>
                    <a:gd name="connsiteY4" fmla="*/ 477575 h 478527"/>
                    <a:gd name="connsiteX5" fmla="*/ 614360 w 925272"/>
                    <a:gd name="connsiteY5" fmla="*/ 239373 h 478527"/>
                    <a:gd name="connsiteX6" fmla="*/ 323181 w 925272"/>
                    <a:gd name="connsiteY6" fmla="*/ 221063 h 478527"/>
                    <a:gd name="connsiteX7" fmla="*/ 182089 w 925272"/>
                    <a:gd name="connsiteY7" fmla="*/ 378679 h 478527"/>
                    <a:gd name="connsiteX8" fmla="*/ 283 w 925272"/>
                    <a:gd name="connsiteY8" fmla="*/ 357772 h 478527"/>
                    <a:gd name="connsiteX0" fmla="*/ 283 w 925272"/>
                    <a:gd name="connsiteY0" fmla="*/ 357772 h 557834"/>
                    <a:gd name="connsiteX1" fmla="*/ 263891 w 925272"/>
                    <a:gd name="connsiteY1" fmla="*/ 48227 h 557834"/>
                    <a:gd name="connsiteX2" fmla="*/ 623863 w 925272"/>
                    <a:gd name="connsiteY2" fmla="*/ 39387 h 557834"/>
                    <a:gd name="connsiteX3" fmla="*/ 925272 w 925272"/>
                    <a:gd name="connsiteY3" fmla="*/ 421509 h 557834"/>
                    <a:gd name="connsiteX4" fmla="*/ 784939 w 925272"/>
                    <a:gd name="connsiteY4" fmla="*/ 477575 h 557834"/>
                    <a:gd name="connsiteX5" fmla="*/ 614360 w 925272"/>
                    <a:gd name="connsiteY5" fmla="*/ 239373 h 557834"/>
                    <a:gd name="connsiteX6" fmla="*/ 323181 w 925272"/>
                    <a:gd name="connsiteY6" fmla="*/ 221063 h 557834"/>
                    <a:gd name="connsiteX7" fmla="*/ 137577 w 925272"/>
                    <a:gd name="connsiteY7" fmla="*/ 551149 h 557834"/>
                    <a:gd name="connsiteX8" fmla="*/ 283 w 925272"/>
                    <a:gd name="connsiteY8" fmla="*/ 357772 h 557834"/>
                    <a:gd name="connsiteX0" fmla="*/ 283 w 925272"/>
                    <a:gd name="connsiteY0" fmla="*/ 357772 h 505215"/>
                    <a:gd name="connsiteX1" fmla="*/ 263891 w 925272"/>
                    <a:gd name="connsiteY1" fmla="*/ 48227 h 505215"/>
                    <a:gd name="connsiteX2" fmla="*/ 623863 w 925272"/>
                    <a:gd name="connsiteY2" fmla="*/ 39387 h 505215"/>
                    <a:gd name="connsiteX3" fmla="*/ 925272 w 925272"/>
                    <a:gd name="connsiteY3" fmla="*/ 421509 h 505215"/>
                    <a:gd name="connsiteX4" fmla="*/ 784939 w 925272"/>
                    <a:gd name="connsiteY4" fmla="*/ 477575 h 505215"/>
                    <a:gd name="connsiteX5" fmla="*/ 614360 w 925272"/>
                    <a:gd name="connsiteY5" fmla="*/ 239373 h 505215"/>
                    <a:gd name="connsiteX6" fmla="*/ 323181 w 925272"/>
                    <a:gd name="connsiteY6" fmla="*/ 221063 h 505215"/>
                    <a:gd name="connsiteX7" fmla="*/ 132607 w 925272"/>
                    <a:gd name="connsiteY7" fmla="*/ 496450 h 505215"/>
                    <a:gd name="connsiteX8" fmla="*/ 283 w 925272"/>
                    <a:gd name="connsiteY8" fmla="*/ 357772 h 505215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344909 w 947000"/>
                    <a:gd name="connsiteY6" fmla="*/ 227109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296839 w 947000"/>
                    <a:gd name="connsiteY6" fmla="*/ 254428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296839 w 947000"/>
                    <a:gd name="connsiteY6" fmla="*/ 254428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296839 w 947000"/>
                    <a:gd name="connsiteY6" fmla="*/ 254428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295554 w 947000"/>
                    <a:gd name="connsiteY6" fmla="*/ 372286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2261 w 947000"/>
                    <a:gd name="connsiteY5" fmla="*/ 503987 h 523249"/>
                    <a:gd name="connsiteX6" fmla="*/ 295554 w 947000"/>
                    <a:gd name="connsiteY6" fmla="*/ 372286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9 w 947002"/>
                    <a:gd name="connsiteY0" fmla="*/ 433331 h 487762"/>
                    <a:gd name="connsiteX1" fmla="*/ 285621 w 947002"/>
                    <a:gd name="connsiteY1" fmla="*/ 18786 h 487762"/>
                    <a:gd name="connsiteX2" fmla="*/ 655110 w 947002"/>
                    <a:gd name="connsiteY2" fmla="*/ 103264 h 487762"/>
                    <a:gd name="connsiteX3" fmla="*/ 947002 w 947002"/>
                    <a:gd name="connsiteY3" fmla="*/ 392068 h 487762"/>
                    <a:gd name="connsiteX4" fmla="*/ 806669 w 947002"/>
                    <a:gd name="connsiteY4" fmla="*/ 448134 h 487762"/>
                    <a:gd name="connsiteX5" fmla="*/ 632263 w 947002"/>
                    <a:gd name="connsiteY5" fmla="*/ 468500 h 487762"/>
                    <a:gd name="connsiteX6" fmla="*/ 295556 w 947002"/>
                    <a:gd name="connsiteY6" fmla="*/ 336799 h 487762"/>
                    <a:gd name="connsiteX7" fmla="*/ 154337 w 947002"/>
                    <a:gd name="connsiteY7" fmla="*/ 467009 h 487762"/>
                    <a:gd name="connsiteX8" fmla="*/ 259 w 947002"/>
                    <a:gd name="connsiteY8" fmla="*/ 433331 h 487762"/>
                    <a:gd name="connsiteX0" fmla="*/ 243 w 946986"/>
                    <a:gd name="connsiteY0" fmla="*/ 412146 h 466577"/>
                    <a:gd name="connsiteX1" fmla="*/ 298890 w 946986"/>
                    <a:gd name="connsiteY1" fmla="*/ 22384 h 466577"/>
                    <a:gd name="connsiteX2" fmla="*/ 655094 w 946986"/>
                    <a:gd name="connsiteY2" fmla="*/ 82079 h 466577"/>
                    <a:gd name="connsiteX3" fmla="*/ 946986 w 946986"/>
                    <a:gd name="connsiteY3" fmla="*/ 370883 h 466577"/>
                    <a:gd name="connsiteX4" fmla="*/ 806653 w 946986"/>
                    <a:gd name="connsiteY4" fmla="*/ 426949 h 466577"/>
                    <a:gd name="connsiteX5" fmla="*/ 632247 w 946986"/>
                    <a:gd name="connsiteY5" fmla="*/ 447315 h 466577"/>
                    <a:gd name="connsiteX6" fmla="*/ 295540 w 946986"/>
                    <a:gd name="connsiteY6" fmla="*/ 315614 h 466577"/>
                    <a:gd name="connsiteX7" fmla="*/ 154321 w 946986"/>
                    <a:gd name="connsiteY7" fmla="*/ 445824 h 466577"/>
                    <a:gd name="connsiteX8" fmla="*/ 243 w 946986"/>
                    <a:gd name="connsiteY8" fmla="*/ 412146 h 466577"/>
                    <a:gd name="connsiteX0" fmla="*/ 243 w 946986"/>
                    <a:gd name="connsiteY0" fmla="*/ 412146 h 466577"/>
                    <a:gd name="connsiteX1" fmla="*/ 298890 w 946986"/>
                    <a:gd name="connsiteY1" fmla="*/ 22384 h 466577"/>
                    <a:gd name="connsiteX2" fmla="*/ 655094 w 946986"/>
                    <a:gd name="connsiteY2" fmla="*/ 82079 h 466577"/>
                    <a:gd name="connsiteX3" fmla="*/ 946986 w 946986"/>
                    <a:gd name="connsiteY3" fmla="*/ 370883 h 466577"/>
                    <a:gd name="connsiteX4" fmla="*/ 806653 w 946986"/>
                    <a:gd name="connsiteY4" fmla="*/ 426949 h 466577"/>
                    <a:gd name="connsiteX5" fmla="*/ 559793 w 946986"/>
                    <a:gd name="connsiteY5" fmla="*/ 347102 h 466577"/>
                    <a:gd name="connsiteX6" fmla="*/ 295540 w 946986"/>
                    <a:gd name="connsiteY6" fmla="*/ 315614 h 466577"/>
                    <a:gd name="connsiteX7" fmla="*/ 154321 w 946986"/>
                    <a:gd name="connsiteY7" fmla="*/ 445824 h 466577"/>
                    <a:gd name="connsiteX8" fmla="*/ 243 w 946986"/>
                    <a:gd name="connsiteY8" fmla="*/ 412146 h 466577"/>
                    <a:gd name="connsiteX0" fmla="*/ 243 w 946986"/>
                    <a:gd name="connsiteY0" fmla="*/ 412146 h 466577"/>
                    <a:gd name="connsiteX1" fmla="*/ 298890 w 946986"/>
                    <a:gd name="connsiteY1" fmla="*/ 22384 h 466577"/>
                    <a:gd name="connsiteX2" fmla="*/ 655094 w 946986"/>
                    <a:gd name="connsiteY2" fmla="*/ 82079 h 466577"/>
                    <a:gd name="connsiteX3" fmla="*/ 946986 w 946986"/>
                    <a:gd name="connsiteY3" fmla="*/ 370883 h 466577"/>
                    <a:gd name="connsiteX4" fmla="*/ 806653 w 946986"/>
                    <a:gd name="connsiteY4" fmla="*/ 426949 h 466577"/>
                    <a:gd name="connsiteX5" fmla="*/ 662849 w 946986"/>
                    <a:gd name="connsiteY5" fmla="*/ 369624 h 466577"/>
                    <a:gd name="connsiteX6" fmla="*/ 295540 w 946986"/>
                    <a:gd name="connsiteY6" fmla="*/ 315614 h 466577"/>
                    <a:gd name="connsiteX7" fmla="*/ 154321 w 946986"/>
                    <a:gd name="connsiteY7" fmla="*/ 445824 h 466577"/>
                    <a:gd name="connsiteX8" fmla="*/ 243 w 946986"/>
                    <a:gd name="connsiteY8" fmla="*/ 412146 h 466577"/>
                    <a:gd name="connsiteX0" fmla="*/ 243 w 946986"/>
                    <a:gd name="connsiteY0" fmla="*/ 412146 h 427901"/>
                    <a:gd name="connsiteX1" fmla="*/ 298890 w 946986"/>
                    <a:gd name="connsiteY1" fmla="*/ 22384 h 427901"/>
                    <a:gd name="connsiteX2" fmla="*/ 655094 w 946986"/>
                    <a:gd name="connsiteY2" fmla="*/ 82079 h 427901"/>
                    <a:gd name="connsiteX3" fmla="*/ 946986 w 946986"/>
                    <a:gd name="connsiteY3" fmla="*/ 370883 h 427901"/>
                    <a:gd name="connsiteX4" fmla="*/ 806653 w 946986"/>
                    <a:gd name="connsiteY4" fmla="*/ 426949 h 427901"/>
                    <a:gd name="connsiteX5" fmla="*/ 662849 w 946986"/>
                    <a:gd name="connsiteY5" fmla="*/ 369624 h 427901"/>
                    <a:gd name="connsiteX6" fmla="*/ 295540 w 946986"/>
                    <a:gd name="connsiteY6" fmla="*/ 315614 h 427901"/>
                    <a:gd name="connsiteX7" fmla="*/ 156720 w 946986"/>
                    <a:gd name="connsiteY7" fmla="*/ 355738 h 427901"/>
                    <a:gd name="connsiteX8" fmla="*/ 243 w 946986"/>
                    <a:gd name="connsiteY8" fmla="*/ 412146 h 427901"/>
                    <a:gd name="connsiteX0" fmla="*/ 272 w 920653"/>
                    <a:gd name="connsiteY0" fmla="*/ 209335 h 414265"/>
                    <a:gd name="connsiteX1" fmla="*/ 272557 w 920653"/>
                    <a:gd name="connsiteY1" fmla="*/ 8748 h 414265"/>
                    <a:gd name="connsiteX2" fmla="*/ 628761 w 920653"/>
                    <a:gd name="connsiteY2" fmla="*/ 68443 h 414265"/>
                    <a:gd name="connsiteX3" fmla="*/ 920653 w 920653"/>
                    <a:gd name="connsiteY3" fmla="*/ 357247 h 414265"/>
                    <a:gd name="connsiteX4" fmla="*/ 780320 w 920653"/>
                    <a:gd name="connsiteY4" fmla="*/ 413313 h 414265"/>
                    <a:gd name="connsiteX5" fmla="*/ 636516 w 920653"/>
                    <a:gd name="connsiteY5" fmla="*/ 355988 h 414265"/>
                    <a:gd name="connsiteX6" fmla="*/ 269207 w 920653"/>
                    <a:gd name="connsiteY6" fmla="*/ 301978 h 414265"/>
                    <a:gd name="connsiteX7" fmla="*/ 130387 w 920653"/>
                    <a:gd name="connsiteY7" fmla="*/ 342102 h 414265"/>
                    <a:gd name="connsiteX8" fmla="*/ 272 w 920653"/>
                    <a:gd name="connsiteY8" fmla="*/ 209335 h 414265"/>
                    <a:gd name="connsiteX0" fmla="*/ 272 w 920653"/>
                    <a:gd name="connsiteY0" fmla="*/ 209335 h 414265"/>
                    <a:gd name="connsiteX1" fmla="*/ 272557 w 920653"/>
                    <a:gd name="connsiteY1" fmla="*/ 8748 h 414265"/>
                    <a:gd name="connsiteX2" fmla="*/ 628761 w 920653"/>
                    <a:gd name="connsiteY2" fmla="*/ 68443 h 414265"/>
                    <a:gd name="connsiteX3" fmla="*/ 920653 w 920653"/>
                    <a:gd name="connsiteY3" fmla="*/ 357247 h 414265"/>
                    <a:gd name="connsiteX4" fmla="*/ 780320 w 920653"/>
                    <a:gd name="connsiteY4" fmla="*/ 413313 h 414265"/>
                    <a:gd name="connsiteX5" fmla="*/ 636516 w 920653"/>
                    <a:gd name="connsiteY5" fmla="*/ 355988 h 414265"/>
                    <a:gd name="connsiteX6" fmla="*/ 269207 w 920653"/>
                    <a:gd name="connsiteY6" fmla="*/ 301978 h 414265"/>
                    <a:gd name="connsiteX7" fmla="*/ 130387 w 920653"/>
                    <a:gd name="connsiteY7" fmla="*/ 342102 h 414265"/>
                    <a:gd name="connsiteX8" fmla="*/ 272 w 920653"/>
                    <a:gd name="connsiteY8" fmla="*/ 209335 h 414265"/>
                    <a:gd name="connsiteX0" fmla="*/ 272 w 920653"/>
                    <a:gd name="connsiteY0" fmla="*/ 209335 h 414265"/>
                    <a:gd name="connsiteX1" fmla="*/ 272557 w 920653"/>
                    <a:gd name="connsiteY1" fmla="*/ 8748 h 414265"/>
                    <a:gd name="connsiteX2" fmla="*/ 628761 w 920653"/>
                    <a:gd name="connsiteY2" fmla="*/ 68443 h 414265"/>
                    <a:gd name="connsiteX3" fmla="*/ 920653 w 920653"/>
                    <a:gd name="connsiteY3" fmla="*/ 357247 h 414265"/>
                    <a:gd name="connsiteX4" fmla="*/ 780320 w 920653"/>
                    <a:gd name="connsiteY4" fmla="*/ 413313 h 414265"/>
                    <a:gd name="connsiteX5" fmla="*/ 636516 w 920653"/>
                    <a:gd name="connsiteY5" fmla="*/ 355988 h 414265"/>
                    <a:gd name="connsiteX6" fmla="*/ 269207 w 920653"/>
                    <a:gd name="connsiteY6" fmla="*/ 301978 h 414265"/>
                    <a:gd name="connsiteX7" fmla="*/ 130387 w 920653"/>
                    <a:gd name="connsiteY7" fmla="*/ 342102 h 414265"/>
                    <a:gd name="connsiteX8" fmla="*/ 272 w 920653"/>
                    <a:gd name="connsiteY8" fmla="*/ 209335 h 414265"/>
                    <a:gd name="connsiteX0" fmla="*/ 0 w 920381"/>
                    <a:gd name="connsiteY0" fmla="*/ 209335 h 414265"/>
                    <a:gd name="connsiteX1" fmla="*/ 272285 w 920381"/>
                    <a:gd name="connsiteY1" fmla="*/ 8748 h 414265"/>
                    <a:gd name="connsiteX2" fmla="*/ 628489 w 920381"/>
                    <a:gd name="connsiteY2" fmla="*/ 68443 h 414265"/>
                    <a:gd name="connsiteX3" fmla="*/ 920381 w 920381"/>
                    <a:gd name="connsiteY3" fmla="*/ 357247 h 414265"/>
                    <a:gd name="connsiteX4" fmla="*/ 780048 w 920381"/>
                    <a:gd name="connsiteY4" fmla="*/ 413313 h 414265"/>
                    <a:gd name="connsiteX5" fmla="*/ 636244 w 920381"/>
                    <a:gd name="connsiteY5" fmla="*/ 355988 h 414265"/>
                    <a:gd name="connsiteX6" fmla="*/ 268935 w 920381"/>
                    <a:gd name="connsiteY6" fmla="*/ 301978 h 414265"/>
                    <a:gd name="connsiteX7" fmla="*/ 130115 w 920381"/>
                    <a:gd name="connsiteY7" fmla="*/ 342102 h 414265"/>
                    <a:gd name="connsiteX8" fmla="*/ 0 w 920381"/>
                    <a:gd name="connsiteY8" fmla="*/ 209335 h 414265"/>
                    <a:gd name="connsiteX0" fmla="*/ 0 w 920381"/>
                    <a:gd name="connsiteY0" fmla="*/ 209335 h 414265"/>
                    <a:gd name="connsiteX1" fmla="*/ 272285 w 920381"/>
                    <a:gd name="connsiteY1" fmla="*/ 8748 h 414265"/>
                    <a:gd name="connsiteX2" fmla="*/ 628489 w 920381"/>
                    <a:gd name="connsiteY2" fmla="*/ 68443 h 414265"/>
                    <a:gd name="connsiteX3" fmla="*/ 920381 w 920381"/>
                    <a:gd name="connsiteY3" fmla="*/ 357247 h 414265"/>
                    <a:gd name="connsiteX4" fmla="*/ 780048 w 920381"/>
                    <a:gd name="connsiteY4" fmla="*/ 413313 h 414265"/>
                    <a:gd name="connsiteX5" fmla="*/ 636244 w 920381"/>
                    <a:gd name="connsiteY5" fmla="*/ 355988 h 414265"/>
                    <a:gd name="connsiteX6" fmla="*/ 268935 w 920381"/>
                    <a:gd name="connsiteY6" fmla="*/ 301978 h 414265"/>
                    <a:gd name="connsiteX7" fmla="*/ 130115 w 920381"/>
                    <a:gd name="connsiteY7" fmla="*/ 342102 h 414265"/>
                    <a:gd name="connsiteX8" fmla="*/ 0 w 920381"/>
                    <a:gd name="connsiteY8" fmla="*/ 209335 h 414265"/>
                    <a:gd name="connsiteX0" fmla="*/ 0 w 920381"/>
                    <a:gd name="connsiteY0" fmla="*/ 209335 h 414265"/>
                    <a:gd name="connsiteX1" fmla="*/ 272285 w 920381"/>
                    <a:gd name="connsiteY1" fmla="*/ 8748 h 414265"/>
                    <a:gd name="connsiteX2" fmla="*/ 628489 w 920381"/>
                    <a:gd name="connsiteY2" fmla="*/ 68443 h 414265"/>
                    <a:gd name="connsiteX3" fmla="*/ 920381 w 920381"/>
                    <a:gd name="connsiteY3" fmla="*/ 357247 h 414265"/>
                    <a:gd name="connsiteX4" fmla="*/ 780048 w 920381"/>
                    <a:gd name="connsiteY4" fmla="*/ 413313 h 414265"/>
                    <a:gd name="connsiteX5" fmla="*/ 636244 w 920381"/>
                    <a:gd name="connsiteY5" fmla="*/ 355988 h 414265"/>
                    <a:gd name="connsiteX6" fmla="*/ 268935 w 920381"/>
                    <a:gd name="connsiteY6" fmla="*/ 301978 h 414265"/>
                    <a:gd name="connsiteX7" fmla="*/ 67804 w 920381"/>
                    <a:gd name="connsiteY7" fmla="*/ 337598 h 414265"/>
                    <a:gd name="connsiteX8" fmla="*/ 0 w 920381"/>
                    <a:gd name="connsiteY8" fmla="*/ 209335 h 414265"/>
                    <a:gd name="connsiteX0" fmla="*/ 0 w 908398"/>
                    <a:gd name="connsiteY0" fmla="*/ 175601 h 412061"/>
                    <a:gd name="connsiteX1" fmla="*/ 260302 w 908398"/>
                    <a:gd name="connsiteY1" fmla="*/ 6544 h 412061"/>
                    <a:gd name="connsiteX2" fmla="*/ 616506 w 908398"/>
                    <a:gd name="connsiteY2" fmla="*/ 66239 h 412061"/>
                    <a:gd name="connsiteX3" fmla="*/ 908398 w 908398"/>
                    <a:gd name="connsiteY3" fmla="*/ 355043 h 412061"/>
                    <a:gd name="connsiteX4" fmla="*/ 768065 w 908398"/>
                    <a:gd name="connsiteY4" fmla="*/ 411109 h 412061"/>
                    <a:gd name="connsiteX5" fmla="*/ 624261 w 908398"/>
                    <a:gd name="connsiteY5" fmla="*/ 353784 h 412061"/>
                    <a:gd name="connsiteX6" fmla="*/ 256952 w 908398"/>
                    <a:gd name="connsiteY6" fmla="*/ 299774 h 412061"/>
                    <a:gd name="connsiteX7" fmla="*/ 55821 w 908398"/>
                    <a:gd name="connsiteY7" fmla="*/ 335394 h 412061"/>
                    <a:gd name="connsiteX8" fmla="*/ 0 w 908398"/>
                    <a:gd name="connsiteY8" fmla="*/ 175601 h 412061"/>
                    <a:gd name="connsiteX0" fmla="*/ 0 w 908398"/>
                    <a:gd name="connsiteY0" fmla="*/ 175601 h 412061"/>
                    <a:gd name="connsiteX1" fmla="*/ 260302 w 908398"/>
                    <a:gd name="connsiteY1" fmla="*/ 6544 h 412061"/>
                    <a:gd name="connsiteX2" fmla="*/ 616506 w 908398"/>
                    <a:gd name="connsiteY2" fmla="*/ 66239 h 412061"/>
                    <a:gd name="connsiteX3" fmla="*/ 908398 w 908398"/>
                    <a:gd name="connsiteY3" fmla="*/ 355043 h 412061"/>
                    <a:gd name="connsiteX4" fmla="*/ 768065 w 908398"/>
                    <a:gd name="connsiteY4" fmla="*/ 411109 h 412061"/>
                    <a:gd name="connsiteX5" fmla="*/ 624261 w 908398"/>
                    <a:gd name="connsiteY5" fmla="*/ 353784 h 412061"/>
                    <a:gd name="connsiteX6" fmla="*/ 256952 w 908398"/>
                    <a:gd name="connsiteY6" fmla="*/ 299774 h 412061"/>
                    <a:gd name="connsiteX7" fmla="*/ 55824 w 908398"/>
                    <a:gd name="connsiteY7" fmla="*/ 353410 h 412061"/>
                    <a:gd name="connsiteX8" fmla="*/ 0 w 908398"/>
                    <a:gd name="connsiteY8" fmla="*/ 175601 h 412061"/>
                    <a:gd name="connsiteX0" fmla="*/ 0 w 908398"/>
                    <a:gd name="connsiteY0" fmla="*/ 175601 h 412061"/>
                    <a:gd name="connsiteX1" fmla="*/ 260302 w 908398"/>
                    <a:gd name="connsiteY1" fmla="*/ 6544 h 412061"/>
                    <a:gd name="connsiteX2" fmla="*/ 616506 w 908398"/>
                    <a:gd name="connsiteY2" fmla="*/ 66239 h 412061"/>
                    <a:gd name="connsiteX3" fmla="*/ 908398 w 908398"/>
                    <a:gd name="connsiteY3" fmla="*/ 355043 h 412061"/>
                    <a:gd name="connsiteX4" fmla="*/ 768065 w 908398"/>
                    <a:gd name="connsiteY4" fmla="*/ 411109 h 412061"/>
                    <a:gd name="connsiteX5" fmla="*/ 624261 w 908398"/>
                    <a:gd name="connsiteY5" fmla="*/ 353784 h 412061"/>
                    <a:gd name="connsiteX6" fmla="*/ 256952 w 908398"/>
                    <a:gd name="connsiteY6" fmla="*/ 299774 h 412061"/>
                    <a:gd name="connsiteX7" fmla="*/ 55824 w 908398"/>
                    <a:gd name="connsiteY7" fmla="*/ 353410 h 412061"/>
                    <a:gd name="connsiteX8" fmla="*/ 0 w 908398"/>
                    <a:gd name="connsiteY8" fmla="*/ 175601 h 412061"/>
                    <a:gd name="connsiteX0" fmla="*/ 5504 w 897124"/>
                    <a:gd name="connsiteY0" fmla="*/ 185232 h 412685"/>
                    <a:gd name="connsiteX1" fmla="*/ 249028 w 897124"/>
                    <a:gd name="connsiteY1" fmla="*/ 7168 h 412685"/>
                    <a:gd name="connsiteX2" fmla="*/ 605232 w 897124"/>
                    <a:gd name="connsiteY2" fmla="*/ 66863 h 412685"/>
                    <a:gd name="connsiteX3" fmla="*/ 897124 w 897124"/>
                    <a:gd name="connsiteY3" fmla="*/ 355667 h 412685"/>
                    <a:gd name="connsiteX4" fmla="*/ 756791 w 897124"/>
                    <a:gd name="connsiteY4" fmla="*/ 411733 h 412685"/>
                    <a:gd name="connsiteX5" fmla="*/ 612987 w 897124"/>
                    <a:gd name="connsiteY5" fmla="*/ 354408 h 412685"/>
                    <a:gd name="connsiteX6" fmla="*/ 245678 w 897124"/>
                    <a:gd name="connsiteY6" fmla="*/ 300398 h 412685"/>
                    <a:gd name="connsiteX7" fmla="*/ 44550 w 897124"/>
                    <a:gd name="connsiteY7" fmla="*/ 354034 h 412685"/>
                    <a:gd name="connsiteX8" fmla="*/ 5504 w 897124"/>
                    <a:gd name="connsiteY8" fmla="*/ 185232 h 412685"/>
                    <a:gd name="connsiteX0" fmla="*/ 6907 w 896127"/>
                    <a:gd name="connsiteY0" fmla="*/ 141914 h 409908"/>
                    <a:gd name="connsiteX1" fmla="*/ 248031 w 896127"/>
                    <a:gd name="connsiteY1" fmla="*/ 4391 h 409908"/>
                    <a:gd name="connsiteX2" fmla="*/ 604235 w 896127"/>
                    <a:gd name="connsiteY2" fmla="*/ 64086 h 409908"/>
                    <a:gd name="connsiteX3" fmla="*/ 896127 w 896127"/>
                    <a:gd name="connsiteY3" fmla="*/ 352890 h 409908"/>
                    <a:gd name="connsiteX4" fmla="*/ 755794 w 896127"/>
                    <a:gd name="connsiteY4" fmla="*/ 408956 h 409908"/>
                    <a:gd name="connsiteX5" fmla="*/ 611990 w 896127"/>
                    <a:gd name="connsiteY5" fmla="*/ 351631 h 409908"/>
                    <a:gd name="connsiteX6" fmla="*/ 244681 w 896127"/>
                    <a:gd name="connsiteY6" fmla="*/ 297621 h 409908"/>
                    <a:gd name="connsiteX7" fmla="*/ 43553 w 896127"/>
                    <a:gd name="connsiteY7" fmla="*/ 351257 h 409908"/>
                    <a:gd name="connsiteX8" fmla="*/ 6907 w 896127"/>
                    <a:gd name="connsiteY8" fmla="*/ 141914 h 409908"/>
                    <a:gd name="connsiteX0" fmla="*/ 6907 w 896127"/>
                    <a:gd name="connsiteY0" fmla="*/ 199687 h 413631"/>
                    <a:gd name="connsiteX1" fmla="*/ 248031 w 896127"/>
                    <a:gd name="connsiteY1" fmla="*/ 8114 h 413631"/>
                    <a:gd name="connsiteX2" fmla="*/ 604235 w 896127"/>
                    <a:gd name="connsiteY2" fmla="*/ 67809 h 413631"/>
                    <a:gd name="connsiteX3" fmla="*/ 896127 w 896127"/>
                    <a:gd name="connsiteY3" fmla="*/ 356613 h 413631"/>
                    <a:gd name="connsiteX4" fmla="*/ 755794 w 896127"/>
                    <a:gd name="connsiteY4" fmla="*/ 412679 h 413631"/>
                    <a:gd name="connsiteX5" fmla="*/ 611990 w 896127"/>
                    <a:gd name="connsiteY5" fmla="*/ 355354 h 413631"/>
                    <a:gd name="connsiteX6" fmla="*/ 244681 w 896127"/>
                    <a:gd name="connsiteY6" fmla="*/ 301344 h 413631"/>
                    <a:gd name="connsiteX7" fmla="*/ 43553 w 896127"/>
                    <a:gd name="connsiteY7" fmla="*/ 354980 h 413631"/>
                    <a:gd name="connsiteX8" fmla="*/ 6907 w 896127"/>
                    <a:gd name="connsiteY8" fmla="*/ 199687 h 413631"/>
                    <a:gd name="connsiteX0" fmla="*/ 6907 w 896127"/>
                    <a:gd name="connsiteY0" fmla="*/ 199687 h 413631"/>
                    <a:gd name="connsiteX1" fmla="*/ 248031 w 896127"/>
                    <a:gd name="connsiteY1" fmla="*/ 8114 h 413631"/>
                    <a:gd name="connsiteX2" fmla="*/ 604235 w 896127"/>
                    <a:gd name="connsiteY2" fmla="*/ 67809 h 413631"/>
                    <a:gd name="connsiteX3" fmla="*/ 896127 w 896127"/>
                    <a:gd name="connsiteY3" fmla="*/ 356613 h 413631"/>
                    <a:gd name="connsiteX4" fmla="*/ 755794 w 896127"/>
                    <a:gd name="connsiteY4" fmla="*/ 412679 h 413631"/>
                    <a:gd name="connsiteX5" fmla="*/ 611990 w 896127"/>
                    <a:gd name="connsiteY5" fmla="*/ 355354 h 413631"/>
                    <a:gd name="connsiteX6" fmla="*/ 244681 w 896127"/>
                    <a:gd name="connsiteY6" fmla="*/ 301344 h 413631"/>
                    <a:gd name="connsiteX7" fmla="*/ 43553 w 896127"/>
                    <a:gd name="connsiteY7" fmla="*/ 354980 h 413631"/>
                    <a:gd name="connsiteX8" fmla="*/ 6907 w 896127"/>
                    <a:gd name="connsiteY8" fmla="*/ 199687 h 413631"/>
                    <a:gd name="connsiteX0" fmla="*/ 9842 w 894268"/>
                    <a:gd name="connsiteY0" fmla="*/ 132305 h 409309"/>
                    <a:gd name="connsiteX1" fmla="*/ 246172 w 894268"/>
                    <a:gd name="connsiteY1" fmla="*/ 3792 h 409309"/>
                    <a:gd name="connsiteX2" fmla="*/ 602376 w 894268"/>
                    <a:gd name="connsiteY2" fmla="*/ 63487 h 409309"/>
                    <a:gd name="connsiteX3" fmla="*/ 894268 w 894268"/>
                    <a:gd name="connsiteY3" fmla="*/ 352291 h 409309"/>
                    <a:gd name="connsiteX4" fmla="*/ 753935 w 894268"/>
                    <a:gd name="connsiteY4" fmla="*/ 408357 h 409309"/>
                    <a:gd name="connsiteX5" fmla="*/ 610131 w 894268"/>
                    <a:gd name="connsiteY5" fmla="*/ 351032 h 409309"/>
                    <a:gd name="connsiteX6" fmla="*/ 242822 w 894268"/>
                    <a:gd name="connsiteY6" fmla="*/ 297022 h 409309"/>
                    <a:gd name="connsiteX7" fmla="*/ 41694 w 894268"/>
                    <a:gd name="connsiteY7" fmla="*/ 350658 h 409309"/>
                    <a:gd name="connsiteX8" fmla="*/ 9842 w 894268"/>
                    <a:gd name="connsiteY8" fmla="*/ 132305 h 409309"/>
                    <a:gd name="connsiteX0" fmla="*/ 0 w 884426"/>
                    <a:gd name="connsiteY0" fmla="*/ 132303 h 409307"/>
                    <a:gd name="connsiteX1" fmla="*/ 236330 w 884426"/>
                    <a:gd name="connsiteY1" fmla="*/ 3790 h 409307"/>
                    <a:gd name="connsiteX2" fmla="*/ 592534 w 884426"/>
                    <a:gd name="connsiteY2" fmla="*/ 63485 h 409307"/>
                    <a:gd name="connsiteX3" fmla="*/ 884426 w 884426"/>
                    <a:gd name="connsiteY3" fmla="*/ 352289 h 409307"/>
                    <a:gd name="connsiteX4" fmla="*/ 744093 w 884426"/>
                    <a:gd name="connsiteY4" fmla="*/ 408355 h 409307"/>
                    <a:gd name="connsiteX5" fmla="*/ 600289 w 884426"/>
                    <a:gd name="connsiteY5" fmla="*/ 351030 h 409307"/>
                    <a:gd name="connsiteX6" fmla="*/ 232980 w 884426"/>
                    <a:gd name="connsiteY6" fmla="*/ 297020 h 409307"/>
                    <a:gd name="connsiteX7" fmla="*/ 55817 w 884426"/>
                    <a:gd name="connsiteY7" fmla="*/ 359664 h 409307"/>
                    <a:gd name="connsiteX8" fmla="*/ 0 w 884426"/>
                    <a:gd name="connsiteY8" fmla="*/ 132303 h 409307"/>
                    <a:gd name="connsiteX0" fmla="*/ 0 w 884426"/>
                    <a:gd name="connsiteY0" fmla="*/ 132303 h 409307"/>
                    <a:gd name="connsiteX1" fmla="*/ 236330 w 884426"/>
                    <a:gd name="connsiteY1" fmla="*/ 3790 h 409307"/>
                    <a:gd name="connsiteX2" fmla="*/ 592534 w 884426"/>
                    <a:gd name="connsiteY2" fmla="*/ 63485 h 409307"/>
                    <a:gd name="connsiteX3" fmla="*/ 884426 w 884426"/>
                    <a:gd name="connsiteY3" fmla="*/ 352289 h 409307"/>
                    <a:gd name="connsiteX4" fmla="*/ 744093 w 884426"/>
                    <a:gd name="connsiteY4" fmla="*/ 408355 h 409307"/>
                    <a:gd name="connsiteX5" fmla="*/ 600289 w 884426"/>
                    <a:gd name="connsiteY5" fmla="*/ 351030 h 409307"/>
                    <a:gd name="connsiteX6" fmla="*/ 232980 w 884426"/>
                    <a:gd name="connsiteY6" fmla="*/ 297020 h 409307"/>
                    <a:gd name="connsiteX7" fmla="*/ 55817 w 884426"/>
                    <a:gd name="connsiteY7" fmla="*/ 359664 h 409307"/>
                    <a:gd name="connsiteX8" fmla="*/ 0 w 884426"/>
                    <a:gd name="connsiteY8" fmla="*/ 132303 h 409307"/>
                    <a:gd name="connsiteX0" fmla="*/ 501 w 884927"/>
                    <a:gd name="connsiteY0" fmla="*/ 132303 h 409307"/>
                    <a:gd name="connsiteX1" fmla="*/ 236831 w 884927"/>
                    <a:gd name="connsiteY1" fmla="*/ 3790 h 409307"/>
                    <a:gd name="connsiteX2" fmla="*/ 593035 w 884927"/>
                    <a:gd name="connsiteY2" fmla="*/ 63485 h 409307"/>
                    <a:gd name="connsiteX3" fmla="*/ 884927 w 884927"/>
                    <a:gd name="connsiteY3" fmla="*/ 352289 h 409307"/>
                    <a:gd name="connsiteX4" fmla="*/ 744594 w 884927"/>
                    <a:gd name="connsiteY4" fmla="*/ 408355 h 409307"/>
                    <a:gd name="connsiteX5" fmla="*/ 600790 w 884927"/>
                    <a:gd name="connsiteY5" fmla="*/ 351030 h 409307"/>
                    <a:gd name="connsiteX6" fmla="*/ 233481 w 884927"/>
                    <a:gd name="connsiteY6" fmla="*/ 297020 h 409307"/>
                    <a:gd name="connsiteX7" fmla="*/ 17973 w 884927"/>
                    <a:gd name="connsiteY7" fmla="*/ 350656 h 409307"/>
                    <a:gd name="connsiteX8" fmla="*/ 501 w 884927"/>
                    <a:gd name="connsiteY8" fmla="*/ 132303 h 409307"/>
                    <a:gd name="connsiteX0" fmla="*/ 1192 w 885618"/>
                    <a:gd name="connsiteY0" fmla="*/ 132303 h 409307"/>
                    <a:gd name="connsiteX1" fmla="*/ 237522 w 885618"/>
                    <a:gd name="connsiteY1" fmla="*/ 3790 h 409307"/>
                    <a:gd name="connsiteX2" fmla="*/ 593726 w 885618"/>
                    <a:gd name="connsiteY2" fmla="*/ 63485 h 409307"/>
                    <a:gd name="connsiteX3" fmla="*/ 885618 w 885618"/>
                    <a:gd name="connsiteY3" fmla="*/ 352289 h 409307"/>
                    <a:gd name="connsiteX4" fmla="*/ 745285 w 885618"/>
                    <a:gd name="connsiteY4" fmla="*/ 408355 h 409307"/>
                    <a:gd name="connsiteX5" fmla="*/ 601481 w 885618"/>
                    <a:gd name="connsiteY5" fmla="*/ 351030 h 409307"/>
                    <a:gd name="connsiteX6" fmla="*/ 234172 w 885618"/>
                    <a:gd name="connsiteY6" fmla="*/ 297020 h 409307"/>
                    <a:gd name="connsiteX7" fmla="*/ 18664 w 885618"/>
                    <a:gd name="connsiteY7" fmla="*/ 350656 h 409307"/>
                    <a:gd name="connsiteX8" fmla="*/ 1192 w 885618"/>
                    <a:gd name="connsiteY8" fmla="*/ 132303 h 409307"/>
                    <a:gd name="connsiteX0" fmla="*/ 1192 w 885618"/>
                    <a:gd name="connsiteY0" fmla="*/ 132303 h 438383"/>
                    <a:gd name="connsiteX1" fmla="*/ 237522 w 885618"/>
                    <a:gd name="connsiteY1" fmla="*/ 3790 h 438383"/>
                    <a:gd name="connsiteX2" fmla="*/ 593726 w 885618"/>
                    <a:gd name="connsiteY2" fmla="*/ 63485 h 438383"/>
                    <a:gd name="connsiteX3" fmla="*/ 885618 w 885618"/>
                    <a:gd name="connsiteY3" fmla="*/ 352289 h 438383"/>
                    <a:gd name="connsiteX4" fmla="*/ 802802 w 885618"/>
                    <a:gd name="connsiteY4" fmla="*/ 438383 h 438383"/>
                    <a:gd name="connsiteX5" fmla="*/ 601481 w 885618"/>
                    <a:gd name="connsiteY5" fmla="*/ 351030 h 438383"/>
                    <a:gd name="connsiteX6" fmla="*/ 234172 w 885618"/>
                    <a:gd name="connsiteY6" fmla="*/ 297020 h 438383"/>
                    <a:gd name="connsiteX7" fmla="*/ 18664 w 885618"/>
                    <a:gd name="connsiteY7" fmla="*/ 350656 h 438383"/>
                    <a:gd name="connsiteX8" fmla="*/ 1192 w 885618"/>
                    <a:gd name="connsiteY8" fmla="*/ 132303 h 438383"/>
                    <a:gd name="connsiteX0" fmla="*/ 1192 w 840848"/>
                    <a:gd name="connsiteY0" fmla="*/ 130868 h 436948"/>
                    <a:gd name="connsiteX1" fmla="*/ 237522 w 840848"/>
                    <a:gd name="connsiteY1" fmla="*/ 2355 h 436948"/>
                    <a:gd name="connsiteX2" fmla="*/ 593726 w 840848"/>
                    <a:gd name="connsiteY2" fmla="*/ 62050 h 436948"/>
                    <a:gd name="connsiteX3" fmla="*/ 837689 w 840848"/>
                    <a:gd name="connsiteY3" fmla="*/ 236746 h 436948"/>
                    <a:gd name="connsiteX4" fmla="*/ 802802 w 840848"/>
                    <a:gd name="connsiteY4" fmla="*/ 436948 h 436948"/>
                    <a:gd name="connsiteX5" fmla="*/ 601481 w 840848"/>
                    <a:gd name="connsiteY5" fmla="*/ 349595 h 436948"/>
                    <a:gd name="connsiteX6" fmla="*/ 234172 w 840848"/>
                    <a:gd name="connsiteY6" fmla="*/ 295585 h 436948"/>
                    <a:gd name="connsiteX7" fmla="*/ 18664 w 840848"/>
                    <a:gd name="connsiteY7" fmla="*/ 349221 h 436948"/>
                    <a:gd name="connsiteX8" fmla="*/ 1192 w 840848"/>
                    <a:gd name="connsiteY8" fmla="*/ 130868 h 436948"/>
                    <a:gd name="connsiteX0" fmla="*/ 1192 w 840847"/>
                    <a:gd name="connsiteY0" fmla="*/ 130868 h 436948"/>
                    <a:gd name="connsiteX1" fmla="*/ 237522 w 840847"/>
                    <a:gd name="connsiteY1" fmla="*/ 2355 h 436948"/>
                    <a:gd name="connsiteX2" fmla="*/ 593726 w 840847"/>
                    <a:gd name="connsiteY2" fmla="*/ 62050 h 436948"/>
                    <a:gd name="connsiteX3" fmla="*/ 837689 w 840847"/>
                    <a:gd name="connsiteY3" fmla="*/ 236746 h 436948"/>
                    <a:gd name="connsiteX4" fmla="*/ 802802 w 840847"/>
                    <a:gd name="connsiteY4" fmla="*/ 436948 h 436948"/>
                    <a:gd name="connsiteX5" fmla="*/ 601481 w 840847"/>
                    <a:gd name="connsiteY5" fmla="*/ 349595 h 436948"/>
                    <a:gd name="connsiteX6" fmla="*/ 234172 w 840847"/>
                    <a:gd name="connsiteY6" fmla="*/ 295585 h 436948"/>
                    <a:gd name="connsiteX7" fmla="*/ 18664 w 840847"/>
                    <a:gd name="connsiteY7" fmla="*/ 349221 h 436948"/>
                    <a:gd name="connsiteX8" fmla="*/ 1192 w 840847"/>
                    <a:gd name="connsiteY8" fmla="*/ 130868 h 436948"/>
                    <a:gd name="connsiteX0" fmla="*/ 1192 w 840847"/>
                    <a:gd name="connsiteY0" fmla="*/ 130868 h 436948"/>
                    <a:gd name="connsiteX1" fmla="*/ 237522 w 840847"/>
                    <a:gd name="connsiteY1" fmla="*/ 2355 h 436948"/>
                    <a:gd name="connsiteX2" fmla="*/ 593726 w 840847"/>
                    <a:gd name="connsiteY2" fmla="*/ 62050 h 436948"/>
                    <a:gd name="connsiteX3" fmla="*/ 837689 w 840847"/>
                    <a:gd name="connsiteY3" fmla="*/ 236746 h 436948"/>
                    <a:gd name="connsiteX4" fmla="*/ 802802 w 840847"/>
                    <a:gd name="connsiteY4" fmla="*/ 436948 h 436948"/>
                    <a:gd name="connsiteX5" fmla="*/ 601481 w 840847"/>
                    <a:gd name="connsiteY5" fmla="*/ 349595 h 436948"/>
                    <a:gd name="connsiteX6" fmla="*/ 234172 w 840847"/>
                    <a:gd name="connsiteY6" fmla="*/ 295585 h 436948"/>
                    <a:gd name="connsiteX7" fmla="*/ 18664 w 840847"/>
                    <a:gd name="connsiteY7" fmla="*/ 349221 h 436948"/>
                    <a:gd name="connsiteX8" fmla="*/ 1192 w 840847"/>
                    <a:gd name="connsiteY8" fmla="*/ 130868 h 436948"/>
                    <a:gd name="connsiteX0" fmla="*/ 1192 w 888817"/>
                    <a:gd name="connsiteY0" fmla="*/ 131148 h 437228"/>
                    <a:gd name="connsiteX1" fmla="*/ 237522 w 888817"/>
                    <a:gd name="connsiteY1" fmla="*/ 2635 h 437228"/>
                    <a:gd name="connsiteX2" fmla="*/ 593726 w 888817"/>
                    <a:gd name="connsiteY2" fmla="*/ 62330 h 437228"/>
                    <a:gd name="connsiteX3" fmla="*/ 888817 w 888817"/>
                    <a:gd name="connsiteY3" fmla="*/ 267055 h 437228"/>
                    <a:gd name="connsiteX4" fmla="*/ 802802 w 888817"/>
                    <a:gd name="connsiteY4" fmla="*/ 437228 h 437228"/>
                    <a:gd name="connsiteX5" fmla="*/ 601481 w 888817"/>
                    <a:gd name="connsiteY5" fmla="*/ 349875 h 437228"/>
                    <a:gd name="connsiteX6" fmla="*/ 234172 w 888817"/>
                    <a:gd name="connsiteY6" fmla="*/ 295865 h 437228"/>
                    <a:gd name="connsiteX7" fmla="*/ 18664 w 888817"/>
                    <a:gd name="connsiteY7" fmla="*/ 349501 h 437228"/>
                    <a:gd name="connsiteX8" fmla="*/ 1192 w 888817"/>
                    <a:gd name="connsiteY8" fmla="*/ 131148 h 437228"/>
                    <a:gd name="connsiteX0" fmla="*/ 1192 w 888817"/>
                    <a:gd name="connsiteY0" fmla="*/ 131148 h 473263"/>
                    <a:gd name="connsiteX1" fmla="*/ 237522 w 888817"/>
                    <a:gd name="connsiteY1" fmla="*/ 2635 h 473263"/>
                    <a:gd name="connsiteX2" fmla="*/ 593726 w 888817"/>
                    <a:gd name="connsiteY2" fmla="*/ 62330 h 473263"/>
                    <a:gd name="connsiteX3" fmla="*/ 888817 w 888817"/>
                    <a:gd name="connsiteY3" fmla="*/ 267055 h 473263"/>
                    <a:gd name="connsiteX4" fmla="*/ 831561 w 888817"/>
                    <a:gd name="connsiteY4" fmla="*/ 473263 h 473263"/>
                    <a:gd name="connsiteX5" fmla="*/ 601481 w 888817"/>
                    <a:gd name="connsiteY5" fmla="*/ 349875 h 473263"/>
                    <a:gd name="connsiteX6" fmla="*/ 234172 w 888817"/>
                    <a:gd name="connsiteY6" fmla="*/ 295865 h 473263"/>
                    <a:gd name="connsiteX7" fmla="*/ 18664 w 888817"/>
                    <a:gd name="connsiteY7" fmla="*/ 349501 h 473263"/>
                    <a:gd name="connsiteX8" fmla="*/ 1192 w 888817"/>
                    <a:gd name="connsiteY8" fmla="*/ 131148 h 47326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888817" h="473263">
                      <a:moveTo>
                        <a:pt x="1192" y="131148"/>
                      </a:moveTo>
                      <a:cubicBezTo>
                        <a:pt x="36213" y="31874"/>
                        <a:pt x="138766" y="14105"/>
                        <a:pt x="237522" y="2635"/>
                      </a:cubicBezTo>
                      <a:cubicBezTo>
                        <a:pt x="336278" y="-8835"/>
                        <a:pt x="485177" y="18260"/>
                        <a:pt x="593726" y="62330"/>
                      </a:cubicBezTo>
                      <a:cubicBezTo>
                        <a:pt x="702275" y="106400"/>
                        <a:pt x="799521" y="130441"/>
                        <a:pt x="888817" y="267055"/>
                      </a:cubicBezTo>
                      <a:cubicBezTo>
                        <a:pt x="885303" y="335997"/>
                        <a:pt x="889693" y="473263"/>
                        <a:pt x="831561" y="473263"/>
                      </a:cubicBezTo>
                      <a:cubicBezTo>
                        <a:pt x="779288" y="428742"/>
                        <a:pt x="663874" y="369282"/>
                        <a:pt x="601481" y="349875"/>
                      </a:cubicBezTo>
                      <a:cubicBezTo>
                        <a:pt x="556482" y="312077"/>
                        <a:pt x="345897" y="223549"/>
                        <a:pt x="234172" y="295865"/>
                      </a:cubicBezTo>
                      <a:cubicBezTo>
                        <a:pt x="134595" y="319799"/>
                        <a:pt x="99893" y="313007"/>
                        <a:pt x="18664" y="349501"/>
                      </a:cubicBezTo>
                      <a:cubicBezTo>
                        <a:pt x="-17791" y="218899"/>
                        <a:pt x="12440" y="254749"/>
                        <a:pt x="1192" y="131148"/>
                      </a:cubicBezTo>
                      <a:close/>
                    </a:path>
                  </a:pathLst>
                </a:custGeom>
                <a:grpFill/>
                <a:ln>
                  <a:solidFill>
                    <a:schemeClr val="tx2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350">
                    <a:solidFill>
                      <a:schemeClr val="bg2">
                        <a:lumMod val="25000"/>
                      </a:schemeClr>
                    </a:solidFill>
                  </a:endParaRPr>
                </a:p>
              </p:txBody>
            </p:sp>
            <p:sp>
              <p:nvSpPr>
                <p:cNvPr id="26" name="Block Arc 15"/>
                <p:cNvSpPr/>
                <p:nvPr/>
              </p:nvSpPr>
              <p:spPr>
                <a:xfrm rot="15288351" flipH="1">
                  <a:off x="4922149" y="815135"/>
                  <a:ext cx="741542" cy="423743"/>
                </a:xfrm>
                <a:custGeom>
                  <a:avLst/>
                  <a:gdLst>
                    <a:gd name="connsiteX0" fmla="*/ 627 w 745516"/>
                    <a:gd name="connsiteY0" fmla="*/ 369014 h 697590"/>
                    <a:gd name="connsiteX1" fmla="*/ 184209 w 745516"/>
                    <a:gd name="connsiteY1" fmla="*/ 47911 h 697590"/>
                    <a:gd name="connsiteX2" fmla="*/ 544181 w 745516"/>
                    <a:gd name="connsiteY2" fmla="*/ 39071 h 697590"/>
                    <a:gd name="connsiteX3" fmla="*/ 745515 w 745516"/>
                    <a:gd name="connsiteY3" fmla="*/ 348795 h 697590"/>
                    <a:gd name="connsiteX4" fmla="*/ 571119 w 745516"/>
                    <a:gd name="connsiteY4" fmla="*/ 348795 h 697590"/>
                    <a:gd name="connsiteX5" fmla="*/ 459552 w 745516"/>
                    <a:gd name="connsiteY5" fmla="*/ 191978 h 697590"/>
                    <a:gd name="connsiteX6" fmla="*/ 277038 w 745516"/>
                    <a:gd name="connsiteY6" fmla="*/ 196046 h 697590"/>
                    <a:gd name="connsiteX7" fmla="*/ 174775 w 745516"/>
                    <a:gd name="connsiteY7" fmla="*/ 359552 h 697590"/>
                    <a:gd name="connsiteX8" fmla="*/ 627 w 745516"/>
                    <a:gd name="connsiteY8" fmla="*/ 369014 h 697590"/>
                    <a:gd name="connsiteX0" fmla="*/ 629 w 745517"/>
                    <a:gd name="connsiteY0" fmla="*/ 369014 h 369014"/>
                    <a:gd name="connsiteX1" fmla="*/ 184211 w 745517"/>
                    <a:gd name="connsiteY1" fmla="*/ 47911 h 369014"/>
                    <a:gd name="connsiteX2" fmla="*/ 544183 w 745517"/>
                    <a:gd name="connsiteY2" fmla="*/ 39071 h 369014"/>
                    <a:gd name="connsiteX3" fmla="*/ 745517 w 745517"/>
                    <a:gd name="connsiteY3" fmla="*/ 348795 h 369014"/>
                    <a:gd name="connsiteX4" fmla="*/ 668191 w 745517"/>
                    <a:gd name="connsiteY4" fmla="*/ 363523 h 369014"/>
                    <a:gd name="connsiteX5" fmla="*/ 459554 w 745517"/>
                    <a:gd name="connsiteY5" fmla="*/ 191978 h 369014"/>
                    <a:gd name="connsiteX6" fmla="*/ 277040 w 745517"/>
                    <a:gd name="connsiteY6" fmla="*/ 196046 h 369014"/>
                    <a:gd name="connsiteX7" fmla="*/ 174777 w 745517"/>
                    <a:gd name="connsiteY7" fmla="*/ 359552 h 369014"/>
                    <a:gd name="connsiteX8" fmla="*/ 629 w 745517"/>
                    <a:gd name="connsiteY8" fmla="*/ 369014 h 369014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59554 w 745517"/>
                    <a:gd name="connsiteY5" fmla="*/ 191978 h 425833"/>
                    <a:gd name="connsiteX6" fmla="*/ 277040 w 745517"/>
                    <a:gd name="connsiteY6" fmla="*/ 196046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48149 w 745517"/>
                    <a:gd name="connsiteY5" fmla="*/ 197842 h 425833"/>
                    <a:gd name="connsiteX6" fmla="*/ 277040 w 745517"/>
                    <a:gd name="connsiteY6" fmla="*/ 196046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277040 w 745517"/>
                    <a:gd name="connsiteY6" fmla="*/ 196046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387239 w 745517"/>
                    <a:gd name="connsiteY6" fmla="*/ 147341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387239 w 745517"/>
                    <a:gd name="connsiteY6" fmla="*/ 147341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387239 w 745517"/>
                    <a:gd name="connsiteY6" fmla="*/ 147341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396919 w 745517"/>
                    <a:gd name="connsiteY6" fmla="*/ 199046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396919 w 745517"/>
                    <a:gd name="connsiteY5" fmla="*/ 199046 h 425833"/>
                    <a:gd name="connsiteX6" fmla="*/ 174777 w 745517"/>
                    <a:gd name="connsiteY6" fmla="*/ 359552 h 425833"/>
                    <a:gd name="connsiteX7" fmla="*/ 629 w 745517"/>
                    <a:gd name="connsiteY7" fmla="*/ 369014 h 425833"/>
                    <a:gd name="connsiteX0" fmla="*/ 629 w 777485"/>
                    <a:gd name="connsiteY0" fmla="*/ 364465 h 421284"/>
                    <a:gd name="connsiteX1" fmla="*/ 184211 w 777485"/>
                    <a:gd name="connsiteY1" fmla="*/ 43362 h 421284"/>
                    <a:gd name="connsiteX2" fmla="*/ 544183 w 777485"/>
                    <a:gd name="connsiteY2" fmla="*/ 34522 h 421284"/>
                    <a:gd name="connsiteX3" fmla="*/ 777485 w 777485"/>
                    <a:gd name="connsiteY3" fmla="*/ 302949 h 421284"/>
                    <a:gd name="connsiteX4" fmla="*/ 666916 w 777485"/>
                    <a:gd name="connsiteY4" fmla="*/ 421284 h 421284"/>
                    <a:gd name="connsiteX5" fmla="*/ 396919 w 777485"/>
                    <a:gd name="connsiteY5" fmla="*/ 194497 h 421284"/>
                    <a:gd name="connsiteX6" fmla="*/ 174777 w 777485"/>
                    <a:gd name="connsiteY6" fmla="*/ 355003 h 421284"/>
                    <a:gd name="connsiteX7" fmla="*/ 629 w 777485"/>
                    <a:gd name="connsiteY7" fmla="*/ 364465 h 421284"/>
                    <a:gd name="connsiteX0" fmla="*/ 629 w 777485"/>
                    <a:gd name="connsiteY0" fmla="*/ 364465 h 421284"/>
                    <a:gd name="connsiteX1" fmla="*/ 184211 w 777485"/>
                    <a:gd name="connsiteY1" fmla="*/ 43362 h 421284"/>
                    <a:gd name="connsiteX2" fmla="*/ 544183 w 777485"/>
                    <a:gd name="connsiteY2" fmla="*/ 34522 h 421284"/>
                    <a:gd name="connsiteX3" fmla="*/ 777485 w 777485"/>
                    <a:gd name="connsiteY3" fmla="*/ 302949 h 421284"/>
                    <a:gd name="connsiteX4" fmla="*/ 666916 w 777485"/>
                    <a:gd name="connsiteY4" fmla="*/ 421284 h 421284"/>
                    <a:gd name="connsiteX5" fmla="*/ 396919 w 777485"/>
                    <a:gd name="connsiteY5" fmla="*/ 194497 h 421284"/>
                    <a:gd name="connsiteX6" fmla="*/ 174777 w 777485"/>
                    <a:gd name="connsiteY6" fmla="*/ 355003 h 421284"/>
                    <a:gd name="connsiteX7" fmla="*/ 629 w 777485"/>
                    <a:gd name="connsiteY7" fmla="*/ 364465 h 421284"/>
                    <a:gd name="connsiteX0" fmla="*/ 629 w 777485"/>
                    <a:gd name="connsiteY0" fmla="*/ 364465 h 421284"/>
                    <a:gd name="connsiteX1" fmla="*/ 184211 w 777485"/>
                    <a:gd name="connsiteY1" fmla="*/ 43362 h 421284"/>
                    <a:gd name="connsiteX2" fmla="*/ 544183 w 777485"/>
                    <a:gd name="connsiteY2" fmla="*/ 34522 h 421284"/>
                    <a:gd name="connsiteX3" fmla="*/ 777485 w 777485"/>
                    <a:gd name="connsiteY3" fmla="*/ 302949 h 421284"/>
                    <a:gd name="connsiteX4" fmla="*/ 666916 w 777485"/>
                    <a:gd name="connsiteY4" fmla="*/ 421284 h 421284"/>
                    <a:gd name="connsiteX5" fmla="*/ 396919 w 777485"/>
                    <a:gd name="connsiteY5" fmla="*/ 194497 h 421284"/>
                    <a:gd name="connsiteX6" fmla="*/ 102409 w 777485"/>
                    <a:gd name="connsiteY6" fmla="*/ 373814 h 421284"/>
                    <a:gd name="connsiteX7" fmla="*/ 629 w 777485"/>
                    <a:gd name="connsiteY7" fmla="*/ 364465 h 421284"/>
                    <a:gd name="connsiteX0" fmla="*/ 329 w 828090"/>
                    <a:gd name="connsiteY0" fmla="*/ 354833 h 418791"/>
                    <a:gd name="connsiteX1" fmla="*/ 234816 w 828090"/>
                    <a:gd name="connsiteY1" fmla="*/ 40869 h 418791"/>
                    <a:gd name="connsiteX2" fmla="*/ 594788 w 828090"/>
                    <a:gd name="connsiteY2" fmla="*/ 32029 h 418791"/>
                    <a:gd name="connsiteX3" fmla="*/ 828090 w 828090"/>
                    <a:gd name="connsiteY3" fmla="*/ 300456 h 418791"/>
                    <a:gd name="connsiteX4" fmla="*/ 717521 w 828090"/>
                    <a:gd name="connsiteY4" fmla="*/ 418791 h 418791"/>
                    <a:gd name="connsiteX5" fmla="*/ 447524 w 828090"/>
                    <a:gd name="connsiteY5" fmla="*/ 192004 h 418791"/>
                    <a:gd name="connsiteX6" fmla="*/ 153014 w 828090"/>
                    <a:gd name="connsiteY6" fmla="*/ 371321 h 418791"/>
                    <a:gd name="connsiteX7" fmla="*/ 329 w 828090"/>
                    <a:gd name="connsiteY7" fmla="*/ 354833 h 418791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476599 w 857165"/>
                    <a:gd name="connsiteY5" fmla="*/ 191739 h 418526"/>
                    <a:gd name="connsiteX6" fmla="*/ 182089 w 857165"/>
                    <a:gd name="connsiteY6" fmla="*/ 371056 h 418526"/>
                    <a:gd name="connsiteX7" fmla="*/ 283 w 857165"/>
                    <a:gd name="connsiteY7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476599 w 857165"/>
                    <a:gd name="connsiteY5" fmla="*/ 191739 h 418526"/>
                    <a:gd name="connsiteX6" fmla="*/ 182089 w 857165"/>
                    <a:gd name="connsiteY6" fmla="*/ 371056 h 418526"/>
                    <a:gd name="connsiteX7" fmla="*/ 283 w 857165"/>
                    <a:gd name="connsiteY7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476599 w 857165"/>
                    <a:gd name="connsiteY5" fmla="*/ 191739 h 418526"/>
                    <a:gd name="connsiteX6" fmla="*/ 182089 w 857165"/>
                    <a:gd name="connsiteY6" fmla="*/ 371056 h 418526"/>
                    <a:gd name="connsiteX7" fmla="*/ 283 w 857165"/>
                    <a:gd name="connsiteY7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476599 w 857165"/>
                    <a:gd name="connsiteY5" fmla="*/ 191739 h 418526"/>
                    <a:gd name="connsiteX6" fmla="*/ 182089 w 857165"/>
                    <a:gd name="connsiteY6" fmla="*/ 371056 h 418526"/>
                    <a:gd name="connsiteX7" fmla="*/ 283 w 857165"/>
                    <a:gd name="connsiteY7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596226 w 857165"/>
                    <a:gd name="connsiteY5" fmla="*/ 269798 h 418526"/>
                    <a:gd name="connsiteX6" fmla="*/ 476599 w 857165"/>
                    <a:gd name="connsiteY6" fmla="*/ 191739 h 418526"/>
                    <a:gd name="connsiteX7" fmla="*/ 182089 w 857165"/>
                    <a:gd name="connsiteY7" fmla="*/ 371056 h 418526"/>
                    <a:gd name="connsiteX8" fmla="*/ 283 w 857165"/>
                    <a:gd name="connsiteY8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631337 w 857165"/>
                    <a:gd name="connsiteY5" fmla="*/ 261689 h 418526"/>
                    <a:gd name="connsiteX6" fmla="*/ 476599 w 857165"/>
                    <a:gd name="connsiteY6" fmla="*/ 191739 h 418526"/>
                    <a:gd name="connsiteX7" fmla="*/ 182089 w 857165"/>
                    <a:gd name="connsiteY7" fmla="*/ 371056 h 418526"/>
                    <a:gd name="connsiteX8" fmla="*/ 283 w 857165"/>
                    <a:gd name="connsiteY8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623229 w 857165"/>
                    <a:gd name="connsiteY5" fmla="*/ 226578 h 418526"/>
                    <a:gd name="connsiteX6" fmla="*/ 476599 w 857165"/>
                    <a:gd name="connsiteY6" fmla="*/ 191739 h 418526"/>
                    <a:gd name="connsiteX7" fmla="*/ 182089 w 857165"/>
                    <a:gd name="connsiteY7" fmla="*/ 371056 h 418526"/>
                    <a:gd name="connsiteX8" fmla="*/ 283 w 857165"/>
                    <a:gd name="connsiteY8" fmla="*/ 350149 h 418526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623229 w 857165"/>
                    <a:gd name="connsiteY5" fmla="*/ 226578 h 418077"/>
                    <a:gd name="connsiteX6" fmla="*/ 476599 w 857165"/>
                    <a:gd name="connsiteY6" fmla="*/ 191739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623229 w 857165"/>
                    <a:gd name="connsiteY5" fmla="*/ 226578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623229 w 857165"/>
                    <a:gd name="connsiteY5" fmla="*/ 226578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91288 w 857165"/>
                    <a:gd name="connsiteY5" fmla="*/ 217643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91288 w 857165"/>
                    <a:gd name="connsiteY5" fmla="*/ 217643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91288 w 857165"/>
                    <a:gd name="connsiteY5" fmla="*/ 217643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13122 w 857165"/>
                    <a:gd name="connsiteY6" fmla="*/ 233528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13122 w 857165"/>
                    <a:gd name="connsiteY6" fmla="*/ 233528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23181 w 857165"/>
                    <a:gd name="connsiteY6" fmla="*/ 213440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23181 w 857165"/>
                    <a:gd name="connsiteY6" fmla="*/ 213440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23181 w 857165"/>
                    <a:gd name="connsiteY6" fmla="*/ 213440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71599"/>
                    <a:gd name="connsiteX1" fmla="*/ 263891 w 857165"/>
                    <a:gd name="connsiteY1" fmla="*/ 40604 h 471599"/>
                    <a:gd name="connsiteX2" fmla="*/ 623863 w 857165"/>
                    <a:gd name="connsiteY2" fmla="*/ 31764 h 471599"/>
                    <a:gd name="connsiteX3" fmla="*/ 857165 w 857165"/>
                    <a:gd name="connsiteY3" fmla="*/ 300191 h 471599"/>
                    <a:gd name="connsiteX4" fmla="*/ 768237 w 857165"/>
                    <a:gd name="connsiteY4" fmla="*/ 471599 h 471599"/>
                    <a:gd name="connsiteX5" fmla="*/ 588791 w 857165"/>
                    <a:gd name="connsiteY5" fmla="*/ 241798 h 471599"/>
                    <a:gd name="connsiteX6" fmla="*/ 323181 w 857165"/>
                    <a:gd name="connsiteY6" fmla="*/ 213440 h 471599"/>
                    <a:gd name="connsiteX7" fmla="*/ 182089 w 857165"/>
                    <a:gd name="connsiteY7" fmla="*/ 371056 h 471599"/>
                    <a:gd name="connsiteX8" fmla="*/ 283 w 857165"/>
                    <a:gd name="connsiteY8" fmla="*/ 350149 h 471599"/>
                    <a:gd name="connsiteX0" fmla="*/ 283 w 922080"/>
                    <a:gd name="connsiteY0" fmla="*/ 359002 h 486990"/>
                    <a:gd name="connsiteX1" fmla="*/ 263891 w 922080"/>
                    <a:gd name="connsiteY1" fmla="*/ 49457 h 486990"/>
                    <a:gd name="connsiteX2" fmla="*/ 623863 w 922080"/>
                    <a:gd name="connsiteY2" fmla="*/ 40617 h 486990"/>
                    <a:gd name="connsiteX3" fmla="*/ 922080 w 922080"/>
                    <a:gd name="connsiteY3" fmla="*/ 440612 h 486990"/>
                    <a:gd name="connsiteX4" fmla="*/ 768237 w 922080"/>
                    <a:gd name="connsiteY4" fmla="*/ 480452 h 486990"/>
                    <a:gd name="connsiteX5" fmla="*/ 588791 w 922080"/>
                    <a:gd name="connsiteY5" fmla="*/ 250651 h 486990"/>
                    <a:gd name="connsiteX6" fmla="*/ 323181 w 922080"/>
                    <a:gd name="connsiteY6" fmla="*/ 222293 h 486990"/>
                    <a:gd name="connsiteX7" fmla="*/ 182089 w 922080"/>
                    <a:gd name="connsiteY7" fmla="*/ 379909 h 486990"/>
                    <a:gd name="connsiteX8" fmla="*/ 283 w 922080"/>
                    <a:gd name="connsiteY8" fmla="*/ 359002 h 486990"/>
                    <a:gd name="connsiteX0" fmla="*/ 283 w 925272"/>
                    <a:gd name="connsiteY0" fmla="*/ 357772 h 480085"/>
                    <a:gd name="connsiteX1" fmla="*/ 263891 w 925272"/>
                    <a:gd name="connsiteY1" fmla="*/ 48227 h 480085"/>
                    <a:gd name="connsiteX2" fmla="*/ 623863 w 925272"/>
                    <a:gd name="connsiteY2" fmla="*/ 39387 h 480085"/>
                    <a:gd name="connsiteX3" fmla="*/ 925272 w 925272"/>
                    <a:gd name="connsiteY3" fmla="*/ 421509 h 480085"/>
                    <a:gd name="connsiteX4" fmla="*/ 768237 w 925272"/>
                    <a:gd name="connsiteY4" fmla="*/ 479222 h 480085"/>
                    <a:gd name="connsiteX5" fmla="*/ 588791 w 925272"/>
                    <a:gd name="connsiteY5" fmla="*/ 249421 h 480085"/>
                    <a:gd name="connsiteX6" fmla="*/ 323181 w 925272"/>
                    <a:gd name="connsiteY6" fmla="*/ 221063 h 480085"/>
                    <a:gd name="connsiteX7" fmla="*/ 182089 w 925272"/>
                    <a:gd name="connsiteY7" fmla="*/ 378679 h 480085"/>
                    <a:gd name="connsiteX8" fmla="*/ 283 w 925272"/>
                    <a:gd name="connsiteY8" fmla="*/ 357772 h 480085"/>
                    <a:gd name="connsiteX0" fmla="*/ 283 w 925272"/>
                    <a:gd name="connsiteY0" fmla="*/ 357772 h 479899"/>
                    <a:gd name="connsiteX1" fmla="*/ 263891 w 925272"/>
                    <a:gd name="connsiteY1" fmla="*/ 48227 h 479899"/>
                    <a:gd name="connsiteX2" fmla="*/ 623863 w 925272"/>
                    <a:gd name="connsiteY2" fmla="*/ 39387 h 479899"/>
                    <a:gd name="connsiteX3" fmla="*/ 925272 w 925272"/>
                    <a:gd name="connsiteY3" fmla="*/ 421509 h 479899"/>
                    <a:gd name="connsiteX4" fmla="*/ 768237 w 925272"/>
                    <a:gd name="connsiteY4" fmla="*/ 479222 h 479899"/>
                    <a:gd name="connsiteX5" fmla="*/ 588791 w 925272"/>
                    <a:gd name="connsiteY5" fmla="*/ 249421 h 479899"/>
                    <a:gd name="connsiteX6" fmla="*/ 323181 w 925272"/>
                    <a:gd name="connsiteY6" fmla="*/ 221063 h 479899"/>
                    <a:gd name="connsiteX7" fmla="*/ 182089 w 925272"/>
                    <a:gd name="connsiteY7" fmla="*/ 378679 h 479899"/>
                    <a:gd name="connsiteX8" fmla="*/ 283 w 925272"/>
                    <a:gd name="connsiteY8" fmla="*/ 357772 h 479899"/>
                    <a:gd name="connsiteX0" fmla="*/ 283 w 925272"/>
                    <a:gd name="connsiteY0" fmla="*/ 357772 h 479899"/>
                    <a:gd name="connsiteX1" fmla="*/ 263891 w 925272"/>
                    <a:gd name="connsiteY1" fmla="*/ 48227 h 479899"/>
                    <a:gd name="connsiteX2" fmla="*/ 623863 w 925272"/>
                    <a:gd name="connsiteY2" fmla="*/ 39387 h 479899"/>
                    <a:gd name="connsiteX3" fmla="*/ 925272 w 925272"/>
                    <a:gd name="connsiteY3" fmla="*/ 421509 h 479899"/>
                    <a:gd name="connsiteX4" fmla="*/ 768237 w 925272"/>
                    <a:gd name="connsiteY4" fmla="*/ 479222 h 479899"/>
                    <a:gd name="connsiteX5" fmla="*/ 588791 w 925272"/>
                    <a:gd name="connsiteY5" fmla="*/ 249421 h 479899"/>
                    <a:gd name="connsiteX6" fmla="*/ 323181 w 925272"/>
                    <a:gd name="connsiteY6" fmla="*/ 221063 h 479899"/>
                    <a:gd name="connsiteX7" fmla="*/ 182089 w 925272"/>
                    <a:gd name="connsiteY7" fmla="*/ 378679 h 479899"/>
                    <a:gd name="connsiteX8" fmla="*/ 283 w 925272"/>
                    <a:gd name="connsiteY8" fmla="*/ 357772 h 479899"/>
                    <a:gd name="connsiteX0" fmla="*/ 283 w 925272"/>
                    <a:gd name="connsiteY0" fmla="*/ 357772 h 479899"/>
                    <a:gd name="connsiteX1" fmla="*/ 263891 w 925272"/>
                    <a:gd name="connsiteY1" fmla="*/ 48227 h 479899"/>
                    <a:gd name="connsiteX2" fmla="*/ 623863 w 925272"/>
                    <a:gd name="connsiteY2" fmla="*/ 39387 h 479899"/>
                    <a:gd name="connsiteX3" fmla="*/ 925272 w 925272"/>
                    <a:gd name="connsiteY3" fmla="*/ 421509 h 479899"/>
                    <a:gd name="connsiteX4" fmla="*/ 768237 w 925272"/>
                    <a:gd name="connsiteY4" fmla="*/ 479222 h 479899"/>
                    <a:gd name="connsiteX5" fmla="*/ 614360 w 925272"/>
                    <a:gd name="connsiteY5" fmla="*/ 239373 h 479899"/>
                    <a:gd name="connsiteX6" fmla="*/ 323181 w 925272"/>
                    <a:gd name="connsiteY6" fmla="*/ 221063 h 479899"/>
                    <a:gd name="connsiteX7" fmla="*/ 182089 w 925272"/>
                    <a:gd name="connsiteY7" fmla="*/ 378679 h 479899"/>
                    <a:gd name="connsiteX8" fmla="*/ 283 w 925272"/>
                    <a:gd name="connsiteY8" fmla="*/ 357772 h 479899"/>
                    <a:gd name="connsiteX0" fmla="*/ 283 w 925272"/>
                    <a:gd name="connsiteY0" fmla="*/ 357772 h 478527"/>
                    <a:gd name="connsiteX1" fmla="*/ 263891 w 925272"/>
                    <a:gd name="connsiteY1" fmla="*/ 48227 h 478527"/>
                    <a:gd name="connsiteX2" fmla="*/ 623863 w 925272"/>
                    <a:gd name="connsiteY2" fmla="*/ 39387 h 478527"/>
                    <a:gd name="connsiteX3" fmla="*/ 925272 w 925272"/>
                    <a:gd name="connsiteY3" fmla="*/ 421509 h 478527"/>
                    <a:gd name="connsiteX4" fmla="*/ 784939 w 925272"/>
                    <a:gd name="connsiteY4" fmla="*/ 477575 h 478527"/>
                    <a:gd name="connsiteX5" fmla="*/ 614360 w 925272"/>
                    <a:gd name="connsiteY5" fmla="*/ 239373 h 478527"/>
                    <a:gd name="connsiteX6" fmla="*/ 323181 w 925272"/>
                    <a:gd name="connsiteY6" fmla="*/ 221063 h 478527"/>
                    <a:gd name="connsiteX7" fmla="*/ 182089 w 925272"/>
                    <a:gd name="connsiteY7" fmla="*/ 378679 h 478527"/>
                    <a:gd name="connsiteX8" fmla="*/ 283 w 925272"/>
                    <a:gd name="connsiteY8" fmla="*/ 357772 h 478527"/>
                    <a:gd name="connsiteX0" fmla="*/ 283 w 925272"/>
                    <a:gd name="connsiteY0" fmla="*/ 357772 h 478527"/>
                    <a:gd name="connsiteX1" fmla="*/ 263891 w 925272"/>
                    <a:gd name="connsiteY1" fmla="*/ 48227 h 478527"/>
                    <a:gd name="connsiteX2" fmla="*/ 623863 w 925272"/>
                    <a:gd name="connsiteY2" fmla="*/ 39387 h 478527"/>
                    <a:gd name="connsiteX3" fmla="*/ 925272 w 925272"/>
                    <a:gd name="connsiteY3" fmla="*/ 421509 h 478527"/>
                    <a:gd name="connsiteX4" fmla="*/ 784939 w 925272"/>
                    <a:gd name="connsiteY4" fmla="*/ 477575 h 478527"/>
                    <a:gd name="connsiteX5" fmla="*/ 614360 w 925272"/>
                    <a:gd name="connsiteY5" fmla="*/ 239373 h 478527"/>
                    <a:gd name="connsiteX6" fmla="*/ 323181 w 925272"/>
                    <a:gd name="connsiteY6" fmla="*/ 221063 h 478527"/>
                    <a:gd name="connsiteX7" fmla="*/ 182089 w 925272"/>
                    <a:gd name="connsiteY7" fmla="*/ 378679 h 478527"/>
                    <a:gd name="connsiteX8" fmla="*/ 283 w 925272"/>
                    <a:gd name="connsiteY8" fmla="*/ 357772 h 478527"/>
                    <a:gd name="connsiteX0" fmla="*/ 283 w 925272"/>
                    <a:gd name="connsiteY0" fmla="*/ 357772 h 557834"/>
                    <a:gd name="connsiteX1" fmla="*/ 263891 w 925272"/>
                    <a:gd name="connsiteY1" fmla="*/ 48227 h 557834"/>
                    <a:gd name="connsiteX2" fmla="*/ 623863 w 925272"/>
                    <a:gd name="connsiteY2" fmla="*/ 39387 h 557834"/>
                    <a:gd name="connsiteX3" fmla="*/ 925272 w 925272"/>
                    <a:gd name="connsiteY3" fmla="*/ 421509 h 557834"/>
                    <a:gd name="connsiteX4" fmla="*/ 784939 w 925272"/>
                    <a:gd name="connsiteY4" fmla="*/ 477575 h 557834"/>
                    <a:gd name="connsiteX5" fmla="*/ 614360 w 925272"/>
                    <a:gd name="connsiteY5" fmla="*/ 239373 h 557834"/>
                    <a:gd name="connsiteX6" fmla="*/ 323181 w 925272"/>
                    <a:gd name="connsiteY6" fmla="*/ 221063 h 557834"/>
                    <a:gd name="connsiteX7" fmla="*/ 137577 w 925272"/>
                    <a:gd name="connsiteY7" fmla="*/ 551149 h 557834"/>
                    <a:gd name="connsiteX8" fmla="*/ 283 w 925272"/>
                    <a:gd name="connsiteY8" fmla="*/ 357772 h 557834"/>
                    <a:gd name="connsiteX0" fmla="*/ 283 w 925272"/>
                    <a:gd name="connsiteY0" fmla="*/ 357772 h 505215"/>
                    <a:gd name="connsiteX1" fmla="*/ 263891 w 925272"/>
                    <a:gd name="connsiteY1" fmla="*/ 48227 h 505215"/>
                    <a:gd name="connsiteX2" fmla="*/ 623863 w 925272"/>
                    <a:gd name="connsiteY2" fmla="*/ 39387 h 505215"/>
                    <a:gd name="connsiteX3" fmla="*/ 925272 w 925272"/>
                    <a:gd name="connsiteY3" fmla="*/ 421509 h 505215"/>
                    <a:gd name="connsiteX4" fmla="*/ 784939 w 925272"/>
                    <a:gd name="connsiteY4" fmla="*/ 477575 h 505215"/>
                    <a:gd name="connsiteX5" fmla="*/ 614360 w 925272"/>
                    <a:gd name="connsiteY5" fmla="*/ 239373 h 505215"/>
                    <a:gd name="connsiteX6" fmla="*/ 323181 w 925272"/>
                    <a:gd name="connsiteY6" fmla="*/ 221063 h 505215"/>
                    <a:gd name="connsiteX7" fmla="*/ 132607 w 925272"/>
                    <a:gd name="connsiteY7" fmla="*/ 496450 h 505215"/>
                    <a:gd name="connsiteX8" fmla="*/ 283 w 925272"/>
                    <a:gd name="connsiteY8" fmla="*/ 357772 h 505215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344909 w 947000"/>
                    <a:gd name="connsiteY6" fmla="*/ 227109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296839 w 947000"/>
                    <a:gd name="connsiteY6" fmla="*/ 254428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296839 w 947000"/>
                    <a:gd name="connsiteY6" fmla="*/ 254428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296839 w 947000"/>
                    <a:gd name="connsiteY6" fmla="*/ 254428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53488 w 947000"/>
                    <a:gd name="connsiteY5" fmla="*/ 203309 h 523249"/>
                    <a:gd name="connsiteX6" fmla="*/ 296839 w 947000"/>
                    <a:gd name="connsiteY6" fmla="*/ 254428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52370 w 947000"/>
                    <a:gd name="connsiteY5" fmla="*/ 215990 h 523249"/>
                    <a:gd name="connsiteX6" fmla="*/ 296839 w 947000"/>
                    <a:gd name="connsiteY6" fmla="*/ 254428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70 w 947013"/>
                    <a:gd name="connsiteY0" fmla="*/ 483982 h 538413"/>
                    <a:gd name="connsiteX1" fmla="*/ 285632 w 947013"/>
                    <a:gd name="connsiteY1" fmla="*/ 69437 h 538413"/>
                    <a:gd name="connsiteX2" fmla="*/ 701029 w 947013"/>
                    <a:gd name="connsiteY2" fmla="*/ 36886 h 538413"/>
                    <a:gd name="connsiteX3" fmla="*/ 947013 w 947013"/>
                    <a:gd name="connsiteY3" fmla="*/ 442719 h 538413"/>
                    <a:gd name="connsiteX4" fmla="*/ 806680 w 947013"/>
                    <a:gd name="connsiteY4" fmla="*/ 498785 h 538413"/>
                    <a:gd name="connsiteX5" fmla="*/ 652383 w 947013"/>
                    <a:gd name="connsiteY5" fmla="*/ 231154 h 538413"/>
                    <a:gd name="connsiteX6" fmla="*/ 296852 w 947013"/>
                    <a:gd name="connsiteY6" fmla="*/ 269592 h 538413"/>
                    <a:gd name="connsiteX7" fmla="*/ 154348 w 947013"/>
                    <a:gd name="connsiteY7" fmla="*/ 517660 h 538413"/>
                    <a:gd name="connsiteX8" fmla="*/ 270 w 947013"/>
                    <a:gd name="connsiteY8" fmla="*/ 483982 h 538413"/>
                    <a:gd name="connsiteX0" fmla="*/ 270 w 947013"/>
                    <a:gd name="connsiteY0" fmla="*/ 483982 h 538413"/>
                    <a:gd name="connsiteX1" fmla="*/ 285632 w 947013"/>
                    <a:gd name="connsiteY1" fmla="*/ 69437 h 538413"/>
                    <a:gd name="connsiteX2" fmla="*/ 701029 w 947013"/>
                    <a:gd name="connsiteY2" fmla="*/ 36886 h 538413"/>
                    <a:gd name="connsiteX3" fmla="*/ 947013 w 947013"/>
                    <a:gd name="connsiteY3" fmla="*/ 442719 h 538413"/>
                    <a:gd name="connsiteX4" fmla="*/ 856579 w 947013"/>
                    <a:gd name="connsiteY4" fmla="*/ 468150 h 538413"/>
                    <a:gd name="connsiteX5" fmla="*/ 652383 w 947013"/>
                    <a:gd name="connsiteY5" fmla="*/ 231154 h 538413"/>
                    <a:gd name="connsiteX6" fmla="*/ 296852 w 947013"/>
                    <a:gd name="connsiteY6" fmla="*/ 269592 h 538413"/>
                    <a:gd name="connsiteX7" fmla="*/ 154348 w 947013"/>
                    <a:gd name="connsiteY7" fmla="*/ 517660 h 538413"/>
                    <a:gd name="connsiteX8" fmla="*/ 270 w 947013"/>
                    <a:gd name="connsiteY8" fmla="*/ 483982 h 538413"/>
                    <a:gd name="connsiteX0" fmla="*/ 270 w 1007459"/>
                    <a:gd name="connsiteY0" fmla="*/ 482425 h 536856"/>
                    <a:gd name="connsiteX1" fmla="*/ 285632 w 1007459"/>
                    <a:gd name="connsiteY1" fmla="*/ 67880 h 536856"/>
                    <a:gd name="connsiteX2" fmla="*/ 701029 w 1007459"/>
                    <a:gd name="connsiteY2" fmla="*/ 35329 h 536856"/>
                    <a:gd name="connsiteX3" fmla="*/ 1007459 w 1007459"/>
                    <a:gd name="connsiteY3" fmla="*/ 419406 h 536856"/>
                    <a:gd name="connsiteX4" fmla="*/ 856579 w 1007459"/>
                    <a:gd name="connsiteY4" fmla="*/ 466593 h 536856"/>
                    <a:gd name="connsiteX5" fmla="*/ 652383 w 1007459"/>
                    <a:gd name="connsiteY5" fmla="*/ 229597 h 536856"/>
                    <a:gd name="connsiteX6" fmla="*/ 296852 w 1007459"/>
                    <a:gd name="connsiteY6" fmla="*/ 268035 h 536856"/>
                    <a:gd name="connsiteX7" fmla="*/ 154348 w 1007459"/>
                    <a:gd name="connsiteY7" fmla="*/ 516103 h 536856"/>
                    <a:gd name="connsiteX8" fmla="*/ 270 w 1007459"/>
                    <a:gd name="connsiteY8" fmla="*/ 482425 h 536856"/>
                    <a:gd name="connsiteX0" fmla="*/ 270 w 1007459"/>
                    <a:gd name="connsiteY0" fmla="*/ 482425 h 536856"/>
                    <a:gd name="connsiteX1" fmla="*/ 285632 w 1007459"/>
                    <a:gd name="connsiteY1" fmla="*/ 67880 h 536856"/>
                    <a:gd name="connsiteX2" fmla="*/ 701029 w 1007459"/>
                    <a:gd name="connsiteY2" fmla="*/ 35329 h 536856"/>
                    <a:gd name="connsiteX3" fmla="*/ 1007459 w 1007459"/>
                    <a:gd name="connsiteY3" fmla="*/ 419406 h 536856"/>
                    <a:gd name="connsiteX4" fmla="*/ 893950 w 1007459"/>
                    <a:gd name="connsiteY4" fmla="*/ 454924 h 536856"/>
                    <a:gd name="connsiteX5" fmla="*/ 652383 w 1007459"/>
                    <a:gd name="connsiteY5" fmla="*/ 229597 h 536856"/>
                    <a:gd name="connsiteX6" fmla="*/ 296852 w 1007459"/>
                    <a:gd name="connsiteY6" fmla="*/ 268035 h 536856"/>
                    <a:gd name="connsiteX7" fmla="*/ 154348 w 1007459"/>
                    <a:gd name="connsiteY7" fmla="*/ 516103 h 536856"/>
                    <a:gd name="connsiteX8" fmla="*/ 270 w 1007459"/>
                    <a:gd name="connsiteY8" fmla="*/ 482425 h 536856"/>
                    <a:gd name="connsiteX0" fmla="*/ 270 w 1007459"/>
                    <a:gd name="connsiteY0" fmla="*/ 482425 h 536856"/>
                    <a:gd name="connsiteX1" fmla="*/ 285632 w 1007459"/>
                    <a:gd name="connsiteY1" fmla="*/ 67880 h 536856"/>
                    <a:gd name="connsiteX2" fmla="*/ 701029 w 1007459"/>
                    <a:gd name="connsiteY2" fmla="*/ 35329 h 536856"/>
                    <a:gd name="connsiteX3" fmla="*/ 1007459 w 1007459"/>
                    <a:gd name="connsiteY3" fmla="*/ 419406 h 536856"/>
                    <a:gd name="connsiteX4" fmla="*/ 893950 w 1007459"/>
                    <a:gd name="connsiteY4" fmla="*/ 454924 h 536856"/>
                    <a:gd name="connsiteX5" fmla="*/ 652383 w 1007459"/>
                    <a:gd name="connsiteY5" fmla="*/ 229597 h 536856"/>
                    <a:gd name="connsiteX6" fmla="*/ 296852 w 1007459"/>
                    <a:gd name="connsiteY6" fmla="*/ 268035 h 536856"/>
                    <a:gd name="connsiteX7" fmla="*/ 154348 w 1007459"/>
                    <a:gd name="connsiteY7" fmla="*/ 516103 h 536856"/>
                    <a:gd name="connsiteX8" fmla="*/ 270 w 1007459"/>
                    <a:gd name="connsiteY8" fmla="*/ 482425 h 536856"/>
                    <a:gd name="connsiteX0" fmla="*/ 270 w 1007459"/>
                    <a:gd name="connsiteY0" fmla="*/ 482425 h 536856"/>
                    <a:gd name="connsiteX1" fmla="*/ 285632 w 1007459"/>
                    <a:gd name="connsiteY1" fmla="*/ 67880 h 536856"/>
                    <a:gd name="connsiteX2" fmla="*/ 701029 w 1007459"/>
                    <a:gd name="connsiteY2" fmla="*/ 35329 h 536856"/>
                    <a:gd name="connsiteX3" fmla="*/ 1007459 w 1007459"/>
                    <a:gd name="connsiteY3" fmla="*/ 419406 h 536856"/>
                    <a:gd name="connsiteX4" fmla="*/ 865351 w 1007459"/>
                    <a:gd name="connsiteY4" fmla="*/ 458087 h 536856"/>
                    <a:gd name="connsiteX5" fmla="*/ 652383 w 1007459"/>
                    <a:gd name="connsiteY5" fmla="*/ 229597 h 536856"/>
                    <a:gd name="connsiteX6" fmla="*/ 296852 w 1007459"/>
                    <a:gd name="connsiteY6" fmla="*/ 268035 h 536856"/>
                    <a:gd name="connsiteX7" fmla="*/ 154348 w 1007459"/>
                    <a:gd name="connsiteY7" fmla="*/ 516103 h 536856"/>
                    <a:gd name="connsiteX8" fmla="*/ 270 w 1007459"/>
                    <a:gd name="connsiteY8" fmla="*/ 482425 h 536856"/>
                    <a:gd name="connsiteX0" fmla="*/ 270 w 1007459"/>
                    <a:gd name="connsiteY0" fmla="*/ 482425 h 536856"/>
                    <a:gd name="connsiteX1" fmla="*/ 285632 w 1007459"/>
                    <a:gd name="connsiteY1" fmla="*/ 67880 h 536856"/>
                    <a:gd name="connsiteX2" fmla="*/ 701029 w 1007459"/>
                    <a:gd name="connsiteY2" fmla="*/ 35329 h 536856"/>
                    <a:gd name="connsiteX3" fmla="*/ 1007459 w 1007459"/>
                    <a:gd name="connsiteY3" fmla="*/ 419406 h 536856"/>
                    <a:gd name="connsiteX4" fmla="*/ 865351 w 1007459"/>
                    <a:gd name="connsiteY4" fmla="*/ 458087 h 536856"/>
                    <a:gd name="connsiteX5" fmla="*/ 652383 w 1007459"/>
                    <a:gd name="connsiteY5" fmla="*/ 229597 h 536856"/>
                    <a:gd name="connsiteX6" fmla="*/ 296852 w 1007459"/>
                    <a:gd name="connsiteY6" fmla="*/ 268035 h 536856"/>
                    <a:gd name="connsiteX7" fmla="*/ 154348 w 1007459"/>
                    <a:gd name="connsiteY7" fmla="*/ 516103 h 536856"/>
                    <a:gd name="connsiteX8" fmla="*/ 270 w 1007459"/>
                    <a:gd name="connsiteY8" fmla="*/ 482425 h 536856"/>
                    <a:gd name="connsiteX0" fmla="*/ 270 w 1007459"/>
                    <a:gd name="connsiteY0" fmla="*/ 482425 h 536856"/>
                    <a:gd name="connsiteX1" fmla="*/ 285632 w 1007459"/>
                    <a:gd name="connsiteY1" fmla="*/ 67880 h 536856"/>
                    <a:gd name="connsiteX2" fmla="*/ 701029 w 1007459"/>
                    <a:gd name="connsiteY2" fmla="*/ 35329 h 536856"/>
                    <a:gd name="connsiteX3" fmla="*/ 1007459 w 1007459"/>
                    <a:gd name="connsiteY3" fmla="*/ 419406 h 536856"/>
                    <a:gd name="connsiteX4" fmla="*/ 865351 w 1007459"/>
                    <a:gd name="connsiteY4" fmla="*/ 458087 h 536856"/>
                    <a:gd name="connsiteX5" fmla="*/ 652383 w 1007459"/>
                    <a:gd name="connsiteY5" fmla="*/ 229597 h 536856"/>
                    <a:gd name="connsiteX6" fmla="*/ 296852 w 1007459"/>
                    <a:gd name="connsiteY6" fmla="*/ 268035 h 536856"/>
                    <a:gd name="connsiteX7" fmla="*/ 154348 w 1007459"/>
                    <a:gd name="connsiteY7" fmla="*/ 516103 h 536856"/>
                    <a:gd name="connsiteX8" fmla="*/ 270 w 1007459"/>
                    <a:gd name="connsiteY8" fmla="*/ 482425 h 536856"/>
                    <a:gd name="connsiteX0" fmla="*/ 270 w 1007459"/>
                    <a:gd name="connsiteY0" fmla="*/ 482425 h 581634"/>
                    <a:gd name="connsiteX1" fmla="*/ 285632 w 1007459"/>
                    <a:gd name="connsiteY1" fmla="*/ 67880 h 581634"/>
                    <a:gd name="connsiteX2" fmla="*/ 701029 w 1007459"/>
                    <a:gd name="connsiteY2" fmla="*/ 35329 h 581634"/>
                    <a:gd name="connsiteX3" fmla="*/ 1007459 w 1007459"/>
                    <a:gd name="connsiteY3" fmla="*/ 419406 h 581634"/>
                    <a:gd name="connsiteX4" fmla="*/ 865351 w 1007459"/>
                    <a:gd name="connsiteY4" fmla="*/ 458087 h 581634"/>
                    <a:gd name="connsiteX5" fmla="*/ 652383 w 1007459"/>
                    <a:gd name="connsiteY5" fmla="*/ 229597 h 581634"/>
                    <a:gd name="connsiteX6" fmla="*/ 296852 w 1007459"/>
                    <a:gd name="connsiteY6" fmla="*/ 268035 h 581634"/>
                    <a:gd name="connsiteX7" fmla="*/ 161581 w 1007459"/>
                    <a:gd name="connsiteY7" fmla="*/ 569264 h 581634"/>
                    <a:gd name="connsiteX8" fmla="*/ 270 w 1007459"/>
                    <a:gd name="connsiteY8" fmla="*/ 482425 h 581634"/>
                    <a:gd name="connsiteX0" fmla="*/ 276 w 1004153"/>
                    <a:gd name="connsiteY0" fmla="*/ 535833 h 592031"/>
                    <a:gd name="connsiteX1" fmla="*/ 282326 w 1004153"/>
                    <a:gd name="connsiteY1" fmla="*/ 70466 h 592031"/>
                    <a:gd name="connsiteX2" fmla="*/ 697723 w 1004153"/>
                    <a:gd name="connsiteY2" fmla="*/ 37915 h 592031"/>
                    <a:gd name="connsiteX3" fmla="*/ 1004153 w 1004153"/>
                    <a:gd name="connsiteY3" fmla="*/ 421992 h 592031"/>
                    <a:gd name="connsiteX4" fmla="*/ 862045 w 1004153"/>
                    <a:gd name="connsiteY4" fmla="*/ 460673 h 592031"/>
                    <a:gd name="connsiteX5" fmla="*/ 649077 w 1004153"/>
                    <a:gd name="connsiteY5" fmla="*/ 232183 h 592031"/>
                    <a:gd name="connsiteX6" fmla="*/ 293546 w 1004153"/>
                    <a:gd name="connsiteY6" fmla="*/ 270621 h 592031"/>
                    <a:gd name="connsiteX7" fmla="*/ 158275 w 1004153"/>
                    <a:gd name="connsiteY7" fmla="*/ 571850 h 592031"/>
                    <a:gd name="connsiteX8" fmla="*/ 276 w 1004153"/>
                    <a:gd name="connsiteY8" fmla="*/ 535833 h 592031"/>
                    <a:gd name="connsiteX0" fmla="*/ 275 w 1004152"/>
                    <a:gd name="connsiteY0" fmla="*/ 535833 h 610191"/>
                    <a:gd name="connsiteX1" fmla="*/ 282325 w 1004152"/>
                    <a:gd name="connsiteY1" fmla="*/ 70466 h 610191"/>
                    <a:gd name="connsiteX2" fmla="*/ 697722 w 1004152"/>
                    <a:gd name="connsiteY2" fmla="*/ 37915 h 610191"/>
                    <a:gd name="connsiteX3" fmla="*/ 1004152 w 1004152"/>
                    <a:gd name="connsiteY3" fmla="*/ 421992 h 610191"/>
                    <a:gd name="connsiteX4" fmla="*/ 862044 w 1004152"/>
                    <a:gd name="connsiteY4" fmla="*/ 460673 h 610191"/>
                    <a:gd name="connsiteX5" fmla="*/ 649076 w 1004152"/>
                    <a:gd name="connsiteY5" fmla="*/ 232183 h 610191"/>
                    <a:gd name="connsiteX6" fmla="*/ 293545 w 1004152"/>
                    <a:gd name="connsiteY6" fmla="*/ 270621 h 610191"/>
                    <a:gd name="connsiteX7" fmla="*/ 164137 w 1004152"/>
                    <a:gd name="connsiteY7" fmla="*/ 594344 h 610191"/>
                    <a:gd name="connsiteX8" fmla="*/ 275 w 1004152"/>
                    <a:gd name="connsiteY8" fmla="*/ 535833 h 610191"/>
                    <a:gd name="connsiteX0" fmla="*/ 282 w 998335"/>
                    <a:gd name="connsiteY0" fmla="*/ 599557 h 631428"/>
                    <a:gd name="connsiteX1" fmla="*/ 276508 w 998335"/>
                    <a:gd name="connsiteY1" fmla="*/ 73728 h 631428"/>
                    <a:gd name="connsiteX2" fmla="*/ 691905 w 998335"/>
                    <a:gd name="connsiteY2" fmla="*/ 41177 h 631428"/>
                    <a:gd name="connsiteX3" fmla="*/ 998335 w 998335"/>
                    <a:gd name="connsiteY3" fmla="*/ 425254 h 631428"/>
                    <a:gd name="connsiteX4" fmla="*/ 856227 w 998335"/>
                    <a:gd name="connsiteY4" fmla="*/ 463935 h 631428"/>
                    <a:gd name="connsiteX5" fmla="*/ 643259 w 998335"/>
                    <a:gd name="connsiteY5" fmla="*/ 235445 h 631428"/>
                    <a:gd name="connsiteX6" fmla="*/ 287728 w 998335"/>
                    <a:gd name="connsiteY6" fmla="*/ 273883 h 631428"/>
                    <a:gd name="connsiteX7" fmla="*/ 158320 w 998335"/>
                    <a:gd name="connsiteY7" fmla="*/ 597606 h 631428"/>
                    <a:gd name="connsiteX8" fmla="*/ 282 w 998335"/>
                    <a:gd name="connsiteY8" fmla="*/ 599557 h 631428"/>
                    <a:gd name="connsiteX0" fmla="*/ 287 w 994686"/>
                    <a:gd name="connsiteY0" fmla="*/ 587545 h 625591"/>
                    <a:gd name="connsiteX1" fmla="*/ 272859 w 994686"/>
                    <a:gd name="connsiteY1" fmla="*/ 73102 h 625591"/>
                    <a:gd name="connsiteX2" fmla="*/ 688256 w 994686"/>
                    <a:gd name="connsiteY2" fmla="*/ 40551 h 625591"/>
                    <a:gd name="connsiteX3" fmla="*/ 994686 w 994686"/>
                    <a:gd name="connsiteY3" fmla="*/ 424628 h 625591"/>
                    <a:gd name="connsiteX4" fmla="*/ 852578 w 994686"/>
                    <a:gd name="connsiteY4" fmla="*/ 463309 h 625591"/>
                    <a:gd name="connsiteX5" fmla="*/ 639610 w 994686"/>
                    <a:gd name="connsiteY5" fmla="*/ 234819 h 625591"/>
                    <a:gd name="connsiteX6" fmla="*/ 284079 w 994686"/>
                    <a:gd name="connsiteY6" fmla="*/ 273257 h 625591"/>
                    <a:gd name="connsiteX7" fmla="*/ 154671 w 994686"/>
                    <a:gd name="connsiteY7" fmla="*/ 596980 h 625591"/>
                    <a:gd name="connsiteX8" fmla="*/ 287 w 994686"/>
                    <a:gd name="connsiteY8" fmla="*/ 587545 h 625591"/>
                    <a:gd name="connsiteX0" fmla="*/ 287 w 994686"/>
                    <a:gd name="connsiteY0" fmla="*/ 587544 h 625590"/>
                    <a:gd name="connsiteX1" fmla="*/ 272859 w 994686"/>
                    <a:gd name="connsiteY1" fmla="*/ 73101 h 625590"/>
                    <a:gd name="connsiteX2" fmla="*/ 688256 w 994686"/>
                    <a:gd name="connsiteY2" fmla="*/ 40550 h 625590"/>
                    <a:gd name="connsiteX3" fmla="*/ 994686 w 994686"/>
                    <a:gd name="connsiteY3" fmla="*/ 424627 h 625590"/>
                    <a:gd name="connsiteX4" fmla="*/ 852578 w 994686"/>
                    <a:gd name="connsiteY4" fmla="*/ 463308 h 625590"/>
                    <a:gd name="connsiteX5" fmla="*/ 639610 w 994686"/>
                    <a:gd name="connsiteY5" fmla="*/ 234818 h 625590"/>
                    <a:gd name="connsiteX6" fmla="*/ 302238 w 994686"/>
                    <a:gd name="connsiteY6" fmla="*/ 330227 h 625590"/>
                    <a:gd name="connsiteX7" fmla="*/ 154671 w 994686"/>
                    <a:gd name="connsiteY7" fmla="*/ 596979 h 625590"/>
                    <a:gd name="connsiteX8" fmla="*/ 287 w 994686"/>
                    <a:gd name="connsiteY8" fmla="*/ 587544 h 625590"/>
                    <a:gd name="connsiteX0" fmla="*/ 690 w 995089"/>
                    <a:gd name="connsiteY0" fmla="*/ 554517 h 592563"/>
                    <a:gd name="connsiteX1" fmla="*/ 171115 w 995089"/>
                    <a:gd name="connsiteY1" fmla="*/ 169049 h 592563"/>
                    <a:gd name="connsiteX2" fmla="*/ 688659 w 995089"/>
                    <a:gd name="connsiteY2" fmla="*/ 7523 h 592563"/>
                    <a:gd name="connsiteX3" fmla="*/ 995089 w 995089"/>
                    <a:gd name="connsiteY3" fmla="*/ 391600 h 592563"/>
                    <a:gd name="connsiteX4" fmla="*/ 852981 w 995089"/>
                    <a:gd name="connsiteY4" fmla="*/ 430281 h 592563"/>
                    <a:gd name="connsiteX5" fmla="*/ 640013 w 995089"/>
                    <a:gd name="connsiteY5" fmla="*/ 201791 h 592563"/>
                    <a:gd name="connsiteX6" fmla="*/ 302641 w 995089"/>
                    <a:gd name="connsiteY6" fmla="*/ 297200 h 592563"/>
                    <a:gd name="connsiteX7" fmla="*/ 155074 w 995089"/>
                    <a:gd name="connsiteY7" fmla="*/ 563952 h 592563"/>
                    <a:gd name="connsiteX8" fmla="*/ 690 w 995089"/>
                    <a:gd name="connsiteY8" fmla="*/ 554517 h 592563"/>
                    <a:gd name="connsiteX0" fmla="*/ 690 w 995089"/>
                    <a:gd name="connsiteY0" fmla="*/ 554516 h 592562"/>
                    <a:gd name="connsiteX1" fmla="*/ 171115 w 995089"/>
                    <a:gd name="connsiteY1" fmla="*/ 169048 h 592562"/>
                    <a:gd name="connsiteX2" fmla="*/ 688659 w 995089"/>
                    <a:gd name="connsiteY2" fmla="*/ 7522 h 592562"/>
                    <a:gd name="connsiteX3" fmla="*/ 995089 w 995089"/>
                    <a:gd name="connsiteY3" fmla="*/ 391599 h 592562"/>
                    <a:gd name="connsiteX4" fmla="*/ 856332 w 995089"/>
                    <a:gd name="connsiteY4" fmla="*/ 443135 h 592562"/>
                    <a:gd name="connsiteX5" fmla="*/ 640013 w 995089"/>
                    <a:gd name="connsiteY5" fmla="*/ 201790 h 592562"/>
                    <a:gd name="connsiteX6" fmla="*/ 302641 w 995089"/>
                    <a:gd name="connsiteY6" fmla="*/ 297199 h 592562"/>
                    <a:gd name="connsiteX7" fmla="*/ 155074 w 995089"/>
                    <a:gd name="connsiteY7" fmla="*/ 563951 h 592562"/>
                    <a:gd name="connsiteX8" fmla="*/ 690 w 995089"/>
                    <a:gd name="connsiteY8" fmla="*/ 554516 h 592562"/>
                    <a:gd name="connsiteX0" fmla="*/ 690 w 995089"/>
                    <a:gd name="connsiteY0" fmla="*/ 554516 h 592562"/>
                    <a:gd name="connsiteX1" fmla="*/ 171115 w 995089"/>
                    <a:gd name="connsiteY1" fmla="*/ 169048 h 592562"/>
                    <a:gd name="connsiteX2" fmla="*/ 688659 w 995089"/>
                    <a:gd name="connsiteY2" fmla="*/ 7522 h 592562"/>
                    <a:gd name="connsiteX3" fmla="*/ 995089 w 995089"/>
                    <a:gd name="connsiteY3" fmla="*/ 391599 h 592562"/>
                    <a:gd name="connsiteX4" fmla="*/ 865851 w 995089"/>
                    <a:gd name="connsiteY4" fmla="*/ 454244 h 592562"/>
                    <a:gd name="connsiteX5" fmla="*/ 640013 w 995089"/>
                    <a:gd name="connsiteY5" fmla="*/ 201790 h 592562"/>
                    <a:gd name="connsiteX6" fmla="*/ 302641 w 995089"/>
                    <a:gd name="connsiteY6" fmla="*/ 297199 h 592562"/>
                    <a:gd name="connsiteX7" fmla="*/ 155074 w 995089"/>
                    <a:gd name="connsiteY7" fmla="*/ 563951 h 592562"/>
                    <a:gd name="connsiteX8" fmla="*/ 690 w 995089"/>
                    <a:gd name="connsiteY8" fmla="*/ 554516 h 592562"/>
                    <a:gd name="connsiteX0" fmla="*/ 690 w 995089"/>
                    <a:gd name="connsiteY0" fmla="*/ 554516 h 592562"/>
                    <a:gd name="connsiteX1" fmla="*/ 171115 w 995089"/>
                    <a:gd name="connsiteY1" fmla="*/ 169048 h 592562"/>
                    <a:gd name="connsiteX2" fmla="*/ 688659 w 995089"/>
                    <a:gd name="connsiteY2" fmla="*/ 7522 h 592562"/>
                    <a:gd name="connsiteX3" fmla="*/ 995089 w 995089"/>
                    <a:gd name="connsiteY3" fmla="*/ 391599 h 592562"/>
                    <a:gd name="connsiteX4" fmla="*/ 865851 w 995089"/>
                    <a:gd name="connsiteY4" fmla="*/ 454244 h 592562"/>
                    <a:gd name="connsiteX5" fmla="*/ 640013 w 995089"/>
                    <a:gd name="connsiteY5" fmla="*/ 201790 h 592562"/>
                    <a:gd name="connsiteX6" fmla="*/ 302641 w 995089"/>
                    <a:gd name="connsiteY6" fmla="*/ 297199 h 592562"/>
                    <a:gd name="connsiteX7" fmla="*/ 155074 w 995089"/>
                    <a:gd name="connsiteY7" fmla="*/ 563951 h 592562"/>
                    <a:gd name="connsiteX8" fmla="*/ 690 w 995089"/>
                    <a:gd name="connsiteY8" fmla="*/ 554516 h 59256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995089" h="592562">
                      <a:moveTo>
                        <a:pt x="690" y="554516"/>
                      </a:moveTo>
                      <a:cubicBezTo>
                        <a:pt x="-7427" y="423713"/>
                        <a:pt x="56454" y="260214"/>
                        <a:pt x="171115" y="169048"/>
                      </a:cubicBezTo>
                      <a:cubicBezTo>
                        <a:pt x="285776" y="77882"/>
                        <a:pt x="551330" y="-29570"/>
                        <a:pt x="688659" y="7522"/>
                      </a:cubicBezTo>
                      <a:cubicBezTo>
                        <a:pt x="825988" y="44614"/>
                        <a:pt x="982482" y="254987"/>
                        <a:pt x="995089" y="391599"/>
                      </a:cubicBezTo>
                      <a:cubicBezTo>
                        <a:pt x="991575" y="460541"/>
                        <a:pt x="932132" y="434685"/>
                        <a:pt x="865851" y="454244"/>
                      </a:cubicBezTo>
                      <a:cubicBezTo>
                        <a:pt x="770015" y="218647"/>
                        <a:pt x="692261" y="239899"/>
                        <a:pt x="640013" y="201790"/>
                      </a:cubicBezTo>
                      <a:cubicBezTo>
                        <a:pt x="595014" y="163992"/>
                        <a:pt x="414366" y="224883"/>
                        <a:pt x="302641" y="297199"/>
                      </a:cubicBezTo>
                      <a:cubicBezTo>
                        <a:pt x="212651" y="393200"/>
                        <a:pt x="190769" y="468903"/>
                        <a:pt x="155074" y="563951"/>
                      </a:cubicBezTo>
                      <a:cubicBezTo>
                        <a:pt x="75480" y="609010"/>
                        <a:pt x="64659" y="597043"/>
                        <a:pt x="690" y="554516"/>
                      </a:cubicBezTo>
                      <a:close/>
                    </a:path>
                  </a:pathLst>
                </a:custGeom>
                <a:grpFill/>
                <a:ln>
                  <a:solidFill>
                    <a:schemeClr val="tx2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350">
                    <a:solidFill>
                      <a:schemeClr val="bg2">
                        <a:lumMod val="25000"/>
                      </a:schemeClr>
                    </a:solidFill>
                  </a:endParaRPr>
                </a:p>
              </p:txBody>
            </p:sp>
            <p:sp>
              <p:nvSpPr>
                <p:cNvPr id="27" name="Block Arc 15"/>
                <p:cNvSpPr/>
                <p:nvPr/>
              </p:nvSpPr>
              <p:spPr>
                <a:xfrm rot="6311649">
                  <a:off x="5296578" y="815135"/>
                  <a:ext cx="741542" cy="423743"/>
                </a:xfrm>
                <a:custGeom>
                  <a:avLst/>
                  <a:gdLst>
                    <a:gd name="connsiteX0" fmla="*/ 627 w 745516"/>
                    <a:gd name="connsiteY0" fmla="*/ 369014 h 697590"/>
                    <a:gd name="connsiteX1" fmla="*/ 184209 w 745516"/>
                    <a:gd name="connsiteY1" fmla="*/ 47911 h 697590"/>
                    <a:gd name="connsiteX2" fmla="*/ 544181 w 745516"/>
                    <a:gd name="connsiteY2" fmla="*/ 39071 h 697590"/>
                    <a:gd name="connsiteX3" fmla="*/ 745515 w 745516"/>
                    <a:gd name="connsiteY3" fmla="*/ 348795 h 697590"/>
                    <a:gd name="connsiteX4" fmla="*/ 571119 w 745516"/>
                    <a:gd name="connsiteY4" fmla="*/ 348795 h 697590"/>
                    <a:gd name="connsiteX5" fmla="*/ 459552 w 745516"/>
                    <a:gd name="connsiteY5" fmla="*/ 191978 h 697590"/>
                    <a:gd name="connsiteX6" fmla="*/ 277038 w 745516"/>
                    <a:gd name="connsiteY6" fmla="*/ 196046 h 697590"/>
                    <a:gd name="connsiteX7" fmla="*/ 174775 w 745516"/>
                    <a:gd name="connsiteY7" fmla="*/ 359552 h 697590"/>
                    <a:gd name="connsiteX8" fmla="*/ 627 w 745516"/>
                    <a:gd name="connsiteY8" fmla="*/ 369014 h 697590"/>
                    <a:gd name="connsiteX0" fmla="*/ 629 w 745517"/>
                    <a:gd name="connsiteY0" fmla="*/ 369014 h 369014"/>
                    <a:gd name="connsiteX1" fmla="*/ 184211 w 745517"/>
                    <a:gd name="connsiteY1" fmla="*/ 47911 h 369014"/>
                    <a:gd name="connsiteX2" fmla="*/ 544183 w 745517"/>
                    <a:gd name="connsiteY2" fmla="*/ 39071 h 369014"/>
                    <a:gd name="connsiteX3" fmla="*/ 745517 w 745517"/>
                    <a:gd name="connsiteY3" fmla="*/ 348795 h 369014"/>
                    <a:gd name="connsiteX4" fmla="*/ 668191 w 745517"/>
                    <a:gd name="connsiteY4" fmla="*/ 363523 h 369014"/>
                    <a:gd name="connsiteX5" fmla="*/ 459554 w 745517"/>
                    <a:gd name="connsiteY5" fmla="*/ 191978 h 369014"/>
                    <a:gd name="connsiteX6" fmla="*/ 277040 w 745517"/>
                    <a:gd name="connsiteY6" fmla="*/ 196046 h 369014"/>
                    <a:gd name="connsiteX7" fmla="*/ 174777 w 745517"/>
                    <a:gd name="connsiteY7" fmla="*/ 359552 h 369014"/>
                    <a:gd name="connsiteX8" fmla="*/ 629 w 745517"/>
                    <a:gd name="connsiteY8" fmla="*/ 369014 h 369014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59554 w 745517"/>
                    <a:gd name="connsiteY5" fmla="*/ 191978 h 425833"/>
                    <a:gd name="connsiteX6" fmla="*/ 277040 w 745517"/>
                    <a:gd name="connsiteY6" fmla="*/ 196046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48149 w 745517"/>
                    <a:gd name="connsiteY5" fmla="*/ 197842 h 425833"/>
                    <a:gd name="connsiteX6" fmla="*/ 277040 w 745517"/>
                    <a:gd name="connsiteY6" fmla="*/ 196046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277040 w 745517"/>
                    <a:gd name="connsiteY6" fmla="*/ 196046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387239 w 745517"/>
                    <a:gd name="connsiteY6" fmla="*/ 147341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387239 w 745517"/>
                    <a:gd name="connsiteY6" fmla="*/ 147341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387239 w 745517"/>
                    <a:gd name="connsiteY6" fmla="*/ 147341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396919 w 745517"/>
                    <a:gd name="connsiteY6" fmla="*/ 199046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396919 w 745517"/>
                    <a:gd name="connsiteY5" fmla="*/ 199046 h 425833"/>
                    <a:gd name="connsiteX6" fmla="*/ 174777 w 745517"/>
                    <a:gd name="connsiteY6" fmla="*/ 359552 h 425833"/>
                    <a:gd name="connsiteX7" fmla="*/ 629 w 745517"/>
                    <a:gd name="connsiteY7" fmla="*/ 369014 h 425833"/>
                    <a:gd name="connsiteX0" fmla="*/ 629 w 777485"/>
                    <a:gd name="connsiteY0" fmla="*/ 364465 h 421284"/>
                    <a:gd name="connsiteX1" fmla="*/ 184211 w 777485"/>
                    <a:gd name="connsiteY1" fmla="*/ 43362 h 421284"/>
                    <a:gd name="connsiteX2" fmla="*/ 544183 w 777485"/>
                    <a:gd name="connsiteY2" fmla="*/ 34522 h 421284"/>
                    <a:gd name="connsiteX3" fmla="*/ 777485 w 777485"/>
                    <a:gd name="connsiteY3" fmla="*/ 302949 h 421284"/>
                    <a:gd name="connsiteX4" fmla="*/ 666916 w 777485"/>
                    <a:gd name="connsiteY4" fmla="*/ 421284 h 421284"/>
                    <a:gd name="connsiteX5" fmla="*/ 396919 w 777485"/>
                    <a:gd name="connsiteY5" fmla="*/ 194497 h 421284"/>
                    <a:gd name="connsiteX6" fmla="*/ 174777 w 777485"/>
                    <a:gd name="connsiteY6" fmla="*/ 355003 h 421284"/>
                    <a:gd name="connsiteX7" fmla="*/ 629 w 777485"/>
                    <a:gd name="connsiteY7" fmla="*/ 364465 h 421284"/>
                    <a:gd name="connsiteX0" fmla="*/ 629 w 777485"/>
                    <a:gd name="connsiteY0" fmla="*/ 364465 h 421284"/>
                    <a:gd name="connsiteX1" fmla="*/ 184211 w 777485"/>
                    <a:gd name="connsiteY1" fmla="*/ 43362 h 421284"/>
                    <a:gd name="connsiteX2" fmla="*/ 544183 w 777485"/>
                    <a:gd name="connsiteY2" fmla="*/ 34522 h 421284"/>
                    <a:gd name="connsiteX3" fmla="*/ 777485 w 777485"/>
                    <a:gd name="connsiteY3" fmla="*/ 302949 h 421284"/>
                    <a:gd name="connsiteX4" fmla="*/ 666916 w 777485"/>
                    <a:gd name="connsiteY4" fmla="*/ 421284 h 421284"/>
                    <a:gd name="connsiteX5" fmla="*/ 396919 w 777485"/>
                    <a:gd name="connsiteY5" fmla="*/ 194497 h 421284"/>
                    <a:gd name="connsiteX6" fmla="*/ 174777 w 777485"/>
                    <a:gd name="connsiteY6" fmla="*/ 355003 h 421284"/>
                    <a:gd name="connsiteX7" fmla="*/ 629 w 777485"/>
                    <a:gd name="connsiteY7" fmla="*/ 364465 h 421284"/>
                    <a:gd name="connsiteX0" fmla="*/ 629 w 777485"/>
                    <a:gd name="connsiteY0" fmla="*/ 364465 h 421284"/>
                    <a:gd name="connsiteX1" fmla="*/ 184211 w 777485"/>
                    <a:gd name="connsiteY1" fmla="*/ 43362 h 421284"/>
                    <a:gd name="connsiteX2" fmla="*/ 544183 w 777485"/>
                    <a:gd name="connsiteY2" fmla="*/ 34522 h 421284"/>
                    <a:gd name="connsiteX3" fmla="*/ 777485 w 777485"/>
                    <a:gd name="connsiteY3" fmla="*/ 302949 h 421284"/>
                    <a:gd name="connsiteX4" fmla="*/ 666916 w 777485"/>
                    <a:gd name="connsiteY4" fmla="*/ 421284 h 421284"/>
                    <a:gd name="connsiteX5" fmla="*/ 396919 w 777485"/>
                    <a:gd name="connsiteY5" fmla="*/ 194497 h 421284"/>
                    <a:gd name="connsiteX6" fmla="*/ 102409 w 777485"/>
                    <a:gd name="connsiteY6" fmla="*/ 373814 h 421284"/>
                    <a:gd name="connsiteX7" fmla="*/ 629 w 777485"/>
                    <a:gd name="connsiteY7" fmla="*/ 364465 h 421284"/>
                    <a:gd name="connsiteX0" fmla="*/ 329 w 828090"/>
                    <a:gd name="connsiteY0" fmla="*/ 354833 h 418791"/>
                    <a:gd name="connsiteX1" fmla="*/ 234816 w 828090"/>
                    <a:gd name="connsiteY1" fmla="*/ 40869 h 418791"/>
                    <a:gd name="connsiteX2" fmla="*/ 594788 w 828090"/>
                    <a:gd name="connsiteY2" fmla="*/ 32029 h 418791"/>
                    <a:gd name="connsiteX3" fmla="*/ 828090 w 828090"/>
                    <a:gd name="connsiteY3" fmla="*/ 300456 h 418791"/>
                    <a:gd name="connsiteX4" fmla="*/ 717521 w 828090"/>
                    <a:gd name="connsiteY4" fmla="*/ 418791 h 418791"/>
                    <a:gd name="connsiteX5" fmla="*/ 447524 w 828090"/>
                    <a:gd name="connsiteY5" fmla="*/ 192004 h 418791"/>
                    <a:gd name="connsiteX6" fmla="*/ 153014 w 828090"/>
                    <a:gd name="connsiteY6" fmla="*/ 371321 h 418791"/>
                    <a:gd name="connsiteX7" fmla="*/ 329 w 828090"/>
                    <a:gd name="connsiteY7" fmla="*/ 354833 h 418791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476599 w 857165"/>
                    <a:gd name="connsiteY5" fmla="*/ 191739 h 418526"/>
                    <a:gd name="connsiteX6" fmla="*/ 182089 w 857165"/>
                    <a:gd name="connsiteY6" fmla="*/ 371056 h 418526"/>
                    <a:gd name="connsiteX7" fmla="*/ 283 w 857165"/>
                    <a:gd name="connsiteY7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476599 w 857165"/>
                    <a:gd name="connsiteY5" fmla="*/ 191739 h 418526"/>
                    <a:gd name="connsiteX6" fmla="*/ 182089 w 857165"/>
                    <a:gd name="connsiteY6" fmla="*/ 371056 h 418526"/>
                    <a:gd name="connsiteX7" fmla="*/ 283 w 857165"/>
                    <a:gd name="connsiteY7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476599 w 857165"/>
                    <a:gd name="connsiteY5" fmla="*/ 191739 h 418526"/>
                    <a:gd name="connsiteX6" fmla="*/ 182089 w 857165"/>
                    <a:gd name="connsiteY6" fmla="*/ 371056 h 418526"/>
                    <a:gd name="connsiteX7" fmla="*/ 283 w 857165"/>
                    <a:gd name="connsiteY7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476599 w 857165"/>
                    <a:gd name="connsiteY5" fmla="*/ 191739 h 418526"/>
                    <a:gd name="connsiteX6" fmla="*/ 182089 w 857165"/>
                    <a:gd name="connsiteY6" fmla="*/ 371056 h 418526"/>
                    <a:gd name="connsiteX7" fmla="*/ 283 w 857165"/>
                    <a:gd name="connsiteY7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596226 w 857165"/>
                    <a:gd name="connsiteY5" fmla="*/ 269798 h 418526"/>
                    <a:gd name="connsiteX6" fmla="*/ 476599 w 857165"/>
                    <a:gd name="connsiteY6" fmla="*/ 191739 h 418526"/>
                    <a:gd name="connsiteX7" fmla="*/ 182089 w 857165"/>
                    <a:gd name="connsiteY7" fmla="*/ 371056 h 418526"/>
                    <a:gd name="connsiteX8" fmla="*/ 283 w 857165"/>
                    <a:gd name="connsiteY8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631337 w 857165"/>
                    <a:gd name="connsiteY5" fmla="*/ 261689 h 418526"/>
                    <a:gd name="connsiteX6" fmla="*/ 476599 w 857165"/>
                    <a:gd name="connsiteY6" fmla="*/ 191739 h 418526"/>
                    <a:gd name="connsiteX7" fmla="*/ 182089 w 857165"/>
                    <a:gd name="connsiteY7" fmla="*/ 371056 h 418526"/>
                    <a:gd name="connsiteX8" fmla="*/ 283 w 857165"/>
                    <a:gd name="connsiteY8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623229 w 857165"/>
                    <a:gd name="connsiteY5" fmla="*/ 226578 h 418526"/>
                    <a:gd name="connsiteX6" fmla="*/ 476599 w 857165"/>
                    <a:gd name="connsiteY6" fmla="*/ 191739 h 418526"/>
                    <a:gd name="connsiteX7" fmla="*/ 182089 w 857165"/>
                    <a:gd name="connsiteY7" fmla="*/ 371056 h 418526"/>
                    <a:gd name="connsiteX8" fmla="*/ 283 w 857165"/>
                    <a:gd name="connsiteY8" fmla="*/ 350149 h 418526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623229 w 857165"/>
                    <a:gd name="connsiteY5" fmla="*/ 226578 h 418077"/>
                    <a:gd name="connsiteX6" fmla="*/ 476599 w 857165"/>
                    <a:gd name="connsiteY6" fmla="*/ 191739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623229 w 857165"/>
                    <a:gd name="connsiteY5" fmla="*/ 226578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623229 w 857165"/>
                    <a:gd name="connsiteY5" fmla="*/ 226578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91288 w 857165"/>
                    <a:gd name="connsiteY5" fmla="*/ 217643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91288 w 857165"/>
                    <a:gd name="connsiteY5" fmla="*/ 217643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91288 w 857165"/>
                    <a:gd name="connsiteY5" fmla="*/ 217643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13122 w 857165"/>
                    <a:gd name="connsiteY6" fmla="*/ 233528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13122 w 857165"/>
                    <a:gd name="connsiteY6" fmla="*/ 233528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23181 w 857165"/>
                    <a:gd name="connsiteY6" fmla="*/ 213440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23181 w 857165"/>
                    <a:gd name="connsiteY6" fmla="*/ 213440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23181 w 857165"/>
                    <a:gd name="connsiteY6" fmla="*/ 213440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71599"/>
                    <a:gd name="connsiteX1" fmla="*/ 263891 w 857165"/>
                    <a:gd name="connsiteY1" fmla="*/ 40604 h 471599"/>
                    <a:gd name="connsiteX2" fmla="*/ 623863 w 857165"/>
                    <a:gd name="connsiteY2" fmla="*/ 31764 h 471599"/>
                    <a:gd name="connsiteX3" fmla="*/ 857165 w 857165"/>
                    <a:gd name="connsiteY3" fmla="*/ 300191 h 471599"/>
                    <a:gd name="connsiteX4" fmla="*/ 768237 w 857165"/>
                    <a:gd name="connsiteY4" fmla="*/ 471599 h 471599"/>
                    <a:gd name="connsiteX5" fmla="*/ 588791 w 857165"/>
                    <a:gd name="connsiteY5" fmla="*/ 241798 h 471599"/>
                    <a:gd name="connsiteX6" fmla="*/ 323181 w 857165"/>
                    <a:gd name="connsiteY6" fmla="*/ 213440 h 471599"/>
                    <a:gd name="connsiteX7" fmla="*/ 182089 w 857165"/>
                    <a:gd name="connsiteY7" fmla="*/ 371056 h 471599"/>
                    <a:gd name="connsiteX8" fmla="*/ 283 w 857165"/>
                    <a:gd name="connsiteY8" fmla="*/ 350149 h 471599"/>
                    <a:gd name="connsiteX0" fmla="*/ 283 w 922080"/>
                    <a:gd name="connsiteY0" fmla="*/ 359002 h 486990"/>
                    <a:gd name="connsiteX1" fmla="*/ 263891 w 922080"/>
                    <a:gd name="connsiteY1" fmla="*/ 49457 h 486990"/>
                    <a:gd name="connsiteX2" fmla="*/ 623863 w 922080"/>
                    <a:gd name="connsiteY2" fmla="*/ 40617 h 486990"/>
                    <a:gd name="connsiteX3" fmla="*/ 922080 w 922080"/>
                    <a:gd name="connsiteY3" fmla="*/ 440612 h 486990"/>
                    <a:gd name="connsiteX4" fmla="*/ 768237 w 922080"/>
                    <a:gd name="connsiteY4" fmla="*/ 480452 h 486990"/>
                    <a:gd name="connsiteX5" fmla="*/ 588791 w 922080"/>
                    <a:gd name="connsiteY5" fmla="*/ 250651 h 486990"/>
                    <a:gd name="connsiteX6" fmla="*/ 323181 w 922080"/>
                    <a:gd name="connsiteY6" fmla="*/ 222293 h 486990"/>
                    <a:gd name="connsiteX7" fmla="*/ 182089 w 922080"/>
                    <a:gd name="connsiteY7" fmla="*/ 379909 h 486990"/>
                    <a:gd name="connsiteX8" fmla="*/ 283 w 922080"/>
                    <a:gd name="connsiteY8" fmla="*/ 359002 h 486990"/>
                    <a:gd name="connsiteX0" fmla="*/ 283 w 925272"/>
                    <a:gd name="connsiteY0" fmla="*/ 357772 h 480085"/>
                    <a:gd name="connsiteX1" fmla="*/ 263891 w 925272"/>
                    <a:gd name="connsiteY1" fmla="*/ 48227 h 480085"/>
                    <a:gd name="connsiteX2" fmla="*/ 623863 w 925272"/>
                    <a:gd name="connsiteY2" fmla="*/ 39387 h 480085"/>
                    <a:gd name="connsiteX3" fmla="*/ 925272 w 925272"/>
                    <a:gd name="connsiteY3" fmla="*/ 421509 h 480085"/>
                    <a:gd name="connsiteX4" fmla="*/ 768237 w 925272"/>
                    <a:gd name="connsiteY4" fmla="*/ 479222 h 480085"/>
                    <a:gd name="connsiteX5" fmla="*/ 588791 w 925272"/>
                    <a:gd name="connsiteY5" fmla="*/ 249421 h 480085"/>
                    <a:gd name="connsiteX6" fmla="*/ 323181 w 925272"/>
                    <a:gd name="connsiteY6" fmla="*/ 221063 h 480085"/>
                    <a:gd name="connsiteX7" fmla="*/ 182089 w 925272"/>
                    <a:gd name="connsiteY7" fmla="*/ 378679 h 480085"/>
                    <a:gd name="connsiteX8" fmla="*/ 283 w 925272"/>
                    <a:gd name="connsiteY8" fmla="*/ 357772 h 480085"/>
                    <a:gd name="connsiteX0" fmla="*/ 283 w 925272"/>
                    <a:gd name="connsiteY0" fmla="*/ 357772 h 479899"/>
                    <a:gd name="connsiteX1" fmla="*/ 263891 w 925272"/>
                    <a:gd name="connsiteY1" fmla="*/ 48227 h 479899"/>
                    <a:gd name="connsiteX2" fmla="*/ 623863 w 925272"/>
                    <a:gd name="connsiteY2" fmla="*/ 39387 h 479899"/>
                    <a:gd name="connsiteX3" fmla="*/ 925272 w 925272"/>
                    <a:gd name="connsiteY3" fmla="*/ 421509 h 479899"/>
                    <a:gd name="connsiteX4" fmla="*/ 768237 w 925272"/>
                    <a:gd name="connsiteY4" fmla="*/ 479222 h 479899"/>
                    <a:gd name="connsiteX5" fmla="*/ 588791 w 925272"/>
                    <a:gd name="connsiteY5" fmla="*/ 249421 h 479899"/>
                    <a:gd name="connsiteX6" fmla="*/ 323181 w 925272"/>
                    <a:gd name="connsiteY6" fmla="*/ 221063 h 479899"/>
                    <a:gd name="connsiteX7" fmla="*/ 182089 w 925272"/>
                    <a:gd name="connsiteY7" fmla="*/ 378679 h 479899"/>
                    <a:gd name="connsiteX8" fmla="*/ 283 w 925272"/>
                    <a:gd name="connsiteY8" fmla="*/ 357772 h 479899"/>
                    <a:gd name="connsiteX0" fmla="*/ 283 w 925272"/>
                    <a:gd name="connsiteY0" fmla="*/ 357772 h 479899"/>
                    <a:gd name="connsiteX1" fmla="*/ 263891 w 925272"/>
                    <a:gd name="connsiteY1" fmla="*/ 48227 h 479899"/>
                    <a:gd name="connsiteX2" fmla="*/ 623863 w 925272"/>
                    <a:gd name="connsiteY2" fmla="*/ 39387 h 479899"/>
                    <a:gd name="connsiteX3" fmla="*/ 925272 w 925272"/>
                    <a:gd name="connsiteY3" fmla="*/ 421509 h 479899"/>
                    <a:gd name="connsiteX4" fmla="*/ 768237 w 925272"/>
                    <a:gd name="connsiteY4" fmla="*/ 479222 h 479899"/>
                    <a:gd name="connsiteX5" fmla="*/ 588791 w 925272"/>
                    <a:gd name="connsiteY5" fmla="*/ 249421 h 479899"/>
                    <a:gd name="connsiteX6" fmla="*/ 323181 w 925272"/>
                    <a:gd name="connsiteY6" fmla="*/ 221063 h 479899"/>
                    <a:gd name="connsiteX7" fmla="*/ 182089 w 925272"/>
                    <a:gd name="connsiteY7" fmla="*/ 378679 h 479899"/>
                    <a:gd name="connsiteX8" fmla="*/ 283 w 925272"/>
                    <a:gd name="connsiteY8" fmla="*/ 357772 h 479899"/>
                    <a:gd name="connsiteX0" fmla="*/ 283 w 925272"/>
                    <a:gd name="connsiteY0" fmla="*/ 357772 h 479899"/>
                    <a:gd name="connsiteX1" fmla="*/ 263891 w 925272"/>
                    <a:gd name="connsiteY1" fmla="*/ 48227 h 479899"/>
                    <a:gd name="connsiteX2" fmla="*/ 623863 w 925272"/>
                    <a:gd name="connsiteY2" fmla="*/ 39387 h 479899"/>
                    <a:gd name="connsiteX3" fmla="*/ 925272 w 925272"/>
                    <a:gd name="connsiteY3" fmla="*/ 421509 h 479899"/>
                    <a:gd name="connsiteX4" fmla="*/ 768237 w 925272"/>
                    <a:gd name="connsiteY4" fmla="*/ 479222 h 479899"/>
                    <a:gd name="connsiteX5" fmla="*/ 614360 w 925272"/>
                    <a:gd name="connsiteY5" fmla="*/ 239373 h 479899"/>
                    <a:gd name="connsiteX6" fmla="*/ 323181 w 925272"/>
                    <a:gd name="connsiteY6" fmla="*/ 221063 h 479899"/>
                    <a:gd name="connsiteX7" fmla="*/ 182089 w 925272"/>
                    <a:gd name="connsiteY7" fmla="*/ 378679 h 479899"/>
                    <a:gd name="connsiteX8" fmla="*/ 283 w 925272"/>
                    <a:gd name="connsiteY8" fmla="*/ 357772 h 479899"/>
                    <a:gd name="connsiteX0" fmla="*/ 283 w 925272"/>
                    <a:gd name="connsiteY0" fmla="*/ 357772 h 478527"/>
                    <a:gd name="connsiteX1" fmla="*/ 263891 w 925272"/>
                    <a:gd name="connsiteY1" fmla="*/ 48227 h 478527"/>
                    <a:gd name="connsiteX2" fmla="*/ 623863 w 925272"/>
                    <a:gd name="connsiteY2" fmla="*/ 39387 h 478527"/>
                    <a:gd name="connsiteX3" fmla="*/ 925272 w 925272"/>
                    <a:gd name="connsiteY3" fmla="*/ 421509 h 478527"/>
                    <a:gd name="connsiteX4" fmla="*/ 784939 w 925272"/>
                    <a:gd name="connsiteY4" fmla="*/ 477575 h 478527"/>
                    <a:gd name="connsiteX5" fmla="*/ 614360 w 925272"/>
                    <a:gd name="connsiteY5" fmla="*/ 239373 h 478527"/>
                    <a:gd name="connsiteX6" fmla="*/ 323181 w 925272"/>
                    <a:gd name="connsiteY6" fmla="*/ 221063 h 478527"/>
                    <a:gd name="connsiteX7" fmla="*/ 182089 w 925272"/>
                    <a:gd name="connsiteY7" fmla="*/ 378679 h 478527"/>
                    <a:gd name="connsiteX8" fmla="*/ 283 w 925272"/>
                    <a:gd name="connsiteY8" fmla="*/ 357772 h 478527"/>
                    <a:gd name="connsiteX0" fmla="*/ 283 w 925272"/>
                    <a:gd name="connsiteY0" fmla="*/ 357772 h 478527"/>
                    <a:gd name="connsiteX1" fmla="*/ 263891 w 925272"/>
                    <a:gd name="connsiteY1" fmla="*/ 48227 h 478527"/>
                    <a:gd name="connsiteX2" fmla="*/ 623863 w 925272"/>
                    <a:gd name="connsiteY2" fmla="*/ 39387 h 478527"/>
                    <a:gd name="connsiteX3" fmla="*/ 925272 w 925272"/>
                    <a:gd name="connsiteY3" fmla="*/ 421509 h 478527"/>
                    <a:gd name="connsiteX4" fmla="*/ 784939 w 925272"/>
                    <a:gd name="connsiteY4" fmla="*/ 477575 h 478527"/>
                    <a:gd name="connsiteX5" fmla="*/ 614360 w 925272"/>
                    <a:gd name="connsiteY5" fmla="*/ 239373 h 478527"/>
                    <a:gd name="connsiteX6" fmla="*/ 323181 w 925272"/>
                    <a:gd name="connsiteY6" fmla="*/ 221063 h 478527"/>
                    <a:gd name="connsiteX7" fmla="*/ 182089 w 925272"/>
                    <a:gd name="connsiteY7" fmla="*/ 378679 h 478527"/>
                    <a:gd name="connsiteX8" fmla="*/ 283 w 925272"/>
                    <a:gd name="connsiteY8" fmla="*/ 357772 h 478527"/>
                    <a:gd name="connsiteX0" fmla="*/ 283 w 925272"/>
                    <a:gd name="connsiteY0" fmla="*/ 357772 h 557834"/>
                    <a:gd name="connsiteX1" fmla="*/ 263891 w 925272"/>
                    <a:gd name="connsiteY1" fmla="*/ 48227 h 557834"/>
                    <a:gd name="connsiteX2" fmla="*/ 623863 w 925272"/>
                    <a:gd name="connsiteY2" fmla="*/ 39387 h 557834"/>
                    <a:gd name="connsiteX3" fmla="*/ 925272 w 925272"/>
                    <a:gd name="connsiteY3" fmla="*/ 421509 h 557834"/>
                    <a:gd name="connsiteX4" fmla="*/ 784939 w 925272"/>
                    <a:gd name="connsiteY4" fmla="*/ 477575 h 557834"/>
                    <a:gd name="connsiteX5" fmla="*/ 614360 w 925272"/>
                    <a:gd name="connsiteY5" fmla="*/ 239373 h 557834"/>
                    <a:gd name="connsiteX6" fmla="*/ 323181 w 925272"/>
                    <a:gd name="connsiteY6" fmla="*/ 221063 h 557834"/>
                    <a:gd name="connsiteX7" fmla="*/ 137577 w 925272"/>
                    <a:gd name="connsiteY7" fmla="*/ 551149 h 557834"/>
                    <a:gd name="connsiteX8" fmla="*/ 283 w 925272"/>
                    <a:gd name="connsiteY8" fmla="*/ 357772 h 557834"/>
                    <a:gd name="connsiteX0" fmla="*/ 283 w 925272"/>
                    <a:gd name="connsiteY0" fmla="*/ 357772 h 505215"/>
                    <a:gd name="connsiteX1" fmla="*/ 263891 w 925272"/>
                    <a:gd name="connsiteY1" fmla="*/ 48227 h 505215"/>
                    <a:gd name="connsiteX2" fmla="*/ 623863 w 925272"/>
                    <a:gd name="connsiteY2" fmla="*/ 39387 h 505215"/>
                    <a:gd name="connsiteX3" fmla="*/ 925272 w 925272"/>
                    <a:gd name="connsiteY3" fmla="*/ 421509 h 505215"/>
                    <a:gd name="connsiteX4" fmla="*/ 784939 w 925272"/>
                    <a:gd name="connsiteY4" fmla="*/ 477575 h 505215"/>
                    <a:gd name="connsiteX5" fmla="*/ 614360 w 925272"/>
                    <a:gd name="connsiteY5" fmla="*/ 239373 h 505215"/>
                    <a:gd name="connsiteX6" fmla="*/ 323181 w 925272"/>
                    <a:gd name="connsiteY6" fmla="*/ 221063 h 505215"/>
                    <a:gd name="connsiteX7" fmla="*/ 132607 w 925272"/>
                    <a:gd name="connsiteY7" fmla="*/ 496450 h 505215"/>
                    <a:gd name="connsiteX8" fmla="*/ 283 w 925272"/>
                    <a:gd name="connsiteY8" fmla="*/ 357772 h 505215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344909 w 947000"/>
                    <a:gd name="connsiteY6" fmla="*/ 227109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296839 w 947000"/>
                    <a:gd name="connsiteY6" fmla="*/ 254428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296839 w 947000"/>
                    <a:gd name="connsiteY6" fmla="*/ 254428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296839 w 947000"/>
                    <a:gd name="connsiteY6" fmla="*/ 254428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53488 w 947000"/>
                    <a:gd name="connsiteY5" fmla="*/ 203309 h 523249"/>
                    <a:gd name="connsiteX6" fmla="*/ 296839 w 947000"/>
                    <a:gd name="connsiteY6" fmla="*/ 254428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52370 w 947000"/>
                    <a:gd name="connsiteY5" fmla="*/ 215990 h 523249"/>
                    <a:gd name="connsiteX6" fmla="*/ 296839 w 947000"/>
                    <a:gd name="connsiteY6" fmla="*/ 254428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70 w 947013"/>
                    <a:gd name="connsiteY0" fmla="*/ 483982 h 538413"/>
                    <a:gd name="connsiteX1" fmla="*/ 285632 w 947013"/>
                    <a:gd name="connsiteY1" fmla="*/ 69437 h 538413"/>
                    <a:gd name="connsiteX2" fmla="*/ 701029 w 947013"/>
                    <a:gd name="connsiteY2" fmla="*/ 36886 h 538413"/>
                    <a:gd name="connsiteX3" fmla="*/ 947013 w 947013"/>
                    <a:gd name="connsiteY3" fmla="*/ 442719 h 538413"/>
                    <a:gd name="connsiteX4" fmla="*/ 806680 w 947013"/>
                    <a:gd name="connsiteY4" fmla="*/ 498785 h 538413"/>
                    <a:gd name="connsiteX5" fmla="*/ 652383 w 947013"/>
                    <a:gd name="connsiteY5" fmla="*/ 231154 h 538413"/>
                    <a:gd name="connsiteX6" fmla="*/ 296852 w 947013"/>
                    <a:gd name="connsiteY6" fmla="*/ 269592 h 538413"/>
                    <a:gd name="connsiteX7" fmla="*/ 154348 w 947013"/>
                    <a:gd name="connsiteY7" fmla="*/ 517660 h 538413"/>
                    <a:gd name="connsiteX8" fmla="*/ 270 w 947013"/>
                    <a:gd name="connsiteY8" fmla="*/ 483982 h 538413"/>
                    <a:gd name="connsiteX0" fmla="*/ 270 w 947013"/>
                    <a:gd name="connsiteY0" fmla="*/ 483982 h 538413"/>
                    <a:gd name="connsiteX1" fmla="*/ 285632 w 947013"/>
                    <a:gd name="connsiteY1" fmla="*/ 69437 h 538413"/>
                    <a:gd name="connsiteX2" fmla="*/ 701029 w 947013"/>
                    <a:gd name="connsiteY2" fmla="*/ 36886 h 538413"/>
                    <a:gd name="connsiteX3" fmla="*/ 947013 w 947013"/>
                    <a:gd name="connsiteY3" fmla="*/ 442719 h 538413"/>
                    <a:gd name="connsiteX4" fmla="*/ 856579 w 947013"/>
                    <a:gd name="connsiteY4" fmla="*/ 468150 h 538413"/>
                    <a:gd name="connsiteX5" fmla="*/ 652383 w 947013"/>
                    <a:gd name="connsiteY5" fmla="*/ 231154 h 538413"/>
                    <a:gd name="connsiteX6" fmla="*/ 296852 w 947013"/>
                    <a:gd name="connsiteY6" fmla="*/ 269592 h 538413"/>
                    <a:gd name="connsiteX7" fmla="*/ 154348 w 947013"/>
                    <a:gd name="connsiteY7" fmla="*/ 517660 h 538413"/>
                    <a:gd name="connsiteX8" fmla="*/ 270 w 947013"/>
                    <a:gd name="connsiteY8" fmla="*/ 483982 h 538413"/>
                    <a:gd name="connsiteX0" fmla="*/ 270 w 1007459"/>
                    <a:gd name="connsiteY0" fmla="*/ 482425 h 536856"/>
                    <a:gd name="connsiteX1" fmla="*/ 285632 w 1007459"/>
                    <a:gd name="connsiteY1" fmla="*/ 67880 h 536856"/>
                    <a:gd name="connsiteX2" fmla="*/ 701029 w 1007459"/>
                    <a:gd name="connsiteY2" fmla="*/ 35329 h 536856"/>
                    <a:gd name="connsiteX3" fmla="*/ 1007459 w 1007459"/>
                    <a:gd name="connsiteY3" fmla="*/ 419406 h 536856"/>
                    <a:gd name="connsiteX4" fmla="*/ 856579 w 1007459"/>
                    <a:gd name="connsiteY4" fmla="*/ 466593 h 536856"/>
                    <a:gd name="connsiteX5" fmla="*/ 652383 w 1007459"/>
                    <a:gd name="connsiteY5" fmla="*/ 229597 h 536856"/>
                    <a:gd name="connsiteX6" fmla="*/ 296852 w 1007459"/>
                    <a:gd name="connsiteY6" fmla="*/ 268035 h 536856"/>
                    <a:gd name="connsiteX7" fmla="*/ 154348 w 1007459"/>
                    <a:gd name="connsiteY7" fmla="*/ 516103 h 536856"/>
                    <a:gd name="connsiteX8" fmla="*/ 270 w 1007459"/>
                    <a:gd name="connsiteY8" fmla="*/ 482425 h 536856"/>
                    <a:gd name="connsiteX0" fmla="*/ 270 w 1007459"/>
                    <a:gd name="connsiteY0" fmla="*/ 482425 h 536856"/>
                    <a:gd name="connsiteX1" fmla="*/ 285632 w 1007459"/>
                    <a:gd name="connsiteY1" fmla="*/ 67880 h 536856"/>
                    <a:gd name="connsiteX2" fmla="*/ 701029 w 1007459"/>
                    <a:gd name="connsiteY2" fmla="*/ 35329 h 536856"/>
                    <a:gd name="connsiteX3" fmla="*/ 1007459 w 1007459"/>
                    <a:gd name="connsiteY3" fmla="*/ 419406 h 536856"/>
                    <a:gd name="connsiteX4" fmla="*/ 893950 w 1007459"/>
                    <a:gd name="connsiteY4" fmla="*/ 454924 h 536856"/>
                    <a:gd name="connsiteX5" fmla="*/ 652383 w 1007459"/>
                    <a:gd name="connsiteY5" fmla="*/ 229597 h 536856"/>
                    <a:gd name="connsiteX6" fmla="*/ 296852 w 1007459"/>
                    <a:gd name="connsiteY6" fmla="*/ 268035 h 536856"/>
                    <a:gd name="connsiteX7" fmla="*/ 154348 w 1007459"/>
                    <a:gd name="connsiteY7" fmla="*/ 516103 h 536856"/>
                    <a:gd name="connsiteX8" fmla="*/ 270 w 1007459"/>
                    <a:gd name="connsiteY8" fmla="*/ 482425 h 536856"/>
                    <a:gd name="connsiteX0" fmla="*/ 270 w 1007459"/>
                    <a:gd name="connsiteY0" fmla="*/ 482425 h 536856"/>
                    <a:gd name="connsiteX1" fmla="*/ 285632 w 1007459"/>
                    <a:gd name="connsiteY1" fmla="*/ 67880 h 536856"/>
                    <a:gd name="connsiteX2" fmla="*/ 701029 w 1007459"/>
                    <a:gd name="connsiteY2" fmla="*/ 35329 h 536856"/>
                    <a:gd name="connsiteX3" fmla="*/ 1007459 w 1007459"/>
                    <a:gd name="connsiteY3" fmla="*/ 419406 h 536856"/>
                    <a:gd name="connsiteX4" fmla="*/ 893950 w 1007459"/>
                    <a:gd name="connsiteY4" fmla="*/ 454924 h 536856"/>
                    <a:gd name="connsiteX5" fmla="*/ 652383 w 1007459"/>
                    <a:gd name="connsiteY5" fmla="*/ 229597 h 536856"/>
                    <a:gd name="connsiteX6" fmla="*/ 296852 w 1007459"/>
                    <a:gd name="connsiteY6" fmla="*/ 268035 h 536856"/>
                    <a:gd name="connsiteX7" fmla="*/ 154348 w 1007459"/>
                    <a:gd name="connsiteY7" fmla="*/ 516103 h 536856"/>
                    <a:gd name="connsiteX8" fmla="*/ 270 w 1007459"/>
                    <a:gd name="connsiteY8" fmla="*/ 482425 h 536856"/>
                    <a:gd name="connsiteX0" fmla="*/ 270 w 1007459"/>
                    <a:gd name="connsiteY0" fmla="*/ 482425 h 536856"/>
                    <a:gd name="connsiteX1" fmla="*/ 285632 w 1007459"/>
                    <a:gd name="connsiteY1" fmla="*/ 67880 h 536856"/>
                    <a:gd name="connsiteX2" fmla="*/ 701029 w 1007459"/>
                    <a:gd name="connsiteY2" fmla="*/ 35329 h 536856"/>
                    <a:gd name="connsiteX3" fmla="*/ 1007459 w 1007459"/>
                    <a:gd name="connsiteY3" fmla="*/ 419406 h 536856"/>
                    <a:gd name="connsiteX4" fmla="*/ 865351 w 1007459"/>
                    <a:gd name="connsiteY4" fmla="*/ 458087 h 536856"/>
                    <a:gd name="connsiteX5" fmla="*/ 652383 w 1007459"/>
                    <a:gd name="connsiteY5" fmla="*/ 229597 h 536856"/>
                    <a:gd name="connsiteX6" fmla="*/ 296852 w 1007459"/>
                    <a:gd name="connsiteY6" fmla="*/ 268035 h 536856"/>
                    <a:gd name="connsiteX7" fmla="*/ 154348 w 1007459"/>
                    <a:gd name="connsiteY7" fmla="*/ 516103 h 536856"/>
                    <a:gd name="connsiteX8" fmla="*/ 270 w 1007459"/>
                    <a:gd name="connsiteY8" fmla="*/ 482425 h 536856"/>
                    <a:gd name="connsiteX0" fmla="*/ 270 w 1007459"/>
                    <a:gd name="connsiteY0" fmla="*/ 482425 h 536856"/>
                    <a:gd name="connsiteX1" fmla="*/ 285632 w 1007459"/>
                    <a:gd name="connsiteY1" fmla="*/ 67880 h 536856"/>
                    <a:gd name="connsiteX2" fmla="*/ 701029 w 1007459"/>
                    <a:gd name="connsiteY2" fmla="*/ 35329 h 536856"/>
                    <a:gd name="connsiteX3" fmla="*/ 1007459 w 1007459"/>
                    <a:gd name="connsiteY3" fmla="*/ 419406 h 536856"/>
                    <a:gd name="connsiteX4" fmla="*/ 865351 w 1007459"/>
                    <a:gd name="connsiteY4" fmla="*/ 458087 h 536856"/>
                    <a:gd name="connsiteX5" fmla="*/ 652383 w 1007459"/>
                    <a:gd name="connsiteY5" fmla="*/ 229597 h 536856"/>
                    <a:gd name="connsiteX6" fmla="*/ 296852 w 1007459"/>
                    <a:gd name="connsiteY6" fmla="*/ 268035 h 536856"/>
                    <a:gd name="connsiteX7" fmla="*/ 154348 w 1007459"/>
                    <a:gd name="connsiteY7" fmla="*/ 516103 h 536856"/>
                    <a:gd name="connsiteX8" fmla="*/ 270 w 1007459"/>
                    <a:gd name="connsiteY8" fmla="*/ 482425 h 536856"/>
                    <a:gd name="connsiteX0" fmla="*/ 270 w 1007459"/>
                    <a:gd name="connsiteY0" fmla="*/ 482425 h 536856"/>
                    <a:gd name="connsiteX1" fmla="*/ 285632 w 1007459"/>
                    <a:gd name="connsiteY1" fmla="*/ 67880 h 536856"/>
                    <a:gd name="connsiteX2" fmla="*/ 701029 w 1007459"/>
                    <a:gd name="connsiteY2" fmla="*/ 35329 h 536856"/>
                    <a:gd name="connsiteX3" fmla="*/ 1007459 w 1007459"/>
                    <a:gd name="connsiteY3" fmla="*/ 419406 h 536856"/>
                    <a:gd name="connsiteX4" fmla="*/ 865351 w 1007459"/>
                    <a:gd name="connsiteY4" fmla="*/ 458087 h 536856"/>
                    <a:gd name="connsiteX5" fmla="*/ 652383 w 1007459"/>
                    <a:gd name="connsiteY5" fmla="*/ 229597 h 536856"/>
                    <a:gd name="connsiteX6" fmla="*/ 296852 w 1007459"/>
                    <a:gd name="connsiteY6" fmla="*/ 268035 h 536856"/>
                    <a:gd name="connsiteX7" fmla="*/ 154348 w 1007459"/>
                    <a:gd name="connsiteY7" fmla="*/ 516103 h 536856"/>
                    <a:gd name="connsiteX8" fmla="*/ 270 w 1007459"/>
                    <a:gd name="connsiteY8" fmla="*/ 482425 h 536856"/>
                    <a:gd name="connsiteX0" fmla="*/ 270 w 1007459"/>
                    <a:gd name="connsiteY0" fmla="*/ 482425 h 581634"/>
                    <a:gd name="connsiteX1" fmla="*/ 285632 w 1007459"/>
                    <a:gd name="connsiteY1" fmla="*/ 67880 h 581634"/>
                    <a:gd name="connsiteX2" fmla="*/ 701029 w 1007459"/>
                    <a:gd name="connsiteY2" fmla="*/ 35329 h 581634"/>
                    <a:gd name="connsiteX3" fmla="*/ 1007459 w 1007459"/>
                    <a:gd name="connsiteY3" fmla="*/ 419406 h 581634"/>
                    <a:gd name="connsiteX4" fmla="*/ 865351 w 1007459"/>
                    <a:gd name="connsiteY4" fmla="*/ 458087 h 581634"/>
                    <a:gd name="connsiteX5" fmla="*/ 652383 w 1007459"/>
                    <a:gd name="connsiteY5" fmla="*/ 229597 h 581634"/>
                    <a:gd name="connsiteX6" fmla="*/ 296852 w 1007459"/>
                    <a:gd name="connsiteY6" fmla="*/ 268035 h 581634"/>
                    <a:gd name="connsiteX7" fmla="*/ 161581 w 1007459"/>
                    <a:gd name="connsiteY7" fmla="*/ 569264 h 581634"/>
                    <a:gd name="connsiteX8" fmla="*/ 270 w 1007459"/>
                    <a:gd name="connsiteY8" fmla="*/ 482425 h 581634"/>
                    <a:gd name="connsiteX0" fmla="*/ 276 w 1004153"/>
                    <a:gd name="connsiteY0" fmla="*/ 535833 h 592031"/>
                    <a:gd name="connsiteX1" fmla="*/ 282326 w 1004153"/>
                    <a:gd name="connsiteY1" fmla="*/ 70466 h 592031"/>
                    <a:gd name="connsiteX2" fmla="*/ 697723 w 1004153"/>
                    <a:gd name="connsiteY2" fmla="*/ 37915 h 592031"/>
                    <a:gd name="connsiteX3" fmla="*/ 1004153 w 1004153"/>
                    <a:gd name="connsiteY3" fmla="*/ 421992 h 592031"/>
                    <a:gd name="connsiteX4" fmla="*/ 862045 w 1004153"/>
                    <a:gd name="connsiteY4" fmla="*/ 460673 h 592031"/>
                    <a:gd name="connsiteX5" fmla="*/ 649077 w 1004153"/>
                    <a:gd name="connsiteY5" fmla="*/ 232183 h 592031"/>
                    <a:gd name="connsiteX6" fmla="*/ 293546 w 1004153"/>
                    <a:gd name="connsiteY6" fmla="*/ 270621 h 592031"/>
                    <a:gd name="connsiteX7" fmla="*/ 158275 w 1004153"/>
                    <a:gd name="connsiteY7" fmla="*/ 571850 h 592031"/>
                    <a:gd name="connsiteX8" fmla="*/ 276 w 1004153"/>
                    <a:gd name="connsiteY8" fmla="*/ 535833 h 592031"/>
                    <a:gd name="connsiteX0" fmla="*/ 275 w 1004152"/>
                    <a:gd name="connsiteY0" fmla="*/ 535833 h 610191"/>
                    <a:gd name="connsiteX1" fmla="*/ 282325 w 1004152"/>
                    <a:gd name="connsiteY1" fmla="*/ 70466 h 610191"/>
                    <a:gd name="connsiteX2" fmla="*/ 697722 w 1004152"/>
                    <a:gd name="connsiteY2" fmla="*/ 37915 h 610191"/>
                    <a:gd name="connsiteX3" fmla="*/ 1004152 w 1004152"/>
                    <a:gd name="connsiteY3" fmla="*/ 421992 h 610191"/>
                    <a:gd name="connsiteX4" fmla="*/ 862044 w 1004152"/>
                    <a:gd name="connsiteY4" fmla="*/ 460673 h 610191"/>
                    <a:gd name="connsiteX5" fmla="*/ 649076 w 1004152"/>
                    <a:gd name="connsiteY5" fmla="*/ 232183 h 610191"/>
                    <a:gd name="connsiteX6" fmla="*/ 293545 w 1004152"/>
                    <a:gd name="connsiteY6" fmla="*/ 270621 h 610191"/>
                    <a:gd name="connsiteX7" fmla="*/ 164137 w 1004152"/>
                    <a:gd name="connsiteY7" fmla="*/ 594344 h 610191"/>
                    <a:gd name="connsiteX8" fmla="*/ 275 w 1004152"/>
                    <a:gd name="connsiteY8" fmla="*/ 535833 h 610191"/>
                    <a:gd name="connsiteX0" fmla="*/ 282 w 998335"/>
                    <a:gd name="connsiteY0" fmla="*/ 599557 h 631428"/>
                    <a:gd name="connsiteX1" fmla="*/ 276508 w 998335"/>
                    <a:gd name="connsiteY1" fmla="*/ 73728 h 631428"/>
                    <a:gd name="connsiteX2" fmla="*/ 691905 w 998335"/>
                    <a:gd name="connsiteY2" fmla="*/ 41177 h 631428"/>
                    <a:gd name="connsiteX3" fmla="*/ 998335 w 998335"/>
                    <a:gd name="connsiteY3" fmla="*/ 425254 h 631428"/>
                    <a:gd name="connsiteX4" fmla="*/ 856227 w 998335"/>
                    <a:gd name="connsiteY4" fmla="*/ 463935 h 631428"/>
                    <a:gd name="connsiteX5" fmla="*/ 643259 w 998335"/>
                    <a:gd name="connsiteY5" fmla="*/ 235445 h 631428"/>
                    <a:gd name="connsiteX6" fmla="*/ 287728 w 998335"/>
                    <a:gd name="connsiteY6" fmla="*/ 273883 h 631428"/>
                    <a:gd name="connsiteX7" fmla="*/ 158320 w 998335"/>
                    <a:gd name="connsiteY7" fmla="*/ 597606 h 631428"/>
                    <a:gd name="connsiteX8" fmla="*/ 282 w 998335"/>
                    <a:gd name="connsiteY8" fmla="*/ 599557 h 631428"/>
                    <a:gd name="connsiteX0" fmla="*/ 287 w 994686"/>
                    <a:gd name="connsiteY0" fmla="*/ 587545 h 625591"/>
                    <a:gd name="connsiteX1" fmla="*/ 272859 w 994686"/>
                    <a:gd name="connsiteY1" fmla="*/ 73102 h 625591"/>
                    <a:gd name="connsiteX2" fmla="*/ 688256 w 994686"/>
                    <a:gd name="connsiteY2" fmla="*/ 40551 h 625591"/>
                    <a:gd name="connsiteX3" fmla="*/ 994686 w 994686"/>
                    <a:gd name="connsiteY3" fmla="*/ 424628 h 625591"/>
                    <a:gd name="connsiteX4" fmla="*/ 852578 w 994686"/>
                    <a:gd name="connsiteY4" fmla="*/ 463309 h 625591"/>
                    <a:gd name="connsiteX5" fmla="*/ 639610 w 994686"/>
                    <a:gd name="connsiteY5" fmla="*/ 234819 h 625591"/>
                    <a:gd name="connsiteX6" fmla="*/ 284079 w 994686"/>
                    <a:gd name="connsiteY6" fmla="*/ 273257 h 625591"/>
                    <a:gd name="connsiteX7" fmla="*/ 154671 w 994686"/>
                    <a:gd name="connsiteY7" fmla="*/ 596980 h 625591"/>
                    <a:gd name="connsiteX8" fmla="*/ 287 w 994686"/>
                    <a:gd name="connsiteY8" fmla="*/ 587545 h 625591"/>
                    <a:gd name="connsiteX0" fmla="*/ 287 w 994686"/>
                    <a:gd name="connsiteY0" fmla="*/ 587544 h 625590"/>
                    <a:gd name="connsiteX1" fmla="*/ 272859 w 994686"/>
                    <a:gd name="connsiteY1" fmla="*/ 73101 h 625590"/>
                    <a:gd name="connsiteX2" fmla="*/ 688256 w 994686"/>
                    <a:gd name="connsiteY2" fmla="*/ 40550 h 625590"/>
                    <a:gd name="connsiteX3" fmla="*/ 994686 w 994686"/>
                    <a:gd name="connsiteY3" fmla="*/ 424627 h 625590"/>
                    <a:gd name="connsiteX4" fmla="*/ 852578 w 994686"/>
                    <a:gd name="connsiteY4" fmla="*/ 463308 h 625590"/>
                    <a:gd name="connsiteX5" fmla="*/ 639610 w 994686"/>
                    <a:gd name="connsiteY5" fmla="*/ 234818 h 625590"/>
                    <a:gd name="connsiteX6" fmla="*/ 302238 w 994686"/>
                    <a:gd name="connsiteY6" fmla="*/ 330227 h 625590"/>
                    <a:gd name="connsiteX7" fmla="*/ 154671 w 994686"/>
                    <a:gd name="connsiteY7" fmla="*/ 596979 h 625590"/>
                    <a:gd name="connsiteX8" fmla="*/ 287 w 994686"/>
                    <a:gd name="connsiteY8" fmla="*/ 587544 h 625590"/>
                    <a:gd name="connsiteX0" fmla="*/ 690 w 995089"/>
                    <a:gd name="connsiteY0" fmla="*/ 554517 h 592563"/>
                    <a:gd name="connsiteX1" fmla="*/ 171115 w 995089"/>
                    <a:gd name="connsiteY1" fmla="*/ 169049 h 592563"/>
                    <a:gd name="connsiteX2" fmla="*/ 688659 w 995089"/>
                    <a:gd name="connsiteY2" fmla="*/ 7523 h 592563"/>
                    <a:gd name="connsiteX3" fmla="*/ 995089 w 995089"/>
                    <a:gd name="connsiteY3" fmla="*/ 391600 h 592563"/>
                    <a:gd name="connsiteX4" fmla="*/ 852981 w 995089"/>
                    <a:gd name="connsiteY4" fmla="*/ 430281 h 592563"/>
                    <a:gd name="connsiteX5" fmla="*/ 640013 w 995089"/>
                    <a:gd name="connsiteY5" fmla="*/ 201791 h 592563"/>
                    <a:gd name="connsiteX6" fmla="*/ 302641 w 995089"/>
                    <a:gd name="connsiteY6" fmla="*/ 297200 h 592563"/>
                    <a:gd name="connsiteX7" fmla="*/ 155074 w 995089"/>
                    <a:gd name="connsiteY7" fmla="*/ 563952 h 592563"/>
                    <a:gd name="connsiteX8" fmla="*/ 690 w 995089"/>
                    <a:gd name="connsiteY8" fmla="*/ 554517 h 592563"/>
                    <a:gd name="connsiteX0" fmla="*/ 690 w 995089"/>
                    <a:gd name="connsiteY0" fmla="*/ 554516 h 592562"/>
                    <a:gd name="connsiteX1" fmla="*/ 171115 w 995089"/>
                    <a:gd name="connsiteY1" fmla="*/ 169048 h 592562"/>
                    <a:gd name="connsiteX2" fmla="*/ 688659 w 995089"/>
                    <a:gd name="connsiteY2" fmla="*/ 7522 h 592562"/>
                    <a:gd name="connsiteX3" fmla="*/ 995089 w 995089"/>
                    <a:gd name="connsiteY3" fmla="*/ 391599 h 592562"/>
                    <a:gd name="connsiteX4" fmla="*/ 856332 w 995089"/>
                    <a:gd name="connsiteY4" fmla="*/ 443135 h 592562"/>
                    <a:gd name="connsiteX5" fmla="*/ 640013 w 995089"/>
                    <a:gd name="connsiteY5" fmla="*/ 201790 h 592562"/>
                    <a:gd name="connsiteX6" fmla="*/ 302641 w 995089"/>
                    <a:gd name="connsiteY6" fmla="*/ 297199 h 592562"/>
                    <a:gd name="connsiteX7" fmla="*/ 155074 w 995089"/>
                    <a:gd name="connsiteY7" fmla="*/ 563951 h 592562"/>
                    <a:gd name="connsiteX8" fmla="*/ 690 w 995089"/>
                    <a:gd name="connsiteY8" fmla="*/ 554516 h 592562"/>
                    <a:gd name="connsiteX0" fmla="*/ 690 w 995089"/>
                    <a:gd name="connsiteY0" fmla="*/ 554516 h 592562"/>
                    <a:gd name="connsiteX1" fmla="*/ 171115 w 995089"/>
                    <a:gd name="connsiteY1" fmla="*/ 169048 h 592562"/>
                    <a:gd name="connsiteX2" fmla="*/ 688659 w 995089"/>
                    <a:gd name="connsiteY2" fmla="*/ 7522 h 592562"/>
                    <a:gd name="connsiteX3" fmla="*/ 995089 w 995089"/>
                    <a:gd name="connsiteY3" fmla="*/ 391599 h 592562"/>
                    <a:gd name="connsiteX4" fmla="*/ 865851 w 995089"/>
                    <a:gd name="connsiteY4" fmla="*/ 454244 h 592562"/>
                    <a:gd name="connsiteX5" fmla="*/ 640013 w 995089"/>
                    <a:gd name="connsiteY5" fmla="*/ 201790 h 592562"/>
                    <a:gd name="connsiteX6" fmla="*/ 302641 w 995089"/>
                    <a:gd name="connsiteY6" fmla="*/ 297199 h 592562"/>
                    <a:gd name="connsiteX7" fmla="*/ 155074 w 995089"/>
                    <a:gd name="connsiteY7" fmla="*/ 563951 h 592562"/>
                    <a:gd name="connsiteX8" fmla="*/ 690 w 995089"/>
                    <a:gd name="connsiteY8" fmla="*/ 554516 h 592562"/>
                    <a:gd name="connsiteX0" fmla="*/ 690 w 995089"/>
                    <a:gd name="connsiteY0" fmla="*/ 554516 h 592562"/>
                    <a:gd name="connsiteX1" fmla="*/ 171115 w 995089"/>
                    <a:gd name="connsiteY1" fmla="*/ 169048 h 592562"/>
                    <a:gd name="connsiteX2" fmla="*/ 688659 w 995089"/>
                    <a:gd name="connsiteY2" fmla="*/ 7522 h 592562"/>
                    <a:gd name="connsiteX3" fmla="*/ 995089 w 995089"/>
                    <a:gd name="connsiteY3" fmla="*/ 391599 h 592562"/>
                    <a:gd name="connsiteX4" fmla="*/ 865851 w 995089"/>
                    <a:gd name="connsiteY4" fmla="*/ 454244 h 592562"/>
                    <a:gd name="connsiteX5" fmla="*/ 640013 w 995089"/>
                    <a:gd name="connsiteY5" fmla="*/ 201790 h 592562"/>
                    <a:gd name="connsiteX6" fmla="*/ 302641 w 995089"/>
                    <a:gd name="connsiteY6" fmla="*/ 297199 h 592562"/>
                    <a:gd name="connsiteX7" fmla="*/ 155074 w 995089"/>
                    <a:gd name="connsiteY7" fmla="*/ 563951 h 592562"/>
                    <a:gd name="connsiteX8" fmla="*/ 690 w 995089"/>
                    <a:gd name="connsiteY8" fmla="*/ 554516 h 59256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995089" h="592562">
                      <a:moveTo>
                        <a:pt x="690" y="554516"/>
                      </a:moveTo>
                      <a:cubicBezTo>
                        <a:pt x="-7427" y="423713"/>
                        <a:pt x="56454" y="260214"/>
                        <a:pt x="171115" y="169048"/>
                      </a:cubicBezTo>
                      <a:cubicBezTo>
                        <a:pt x="285776" y="77882"/>
                        <a:pt x="551330" y="-29570"/>
                        <a:pt x="688659" y="7522"/>
                      </a:cubicBezTo>
                      <a:cubicBezTo>
                        <a:pt x="825988" y="44614"/>
                        <a:pt x="982482" y="254987"/>
                        <a:pt x="995089" y="391599"/>
                      </a:cubicBezTo>
                      <a:cubicBezTo>
                        <a:pt x="991575" y="460541"/>
                        <a:pt x="932132" y="434685"/>
                        <a:pt x="865851" y="454244"/>
                      </a:cubicBezTo>
                      <a:cubicBezTo>
                        <a:pt x="770015" y="218647"/>
                        <a:pt x="692261" y="239899"/>
                        <a:pt x="640013" y="201790"/>
                      </a:cubicBezTo>
                      <a:cubicBezTo>
                        <a:pt x="595014" y="163992"/>
                        <a:pt x="414366" y="224883"/>
                        <a:pt x="302641" y="297199"/>
                      </a:cubicBezTo>
                      <a:cubicBezTo>
                        <a:pt x="212651" y="393200"/>
                        <a:pt x="190769" y="468903"/>
                        <a:pt x="155074" y="563951"/>
                      </a:cubicBezTo>
                      <a:cubicBezTo>
                        <a:pt x="75480" y="609010"/>
                        <a:pt x="64659" y="597043"/>
                        <a:pt x="690" y="554516"/>
                      </a:cubicBezTo>
                      <a:close/>
                    </a:path>
                  </a:pathLst>
                </a:custGeom>
                <a:grpFill/>
                <a:ln>
                  <a:solidFill>
                    <a:schemeClr val="tx2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350">
                    <a:solidFill>
                      <a:schemeClr val="bg2">
                        <a:lumMod val="25000"/>
                      </a:schemeClr>
                    </a:solidFill>
                  </a:endParaRPr>
                </a:p>
              </p:txBody>
            </p:sp>
          </p:grpSp>
        </p:grpSp>
        <p:grpSp>
          <p:nvGrpSpPr>
            <p:cNvPr id="12" name="Group 11"/>
            <p:cNvGrpSpPr/>
            <p:nvPr/>
          </p:nvGrpSpPr>
          <p:grpSpPr>
            <a:xfrm>
              <a:off x="2891259" y="2293618"/>
              <a:ext cx="1262743" cy="655092"/>
              <a:chOff x="2112204" y="1509831"/>
              <a:chExt cx="1521376" cy="789268"/>
            </a:xfrm>
          </p:grpSpPr>
          <p:sp>
            <p:nvSpPr>
              <p:cNvPr id="21" name="Curved Right Arrow 20"/>
              <p:cNvSpPr/>
              <p:nvPr/>
            </p:nvSpPr>
            <p:spPr>
              <a:xfrm>
                <a:off x="2112204" y="1509831"/>
                <a:ext cx="412132" cy="789268"/>
              </a:xfrm>
              <a:prstGeom prst="curvedRightArrow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350">
                  <a:solidFill>
                    <a:schemeClr val="tx1"/>
                  </a:solidFill>
                </a:endParaRPr>
              </a:p>
            </p:txBody>
          </p:sp>
          <p:sp>
            <p:nvSpPr>
              <p:cNvPr id="22" name="Curved Right Arrow 21"/>
              <p:cNvSpPr/>
              <p:nvPr/>
            </p:nvSpPr>
            <p:spPr>
              <a:xfrm flipH="1" flipV="1">
                <a:off x="3221448" y="1509831"/>
                <a:ext cx="412132" cy="789268"/>
              </a:xfrm>
              <a:prstGeom prst="curvedRightArrow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350">
                  <a:solidFill>
                    <a:schemeClr val="tx1"/>
                  </a:solidFill>
                </a:endParaRPr>
              </a:p>
            </p:txBody>
          </p:sp>
        </p:grpSp>
      </p:grpSp>
      <p:grpSp>
        <p:nvGrpSpPr>
          <p:cNvPr id="39" name="Group 38"/>
          <p:cNvGrpSpPr/>
          <p:nvPr/>
        </p:nvGrpSpPr>
        <p:grpSpPr>
          <a:xfrm>
            <a:off x="1104055" y="1456975"/>
            <a:ext cx="1368294" cy="1892487"/>
            <a:chOff x="1294554" y="1431575"/>
            <a:chExt cx="1368294" cy="1892487"/>
          </a:xfrm>
        </p:grpSpPr>
        <p:grpSp>
          <p:nvGrpSpPr>
            <p:cNvPr id="3" name="Group 2"/>
            <p:cNvGrpSpPr/>
            <p:nvPr/>
          </p:nvGrpSpPr>
          <p:grpSpPr>
            <a:xfrm>
              <a:off x="1299283" y="2746444"/>
              <a:ext cx="1363565" cy="577618"/>
              <a:chOff x="7360562" y="3102368"/>
              <a:chExt cx="2035172" cy="862116"/>
            </a:xfrm>
          </p:grpSpPr>
          <p:grpSp>
            <p:nvGrpSpPr>
              <p:cNvPr id="33" name="Group 32"/>
              <p:cNvGrpSpPr/>
              <p:nvPr/>
            </p:nvGrpSpPr>
            <p:grpSpPr>
              <a:xfrm>
                <a:off x="7360562" y="3102368"/>
                <a:ext cx="1731318" cy="444565"/>
                <a:chOff x="6998612" y="1300505"/>
                <a:chExt cx="1731318" cy="444565"/>
              </a:xfrm>
            </p:grpSpPr>
            <p:pic>
              <p:nvPicPr>
                <p:cNvPr id="37" name="Picture 4" descr="http://image.marginup.com/u/u132/medium_MAB%283%29.jpg"/>
                <p:cNvPicPr>
                  <a:picLocks noChangeAspect="1" noChangeArrowheads="1"/>
                </p:cNvPicPr>
                <p:nvPr/>
              </p:nvPicPr>
              <p:blipFill>
                <a:blip r:embed="rId2" cstate="print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ackgroundRemoval t="5729" b="85938" l="0" r="10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 rot="10800000" flipH="1">
                  <a:off x="6998612" y="1300505"/>
                  <a:ext cx="285241" cy="370042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38" name="TextBox 37"/>
                <p:cNvSpPr txBox="1"/>
                <p:nvPr/>
              </p:nvSpPr>
              <p:spPr>
                <a:xfrm>
                  <a:off x="7332207" y="1331638"/>
                  <a:ext cx="1397723" cy="4134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V2q </a:t>
                  </a:r>
                  <a:r>
                    <a:rPr lang="en-US" sz="1200" b="1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Abs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4" name="Group 33"/>
              <p:cNvGrpSpPr/>
              <p:nvPr/>
            </p:nvGrpSpPr>
            <p:grpSpPr>
              <a:xfrm>
                <a:off x="7360562" y="3545147"/>
                <a:ext cx="2035172" cy="419337"/>
                <a:chOff x="6998612" y="1743284"/>
                <a:chExt cx="2035172" cy="419337"/>
              </a:xfrm>
            </p:grpSpPr>
            <p:pic>
              <p:nvPicPr>
                <p:cNvPr id="35" name="Picture 2" descr="http://1degreebio.org/blog/files/blog/antibody.png"/>
                <p:cNvPicPr>
                  <a:picLocks noChangeAspect="1" noChangeArrowheads="1"/>
                </p:cNvPicPr>
                <p:nvPr/>
              </p:nvPicPr>
              <p:blipFill>
                <a:blip r:embed="rId6" cstate="print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backgroundRemoval t="0" b="99167" l="0" r="10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 rot="10800000">
                  <a:off x="6998612" y="1743284"/>
                  <a:ext cx="266323" cy="319588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36" name="TextBox 35"/>
                <p:cNvSpPr txBox="1"/>
                <p:nvPr/>
              </p:nvSpPr>
              <p:spPr>
                <a:xfrm>
                  <a:off x="7332208" y="1749190"/>
                  <a:ext cx="1701576" cy="41343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D4bs </a:t>
                  </a:r>
                  <a:r>
                    <a:rPr lang="en-US" sz="1200" b="1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Abs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13" name="Group 12"/>
            <p:cNvGrpSpPr/>
            <p:nvPr/>
          </p:nvGrpSpPr>
          <p:grpSpPr>
            <a:xfrm>
              <a:off x="1294554" y="1431575"/>
              <a:ext cx="1170011" cy="906224"/>
              <a:chOff x="1281622" y="1320888"/>
              <a:chExt cx="1409650" cy="1091836"/>
            </a:xfrm>
          </p:grpSpPr>
          <p:pic>
            <p:nvPicPr>
              <p:cNvPr id="14" name="Picture 4" descr="http://image.marginup.com/u/u132/medium_MAB%283%29.jpg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ackgroundRemoval t="5729" b="85938" l="0" r="10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rot="10800000" flipH="1">
                <a:off x="1841199" y="1320888"/>
                <a:ext cx="285241" cy="37004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5" name="Picture 2" descr="http://1degreebio.org/blog/files/blog/antibody.png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ackgroundRemoval t="0" b="99167" l="0" r="10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rot="12664011">
                <a:off x="1522880" y="1839506"/>
                <a:ext cx="266323" cy="31958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6" name="Picture 2" descr="http://1degreebio.org/blog/files/blog/antibody.png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ackgroundRemoval t="0" b="99167" l="0" r="10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rot="8483042">
                <a:off x="2190207" y="1837136"/>
                <a:ext cx="266323" cy="31958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grpSp>
            <p:nvGrpSpPr>
              <p:cNvPr id="17" name="Group 16"/>
              <p:cNvGrpSpPr/>
              <p:nvPr/>
            </p:nvGrpSpPr>
            <p:grpSpPr>
              <a:xfrm>
                <a:off x="1901691" y="1669912"/>
                <a:ext cx="789581" cy="739622"/>
                <a:chOff x="2796330" y="646123"/>
                <a:chExt cx="789581" cy="739622"/>
              </a:xfrm>
            </p:grpSpPr>
            <p:sp>
              <p:nvSpPr>
                <p:cNvPr id="19" name="Block Arc 15"/>
                <p:cNvSpPr/>
                <p:nvPr/>
              </p:nvSpPr>
              <p:spPr>
                <a:xfrm rot="5400000">
                  <a:off x="2535524" y="906929"/>
                  <a:ext cx="685870" cy="164258"/>
                </a:xfrm>
                <a:custGeom>
                  <a:avLst/>
                  <a:gdLst>
                    <a:gd name="connsiteX0" fmla="*/ 627 w 745516"/>
                    <a:gd name="connsiteY0" fmla="*/ 369014 h 697590"/>
                    <a:gd name="connsiteX1" fmla="*/ 184209 w 745516"/>
                    <a:gd name="connsiteY1" fmla="*/ 47911 h 697590"/>
                    <a:gd name="connsiteX2" fmla="*/ 544181 w 745516"/>
                    <a:gd name="connsiteY2" fmla="*/ 39071 h 697590"/>
                    <a:gd name="connsiteX3" fmla="*/ 745515 w 745516"/>
                    <a:gd name="connsiteY3" fmla="*/ 348795 h 697590"/>
                    <a:gd name="connsiteX4" fmla="*/ 571119 w 745516"/>
                    <a:gd name="connsiteY4" fmla="*/ 348795 h 697590"/>
                    <a:gd name="connsiteX5" fmla="*/ 459552 w 745516"/>
                    <a:gd name="connsiteY5" fmla="*/ 191978 h 697590"/>
                    <a:gd name="connsiteX6" fmla="*/ 277038 w 745516"/>
                    <a:gd name="connsiteY6" fmla="*/ 196046 h 697590"/>
                    <a:gd name="connsiteX7" fmla="*/ 174775 w 745516"/>
                    <a:gd name="connsiteY7" fmla="*/ 359552 h 697590"/>
                    <a:gd name="connsiteX8" fmla="*/ 627 w 745516"/>
                    <a:gd name="connsiteY8" fmla="*/ 369014 h 697590"/>
                    <a:gd name="connsiteX0" fmla="*/ 629 w 745517"/>
                    <a:gd name="connsiteY0" fmla="*/ 369014 h 369014"/>
                    <a:gd name="connsiteX1" fmla="*/ 184211 w 745517"/>
                    <a:gd name="connsiteY1" fmla="*/ 47911 h 369014"/>
                    <a:gd name="connsiteX2" fmla="*/ 544183 w 745517"/>
                    <a:gd name="connsiteY2" fmla="*/ 39071 h 369014"/>
                    <a:gd name="connsiteX3" fmla="*/ 745517 w 745517"/>
                    <a:gd name="connsiteY3" fmla="*/ 348795 h 369014"/>
                    <a:gd name="connsiteX4" fmla="*/ 668191 w 745517"/>
                    <a:gd name="connsiteY4" fmla="*/ 363523 h 369014"/>
                    <a:gd name="connsiteX5" fmla="*/ 459554 w 745517"/>
                    <a:gd name="connsiteY5" fmla="*/ 191978 h 369014"/>
                    <a:gd name="connsiteX6" fmla="*/ 277040 w 745517"/>
                    <a:gd name="connsiteY6" fmla="*/ 196046 h 369014"/>
                    <a:gd name="connsiteX7" fmla="*/ 174777 w 745517"/>
                    <a:gd name="connsiteY7" fmla="*/ 359552 h 369014"/>
                    <a:gd name="connsiteX8" fmla="*/ 629 w 745517"/>
                    <a:gd name="connsiteY8" fmla="*/ 369014 h 369014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59554 w 745517"/>
                    <a:gd name="connsiteY5" fmla="*/ 191978 h 425833"/>
                    <a:gd name="connsiteX6" fmla="*/ 277040 w 745517"/>
                    <a:gd name="connsiteY6" fmla="*/ 196046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48149 w 745517"/>
                    <a:gd name="connsiteY5" fmla="*/ 197842 h 425833"/>
                    <a:gd name="connsiteX6" fmla="*/ 277040 w 745517"/>
                    <a:gd name="connsiteY6" fmla="*/ 196046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277040 w 745517"/>
                    <a:gd name="connsiteY6" fmla="*/ 196046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387239 w 745517"/>
                    <a:gd name="connsiteY6" fmla="*/ 147341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387239 w 745517"/>
                    <a:gd name="connsiteY6" fmla="*/ 147341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387239 w 745517"/>
                    <a:gd name="connsiteY6" fmla="*/ 147341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396919 w 745517"/>
                    <a:gd name="connsiteY6" fmla="*/ 199046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396919 w 745517"/>
                    <a:gd name="connsiteY5" fmla="*/ 199046 h 425833"/>
                    <a:gd name="connsiteX6" fmla="*/ 174777 w 745517"/>
                    <a:gd name="connsiteY6" fmla="*/ 359552 h 425833"/>
                    <a:gd name="connsiteX7" fmla="*/ 629 w 745517"/>
                    <a:gd name="connsiteY7" fmla="*/ 369014 h 425833"/>
                    <a:gd name="connsiteX0" fmla="*/ 629 w 777485"/>
                    <a:gd name="connsiteY0" fmla="*/ 364465 h 421284"/>
                    <a:gd name="connsiteX1" fmla="*/ 184211 w 777485"/>
                    <a:gd name="connsiteY1" fmla="*/ 43362 h 421284"/>
                    <a:gd name="connsiteX2" fmla="*/ 544183 w 777485"/>
                    <a:gd name="connsiteY2" fmla="*/ 34522 h 421284"/>
                    <a:gd name="connsiteX3" fmla="*/ 777485 w 777485"/>
                    <a:gd name="connsiteY3" fmla="*/ 302949 h 421284"/>
                    <a:gd name="connsiteX4" fmla="*/ 666916 w 777485"/>
                    <a:gd name="connsiteY4" fmla="*/ 421284 h 421284"/>
                    <a:gd name="connsiteX5" fmla="*/ 396919 w 777485"/>
                    <a:gd name="connsiteY5" fmla="*/ 194497 h 421284"/>
                    <a:gd name="connsiteX6" fmla="*/ 174777 w 777485"/>
                    <a:gd name="connsiteY6" fmla="*/ 355003 h 421284"/>
                    <a:gd name="connsiteX7" fmla="*/ 629 w 777485"/>
                    <a:gd name="connsiteY7" fmla="*/ 364465 h 421284"/>
                    <a:gd name="connsiteX0" fmla="*/ 629 w 777485"/>
                    <a:gd name="connsiteY0" fmla="*/ 364465 h 421284"/>
                    <a:gd name="connsiteX1" fmla="*/ 184211 w 777485"/>
                    <a:gd name="connsiteY1" fmla="*/ 43362 h 421284"/>
                    <a:gd name="connsiteX2" fmla="*/ 544183 w 777485"/>
                    <a:gd name="connsiteY2" fmla="*/ 34522 h 421284"/>
                    <a:gd name="connsiteX3" fmla="*/ 777485 w 777485"/>
                    <a:gd name="connsiteY3" fmla="*/ 302949 h 421284"/>
                    <a:gd name="connsiteX4" fmla="*/ 666916 w 777485"/>
                    <a:gd name="connsiteY4" fmla="*/ 421284 h 421284"/>
                    <a:gd name="connsiteX5" fmla="*/ 396919 w 777485"/>
                    <a:gd name="connsiteY5" fmla="*/ 194497 h 421284"/>
                    <a:gd name="connsiteX6" fmla="*/ 174777 w 777485"/>
                    <a:gd name="connsiteY6" fmla="*/ 355003 h 421284"/>
                    <a:gd name="connsiteX7" fmla="*/ 629 w 777485"/>
                    <a:gd name="connsiteY7" fmla="*/ 364465 h 421284"/>
                    <a:gd name="connsiteX0" fmla="*/ 629 w 777485"/>
                    <a:gd name="connsiteY0" fmla="*/ 364465 h 421284"/>
                    <a:gd name="connsiteX1" fmla="*/ 184211 w 777485"/>
                    <a:gd name="connsiteY1" fmla="*/ 43362 h 421284"/>
                    <a:gd name="connsiteX2" fmla="*/ 544183 w 777485"/>
                    <a:gd name="connsiteY2" fmla="*/ 34522 h 421284"/>
                    <a:gd name="connsiteX3" fmla="*/ 777485 w 777485"/>
                    <a:gd name="connsiteY3" fmla="*/ 302949 h 421284"/>
                    <a:gd name="connsiteX4" fmla="*/ 666916 w 777485"/>
                    <a:gd name="connsiteY4" fmla="*/ 421284 h 421284"/>
                    <a:gd name="connsiteX5" fmla="*/ 396919 w 777485"/>
                    <a:gd name="connsiteY5" fmla="*/ 194497 h 421284"/>
                    <a:gd name="connsiteX6" fmla="*/ 102409 w 777485"/>
                    <a:gd name="connsiteY6" fmla="*/ 373814 h 421284"/>
                    <a:gd name="connsiteX7" fmla="*/ 629 w 777485"/>
                    <a:gd name="connsiteY7" fmla="*/ 364465 h 421284"/>
                    <a:gd name="connsiteX0" fmla="*/ 329 w 828090"/>
                    <a:gd name="connsiteY0" fmla="*/ 354833 h 418791"/>
                    <a:gd name="connsiteX1" fmla="*/ 234816 w 828090"/>
                    <a:gd name="connsiteY1" fmla="*/ 40869 h 418791"/>
                    <a:gd name="connsiteX2" fmla="*/ 594788 w 828090"/>
                    <a:gd name="connsiteY2" fmla="*/ 32029 h 418791"/>
                    <a:gd name="connsiteX3" fmla="*/ 828090 w 828090"/>
                    <a:gd name="connsiteY3" fmla="*/ 300456 h 418791"/>
                    <a:gd name="connsiteX4" fmla="*/ 717521 w 828090"/>
                    <a:gd name="connsiteY4" fmla="*/ 418791 h 418791"/>
                    <a:gd name="connsiteX5" fmla="*/ 447524 w 828090"/>
                    <a:gd name="connsiteY5" fmla="*/ 192004 h 418791"/>
                    <a:gd name="connsiteX6" fmla="*/ 153014 w 828090"/>
                    <a:gd name="connsiteY6" fmla="*/ 371321 h 418791"/>
                    <a:gd name="connsiteX7" fmla="*/ 329 w 828090"/>
                    <a:gd name="connsiteY7" fmla="*/ 354833 h 418791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476599 w 857165"/>
                    <a:gd name="connsiteY5" fmla="*/ 191739 h 418526"/>
                    <a:gd name="connsiteX6" fmla="*/ 182089 w 857165"/>
                    <a:gd name="connsiteY6" fmla="*/ 371056 h 418526"/>
                    <a:gd name="connsiteX7" fmla="*/ 283 w 857165"/>
                    <a:gd name="connsiteY7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476599 w 857165"/>
                    <a:gd name="connsiteY5" fmla="*/ 191739 h 418526"/>
                    <a:gd name="connsiteX6" fmla="*/ 182089 w 857165"/>
                    <a:gd name="connsiteY6" fmla="*/ 371056 h 418526"/>
                    <a:gd name="connsiteX7" fmla="*/ 283 w 857165"/>
                    <a:gd name="connsiteY7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476599 w 857165"/>
                    <a:gd name="connsiteY5" fmla="*/ 191739 h 418526"/>
                    <a:gd name="connsiteX6" fmla="*/ 182089 w 857165"/>
                    <a:gd name="connsiteY6" fmla="*/ 371056 h 418526"/>
                    <a:gd name="connsiteX7" fmla="*/ 283 w 857165"/>
                    <a:gd name="connsiteY7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476599 w 857165"/>
                    <a:gd name="connsiteY5" fmla="*/ 191739 h 418526"/>
                    <a:gd name="connsiteX6" fmla="*/ 182089 w 857165"/>
                    <a:gd name="connsiteY6" fmla="*/ 371056 h 418526"/>
                    <a:gd name="connsiteX7" fmla="*/ 283 w 857165"/>
                    <a:gd name="connsiteY7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596226 w 857165"/>
                    <a:gd name="connsiteY5" fmla="*/ 269798 h 418526"/>
                    <a:gd name="connsiteX6" fmla="*/ 476599 w 857165"/>
                    <a:gd name="connsiteY6" fmla="*/ 191739 h 418526"/>
                    <a:gd name="connsiteX7" fmla="*/ 182089 w 857165"/>
                    <a:gd name="connsiteY7" fmla="*/ 371056 h 418526"/>
                    <a:gd name="connsiteX8" fmla="*/ 283 w 857165"/>
                    <a:gd name="connsiteY8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631337 w 857165"/>
                    <a:gd name="connsiteY5" fmla="*/ 261689 h 418526"/>
                    <a:gd name="connsiteX6" fmla="*/ 476599 w 857165"/>
                    <a:gd name="connsiteY6" fmla="*/ 191739 h 418526"/>
                    <a:gd name="connsiteX7" fmla="*/ 182089 w 857165"/>
                    <a:gd name="connsiteY7" fmla="*/ 371056 h 418526"/>
                    <a:gd name="connsiteX8" fmla="*/ 283 w 857165"/>
                    <a:gd name="connsiteY8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623229 w 857165"/>
                    <a:gd name="connsiteY5" fmla="*/ 226578 h 418526"/>
                    <a:gd name="connsiteX6" fmla="*/ 476599 w 857165"/>
                    <a:gd name="connsiteY6" fmla="*/ 191739 h 418526"/>
                    <a:gd name="connsiteX7" fmla="*/ 182089 w 857165"/>
                    <a:gd name="connsiteY7" fmla="*/ 371056 h 418526"/>
                    <a:gd name="connsiteX8" fmla="*/ 283 w 857165"/>
                    <a:gd name="connsiteY8" fmla="*/ 350149 h 418526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623229 w 857165"/>
                    <a:gd name="connsiteY5" fmla="*/ 226578 h 418077"/>
                    <a:gd name="connsiteX6" fmla="*/ 476599 w 857165"/>
                    <a:gd name="connsiteY6" fmla="*/ 191739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623229 w 857165"/>
                    <a:gd name="connsiteY5" fmla="*/ 226578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623229 w 857165"/>
                    <a:gd name="connsiteY5" fmla="*/ 226578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91288 w 857165"/>
                    <a:gd name="connsiteY5" fmla="*/ 217643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91288 w 857165"/>
                    <a:gd name="connsiteY5" fmla="*/ 217643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91288 w 857165"/>
                    <a:gd name="connsiteY5" fmla="*/ 217643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13122 w 857165"/>
                    <a:gd name="connsiteY6" fmla="*/ 233528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13122 w 857165"/>
                    <a:gd name="connsiteY6" fmla="*/ 233528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23181 w 857165"/>
                    <a:gd name="connsiteY6" fmla="*/ 213440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23181 w 857165"/>
                    <a:gd name="connsiteY6" fmla="*/ 213440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23181 w 857165"/>
                    <a:gd name="connsiteY6" fmla="*/ 213440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71599"/>
                    <a:gd name="connsiteX1" fmla="*/ 263891 w 857165"/>
                    <a:gd name="connsiteY1" fmla="*/ 40604 h 471599"/>
                    <a:gd name="connsiteX2" fmla="*/ 623863 w 857165"/>
                    <a:gd name="connsiteY2" fmla="*/ 31764 h 471599"/>
                    <a:gd name="connsiteX3" fmla="*/ 857165 w 857165"/>
                    <a:gd name="connsiteY3" fmla="*/ 300191 h 471599"/>
                    <a:gd name="connsiteX4" fmla="*/ 768237 w 857165"/>
                    <a:gd name="connsiteY4" fmla="*/ 471599 h 471599"/>
                    <a:gd name="connsiteX5" fmla="*/ 588791 w 857165"/>
                    <a:gd name="connsiteY5" fmla="*/ 241798 h 471599"/>
                    <a:gd name="connsiteX6" fmla="*/ 323181 w 857165"/>
                    <a:gd name="connsiteY6" fmla="*/ 213440 h 471599"/>
                    <a:gd name="connsiteX7" fmla="*/ 182089 w 857165"/>
                    <a:gd name="connsiteY7" fmla="*/ 371056 h 471599"/>
                    <a:gd name="connsiteX8" fmla="*/ 283 w 857165"/>
                    <a:gd name="connsiteY8" fmla="*/ 350149 h 471599"/>
                    <a:gd name="connsiteX0" fmla="*/ 283 w 922080"/>
                    <a:gd name="connsiteY0" fmla="*/ 359002 h 486990"/>
                    <a:gd name="connsiteX1" fmla="*/ 263891 w 922080"/>
                    <a:gd name="connsiteY1" fmla="*/ 49457 h 486990"/>
                    <a:gd name="connsiteX2" fmla="*/ 623863 w 922080"/>
                    <a:gd name="connsiteY2" fmla="*/ 40617 h 486990"/>
                    <a:gd name="connsiteX3" fmla="*/ 922080 w 922080"/>
                    <a:gd name="connsiteY3" fmla="*/ 440612 h 486990"/>
                    <a:gd name="connsiteX4" fmla="*/ 768237 w 922080"/>
                    <a:gd name="connsiteY4" fmla="*/ 480452 h 486990"/>
                    <a:gd name="connsiteX5" fmla="*/ 588791 w 922080"/>
                    <a:gd name="connsiteY5" fmla="*/ 250651 h 486990"/>
                    <a:gd name="connsiteX6" fmla="*/ 323181 w 922080"/>
                    <a:gd name="connsiteY6" fmla="*/ 222293 h 486990"/>
                    <a:gd name="connsiteX7" fmla="*/ 182089 w 922080"/>
                    <a:gd name="connsiteY7" fmla="*/ 379909 h 486990"/>
                    <a:gd name="connsiteX8" fmla="*/ 283 w 922080"/>
                    <a:gd name="connsiteY8" fmla="*/ 359002 h 486990"/>
                    <a:gd name="connsiteX0" fmla="*/ 283 w 925272"/>
                    <a:gd name="connsiteY0" fmla="*/ 357772 h 480085"/>
                    <a:gd name="connsiteX1" fmla="*/ 263891 w 925272"/>
                    <a:gd name="connsiteY1" fmla="*/ 48227 h 480085"/>
                    <a:gd name="connsiteX2" fmla="*/ 623863 w 925272"/>
                    <a:gd name="connsiteY2" fmla="*/ 39387 h 480085"/>
                    <a:gd name="connsiteX3" fmla="*/ 925272 w 925272"/>
                    <a:gd name="connsiteY3" fmla="*/ 421509 h 480085"/>
                    <a:gd name="connsiteX4" fmla="*/ 768237 w 925272"/>
                    <a:gd name="connsiteY4" fmla="*/ 479222 h 480085"/>
                    <a:gd name="connsiteX5" fmla="*/ 588791 w 925272"/>
                    <a:gd name="connsiteY5" fmla="*/ 249421 h 480085"/>
                    <a:gd name="connsiteX6" fmla="*/ 323181 w 925272"/>
                    <a:gd name="connsiteY6" fmla="*/ 221063 h 480085"/>
                    <a:gd name="connsiteX7" fmla="*/ 182089 w 925272"/>
                    <a:gd name="connsiteY7" fmla="*/ 378679 h 480085"/>
                    <a:gd name="connsiteX8" fmla="*/ 283 w 925272"/>
                    <a:gd name="connsiteY8" fmla="*/ 357772 h 480085"/>
                    <a:gd name="connsiteX0" fmla="*/ 283 w 925272"/>
                    <a:gd name="connsiteY0" fmla="*/ 357772 h 479899"/>
                    <a:gd name="connsiteX1" fmla="*/ 263891 w 925272"/>
                    <a:gd name="connsiteY1" fmla="*/ 48227 h 479899"/>
                    <a:gd name="connsiteX2" fmla="*/ 623863 w 925272"/>
                    <a:gd name="connsiteY2" fmla="*/ 39387 h 479899"/>
                    <a:gd name="connsiteX3" fmla="*/ 925272 w 925272"/>
                    <a:gd name="connsiteY3" fmla="*/ 421509 h 479899"/>
                    <a:gd name="connsiteX4" fmla="*/ 768237 w 925272"/>
                    <a:gd name="connsiteY4" fmla="*/ 479222 h 479899"/>
                    <a:gd name="connsiteX5" fmla="*/ 588791 w 925272"/>
                    <a:gd name="connsiteY5" fmla="*/ 249421 h 479899"/>
                    <a:gd name="connsiteX6" fmla="*/ 323181 w 925272"/>
                    <a:gd name="connsiteY6" fmla="*/ 221063 h 479899"/>
                    <a:gd name="connsiteX7" fmla="*/ 182089 w 925272"/>
                    <a:gd name="connsiteY7" fmla="*/ 378679 h 479899"/>
                    <a:gd name="connsiteX8" fmla="*/ 283 w 925272"/>
                    <a:gd name="connsiteY8" fmla="*/ 357772 h 479899"/>
                    <a:gd name="connsiteX0" fmla="*/ 283 w 925272"/>
                    <a:gd name="connsiteY0" fmla="*/ 357772 h 479899"/>
                    <a:gd name="connsiteX1" fmla="*/ 263891 w 925272"/>
                    <a:gd name="connsiteY1" fmla="*/ 48227 h 479899"/>
                    <a:gd name="connsiteX2" fmla="*/ 623863 w 925272"/>
                    <a:gd name="connsiteY2" fmla="*/ 39387 h 479899"/>
                    <a:gd name="connsiteX3" fmla="*/ 925272 w 925272"/>
                    <a:gd name="connsiteY3" fmla="*/ 421509 h 479899"/>
                    <a:gd name="connsiteX4" fmla="*/ 768237 w 925272"/>
                    <a:gd name="connsiteY4" fmla="*/ 479222 h 479899"/>
                    <a:gd name="connsiteX5" fmla="*/ 588791 w 925272"/>
                    <a:gd name="connsiteY5" fmla="*/ 249421 h 479899"/>
                    <a:gd name="connsiteX6" fmla="*/ 323181 w 925272"/>
                    <a:gd name="connsiteY6" fmla="*/ 221063 h 479899"/>
                    <a:gd name="connsiteX7" fmla="*/ 182089 w 925272"/>
                    <a:gd name="connsiteY7" fmla="*/ 378679 h 479899"/>
                    <a:gd name="connsiteX8" fmla="*/ 283 w 925272"/>
                    <a:gd name="connsiteY8" fmla="*/ 357772 h 479899"/>
                    <a:gd name="connsiteX0" fmla="*/ 283 w 925272"/>
                    <a:gd name="connsiteY0" fmla="*/ 357772 h 479899"/>
                    <a:gd name="connsiteX1" fmla="*/ 263891 w 925272"/>
                    <a:gd name="connsiteY1" fmla="*/ 48227 h 479899"/>
                    <a:gd name="connsiteX2" fmla="*/ 623863 w 925272"/>
                    <a:gd name="connsiteY2" fmla="*/ 39387 h 479899"/>
                    <a:gd name="connsiteX3" fmla="*/ 925272 w 925272"/>
                    <a:gd name="connsiteY3" fmla="*/ 421509 h 479899"/>
                    <a:gd name="connsiteX4" fmla="*/ 768237 w 925272"/>
                    <a:gd name="connsiteY4" fmla="*/ 479222 h 479899"/>
                    <a:gd name="connsiteX5" fmla="*/ 614360 w 925272"/>
                    <a:gd name="connsiteY5" fmla="*/ 239373 h 479899"/>
                    <a:gd name="connsiteX6" fmla="*/ 323181 w 925272"/>
                    <a:gd name="connsiteY6" fmla="*/ 221063 h 479899"/>
                    <a:gd name="connsiteX7" fmla="*/ 182089 w 925272"/>
                    <a:gd name="connsiteY7" fmla="*/ 378679 h 479899"/>
                    <a:gd name="connsiteX8" fmla="*/ 283 w 925272"/>
                    <a:gd name="connsiteY8" fmla="*/ 357772 h 479899"/>
                    <a:gd name="connsiteX0" fmla="*/ 283 w 925272"/>
                    <a:gd name="connsiteY0" fmla="*/ 357772 h 478527"/>
                    <a:gd name="connsiteX1" fmla="*/ 263891 w 925272"/>
                    <a:gd name="connsiteY1" fmla="*/ 48227 h 478527"/>
                    <a:gd name="connsiteX2" fmla="*/ 623863 w 925272"/>
                    <a:gd name="connsiteY2" fmla="*/ 39387 h 478527"/>
                    <a:gd name="connsiteX3" fmla="*/ 925272 w 925272"/>
                    <a:gd name="connsiteY3" fmla="*/ 421509 h 478527"/>
                    <a:gd name="connsiteX4" fmla="*/ 784939 w 925272"/>
                    <a:gd name="connsiteY4" fmla="*/ 477575 h 478527"/>
                    <a:gd name="connsiteX5" fmla="*/ 614360 w 925272"/>
                    <a:gd name="connsiteY5" fmla="*/ 239373 h 478527"/>
                    <a:gd name="connsiteX6" fmla="*/ 323181 w 925272"/>
                    <a:gd name="connsiteY6" fmla="*/ 221063 h 478527"/>
                    <a:gd name="connsiteX7" fmla="*/ 182089 w 925272"/>
                    <a:gd name="connsiteY7" fmla="*/ 378679 h 478527"/>
                    <a:gd name="connsiteX8" fmla="*/ 283 w 925272"/>
                    <a:gd name="connsiteY8" fmla="*/ 357772 h 478527"/>
                    <a:gd name="connsiteX0" fmla="*/ 283 w 925272"/>
                    <a:gd name="connsiteY0" fmla="*/ 357772 h 478527"/>
                    <a:gd name="connsiteX1" fmla="*/ 263891 w 925272"/>
                    <a:gd name="connsiteY1" fmla="*/ 48227 h 478527"/>
                    <a:gd name="connsiteX2" fmla="*/ 623863 w 925272"/>
                    <a:gd name="connsiteY2" fmla="*/ 39387 h 478527"/>
                    <a:gd name="connsiteX3" fmla="*/ 925272 w 925272"/>
                    <a:gd name="connsiteY3" fmla="*/ 421509 h 478527"/>
                    <a:gd name="connsiteX4" fmla="*/ 784939 w 925272"/>
                    <a:gd name="connsiteY4" fmla="*/ 477575 h 478527"/>
                    <a:gd name="connsiteX5" fmla="*/ 614360 w 925272"/>
                    <a:gd name="connsiteY5" fmla="*/ 239373 h 478527"/>
                    <a:gd name="connsiteX6" fmla="*/ 323181 w 925272"/>
                    <a:gd name="connsiteY6" fmla="*/ 221063 h 478527"/>
                    <a:gd name="connsiteX7" fmla="*/ 182089 w 925272"/>
                    <a:gd name="connsiteY7" fmla="*/ 378679 h 478527"/>
                    <a:gd name="connsiteX8" fmla="*/ 283 w 925272"/>
                    <a:gd name="connsiteY8" fmla="*/ 357772 h 478527"/>
                    <a:gd name="connsiteX0" fmla="*/ 283 w 925272"/>
                    <a:gd name="connsiteY0" fmla="*/ 357772 h 557834"/>
                    <a:gd name="connsiteX1" fmla="*/ 263891 w 925272"/>
                    <a:gd name="connsiteY1" fmla="*/ 48227 h 557834"/>
                    <a:gd name="connsiteX2" fmla="*/ 623863 w 925272"/>
                    <a:gd name="connsiteY2" fmla="*/ 39387 h 557834"/>
                    <a:gd name="connsiteX3" fmla="*/ 925272 w 925272"/>
                    <a:gd name="connsiteY3" fmla="*/ 421509 h 557834"/>
                    <a:gd name="connsiteX4" fmla="*/ 784939 w 925272"/>
                    <a:gd name="connsiteY4" fmla="*/ 477575 h 557834"/>
                    <a:gd name="connsiteX5" fmla="*/ 614360 w 925272"/>
                    <a:gd name="connsiteY5" fmla="*/ 239373 h 557834"/>
                    <a:gd name="connsiteX6" fmla="*/ 323181 w 925272"/>
                    <a:gd name="connsiteY6" fmla="*/ 221063 h 557834"/>
                    <a:gd name="connsiteX7" fmla="*/ 137577 w 925272"/>
                    <a:gd name="connsiteY7" fmla="*/ 551149 h 557834"/>
                    <a:gd name="connsiteX8" fmla="*/ 283 w 925272"/>
                    <a:gd name="connsiteY8" fmla="*/ 357772 h 557834"/>
                    <a:gd name="connsiteX0" fmla="*/ 283 w 925272"/>
                    <a:gd name="connsiteY0" fmla="*/ 357772 h 505215"/>
                    <a:gd name="connsiteX1" fmla="*/ 263891 w 925272"/>
                    <a:gd name="connsiteY1" fmla="*/ 48227 h 505215"/>
                    <a:gd name="connsiteX2" fmla="*/ 623863 w 925272"/>
                    <a:gd name="connsiteY2" fmla="*/ 39387 h 505215"/>
                    <a:gd name="connsiteX3" fmla="*/ 925272 w 925272"/>
                    <a:gd name="connsiteY3" fmla="*/ 421509 h 505215"/>
                    <a:gd name="connsiteX4" fmla="*/ 784939 w 925272"/>
                    <a:gd name="connsiteY4" fmla="*/ 477575 h 505215"/>
                    <a:gd name="connsiteX5" fmla="*/ 614360 w 925272"/>
                    <a:gd name="connsiteY5" fmla="*/ 239373 h 505215"/>
                    <a:gd name="connsiteX6" fmla="*/ 323181 w 925272"/>
                    <a:gd name="connsiteY6" fmla="*/ 221063 h 505215"/>
                    <a:gd name="connsiteX7" fmla="*/ 132607 w 925272"/>
                    <a:gd name="connsiteY7" fmla="*/ 496450 h 505215"/>
                    <a:gd name="connsiteX8" fmla="*/ 283 w 925272"/>
                    <a:gd name="connsiteY8" fmla="*/ 357772 h 505215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344909 w 947000"/>
                    <a:gd name="connsiteY6" fmla="*/ 227109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296839 w 947000"/>
                    <a:gd name="connsiteY6" fmla="*/ 254428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296839 w 947000"/>
                    <a:gd name="connsiteY6" fmla="*/ 254428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296839 w 947000"/>
                    <a:gd name="connsiteY6" fmla="*/ 254428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295554 w 947000"/>
                    <a:gd name="connsiteY6" fmla="*/ 372286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2261 w 947000"/>
                    <a:gd name="connsiteY5" fmla="*/ 503987 h 523249"/>
                    <a:gd name="connsiteX6" fmla="*/ 295554 w 947000"/>
                    <a:gd name="connsiteY6" fmla="*/ 372286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9 w 947002"/>
                    <a:gd name="connsiteY0" fmla="*/ 433331 h 487762"/>
                    <a:gd name="connsiteX1" fmla="*/ 285621 w 947002"/>
                    <a:gd name="connsiteY1" fmla="*/ 18786 h 487762"/>
                    <a:gd name="connsiteX2" fmla="*/ 655110 w 947002"/>
                    <a:gd name="connsiteY2" fmla="*/ 103264 h 487762"/>
                    <a:gd name="connsiteX3" fmla="*/ 947002 w 947002"/>
                    <a:gd name="connsiteY3" fmla="*/ 392068 h 487762"/>
                    <a:gd name="connsiteX4" fmla="*/ 806669 w 947002"/>
                    <a:gd name="connsiteY4" fmla="*/ 448134 h 487762"/>
                    <a:gd name="connsiteX5" fmla="*/ 632263 w 947002"/>
                    <a:gd name="connsiteY5" fmla="*/ 468500 h 487762"/>
                    <a:gd name="connsiteX6" fmla="*/ 295556 w 947002"/>
                    <a:gd name="connsiteY6" fmla="*/ 336799 h 487762"/>
                    <a:gd name="connsiteX7" fmla="*/ 154337 w 947002"/>
                    <a:gd name="connsiteY7" fmla="*/ 467009 h 487762"/>
                    <a:gd name="connsiteX8" fmla="*/ 259 w 947002"/>
                    <a:gd name="connsiteY8" fmla="*/ 433331 h 487762"/>
                    <a:gd name="connsiteX0" fmla="*/ 243 w 946986"/>
                    <a:gd name="connsiteY0" fmla="*/ 412146 h 466577"/>
                    <a:gd name="connsiteX1" fmla="*/ 298890 w 946986"/>
                    <a:gd name="connsiteY1" fmla="*/ 22384 h 466577"/>
                    <a:gd name="connsiteX2" fmla="*/ 655094 w 946986"/>
                    <a:gd name="connsiteY2" fmla="*/ 82079 h 466577"/>
                    <a:gd name="connsiteX3" fmla="*/ 946986 w 946986"/>
                    <a:gd name="connsiteY3" fmla="*/ 370883 h 466577"/>
                    <a:gd name="connsiteX4" fmla="*/ 806653 w 946986"/>
                    <a:gd name="connsiteY4" fmla="*/ 426949 h 466577"/>
                    <a:gd name="connsiteX5" fmla="*/ 632247 w 946986"/>
                    <a:gd name="connsiteY5" fmla="*/ 447315 h 466577"/>
                    <a:gd name="connsiteX6" fmla="*/ 295540 w 946986"/>
                    <a:gd name="connsiteY6" fmla="*/ 315614 h 466577"/>
                    <a:gd name="connsiteX7" fmla="*/ 154321 w 946986"/>
                    <a:gd name="connsiteY7" fmla="*/ 445824 h 466577"/>
                    <a:gd name="connsiteX8" fmla="*/ 243 w 946986"/>
                    <a:gd name="connsiteY8" fmla="*/ 412146 h 466577"/>
                    <a:gd name="connsiteX0" fmla="*/ 243 w 946986"/>
                    <a:gd name="connsiteY0" fmla="*/ 412146 h 466577"/>
                    <a:gd name="connsiteX1" fmla="*/ 298890 w 946986"/>
                    <a:gd name="connsiteY1" fmla="*/ 22384 h 466577"/>
                    <a:gd name="connsiteX2" fmla="*/ 655094 w 946986"/>
                    <a:gd name="connsiteY2" fmla="*/ 82079 h 466577"/>
                    <a:gd name="connsiteX3" fmla="*/ 946986 w 946986"/>
                    <a:gd name="connsiteY3" fmla="*/ 370883 h 466577"/>
                    <a:gd name="connsiteX4" fmla="*/ 806653 w 946986"/>
                    <a:gd name="connsiteY4" fmla="*/ 426949 h 466577"/>
                    <a:gd name="connsiteX5" fmla="*/ 559793 w 946986"/>
                    <a:gd name="connsiteY5" fmla="*/ 347102 h 466577"/>
                    <a:gd name="connsiteX6" fmla="*/ 295540 w 946986"/>
                    <a:gd name="connsiteY6" fmla="*/ 315614 h 466577"/>
                    <a:gd name="connsiteX7" fmla="*/ 154321 w 946986"/>
                    <a:gd name="connsiteY7" fmla="*/ 445824 h 466577"/>
                    <a:gd name="connsiteX8" fmla="*/ 243 w 946986"/>
                    <a:gd name="connsiteY8" fmla="*/ 412146 h 466577"/>
                    <a:gd name="connsiteX0" fmla="*/ 243 w 946986"/>
                    <a:gd name="connsiteY0" fmla="*/ 412146 h 466577"/>
                    <a:gd name="connsiteX1" fmla="*/ 298890 w 946986"/>
                    <a:gd name="connsiteY1" fmla="*/ 22384 h 466577"/>
                    <a:gd name="connsiteX2" fmla="*/ 655094 w 946986"/>
                    <a:gd name="connsiteY2" fmla="*/ 82079 h 466577"/>
                    <a:gd name="connsiteX3" fmla="*/ 946986 w 946986"/>
                    <a:gd name="connsiteY3" fmla="*/ 370883 h 466577"/>
                    <a:gd name="connsiteX4" fmla="*/ 806653 w 946986"/>
                    <a:gd name="connsiteY4" fmla="*/ 426949 h 466577"/>
                    <a:gd name="connsiteX5" fmla="*/ 662849 w 946986"/>
                    <a:gd name="connsiteY5" fmla="*/ 369624 h 466577"/>
                    <a:gd name="connsiteX6" fmla="*/ 295540 w 946986"/>
                    <a:gd name="connsiteY6" fmla="*/ 315614 h 466577"/>
                    <a:gd name="connsiteX7" fmla="*/ 154321 w 946986"/>
                    <a:gd name="connsiteY7" fmla="*/ 445824 h 466577"/>
                    <a:gd name="connsiteX8" fmla="*/ 243 w 946986"/>
                    <a:gd name="connsiteY8" fmla="*/ 412146 h 466577"/>
                    <a:gd name="connsiteX0" fmla="*/ 243 w 946986"/>
                    <a:gd name="connsiteY0" fmla="*/ 412146 h 427901"/>
                    <a:gd name="connsiteX1" fmla="*/ 298890 w 946986"/>
                    <a:gd name="connsiteY1" fmla="*/ 22384 h 427901"/>
                    <a:gd name="connsiteX2" fmla="*/ 655094 w 946986"/>
                    <a:gd name="connsiteY2" fmla="*/ 82079 h 427901"/>
                    <a:gd name="connsiteX3" fmla="*/ 946986 w 946986"/>
                    <a:gd name="connsiteY3" fmla="*/ 370883 h 427901"/>
                    <a:gd name="connsiteX4" fmla="*/ 806653 w 946986"/>
                    <a:gd name="connsiteY4" fmla="*/ 426949 h 427901"/>
                    <a:gd name="connsiteX5" fmla="*/ 662849 w 946986"/>
                    <a:gd name="connsiteY5" fmla="*/ 369624 h 427901"/>
                    <a:gd name="connsiteX6" fmla="*/ 295540 w 946986"/>
                    <a:gd name="connsiteY6" fmla="*/ 315614 h 427901"/>
                    <a:gd name="connsiteX7" fmla="*/ 156720 w 946986"/>
                    <a:gd name="connsiteY7" fmla="*/ 355738 h 427901"/>
                    <a:gd name="connsiteX8" fmla="*/ 243 w 946986"/>
                    <a:gd name="connsiteY8" fmla="*/ 412146 h 427901"/>
                    <a:gd name="connsiteX0" fmla="*/ 272 w 920653"/>
                    <a:gd name="connsiteY0" fmla="*/ 209335 h 414265"/>
                    <a:gd name="connsiteX1" fmla="*/ 272557 w 920653"/>
                    <a:gd name="connsiteY1" fmla="*/ 8748 h 414265"/>
                    <a:gd name="connsiteX2" fmla="*/ 628761 w 920653"/>
                    <a:gd name="connsiteY2" fmla="*/ 68443 h 414265"/>
                    <a:gd name="connsiteX3" fmla="*/ 920653 w 920653"/>
                    <a:gd name="connsiteY3" fmla="*/ 357247 h 414265"/>
                    <a:gd name="connsiteX4" fmla="*/ 780320 w 920653"/>
                    <a:gd name="connsiteY4" fmla="*/ 413313 h 414265"/>
                    <a:gd name="connsiteX5" fmla="*/ 636516 w 920653"/>
                    <a:gd name="connsiteY5" fmla="*/ 355988 h 414265"/>
                    <a:gd name="connsiteX6" fmla="*/ 269207 w 920653"/>
                    <a:gd name="connsiteY6" fmla="*/ 301978 h 414265"/>
                    <a:gd name="connsiteX7" fmla="*/ 130387 w 920653"/>
                    <a:gd name="connsiteY7" fmla="*/ 342102 h 414265"/>
                    <a:gd name="connsiteX8" fmla="*/ 272 w 920653"/>
                    <a:gd name="connsiteY8" fmla="*/ 209335 h 414265"/>
                    <a:gd name="connsiteX0" fmla="*/ 272 w 920653"/>
                    <a:gd name="connsiteY0" fmla="*/ 209335 h 414265"/>
                    <a:gd name="connsiteX1" fmla="*/ 272557 w 920653"/>
                    <a:gd name="connsiteY1" fmla="*/ 8748 h 414265"/>
                    <a:gd name="connsiteX2" fmla="*/ 628761 w 920653"/>
                    <a:gd name="connsiteY2" fmla="*/ 68443 h 414265"/>
                    <a:gd name="connsiteX3" fmla="*/ 920653 w 920653"/>
                    <a:gd name="connsiteY3" fmla="*/ 357247 h 414265"/>
                    <a:gd name="connsiteX4" fmla="*/ 780320 w 920653"/>
                    <a:gd name="connsiteY4" fmla="*/ 413313 h 414265"/>
                    <a:gd name="connsiteX5" fmla="*/ 636516 w 920653"/>
                    <a:gd name="connsiteY5" fmla="*/ 355988 h 414265"/>
                    <a:gd name="connsiteX6" fmla="*/ 269207 w 920653"/>
                    <a:gd name="connsiteY6" fmla="*/ 301978 h 414265"/>
                    <a:gd name="connsiteX7" fmla="*/ 130387 w 920653"/>
                    <a:gd name="connsiteY7" fmla="*/ 342102 h 414265"/>
                    <a:gd name="connsiteX8" fmla="*/ 272 w 920653"/>
                    <a:gd name="connsiteY8" fmla="*/ 209335 h 414265"/>
                    <a:gd name="connsiteX0" fmla="*/ 272 w 920653"/>
                    <a:gd name="connsiteY0" fmla="*/ 209335 h 414265"/>
                    <a:gd name="connsiteX1" fmla="*/ 272557 w 920653"/>
                    <a:gd name="connsiteY1" fmla="*/ 8748 h 414265"/>
                    <a:gd name="connsiteX2" fmla="*/ 628761 w 920653"/>
                    <a:gd name="connsiteY2" fmla="*/ 68443 h 414265"/>
                    <a:gd name="connsiteX3" fmla="*/ 920653 w 920653"/>
                    <a:gd name="connsiteY3" fmla="*/ 357247 h 414265"/>
                    <a:gd name="connsiteX4" fmla="*/ 780320 w 920653"/>
                    <a:gd name="connsiteY4" fmla="*/ 413313 h 414265"/>
                    <a:gd name="connsiteX5" fmla="*/ 636516 w 920653"/>
                    <a:gd name="connsiteY5" fmla="*/ 355988 h 414265"/>
                    <a:gd name="connsiteX6" fmla="*/ 269207 w 920653"/>
                    <a:gd name="connsiteY6" fmla="*/ 301978 h 414265"/>
                    <a:gd name="connsiteX7" fmla="*/ 130387 w 920653"/>
                    <a:gd name="connsiteY7" fmla="*/ 342102 h 414265"/>
                    <a:gd name="connsiteX8" fmla="*/ 272 w 920653"/>
                    <a:gd name="connsiteY8" fmla="*/ 209335 h 414265"/>
                    <a:gd name="connsiteX0" fmla="*/ 0 w 920381"/>
                    <a:gd name="connsiteY0" fmla="*/ 209335 h 414265"/>
                    <a:gd name="connsiteX1" fmla="*/ 272285 w 920381"/>
                    <a:gd name="connsiteY1" fmla="*/ 8748 h 414265"/>
                    <a:gd name="connsiteX2" fmla="*/ 628489 w 920381"/>
                    <a:gd name="connsiteY2" fmla="*/ 68443 h 414265"/>
                    <a:gd name="connsiteX3" fmla="*/ 920381 w 920381"/>
                    <a:gd name="connsiteY3" fmla="*/ 357247 h 414265"/>
                    <a:gd name="connsiteX4" fmla="*/ 780048 w 920381"/>
                    <a:gd name="connsiteY4" fmla="*/ 413313 h 414265"/>
                    <a:gd name="connsiteX5" fmla="*/ 636244 w 920381"/>
                    <a:gd name="connsiteY5" fmla="*/ 355988 h 414265"/>
                    <a:gd name="connsiteX6" fmla="*/ 268935 w 920381"/>
                    <a:gd name="connsiteY6" fmla="*/ 301978 h 414265"/>
                    <a:gd name="connsiteX7" fmla="*/ 130115 w 920381"/>
                    <a:gd name="connsiteY7" fmla="*/ 342102 h 414265"/>
                    <a:gd name="connsiteX8" fmla="*/ 0 w 920381"/>
                    <a:gd name="connsiteY8" fmla="*/ 209335 h 414265"/>
                    <a:gd name="connsiteX0" fmla="*/ 0 w 920381"/>
                    <a:gd name="connsiteY0" fmla="*/ 209335 h 414265"/>
                    <a:gd name="connsiteX1" fmla="*/ 272285 w 920381"/>
                    <a:gd name="connsiteY1" fmla="*/ 8748 h 414265"/>
                    <a:gd name="connsiteX2" fmla="*/ 628489 w 920381"/>
                    <a:gd name="connsiteY2" fmla="*/ 68443 h 414265"/>
                    <a:gd name="connsiteX3" fmla="*/ 920381 w 920381"/>
                    <a:gd name="connsiteY3" fmla="*/ 357247 h 414265"/>
                    <a:gd name="connsiteX4" fmla="*/ 780048 w 920381"/>
                    <a:gd name="connsiteY4" fmla="*/ 413313 h 414265"/>
                    <a:gd name="connsiteX5" fmla="*/ 636244 w 920381"/>
                    <a:gd name="connsiteY5" fmla="*/ 355988 h 414265"/>
                    <a:gd name="connsiteX6" fmla="*/ 268935 w 920381"/>
                    <a:gd name="connsiteY6" fmla="*/ 301978 h 414265"/>
                    <a:gd name="connsiteX7" fmla="*/ 130115 w 920381"/>
                    <a:gd name="connsiteY7" fmla="*/ 342102 h 414265"/>
                    <a:gd name="connsiteX8" fmla="*/ 0 w 920381"/>
                    <a:gd name="connsiteY8" fmla="*/ 209335 h 41426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920381" h="414265">
                      <a:moveTo>
                        <a:pt x="0" y="209335"/>
                      </a:moveTo>
                      <a:cubicBezTo>
                        <a:pt x="35021" y="24482"/>
                        <a:pt x="167537" y="32230"/>
                        <a:pt x="272285" y="8748"/>
                      </a:cubicBezTo>
                      <a:cubicBezTo>
                        <a:pt x="377033" y="-14734"/>
                        <a:pt x="520473" y="10360"/>
                        <a:pt x="628489" y="68443"/>
                      </a:cubicBezTo>
                      <a:cubicBezTo>
                        <a:pt x="736505" y="126526"/>
                        <a:pt x="907774" y="220635"/>
                        <a:pt x="920381" y="357247"/>
                      </a:cubicBezTo>
                      <a:cubicBezTo>
                        <a:pt x="916867" y="426189"/>
                        <a:pt x="838180" y="413313"/>
                        <a:pt x="780048" y="413313"/>
                      </a:cubicBezTo>
                      <a:cubicBezTo>
                        <a:pt x="727775" y="368792"/>
                        <a:pt x="698637" y="375395"/>
                        <a:pt x="636244" y="355988"/>
                      </a:cubicBezTo>
                      <a:cubicBezTo>
                        <a:pt x="591245" y="318190"/>
                        <a:pt x="380660" y="229662"/>
                        <a:pt x="268935" y="301978"/>
                      </a:cubicBezTo>
                      <a:cubicBezTo>
                        <a:pt x="169358" y="325912"/>
                        <a:pt x="211344" y="305608"/>
                        <a:pt x="130115" y="342102"/>
                      </a:cubicBezTo>
                      <a:cubicBezTo>
                        <a:pt x="50521" y="387161"/>
                        <a:pt x="44797" y="301407"/>
                        <a:pt x="0" y="209335"/>
                      </a:cubicBezTo>
                      <a:close/>
                    </a:path>
                  </a:pathLst>
                </a:custGeom>
                <a:solidFill>
                  <a:schemeClr val="tx1">
                    <a:lumMod val="50000"/>
                    <a:lumOff val="50000"/>
                  </a:schemeClr>
                </a:solidFill>
                <a:ln>
                  <a:solidFill>
                    <a:schemeClr val="tx2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350">
                    <a:solidFill>
                      <a:schemeClr val="bg2">
                        <a:lumMod val="25000"/>
                      </a:schemeClr>
                    </a:solidFill>
                  </a:endParaRPr>
                </a:p>
              </p:txBody>
            </p:sp>
            <p:sp>
              <p:nvSpPr>
                <p:cNvPr id="20" name="Block Arc 15"/>
                <p:cNvSpPr/>
                <p:nvPr/>
              </p:nvSpPr>
              <p:spPr>
                <a:xfrm rot="5938083">
                  <a:off x="2890778" y="690613"/>
                  <a:ext cx="705901" cy="684364"/>
                </a:xfrm>
                <a:custGeom>
                  <a:avLst/>
                  <a:gdLst>
                    <a:gd name="connsiteX0" fmla="*/ 627 w 745516"/>
                    <a:gd name="connsiteY0" fmla="*/ 369014 h 697590"/>
                    <a:gd name="connsiteX1" fmla="*/ 184209 w 745516"/>
                    <a:gd name="connsiteY1" fmla="*/ 47911 h 697590"/>
                    <a:gd name="connsiteX2" fmla="*/ 544181 w 745516"/>
                    <a:gd name="connsiteY2" fmla="*/ 39071 h 697590"/>
                    <a:gd name="connsiteX3" fmla="*/ 745515 w 745516"/>
                    <a:gd name="connsiteY3" fmla="*/ 348795 h 697590"/>
                    <a:gd name="connsiteX4" fmla="*/ 571119 w 745516"/>
                    <a:gd name="connsiteY4" fmla="*/ 348795 h 697590"/>
                    <a:gd name="connsiteX5" fmla="*/ 459552 w 745516"/>
                    <a:gd name="connsiteY5" fmla="*/ 191978 h 697590"/>
                    <a:gd name="connsiteX6" fmla="*/ 277038 w 745516"/>
                    <a:gd name="connsiteY6" fmla="*/ 196046 h 697590"/>
                    <a:gd name="connsiteX7" fmla="*/ 174775 w 745516"/>
                    <a:gd name="connsiteY7" fmla="*/ 359552 h 697590"/>
                    <a:gd name="connsiteX8" fmla="*/ 627 w 745516"/>
                    <a:gd name="connsiteY8" fmla="*/ 369014 h 697590"/>
                    <a:gd name="connsiteX0" fmla="*/ 629 w 745517"/>
                    <a:gd name="connsiteY0" fmla="*/ 369014 h 369014"/>
                    <a:gd name="connsiteX1" fmla="*/ 184211 w 745517"/>
                    <a:gd name="connsiteY1" fmla="*/ 47911 h 369014"/>
                    <a:gd name="connsiteX2" fmla="*/ 544183 w 745517"/>
                    <a:gd name="connsiteY2" fmla="*/ 39071 h 369014"/>
                    <a:gd name="connsiteX3" fmla="*/ 745517 w 745517"/>
                    <a:gd name="connsiteY3" fmla="*/ 348795 h 369014"/>
                    <a:gd name="connsiteX4" fmla="*/ 668191 w 745517"/>
                    <a:gd name="connsiteY4" fmla="*/ 363523 h 369014"/>
                    <a:gd name="connsiteX5" fmla="*/ 459554 w 745517"/>
                    <a:gd name="connsiteY5" fmla="*/ 191978 h 369014"/>
                    <a:gd name="connsiteX6" fmla="*/ 277040 w 745517"/>
                    <a:gd name="connsiteY6" fmla="*/ 196046 h 369014"/>
                    <a:gd name="connsiteX7" fmla="*/ 174777 w 745517"/>
                    <a:gd name="connsiteY7" fmla="*/ 359552 h 369014"/>
                    <a:gd name="connsiteX8" fmla="*/ 629 w 745517"/>
                    <a:gd name="connsiteY8" fmla="*/ 369014 h 369014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59554 w 745517"/>
                    <a:gd name="connsiteY5" fmla="*/ 191978 h 425833"/>
                    <a:gd name="connsiteX6" fmla="*/ 277040 w 745517"/>
                    <a:gd name="connsiteY6" fmla="*/ 196046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48149 w 745517"/>
                    <a:gd name="connsiteY5" fmla="*/ 197842 h 425833"/>
                    <a:gd name="connsiteX6" fmla="*/ 277040 w 745517"/>
                    <a:gd name="connsiteY6" fmla="*/ 196046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277040 w 745517"/>
                    <a:gd name="connsiteY6" fmla="*/ 196046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387239 w 745517"/>
                    <a:gd name="connsiteY6" fmla="*/ 147341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387239 w 745517"/>
                    <a:gd name="connsiteY6" fmla="*/ 147341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387239 w 745517"/>
                    <a:gd name="connsiteY6" fmla="*/ 147341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465543 w 745517"/>
                    <a:gd name="connsiteY5" fmla="*/ 179451 h 425833"/>
                    <a:gd name="connsiteX6" fmla="*/ 396919 w 745517"/>
                    <a:gd name="connsiteY6" fmla="*/ 199046 h 425833"/>
                    <a:gd name="connsiteX7" fmla="*/ 174777 w 745517"/>
                    <a:gd name="connsiteY7" fmla="*/ 359552 h 425833"/>
                    <a:gd name="connsiteX8" fmla="*/ 629 w 745517"/>
                    <a:gd name="connsiteY8" fmla="*/ 369014 h 425833"/>
                    <a:gd name="connsiteX0" fmla="*/ 629 w 745517"/>
                    <a:gd name="connsiteY0" fmla="*/ 369014 h 425833"/>
                    <a:gd name="connsiteX1" fmla="*/ 184211 w 745517"/>
                    <a:gd name="connsiteY1" fmla="*/ 47911 h 425833"/>
                    <a:gd name="connsiteX2" fmla="*/ 544183 w 745517"/>
                    <a:gd name="connsiteY2" fmla="*/ 39071 h 425833"/>
                    <a:gd name="connsiteX3" fmla="*/ 745517 w 745517"/>
                    <a:gd name="connsiteY3" fmla="*/ 348795 h 425833"/>
                    <a:gd name="connsiteX4" fmla="*/ 666916 w 745517"/>
                    <a:gd name="connsiteY4" fmla="*/ 425833 h 425833"/>
                    <a:gd name="connsiteX5" fmla="*/ 396919 w 745517"/>
                    <a:gd name="connsiteY5" fmla="*/ 199046 h 425833"/>
                    <a:gd name="connsiteX6" fmla="*/ 174777 w 745517"/>
                    <a:gd name="connsiteY6" fmla="*/ 359552 h 425833"/>
                    <a:gd name="connsiteX7" fmla="*/ 629 w 745517"/>
                    <a:gd name="connsiteY7" fmla="*/ 369014 h 425833"/>
                    <a:gd name="connsiteX0" fmla="*/ 629 w 777485"/>
                    <a:gd name="connsiteY0" fmla="*/ 364465 h 421284"/>
                    <a:gd name="connsiteX1" fmla="*/ 184211 w 777485"/>
                    <a:gd name="connsiteY1" fmla="*/ 43362 h 421284"/>
                    <a:gd name="connsiteX2" fmla="*/ 544183 w 777485"/>
                    <a:gd name="connsiteY2" fmla="*/ 34522 h 421284"/>
                    <a:gd name="connsiteX3" fmla="*/ 777485 w 777485"/>
                    <a:gd name="connsiteY3" fmla="*/ 302949 h 421284"/>
                    <a:gd name="connsiteX4" fmla="*/ 666916 w 777485"/>
                    <a:gd name="connsiteY4" fmla="*/ 421284 h 421284"/>
                    <a:gd name="connsiteX5" fmla="*/ 396919 w 777485"/>
                    <a:gd name="connsiteY5" fmla="*/ 194497 h 421284"/>
                    <a:gd name="connsiteX6" fmla="*/ 174777 w 777485"/>
                    <a:gd name="connsiteY6" fmla="*/ 355003 h 421284"/>
                    <a:gd name="connsiteX7" fmla="*/ 629 w 777485"/>
                    <a:gd name="connsiteY7" fmla="*/ 364465 h 421284"/>
                    <a:gd name="connsiteX0" fmla="*/ 629 w 777485"/>
                    <a:gd name="connsiteY0" fmla="*/ 364465 h 421284"/>
                    <a:gd name="connsiteX1" fmla="*/ 184211 w 777485"/>
                    <a:gd name="connsiteY1" fmla="*/ 43362 h 421284"/>
                    <a:gd name="connsiteX2" fmla="*/ 544183 w 777485"/>
                    <a:gd name="connsiteY2" fmla="*/ 34522 h 421284"/>
                    <a:gd name="connsiteX3" fmla="*/ 777485 w 777485"/>
                    <a:gd name="connsiteY3" fmla="*/ 302949 h 421284"/>
                    <a:gd name="connsiteX4" fmla="*/ 666916 w 777485"/>
                    <a:gd name="connsiteY4" fmla="*/ 421284 h 421284"/>
                    <a:gd name="connsiteX5" fmla="*/ 396919 w 777485"/>
                    <a:gd name="connsiteY5" fmla="*/ 194497 h 421284"/>
                    <a:gd name="connsiteX6" fmla="*/ 174777 w 777485"/>
                    <a:gd name="connsiteY6" fmla="*/ 355003 h 421284"/>
                    <a:gd name="connsiteX7" fmla="*/ 629 w 777485"/>
                    <a:gd name="connsiteY7" fmla="*/ 364465 h 421284"/>
                    <a:gd name="connsiteX0" fmla="*/ 629 w 777485"/>
                    <a:gd name="connsiteY0" fmla="*/ 364465 h 421284"/>
                    <a:gd name="connsiteX1" fmla="*/ 184211 w 777485"/>
                    <a:gd name="connsiteY1" fmla="*/ 43362 h 421284"/>
                    <a:gd name="connsiteX2" fmla="*/ 544183 w 777485"/>
                    <a:gd name="connsiteY2" fmla="*/ 34522 h 421284"/>
                    <a:gd name="connsiteX3" fmla="*/ 777485 w 777485"/>
                    <a:gd name="connsiteY3" fmla="*/ 302949 h 421284"/>
                    <a:gd name="connsiteX4" fmla="*/ 666916 w 777485"/>
                    <a:gd name="connsiteY4" fmla="*/ 421284 h 421284"/>
                    <a:gd name="connsiteX5" fmla="*/ 396919 w 777485"/>
                    <a:gd name="connsiteY5" fmla="*/ 194497 h 421284"/>
                    <a:gd name="connsiteX6" fmla="*/ 102409 w 777485"/>
                    <a:gd name="connsiteY6" fmla="*/ 373814 h 421284"/>
                    <a:gd name="connsiteX7" fmla="*/ 629 w 777485"/>
                    <a:gd name="connsiteY7" fmla="*/ 364465 h 421284"/>
                    <a:gd name="connsiteX0" fmla="*/ 329 w 828090"/>
                    <a:gd name="connsiteY0" fmla="*/ 354833 h 418791"/>
                    <a:gd name="connsiteX1" fmla="*/ 234816 w 828090"/>
                    <a:gd name="connsiteY1" fmla="*/ 40869 h 418791"/>
                    <a:gd name="connsiteX2" fmla="*/ 594788 w 828090"/>
                    <a:gd name="connsiteY2" fmla="*/ 32029 h 418791"/>
                    <a:gd name="connsiteX3" fmla="*/ 828090 w 828090"/>
                    <a:gd name="connsiteY3" fmla="*/ 300456 h 418791"/>
                    <a:gd name="connsiteX4" fmla="*/ 717521 w 828090"/>
                    <a:gd name="connsiteY4" fmla="*/ 418791 h 418791"/>
                    <a:gd name="connsiteX5" fmla="*/ 447524 w 828090"/>
                    <a:gd name="connsiteY5" fmla="*/ 192004 h 418791"/>
                    <a:gd name="connsiteX6" fmla="*/ 153014 w 828090"/>
                    <a:gd name="connsiteY6" fmla="*/ 371321 h 418791"/>
                    <a:gd name="connsiteX7" fmla="*/ 329 w 828090"/>
                    <a:gd name="connsiteY7" fmla="*/ 354833 h 418791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476599 w 857165"/>
                    <a:gd name="connsiteY5" fmla="*/ 191739 h 418526"/>
                    <a:gd name="connsiteX6" fmla="*/ 182089 w 857165"/>
                    <a:gd name="connsiteY6" fmla="*/ 371056 h 418526"/>
                    <a:gd name="connsiteX7" fmla="*/ 283 w 857165"/>
                    <a:gd name="connsiteY7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476599 w 857165"/>
                    <a:gd name="connsiteY5" fmla="*/ 191739 h 418526"/>
                    <a:gd name="connsiteX6" fmla="*/ 182089 w 857165"/>
                    <a:gd name="connsiteY6" fmla="*/ 371056 h 418526"/>
                    <a:gd name="connsiteX7" fmla="*/ 283 w 857165"/>
                    <a:gd name="connsiteY7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476599 w 857165"/>
                    <a:gd name="connsiteY5" fmla="*/ 191739 h 418526"/>
                    <a:gd name="connsiteX6" fmla="*/ 182089 w 857165"/>
                    <a:gd name="connsiteY6" fmla="*/ 371056 h 418526"/>
                    <a:gd name="connsiteX7" fmla="*/ 283 w 857165"/>
                    <a:gd name="connsiteY7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476599 w 857165"/>
                    <a:gd name="connsiteY5" fmla="*/ 191739 h 418526"/>
                    <a:gd name="connsiteX6" fmla="*/ 182089 w 857165"/>
                    <a:gd name="connsiteY6" fmla="*/ 371056 h 418526"/>
                    <a:gd name="connsiteX7" fmla="*/ 283 w 857165"/>
                    <a:gd name="connsiteY7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596226 w 857165"/>
                    <a:gd name="connsiteY5" fmla="*/ 269798 h 418526"/>
                    <a:gd name="connsiteX6" fmla="*/ 476599 w 857165"/>
                    <a:gd name="connsiteY6" fmla="*/ 191739 h 418526"/>
                    <a:gd name="connsiteX7" fmla="*/ 182089 w 857165"/>
                    <a:gd name="connsiteY7" fmla="*/ 371056 h 418526"/>
                    <a:gd name="connsiteX8" fmla="*/ 283 w 857165"/>
                    <a:gd name="connsiteY8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631337 w 857165"/>
                    <a:gd name="connsiteY5" fmla="*/ 261689 h 418526"/>
                    <a:gd name="connsiteX6" fmla="*/ 476599 w 857165"/>
                    <a:gd name="connsiteY6" fmla="*/ 191739 h 418526"/>
                    <a:gd name="connsiteX7" fmla="*/ 182089 w 857165"/>
                    <a:gd name="connsiteY7" fmla="*/ 371056 h 418526"/>
                    <a:gd name="connsiteX8" fmla="*/ 283 w 857165"/>
                    <a:gd name="connsiteY8" fmla="*/ 350149 h 418526"/>
                    <a:gd name="connsiteX0" fmla="*/ 283 w 857165"/>
                    <a:gd name="connsiteY0" fmla="*/ 350149 h 418526"/>
                    <a:gd name="connsiteX1" fmla="*/ 263891 w 857165"/>
                    <a:gd name="connsiteY1" fmla="*/ 40604 h 418526"/>
                    <a:gd name="connsiteX2" fmla="*/ 623863 w 857165"/>
                    <a:gd name="connsiteY2" fmla="*/ 31764 h 418526"/>
                    <a:gd name="connsiteX3" fmla="*/ 857165 w 857165"/>
                    <a:gd name="connsiteY3" fmla="*/ 300191 h 418526"/>
                    <a:gd name="connsiteX4" fmla="*/ 746596 w 857165"/>
                    <a:gd name="connsiteY4" fmla="*/ 418526 h 418526"/>
                    <a:gd name="connsiteX5" fmla="*/ 623229 w 857165"/>
                    <a:gd name="connsiteY5" fmla="*/ 226578 h 418526"/>
                    <a:gd name="connsiteX6" fmla="*/ 476599 w 857165"/>
                    <a:gd name="connsiteY6" fmla="*/ 191739 h 418526"/>
                    <a:gd name="connsiteX7" fmla="*/ 182089 w 857165"/>
                    <a:gd name="connsiteY7" fmla="*/ 371056 h 418526"/>
                    <a:gd name="connsiteX8" fmla="*/ 283 w 857165"/>
                    <a:gd name="connsiteY8" fmla="*/ 350149 h 418526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623229 w 857165"/>
                    <a:gd name="connsiteY5" fmla="*/ 226578 h 418077"/>
                    <a:gd name="connsiteX6" fmla="*/ 476599 w 857165"/>
                    <a:gd name="connsiteY6" fmla="*/ 191739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623229 w 857165"/>
                    <a:gd name="connsiteY5" fmla="*/ 226578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623229 w 857165"/>
                    <a:gd name="connsiteY5" fmla="*/ 226578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91288 w 857165"/>
                    <a:gd name="connsiteY5" fmla="*/ 217643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91288 w 857165"/>
                    <a:gd name="connsiteY5" fmla="*/ 217643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91288 w 857165"/>
                    <a:gd name="connsiteY5" fmla="*/ 217643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55471 w 857165"/>
                    <a:gd name="connsiteY6" fmla="*/ 200816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13122 w 857165"/>
                    <a:gd name="connsiteY6" fmla="*/ 233528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13122 w 857165"/>
                    <a:gd name="connsiteY6" fmla="*/ 233528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23181 w 857165"/>
                    <a:gd name="connsiteY6" fmla="*/ 213440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23181 w 857165"/>
                    <a:gd name="connsiteY6" fmla="*/ 213440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18077"/>
                    <a:gd name="connsiteX1" fmla="*/ 263891 w 857165"/>
                    <a:gd name="connsiteY1" fmla="*/ 40604 h 418077"/>
                    <a:gd name="connsiteX2" fmla="*/ 623863 w 857165"/>
                    <a:gd name="connsiteY2" fmla="*/ 31764 h 418077"/>
                    <a:gd name="connsiteX3" fmla="*/ 857165 w 857165"/>
                    <a:gd name="connsiteY3" fmla="*/ 300191 h 418077"/>
                    <a:gd name="connsiteX4" fmla="*/ 751337 w 857165"/>
                    <a:gd name="connsiteY4" fmla="*/ 418077 h 418077"/>
                    <a:gd name="connsiteX5" fmla="*/ 588791 w 857165"/>
                    <a:gd name="connsiteY5" fmla="*/ 241798 h 418077"/>
                    <a:gd name="connsiteX6" fmla="*/ 323181 w 857165"/>
                    <a:gd name="connsiteY6" fmla="*/ 213440 h 418077"/>
                    <a:gd name="connsiteX7" fmla="*/ 182089 w 857165"/>
                    <a:gd name="connsiteY7" fmla="*/ 371056 h 418077"/>
                    <a:gd name="connsiteX8" fmla="*/ 283 w 857165"/>
                    <a:gd name="connsiteY8" fmla="*/ 350149 h 418077"/>
                    <a:gd name="connsiteX0" fmla="*/ 283 w 857165"/>
                    <a:gd name="connsiteY0" fmla="*/ 350149 h 471599"/>
                    <a:gd name="connsiteX1" fmla="*/ 263891 w 857165"/>
                    <a:gd name="connsiteY1" fmla="*/ 40604 h 471599"/>
                    <a:gd name="connsiteX2" fmla="*/ 623863 w 857165"/>
                    <a:gd name="connsiteY2" fmla="*/ 31764 h 471599"/>
                    <a:gd name="connsiteX3" fmla="*/ 857165 w 857165"/>
                    <a:gd name="connsiteY3" fmla="*/ 300191 h 471599"/>
                    <a:gd name="connsiteX4" fmla="*/ 768237 w 857165"/>
                    <a:gd name="connsiteY4" fmla="*/ 471599 h 471599"/>
                    <a:gd name="connsiteX5" fmla="*/ 588791 w 857165"/>
                    <a:gd name="connsiteY5" fmla="*/ 241798 h 471599"/>
                    <a:gd name="connsiteX6" fmla="*/ 323181 w 857165"/>
                    <a:gd name="connsiteY6" fmla="*/ 213440 h 471599"/>
                    <a:gd name="connsiteX7" fmla="*/ 182089 w 857165"/>
                    <a:gd name="connsiteY7" fmla="*/ 371056 h 471599"/>
                    <a:gd name="connsiteX8" fmla="*/ 283 w 857165"/>
                    <a:gd name="connsiteY8" fmla="*/ 350149 h 471599"/>
                    <a:gd name="connsiteX0" fmla="*/ 283 w 922080"/>
                    <a:gd name="connsiteY0" fmla="*/ 359002 h 486990"/>
                    <a:gd name="connsiteX1" fmla="*/ 263891 w 922080"/>
                    <a:gd name="connsiteY1" fmla="*/ 49457 h 486990"/>
                    <a:gd name="connsiteX2" fmla="*/ 623863 w 922080"/>
                    <a:gd name="connsiteY2" fmla="*/ 40617 h 486990"/>
                    <a:gd name="connsiteX3" fmla="*/ 922080 w 922080"/>
                    <a:gd name="connsiteY3" fmla="*/ 440612 h 486990"/>
                    <a:gd name="connsiteX4" fmla="*/ 768237 w 922080"/>
                    <a:gd name="connsiteY4" fmla="*/ 480452 h 486990"/>
                    <a:gd name="connsiteX5" fmla="*/ 588791 w 922080"/>
                    <a:gd name="connsiteY5" fmla="*/ 250651 h 486990"/>
                    <a:gd name="connsiteX6" fmla="*/ 323181 w 922080"/>
                    <a:gd name="connsiteY6" fmla="*/ 222293 h 486990"/>
                    <a:gd name="connsiteX7" fmla="*/ 182089 w 922080"/>
                    <a:gd name="connsiteY7" fmla="*/ 379909 h 486990"/>
                    <a:gd name="connsiteX8" fmla="*/ 283 w 922080"/>
                    <a:gd name="connsiteY8" fmla="*/ 359002 h 486990"/>
                    <a:gd name="connsiteX0" fmla="*/ 283 w 925272"/>
                    <a:gd name="connsiteY0" fmla="*/ 357772 h 480085"/>
                    <a:gd name="connsiteX1" fmla="*/ 263891 w 925272"/>
                    <a:gd name="connsiteY1" fmla="*/ 48227 h 480085"/>
                    <a:gd name="connsiteX2" fmla="*/ 623863 w 925272"/>
                    <a:gd name="connsiteY2" fmla="*/ 39387 h 480085"/>
                    <a:gd name="connsiteX3" fmla="*/ 925272 w 925272"/>
                    <a:gd name="connsiteY3" fmla="*/ 421509 h 480085"/>
                    <a:gd name="connsiteX4" fmla="*/ 768237 w 925272"/>
                    <a:gd name="connsiteY4" fmla="*/ 479222 h 480085"/>
                    <a:gd name="connsiteX5" fmla="*/ 588791 w 925272"/>
                    <a:gd name="connsiteY5" fmla="*/ 249421 h 480085"/>
                    <a:gd name="connsiteX6" fmla="*/ 323181 w 925272"/>
                    <a:gd name="connsiteY6" fmla="*/ 221063 h 480085"/>
                    <a:gd name="connsiteX7" fmla="*/ 182089 w 925272"/>
                    <a:gd name="connsiteY7" fmla="*/ 378679 h 480085"/>
                    <a:gd name="connsiteX8" fmla="*/ 283 w 925272"/>
                    <a:gd name="connsiteY8" fmla="*/ 357772 h 480085"/>
                    <a:gd name="connsiteX0" fmla="*/ 283 w 925272"/>
                    <a:gd name="connsiteY0" fmla="*/ 357772 h 479899"/>
                    <a:gd name="connsiteX1" fmla="*/ 263891 w 925272"/>
                    <a:gd name="connsiteY1" fmla="*/ 48227 h 479899"/>
                    <a:gd name="connsiteX2" fmla="*/ 623863 w 925272"/>
                    <a:gd name="connsiteY2" fmla="*/ 39387 h 479899"/>
                    <a:gd name="connsiteX3" fmla="*/ 925272 w 925272"/>
                    <a:gd name="connsiteY3" fmla="*/ 421509 h 479899"/>
                    <a:gd name="connsiteX4" fmla="*/ 768237 w 925272"/>
                    <a:gd name="connsiteY4" fmla="*/ 479222 h 479899"/>
                    <a:gd name="connsiteX5" fmla="*/ 588791 w 925272"/>
                    <a:gd name="connsiteY5" fmla="*/ 249421 h 479899"/>
                    <a:gd name="connsiteX6" fmla="*/ 323181 w 925272"/>
                    <a:gd name="connsiteY6" fmla="*/ 221063 h 479899"/>
                    <a:gd name="connsiteX7" fmla="*/ 182089 w 925272"/>
                    <a:gd name="connsiteY7" fmla="*/ 378679 h 479899"/>
                    <a:gd name="connsiteX8" fmla="*/ 283 w 925272"/>
                    <a:gd name="connsiteY8" fmla="*/ 357772 h 479899"/>
                    <a:gd name="connsiteX0" fmla="*/ 283 w 925272"/>
                    <a:gd name="connsiteY0" fmla="*/ 357772 h 479899"/>
                    <a:gd name="connsiteX1" fmla="*/ 263891 w 925272"/>
                    <a:gd name="connsiteY1" fmla="*/ 48227 h 479899"/>
                    <a:gd name="connsiteX2" fmla="*/ 623863 w 925272"/>
                    <a:gd name="connsiteY2" fmla="*/ 39387 h 479899"/>
                    <a:gd name="connsiteX3" fmla="*/ 925272 w 925272"/>
                    <a:gd name="connsiteY3" fmla="*/ 421509 h 479899"/>
                    <a:gd name="connsiteX4" fmla="*/ 768237 w 925272"/>
                    <a:gd name="connsiteY4" fmla="*/ 479222 h 479899"/>
                    <a:gd name="connsiteX5" fmla="*/ 588791 w 925272"/>
                    <a:gd name="connsiteY5" fmla="*/ 249421 h 479899"/>
                    <a:gd name="connsiteX6" fmla="*/ 323181 w 925272"/>
                    <a:gd name="connsiteY6" fmla="*/ 221063 h 479899"/>
                    <a:gd name="connsiteX7" fmla="*/ 182089 w 925272"/>
                    <a:gd name="connsiteY7" fmla="*/ 378679 h 479899"/>
                    <a:gd name="connsiteX8" fmla="*/ 283 w 925272"/>
                    <a:gd name="connsiteY8" fmla="*/ 357772 h 479899"/>
                    <a:gd name="connsiteX0" fmla="*/ 283 w 925272"/>
                    <a:gd name="connsiteY0" fmla="*/ 357772 h 479899"/>
                    <a:gd name="connsiteX1" fmla="*/ 263891 w 925272"/>
                    <a:gd name="connsiteY1" fmla="*/ 48227 h 479899"/>
                    <a:gd name="connsiteX2" fmla="*/ 623863 w 925272"/>
                    <a:gd name="connsiteY2" fmla="*/ 39387 h 479899"/>
                    <a:gd name="connsiteX3" fmla="*/ 925272 w 925272"/>
                    <a:gd name="connsiteY3" fmla="*/ 421509 h 479899"/>
                    <a:gd name="connsiteX4" fmla="*/ 768237 w 925272"/>
                    <a:gd name="connsiteY4" fmla="*/ 479222 h 479899"/>
                    <a:gd name="connsiteX5" fmla="*/ 614360 w 925272"/>
                    <a:gd name="connsiteY5" fmla="*/ 239373 h 479899"/>
                    <a:gd name="connsiteX6" fmla="*/ 323181 w 925272"/>
                    <a:gd name="connsiteY6" fmla="*/ 221063 h 479899"/>
                    <a:gd name="connsiteX7" fmla="*/ 182089 w 925272"/>
                    <a:gd name="connsiteY7" fmla="*/ 378679 h 479899"/>
                    <a:gd name="connsiteX8" fmla="*/ 283 w 925272"/>
                    <a:gd name="connsiteY8" fmla="*/ 357772 h 479899"/>
                    <a:gd name="connsiteX0" fmla="*/ 283 w 925272"/>
                    <a:gd name="connsiteY0" fmla="*/ 357772 h 478527"/>
                    <a:gd name="connsiteX1" fmla="*/ 263891 w 925272"/>
                    <a:gd name="connsiteY1" fmla="*/ 48227 h 478527"/>
                    <a:gd name="connsiteX2" fmla="*/ 623863 w 925272"/>
                    <a:gd name="connsiteY2" fmla="*/ 39387 h 478527"/>
                    <a:gd name="connsiteX3" fmla="*/ 925272 w 925272"/>
                    <a:gd name="connsiteY3" fmla="*/ 421509 h 478527"/>
                    <a:gd name="connsiteX4" fmla="*/ 784939 w 925272"/>
                    <a:gd name="connsiteY4" fmla="*/ 477575 h 478527"/>
                    <a:gd name="connsiteX5" fmla="*/ 614360 w 925272"/>
                    <a:gd name="connsiteY5" fmla="*/ 239373 h 478527"/>
                    <a:gd name="connsiteX6" fmla="*/ 323181 w 925272"/>
                    <a:gd name="connsiteY6" fmla="*/ 221063 h 478527"/>
                    <a:gd name="connsiteX7" fmla="*/ 182089 w 925272"/>
                    <a:gd name="connsiteY7" fmla="*/ 378679 h 478527"/>
                    <a:gd name="connsiteX8" fmla="*/ 283 w 925272"/>
                    <a:gd name="connsiteY8" fmla="*/ 357772 h 478527"/>
                    <a:gd name="connsiteX0" fmla="*/ 283 w 925272"/>
                    <a:gd name="connsiteY0" fmla="*/ 357772 h 478527"/>
                    <a:gd name="connsiteX1" fmla="*/ 263891 w 925272"/>
                    <a:gd name="connsiteY1" fmla="*/ 48227 h 478527"/>
                    <a:gd name="connsiteX2" fmla="*/ 623863 w 925272"/>
                    <a:gd name="connsiteY2" fmla="*/ 39387 h 478527"/>
                    <a:gd name="connsiteX3" fmla="*/ 925272 w 925272"/>
                    <a:gd name="connsiteY3" fmla="*/ 421509 h 478527"/>
                    <a:gd name="connsiteX4" fmla="*/ 784939 w 925272"/>
                    <a:gd name="connsiteY4" fmla="*/ 477575 h 478527"/>
                    <a:gd name="connsiteX5" fmla="*/ 614360 w 925272"/>
                    <a:gd name="connsiteY5" fmla="*/ 239373 h 478527"/>
                    <a:gd name="connsiteX6" fmla="*/ 323181 w 925272"/>
                    <a:gd name="connsiteY6" fmla="*/ 221063 h 478527"/>
                    <a:gd name="connsiteX7" fmla="*/ 182089 w 925272"/>
                    <a:gd name="connsiteY7" fmla="*/ 378679 h 478527"/>
                    <a:gd name="connsiteX8" fmla="*/ 283 w 925272"/>
                    <a:gd name="connsiteY8" fmla="*/ 357772 h 478527"/>
                    <a:gd name="connsiteX0" fmla="*/ 283 w 925272"/>
                    <a:gd name="connsiteY0" fmla="*/ 357772 h 557834"/>
                    <a:gd name="connsiteX1" fmla="*/ 263891 w 925272"/>
                    <a:gd name="connsiteY1" fmla="*/ 48227 h 557834"/>
                    <a:gd name="connsiteX2" fmla="*/ 623863 w 925272"/>
                    <a:gd name="connsiteY2" fmla="*/ 39387 h 557834"/>
                    <a:gd name="connsiteX3" fmla="*/ 925272 w 925272"/>
                    <a:gd name="connsiteY3" fmla="*/ 421509 h 557834"/>
                    <a:gd name="connsiteX4" fmla="*/ 784939 w 925272"/>
                    <a:gd name="connsiteY4" fmla="*/ 477575 h 557834"/>
                    <a:gd name="connsiteX5" fmla="*/ 614360 w 925272"/>
                    <a:gd name="connsiteY5" fmla="*/ 239373 h 557834"/>
                    <a:gd name="connsiteX6" fmla="*/ 323181 w 925272"/>
                    <a:gd name="connsiteY6" fmla="*/ 221063 h 557834"/>
                    <a:gd name="connsiteX7" fmla="*/ 137577 w 925272"/>
                    <a:gd name="connsiteY7" fmla="*/ 551149 h 557834"/>
                    <a:gd name="connsiteX8" fmla="*/ 283 w 925272"/>
                    <a:gd name="connsiteY8" fmla="*/ 357772 h 557834"/>
                    <a:gd name="connsiteX0" fmla="*/ 283 w 925272"/>
                    <a:gd name="connsiteY0" fmla="*/ 357772 h 505215"/>
                    <a:gd name="connsiteX1" fmla="*/ 263891 w 925272"/>
                    <a:gd name="connsiteY1" fmla="*/ 48227 h 505215"/>
                    <a:gd name="connsiteX2" fmla="*/ 623863 w 925272"/>
                    <a:gd name="connsiteY2" fmla="*/ 39387 h 505215"/>
                    <a:gd name="connsiteX3" fmla="*/ 925272 w 925272"/>
                    <a:gd name="connsiteY3" fmla="*/ 421509 h 505215"/>
                    <a:gd name="connsiteX4" fmla="*/ 784939 w 925272"/>
                    <a:gd name="connsiteY4" fmla="*/ 477575 h 505215"/>
                    <a:gd name="connsiteX5" fmla="*/ 614360 w 925272"/>
                    <a:gd name="connsiteY5" fmla="*/ 239373 h 505215"/>
                    <a:gd name="connsiteX6" fmla="*/ 323181 w 925272"/>
                    <a:gd name="connsiteY6" fmla="*/ 221063 h 505215"/>
                    <a:gd name="connsiteX7" fmla="*/ 132607 w 925272"/>
                    <a:gd name="connsiteY7" fmla="*/ 496450 h 505215"/>
                    <a:gd name="connsiteX8" fmla="*/ 283 w 925272"/>
                    <a:gd name="connsiteY8" fmla="*/ 357772 h 505215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344909 w 947000"/>
                    <a:gd name="connsiteY6" fmla="*/ 227109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296839 w 947000"/>
                    <a:gd name="connsiteY6" fmla="*/ 254428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296839 w 947000"/>
                    <a:gd name="connsiteY6" fmla="*/ 254428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296839 w 947000"/>
                    <a:gd name="connsiteY6" fmla="*/ 254428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36088 w 947000"/>
                    <a:gd name="connsiteY5" fmla="*/ 245419 h 523249"/>
                    <a:gd name="connsiteX6" fmla="*/ 279943 w 947000"/>
                    <a:gd name="connsiteY6" fmla="*/ 193567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257 w 947000"/>
                    <a:gd name="connsiteY0" fmla="*/ 468818 h 523249"/>
                    <a:gd name="connsiteX1" fmla="*/ 285619 w 947000"/>
                    <a:gd name="connsiteY1" fmla="*/ 54273 h 523249"/>
                    <a:gd name="connsiteX2" fmla="*/ 645591 w 947000"/>
                    <a:gd name="connsiteY2" fmla="*/ 45433 h 523249"/>
                    <a:gd name="connsiteX3" fmla="*/ 947000 w 947000"/>
                    <a:gd name="connsiteY3" fmla="*/ 427555 h 523249"/>
                    <a:gd name="connsiteX4" fmla="*/ 806667 w 947000"/>
                    <a:gd name="connsiteY4" fmla="*/ 483621 h 523249"/>
                    <a:gd name="connsiteX5" fmla="*/ 608824 w 947000"/>
                    <a:gd name="connsiteY5" fmla="*/ 152885 h 523249"/>
                    <a:gd name="connsiteX6" fmla="*/ 279943 w 947000"/>
                    <a:gd name="connsiteY6" fmla="*/ 193567 h 523249"/>
                    <a:gd name="connsiteX7" fmla="*/ 154335 w 947000"/>
                    <a:gd name="connsiteY7" fmla="*/ 502496 h 523249"/>
                    <a:gd name="connsiteX8" fmla="*/ 257 w 947000"/>
                    <a:gd name="connsiteY8" fmla="*/ 468818 h 523249"/>
                    <a:gd name="connsiteX0" fmla="*/ 313 w 947056"/>
                    <a:gd name="connsiteY0" fmla="*/ 503452 h 557883"/>
                    <a:gd name="connsiteX1" fmla="*/ 250832 w 947056"/>
                    <a:gd name="connsiteY1" fmla="*/ 35826 h 557883"/>
                    <a:gd name="connsiteX2" fmla="*/ 645647 w 947056"/>
                    <a:gd name="connsiteY2" fmla="*/ 80067 h 557883"/>
                    <a:gd name="connsiteX3" fmla="*/ 947056 w 947056"/>
                    <a:gd name="connsiteY3" fmla="*/ 462189 h 557883"/>
                    <a:gd name="connsiteX4" fmla="*/ 806723 w 947056"/>
                    <a:gd name="connsiteY4" fmla="*/ 518255 h 557883"/>
                    <a:gd name="connsiteX5" fmla="*/ 608880 w 947056"/>
                    <a:gd name="connsiteY5" fmla="*/ 187519 h 557883"/>
                    <a:gd name="connsiteX6" fmla="*/ 279999 w 947056"/>
                    <a:gd name="connsiteY6" fmla="*/ 228201 h 557883"/>
                    <a:gd name="connsiteX7" fmla="*/ 154391 w 947056"/>
                    <a:gd name="connsiteY7" fmla="*/ 537130 h 557883"/>
                    <a:gd name="connsiteX8" fmla="*/ 313 w 947056"/>
                    <a:gd name="connsiteY8" fmla="*/ 503452 h 557883"/>
                    <a:gd name="connsiteX0" fmla="*/ 329 w 947072"/>
                    <a:gd name="connsiteY0" fmla="*/ 540777 h 595208"/>
                    <a:gd name="connsiteX1" fmla="*/ 250848 w 947072"/>
                    <a:gd name="connsiteY1" fmla="*/ 73151 h 595208"/>
                    <a:gd name="connsiteX2" fmla="*/ 691733 w 947072"/>
                    <a:gd name="connsiteY2" fmla="*/ 44653 h 595208"/>
                    <a:gd name="connsiteX3" fmla="*/ 947072 w 947072"/>
                    <a:gd name="connsiteY3" fmla="*/ 499514 h 595208"/>
                    <a:gd name="connsiteX4" fmla="*/ 806739 w 947072"/>
                    <a:gd name="connsiteY4" fmla="*/ 555580 h 595208"/>
                    <a:gd name="connsiteX5" fmla="*/ 608896 w 947072"/>
                    <a:gd name="connsiteY5" fmla="*/ 224844 h 595208"/>
                    <a:gd name="connsiteX6" fmla="*/ 280015 w 947072"/>
                    <a:gd name="connsiteY6" fmla="*/ 265526 h 595208"/>
                    <a:gd name="connsiteX7" fmla="*/ 154407 w 947072"/>
                    <a:gd name="connsiteY7" fmla="*/ 574455 h 595208"/>
                    <a:gd name="connsiteX8" fmla="*/ 329 w 947072"/>
                    <a:gd name="connsiteY8" fmla="*/ 540777 h 595208"/>
                    <a:gd name="connsiteX0" fmla="*/ 329 w 947072"/>
                    <a:gd name="connsiteY0" fmla="*/ 540777 h 595208"/>
                    <a:gd name="connsiteX1" fmla="*/ 250848 w 947072"/>
                    <a:gd name="connsiteY1" fmla="*/ 73151 h 595208"/>
                    <a:gd name="connsiteX2" fmla="*/ 691733 w 947072"/>
                    <a:gd name="connsiteY2" fmla="*/ 44653 h 595208"/>
                    <a:gd name="connsiteX3" fmla="*/ 947072 w 947072"/>
                    <a:gd name="connsiteY3" fmla="*/ 499514 h 595208"/>
                    <a:gd name="connsiteX4" fmla="*/ 806739 w 947072"/>
                    <a:gd name="connsiteY4" fmla="*/ 555580 h 595208"/>
                    <a:gd name="connsiteX5" fmla="*/ 608896 w 947072"/>
                    <a:gd name="connsiteY5" fmla="*/ 224844 h 595208"/>
                    <a:gd name="connsiteX6" fmla="*/ 311460 w 947072"/>
                    <a:gd name="connsiteY6" fmla="*/ 186083 h 595208"/>
                    <a:gd name="connsiteX7" fmla="*/ 154407 w 947072"/>
                    <a:gd name="connsiteY7" fmla="*/ 574455 h 595208"/>
                    <a:gd name="connsiteX8" fmla="*/ 329 w 947072"/>
                    <a:gd name="connsiteY8" fmla="*/ 540777 h 595208"/>
                    <a:gd name="connsiteX0" fmla="*/ 329 w 947072"/>
                    <a:gd name="connsiteY0" fmla="*/ 540777 h 595208"/>
                    <a:gd name="connsiteX1" fmla="*/ 250848 w 947072"/>
                    <a:gd name="connsiteY1" fmla="*/ 73151 h 595208"/>
                    <a:gd name="connsiteX2" fmla="*/ 691733 w 947072"/>
                    <a:gd name="connsiteY2" fmla="*/ 44653 h 595208"/>
                    <a:gd name="connsiteX3" fmla="*/ 947072 w 947072"/>
                    <a:gd name="connsiteY3" fmla="*/ 499514 h 595208"/>
                    <a:gd name="connsiteX4" fmla="*/ 806739 w 947072"/>
                    <a:gd name="connsiteY4" fmla="*/ 555580 h 595208"/>
                    <a:gd name="connsiteX5" fmla="*/ 576648 w 947072"/>
                    <a:gd name="connsiteY5" fmla="*/ 154037 h 595208"/>
                    <a:gd name="connsiteX6" fmla="*/ 311460 w 947072"/>
                    <a:gd name="connsiteY6" fmla="*/ 186083 h 595208"/>
                    <a:gd name="connsiteX7" fmla="*/ 154407 w 947072"/>
                    <a:gd name="connsiteY7" fmla="*/ 574455 h 595208"/>
                    <a:gd name="connsiteX8" fmla="*/ 329 w 947072"/>
                    <a:gd name="connsiteY8" fmla="*/ 540777 h 595208"/>
                    <a:gd name="connsiteX0" fmla="*/ 350 w 947093"/>
                    <a:gd name="connsiteY0" fmla="*/ 563834 h 618265"/>
                    <a:gd name="connsiteX1" fmla="*/ 241437 w 947093"/>
                    <a:gd name="connsiteY1" fmla="*/ 54049 h 618265"/>
                    <a:gd name="connsiteX2" fmla="*/ 691754 w 947093"/>
                    <a:gd name="connsiteY2" fmla="*/ 67710 h 618265"/>
                    <a:gd name="connsiteX3" fmla="*/ 947093 w 947093"/>
                    <a:gd name="connsiteY3" fmla="*/ 522571 h 618265"/>
                    <a:gd name="connsiteX4" fmla="*/ 806760 w 947093"/>
                    <a:gd name="connsiteY4" fmla="*/ 578637 h 618265"/>
                    <a:gd name="connsiteX5" fmla="*/ 576669 w 947093"/>
                    <a:gd name="connsiteY5" fmla="*/ 177094 h 618265"/>
                    <a:gd name="connsiteX6" fmla="*/ 311481 w 947093"/>
                    <a:gd name="connsiteY6" fmla="*/ 209140 h 618265"/>
                    <a:gd name="connsiteX7" fmla="*/ 154428 w 947093"/>
                    <a:gd name="connsiteY7" fmla="*/ 597512 h 618265"/>
                    <a:gd name="connsiteX8" fmla="*/ 350 w 947093"/>
                    <a:gd name="connsiteY8" fmla="*/ 563834 h 618265"/>
                    <a:gd name="connsiteX0" fmla="*/ 359 w 947102"/>
                    <a:gd name="connsiteY0" fmla="*/ 592621 h 647052"/>
                    <a:gd name="connsiteX1" fmla="*/ 241446 w 947102"/>
                    <a:gd name="connsiteY1" fmla="*/ 82836 h 647052"/>
                    <a:gd name="connsiteX2" fmla="*/ 710339 w 947102"/>
                    <a:gd name="connsiteY2" fmla="*/ 47536 h 647052"/>
                    <a:gd name="connsiteX3" fmla="*/ 947102 w 947102"/>
                    <a:gd name="connsiteY3" fmla="*/ 551358 h 647052"/>
                    <a:gd name="connsiteX4" fmla="*/ 806769 w 947102"/>
                    <a:gd name="connsiteY4" fmla="*/ 607424 h 647052"/>
                    <a:gd name="connsiteX5" fmla="*/ 576678 w 947102"/>
                    <a:gd name="connsiteY5" fmla="*/ 205881 h 647052"/>
                    <a:gd name="connsiteX6" fmla="*/ 311490 w 947102"/>
                    <a:gd name="connsiteY6" fmla="*/ 237927 h 647052"/>
                    <a:gd name="connsiteX7" fmla="*/ 154437 w 947102"/>
                    <a:gd name="connsiteY7" fmla="*/ 626299 h 647052"/>
                    <a:gd name="connsiteX8" fmla="*/ 359 w 947102"/>
                    <a:gd name="connsiteY8" fmla="*/ 592621 h 647052"/>
                    <a:gd name="connsiteX0" fmla="*/ 359 w 947102"/>
                    <a:gd name="connsiteY0" fmla="*/ 592622 h 647053"/>
                    <a:gd name="connsiteX1" fmla="*/ 241446 w 947102"/>
                    <a:gd name="connsiteY1" fmla="*/ 82837 h 647053"/>
                    <a:gd name="connsiteX2" fmla="*/ 710339 w 947102"/>
                    <a:gd name="connsiteY2" fmla="*/ 47537 h 647053"/>
                    <a:gd name="connsiteX3" fmla="*/ 947102 w 947102"/>
                    <a:gd name="connsiteY3" fmla="*/ 551359 h 647053"/>
                    <a:gd name="connsiteX4" fmla="*/ 806769 w 947102"/>
                    <a:gd name="connsiteY4" fmla="*/ 607425 h 647053"/>
                    <a:gd name="connsiteX5" fmla="*/ 576678 w 947102"/>
                    <a:gd name="connsiteY5" fmla="*/ 205882 h 647053"/>
                    <a:gd name="connsiteX6" fmla="*/ 322279 w 947102"/>
                    <a:gd name="connsiteY6" fmla="*/ 242145 h 647053"/>
                    <a:gd name="connsiteX7" fmla="*/ 154437 w 947102"/>
                    <a:gd name="connsiteY7" fmla="*/ 626300 h 647053"/>
                    <a:gd name="connsiteX8" fmla="*/ 359 w 947102"/>
                    <a:gd name="connsiteY8" fmla="*/ 592622 h 647053"/>
                    <a:gd name="connsiteX0" fmla="*/ 359 w 947102"/>
                    <a:gd name="connsiteY0" fmla="*/ 592622 h 647053"/>
                    <a:gd name="connsiteX1" fmla="*/ 241446 w 947102"/>
                    <a:gd name="connsiteY1" fmla="*/ 82837 h 647053"/>
                    <a:gd name="connsiteX2" fmla="*/ 710339 w 947102"/>
                    <a:gd name="connsiteY2" fmla="*/ 47537 h 647053"/>
                    <a:gd name="connsiteX3" fmla="*/ 947102 w 947102"/>
                    <a:gd name="connsiteY3" fmla="*/ 551359 h 647053"/>
                    <a:gd name="connsiteX4" fmla="*/ 806769 w 947102"/>
                    <a:gd name="connsiteY4" fmla="*/ 607425 h 647053"/>
                    <a:gd name="connsiteX5" fmla="*/ 558525 w 947102"/>
                    <a:gd name="connsiteY5" fmla="*/ 227392 h 647053"/>
                    <a:gd name="connsiteX6" fmla="*/ 322279 w 947102"/>
                    <a:gd name="connsiteY6" fmla="*/ 242145 h 647053"/>
                    <a:gd name="connsiteX7" fmla="*/ 154437 w 947102"/>
                    <a:gd name="connsiteY7" fmla="*/ 626300 h 647053"/>
                    <a:gd name="connsiteX8" fmla="*/ 359 w 947102"/>
                    <a:gd name="connsiteY8" fmla="*/ 592622 h 647053"/>
                    <a:gd name="connsiteX0" fmla="*/ 359 w 947102"/>
                    <a:gd name="connsiteY0" fmla="*/ 592622 h 647053"/>
                    <a:gd name="connsiteX1" fmla="*/ 241446 w 947102"/>
                    <a:gd name="connsiteY1" fmla="*/ 82837 h 647053"/>
                    <a:gd name="connsiteX2" fmla="*/ 710339 w 947102"/>
                    <a:gd name="connsiteY2" fmla="*/ 47537 h 647053"/>
                    <a:gd name="connsiteX3" fmla="*/ 947102 w 947102"/>
                    <a:gd name="connsiteY3" fmla="*/ 551359 h 647053"/>
                    <a:gd name="connsiteX4" fmla="*/ 806769 w 947102"/>
                    <a:gd name="connsiteY4" fmla="*/ 607425 h 647053"/>
                    <a:gd name="connsiteX5" fmla="*/ 578131 w 947102"/>
                    <a:gd name="connsiteY5" fmla="*/ 212367 h 647053"/>
                    <a:gd name="connsiteX6" fmla="*/ 322279 w 947102"/>
                    <a:gd name="connsiteY6" fmla="*/ 242145 h 647053"/>
                    <a:gd name="connsiteX7" fmla="*/ 154437 w 947102"/>
                    <a:gd name="connsiteY7" fmla="*/ 626300 h 647053"/>
                    <a:gd name="connsiteX8" fmla="*/ 359 w 947102"/>
                    <a:gd name="connsiteY8" fmla="*/ 592622 h 647053"/>
                    <a:gd name="connsiteX0" fmla="*/ 359 w 947102"/>
                    <a:gd name="connsiteY0" fmla="*/ 592622 h 647053"/>
                    <a:gd name="connsiteX1" fmla="*/ 241446 w 947102"/>
                    <a:gd name="connsiteY1" fmla="*/ 82837 h 647053"/>
                    <a:gd name="connsiteX2" fmla="*/ 710339 w 947102"/>
                    <a:gd name="connsiteY2" fmla="*/ 47537 h 647053"/>
                    <a:gd name="connsiteX3" fmla="*/ 947102 w 947102"/>
                    <a:gd name="connsiteY3" fmla="*/ 551359 h 647053"/>
                    <a:gd name="connsiteX4" fmla="*/ 806769 w 947102"/>
                    <a:gd name="connsiteY4" fmla="*/ 607425 h 647053"/>
                    <a:gd name="connsiteX5" fmla="*/ 588192 w 947102"/>
                    <a:gd name="connsiteY5" fmla="*/ 213340 h 647053"/>
                    <a:gd name="connsiteX6" fmla="*/ 322279 w 947102"/>
                    <a:gd name="connsiteY6" fmla="*/ 242145 h 647053"/>
                    <a:gd name="connsiteX7" fmla="*/ 154437 w 947102"/>
                    <a:gd name="connsiteY7" fmla="*/ 626300 h 647053"/>
                    <a:gd name="connsiteX8" fmla="*/ 359 w 947102"/>
                    <a:gd name="connsiteY8" fmla="*/ 592622 h 647053"/>
                    <a:gd name="connsiteX0" fmla="*/ 351 w 947094"/>
                    <a:gd name="connsiteY0" fmla="*/ 658398 h 712829"/>
                    <a:gd name="connsiteX1" fmla="*/ 244933 w 947094"/>
                    <a:gd name="connsiteY1" fmla="*/ 43534 h 712829"/>
                    <a:gd name="connsiteX2" fmla="*/ 710331 w 947094"/>
                    <a:gd name="connsiteY2" fmla="*/ 113313 h 712829"/>
                    <a:gd name="connsiteX3" fmla="*/ 947094 w 947094"/>
                    <a:gd name="connsiteY3" fmla="*/ 617135 h 712829"/>
                    <a:gd name="connsiteX4" fmla="*/ 806761 w 947094"/>
                    <a:gd name="connsiteY4" fmla="*/ 673201 h 712829"/>
                    <a:gd name="connsiteX5" fmla="*/ 588184 w 947094"/>
                    <a:gd name="connsiteY5" fmla="*/ 279116 h 712829"/>
                    <a:gd name="connsiteX6" fmla="*/ 322271 w 947094"/>
                    <a:gd name="connsiteY6" fmla="*/ 307921 h 712829"/>
                    <a:gd name="connsiteX7" fmla="*/ 154429 w 947094"/>
                    <a:gd name="connsiteY7" fmla="*/ 692076 h 712829"/>
                    <a:gd name="connsiteX8" fmla="*/ 351 w 947094"/>
                    <a:gd name="connsiteY8" fmla="*/ 658398 h 712829"/>
                    <a:gd name="connsiteX0" fmla="*/ 350 w 947093"/>
                    <a:gd name="connsiteY0" fmla="*/ 697187 h 751618"/>
                    <a:gd name="connsiteX1" fmla="*/ 244932 w 947093"/>
                    <a:gd name="connsiteY1" fmla="*/ 82323 h 751618"/>
                    <a:gd name="connsiteX2" fmla="*/ 707346 w 947093"/>
                    <a:gd name="connsiteY2" fmla="*/ 68315 h 751618"/>
                    <a:gd name="connsiteX3" fmla="*/ 947093 w 947093"/>
                    <a:gd name="connsiteY3" fmla="*/ 655924 h 751618"/>
                    <a:gd name="connsiteX4" fmla="*/ 806760 w 947093"/>
                    <a:gd name="connsiteY4" fmla="*/ 711990 h 751618"/>
                    <a:gd name="connsiteX5" fmla="*/ 588183 w 947093"/>
                    <a:gd name="connsiteY5" fmla="*/ 317905 h 751618"/>
                    <a:gd name="connsiteX6" fmla="*/ 322270 w 947093"/>
                    <a:gd name="connsiteY6" fmla="*/ 346710 h 751618"/>
                    <a:gd name="connsiteX7" fmla="*/ 154428 w 947093"/>
                    <a:gd name="connsiteY7" fmla="*/ 730865 h 751618"/>
                    <a:gd name="connsiteX8" fmla="*/ 350 w 947093"/>
                    <a:gd name="connsiteY8" fmla="*/ 697187 h 751618"/>
                    <a:gd name="connsiteX0" fmla="*/ 350 w 947093"/>
                    <a:gd name="connsiteY0" fmla="*/ 697187 h 751618"/>
                    <a:gd name="connsiteX1" fmla="*/ 244932 w 947093"/>
                    <a:gd name="connsiteY1" fmla="*/ 82323 h 751618"/>
                    <a:gd name="connsiteX2" fmla="*/ 707346 w 947093"/>
                    <a:gd name="connsiteY2" fmla="*/ 68315 h 751618"/>
                    <a:gd name="connsiteX3" fmla="*/ 947093 w 947093"/>
                    <a:gd name="connsiteY3" fmla="*/ 655924 h 751618"/>
                    <a:gd name="connsiteX4" fmla="*/ 806760 w 947093"/>
                    <a:gd name="connsiteY4" fmla="*/ 711990 h 751618"/>
                    <a:gd name="connsiteX5" fmla="*/ 588183 w 947093"/>
                    <a:gd name="connsiteY5" fmla="*/ 317905 h 751618"/>
                    <a:gd name="connsiteX6" fmla="*/ 360818 w 947093"/>
                    <a:gd name="connsiteY6" fmla="*/ 259462 h 751618"/>
                    <a:gd name="connsiteX7" fmla="*/ 154428 w 947093"/>
                    <a:gd name="connsiteY7" fmla="*/ 730865 h 751618"/>
                    <a:gd name="connsiteX8" fmla="*/ 350 w 947093"/>
                    <a:gd name="connsiteY8" fmla="*/ 697187 h 751618"/>
                    <a:gd name="connsiteX0" fmla="*/ 350 w 947093"/>
                    <a:gd name="connsiteY0" fmla="*/ 697187 h 751618"/>
                    <a:gd name="connsiteX1" fmla="*/ 244932 w 947093"/>
                    <a:gd name="connsiteY1" fmla="*/ 82323 h 751618"/>
                    <a:gd name="connsiteX2" fmla="*/ 707346 w 947093"/>
                    <a:gd name="connsiteY2" fmla="*/ 68315 h 751618"/>
                    <a:gd name="connsiteX3" fmla="*/ 947093 w 947093"/>
                    <a:gd name="connsiteY3" fmla="*/ 655924 h 751618"/>
                    <a:gd name="connsiteX4" fmla="*/ 806760 w 947093"/>
                    <a:gd name="connsiteY4" fmla="*/ 711990 h 751618"/>
                    <a:gd name="connsiteX5" fmla="*/ 643341 w 947093"/>
                    <a:gd name="connsiteY5" fmla="*/ 254897 h 751618"/>
                    <a:gd name="connsiteX6" fmla="*/ 360818 w 947093"/>
                    <a:gd name="connsiteY6" fmla="*/ 259462 h 751618"/>
                    <a:gd name="connsiteX7" fmla="*/ 154428 w 947093"/>
                    <a:gd name="connsiteY7" fmla="*/ 730865 h 751618"/>
                    <a:gd name="connsiteX8" fmla="*/ 350 w 947093"/>
                    <a:gd name="connsiteY8" fmla="*/ 697187 h 751618"/>
                    <a:gd name="connsiteX0" fmla="*/ 350 w 947093"/>
                    <a:gd name="connsiteY0" fmla="*/ 697187 h 751618"/>
                    <a:gd name="connsiteX1" fmla="*/ 244932 w 947093"/>
                    <a:gd name="connsiteY1" fmla="*/ 82323 h 751618"/>
                    <a:gd name="connsiteX2" fmla="*/ 707346 w 947093"/>
                    <a:gd name="connsiteY2" fmla="*/ 68315 h 751618"/>
                    <a:gd name="connsiteX3" fmla="*/ 947093 w 947093"/>
                    <a:gd name="connsiteY3" fmla="*/ 655924 h 751618"/>
                    <a:gd name="connsiteX4" fmla="*/ 806760 w 947093"/>
                    <a:gd name="connsiteY4" fmla="*/ 711990 h 751618"/>
                    <a:gd name="connsiteX5" fmla="*/ 643341 w 947093"/>
                    <a:gd name="connsiteY5" fmla="*/ 254897 h 751618"/>
                    <a:gd name="connsiteX6" fmla="*/ 346368 w 947093"/>
                    <a:gd name="connsiteY6" fmla="*/ 228128 h 751618"/>
                    <a:gd name="connsiteX7" fmla="*/ 154428 w 947093"/>
                    <a:gd name="connsiteY7" fmla="*/ 730865 h 751618"/>
                    <a:gd name="connsiteX8" fmla="*/ 350 w 947093"/>
                    <a:gd name="connsiteY8" fmla="*/ 697187 h 751618"/>
                    <a:gd name="connsiteX0" fmla="*/ 350 w 947093"/>
                    <a:gd name="connsiteY0" fmla="*/ 697187 h 751618"/>
                    <a:gd name="connsiteX1" fmla="*/ 244932 w 947093"/>
                    <a:gd name="connsiteY1" fmla="*/ 82323 h 751618"/>
                    <a:gd name="connsiteX2" fmla="*/ 707346 w 947093"/>
                    <a:gd name="connsiteY2" fmla="*/ 68315 h 751618"/>
                    <a:gd name="connsiteX3" fmla="*/ 947093 w 947093"/>
                    <a:gd name="connsiteY3" fmla="*/ 655924 h 751618"/>
                    <a:gd name="connsiteX4" fmla="*/ 821380 w 947093"/>
                    <a:gd name="connsiteY4" fmla="*/ 723070 h 751618"/>
                    <a:gd name="connsiteX5" fmla="*/ 643341 w 947093"/>
                    <a:gd name="connsiteY5" fmla="*/ 254897 h 751618"/>
                    <a:gd name="connsiteX6" fmla="*/ 346368 w 947093"/>
                    <a:gd name="connsiteY6" fmla="*/ 228128 h 751618"/>
                    <a:gd name="connsiteX7" fmla="*/ 154428 w 947093"/>
                    <a:gd name="connsiteY7" fmla="*/ 730865 h 751618"/>
                    <a:gd name="connsiteX8" fmla="*/ 350 w 947093"/>
                    <a:gd name="connsiteY8" fmla="*/ 697187 h 751618"/>
                    <a:gd name="connsiteX0" fmla="*/ 350 w 947093"/>
                    <a:gd name="connsiteY0" fmla="*/ 697187 h 751618"/>
                    <a:gd name="connsiteX1" fmla="*/ 244932 w 947093"/>
                    <a:gd name="connsiteY1" fmla="*/ 82323 h 751618"/>
                    <a:gd name="connsiteX2" fmla="*/ 707346 w 947093"/>
                    <a:gd name="connsiteY2" fmla="*/ 68315 h 751618"/>
                    <a:gd name="connsiteX3" fmla="*/ 947093 w 947093"/>
                    <a:gd name="connsiteY3" fmla="*/ 655924 h 751618"/>
                    <a:gd name="connsiteX4" fmla="*/ 821380 w 947093"/>
                    <a:gd name="connsiteY4" fmla="*/ 723070 h 751618"/>
                    <a:gd name="connsiteX5" fmla="*/ 643341 w 947093"/>
                    <a:gd name="connsiteY5" fmla="*/ 254897 h 751618"/>
                    <a:gd name="connsiteX6" fmla="*/ 346368 w 947093"/>
                    <a:gd name="connsiteY6" fmla="*/ 228128 h 751618"/>
                    <a:gd name="connsiteX7" fmla="*/ 154428 w 947093"/>
                    <a:gd name="connsiteY7" fmla="*/ 730865 h 751618"/>
                    <a:gd name="connsiteX8" fmla="*/ 350 w 947093"/>
                    <a:gd name="connsiteY8" fmla="*/ 697187 h 751618"/>
                    <a:gd name="connsiteX0" fmla="*/ 350 w 947093"/>
                    <a:gd name="connsiteY0" fmla="*/ 697187 h 751618"/>
                    <a:gd name="connsiteX1" fmla="*/ 244932 w 947093"/>
                    <a:gd name="connsiteY1" fmla="*/ 82323 h 751618"/>
                    <a:gd name="connsiteX2" fmla="*/ 707346 w 947093"/>
                    <a:gd name="connsiteY2" fmla="*/ 68315 h 751618"/>
                    <a:gd name="connsiteX3" fmla="*/ 947093 w 947093"/>
                    <a:gd name="connsiteY3" fmla="*/ 655924 h 751618"/>
                    <a:gd name="connsiteX4" fmla="*/ 821380 w 947093"/>
                    <a:gd name="connsiteY4" fmla="*/ 723070 h 751618"/>
                    <a:gd name="connsiteX5" fmla="*/ 643341 w 947093"/>
                    <a:gd name="connsiteY5" fmla="*/ 254897 h 751618"/>
                    <a:gd name="connsiteX6" fmla="*/ 346368 w 947093"/>
                    <a:gd name="connsiteY6" fmla="*/ 228128 h 751618"/>
                    <a:gd name="connsiteX7" fmla="*/ 154428 w 947093"/>
                    <a:gd name="connsiteY7" fmla="*/ 730865 h 751618"/>
                    <a:gd name="connsiteX8" fmla="*/ 350 w 947093"/>
                    <a:gd name="connsiteY8" fmla="*/ 697187 h 751618"/>
                    <a:gd name="connsiteX0" fmla="*/ 350 w 947093"/>
                    <a:gd name="connsiteY0" fmla="*/ 697187 h 751618"/>
                    <a:gd name="connsiteX1" fmla="*/ 244932 w 947093"/>
                    <a:gd name="connsiteY1" fmla="*/ 82323 h 751618"/>
                    <a:gd name="connsiteX2" fmla="*/ 707346 w 947093"/>
                    <a:gd name="connsiteY2" fmla="*/ 68315 h 751618"/>
                    <a:gd name="connsiteX3" fmla="*/ 947093 w 947093"/>
                    <a:gd name="connsiteY3" fmla="*/ 655924 h 751618"/>
                    <a:gd name="connsiteX4" fmla="*/ 821380 w 947093"/>
                    <a:gd name="connsiteY4" fmla="*/ 723070 h 751618"/>
                    <a:gd name="connsiteX5" fmla="*/ 643341 w 947093"/>
                    <a:gd name="connsiteY5" fmla="*/ 254897 h 751618"/>
                    <a:gd name="connsiteX6" fmla="*/ 281080 w 947093"/>
                    <a:gd name="connsiteY6" fmla="*/ 245606 h 751618"/>
                    <a:gd name="connsiteX7" fmla="*/ 154428 w 947093"/>
                    <a:gd name="connsiteY7" fmla="*/ 730865 h 751618"/>
                    <a:gd name="connsiteX8" fmla="*/ 350 w 947093"/>
                    <a:gd name="connsiteY8" fmla="*/ 697187 h 751618"/>
                    <a:gd name="connsiteX0" fmla="*/ 350 w 947093"/>
                    <a:gd name="connsiteY0" fmla="*/ 697187 h 751618"/>
                    <a:gd name="connsiteX1" fmla="*/ 244932 w 947093"/>
                    <a:gd name="connsiteY1" fmla="*/ 82323 h 751618"/>
                    <a:gd name="connsiteX2" fmla="*/ 707346 w 947093"/>
                    <a:gd name="connsiteY2" fmla="*/ 68315 h 751618"/>
                    <a:gd name="connsiteX3" fmla="*/ 947093 w 947093"/>
                    <a:gd name="connsiteY3" fmla="*/ 655924 h 751618"/>
                    <a:gd name="connsiteX4" fmla="*/ 821380 w 947093"/>
                    <a:gd name="connsiteY4" fmla="*/ 723070 h 751618"/>
                    <a:gd name="connsiteX5" fmla="*/ 643341 w 947093"/>
                    <a:gd name="connsiteY5" fmla="*/ 254897 h 751618"/>
                    <a:gd name="connsiteX6" fmla="*/ 414939 w 947093"/>
                    <a:gd name="connsiteY6" fmla="*/ 207000 h 751618"/>
                    <a:gd name="connsiteX7" fmla="*/ 281080 w 947093"/>
                    <a:gd name="connsiteY7" fmla="*/ 245606 h 751618"/>
                    <a:gd name="connsiteX8" fmla="*/ 154428 w 947093"/>
                    <a:gd name="connsiteY8" fmla="*/ 730865 h 751618"/>
                    <a:gd name="connsiteX9" fmla="*/ 350 w 947093"/>
                    <a:gd name="connsiteY9" fmla="*/ 697187 h 751618"/>
                    <a:gd name="connsiteX0" fmla="*/ 350 w 947093"/>
                    <a:gd name="connsiteY0" fmla="*/ 697187 h 751618"/>
                    <a:gd name="connsiteX1" fmla="*/ 244932 w 947093"/>
                    <a:gd name="connsiteY1" fmla="*/ 82323 h 751618"/>
                    <a:gd name="connsiteX2" fmla="*/ 707346 w 947093"/>
                    <a:gd name="connsiteY2" fmla="*/ 68315 h 751618"/>
                    <a:gd name="connsiteX3" fmla="*/ 947093 w 947093"/>
                    <a:gd name="connsiteY3" fmla="*/ 655924 h 751618"/>
                    <a:gd name="connsiteX4" fmla="*/ 821380 w 947093"/>
                    <a:gd name="connsiteY4" fmla="*/ 723070 h 751618"/>
                    <a:gd name="connsiteX5" fmla="*/ 643341 w 947093"/>
                    <a:gd name="connsiteY5" fmla="*/ 254897 h 751618"/>
                    <a:gd name="connsiteX6" fmla="*/ 436876 w 947093"/>
                    <a:gd name="connsiteY6" fmla="*/ 95516 h 751618"/>
                    <a:gd name="connsiteX7" fmla="*/ 281080 w 947093"/>
                    <a:gd name="connsiteY7" fmla="*/ 245606 h 751618"/>
                    <a:gd name="connsiteX8" fmla="*/ 154428 w 947093"/>
                    <a:gd name="connsiteY8" fmla="*/ 730865 h 751618"/>
                    <a:gd name="connsiteX9" fmla="*/ 350 w 947093"/>
                    <a:gd name="connsiteY9" fmla="*/ 697187 h 751618"/>
                    <a:gd name="connsiteX0" fmla="*/ 350 w 947093"/>
                    <a:gd name="connsiteY0" fmla="*/ 702809 h 757240"/>
                    <a:gd name="connsiteX1" fmla="*/ 244932 w 947093"/>
                    <a:gd name="connsiteY1" fmla="*/ 87945 h 757240"/>
                    <a:gd name="connsiteX2" fmla="*/ 416616 w 947093"/>
                    <a:gd name="connsiteY2" fmla="*/ 10077 h 757240"/>
                    <a:gd name="connsiteX3" fmla="*/ 707346 w 947093"/>
                    <a:gd name="connsiteY3" fmla="*/ 73937 h 757240"/>
                    <a:gd name="connsiteX4" fmla="*/ 947093 w 947093"/>
                    <a:gd name="connsiteY4" fmla="*/ 661546 h 757240"/>
                    <a:gd name="connsiteX5" fmla="*/ 821380 w 947093"/>
                    <a:gd name="connsiteY5" fmla="*/ 728692 h 757240"/>
                    <a:gd name="connsiteX6" fmla="*/ 643341 w 947093"/>
                    <a:gd name="connsiteY6" fmla="*/ 260519 h 757240"/>
                    <a:gd name="connsiteX7" fmla="*/ 436876 w 947093"/>
                    <a:gd name="connsiteY7" fmla="*/ 101138 h 757240"/>
                    <a:gd name="connsiteX8" fmla="*/ 281080 w 947093"/>
                    <a:gd name="connsiteY8" fmla="*/ 251228 h 757240"/>
                    <a:gd name="connsiteX9" fmla="*/ 154428 w 947093"/>
                    <a:gd name="connsiteY9" fmla="*/ 736487 h 757240"/>
                    <a:gd name="connsiteX10" fmla="*/ 350 w 947093"/>
                    <a:gd name="connsiteY10" fmla="*/ 702809 h 757240"/>
                    <a:gd name="connsiteX0" fmla="*/ 263 w 947006"/>
                    <a:gd name="connsiteY0" fmla="*/ 859139 h 913570"/>
                    <a:gd name="connsiteX1" fmla="*/ 244845 w 947006"/>
                    <a:gd name="connsiteY1" fmla="*/ 244275 h 913570"/>
                    <a:gd name="connsiteX2" fmla="*/ 423685 w 947006"/>
                    <a:gd name="connsiteY2" fmla="*/ 42 h 913570"/>
                    <a:gd name="connsiteX3" fmla="*/ 707259 w 947006"/>
                    <a:gd name="connsiteY3" fmla="*/ 230267 h 913570"/>
                    <a:gd name="connsiteX4" fmla="*/ 947006 w 947006"/>
                    <a:gd name="connsiteY4" fmla="*/ 817876 h 913570"/>
                    <a:gd name="connsiteX5" fmla="*/ 821293 w 947006"/>
                    <a:gd name="connsiteY5" fmla="*/ 885022 h 913570"/>
                    <a:gd name="connsiteX6" fmla="*/ 643254 w 947006"/>
                    <a:gd name="connsiteY6" fmla="*/ 416849 h 913570"/>
                    <a:gd name="connsiteX7" fmla="*/ 436789 w 947006"/>
                    <a:gd name="connsiteY7" fmla="*/ 257468 h 913570"/>
                    <a:gd name="connsiteX8" fmla="*/ 280993 w 947006"/>
                    <a:gd name="connsiteY8" fmla="*/ 407558 h 913570"/>
                    <a:gd name="connsiteX9" fmla="*/ 154341 w 947006"/>
                    <a:gd name="connsiteY9" fmla="*/ 892817 h 913570"/>
                    <a:gd name="connsiteX10" fmla="*/ 263 w 947006"/>
                    <a:gd name="connsiteY10" fmla="*/ 859139 h 913570"/>
                    <a:gd name="connsiteX0" fmla="*/ 263 w 947006"/>
                    <a:gd name="connsiteY0" fmla="*/ 859139 h 913570"/>
                    <a:gd name="connsiteX1" fmla="*/ 244845 w 947006"/>
                    <a:gd name="connsiteY1" fmla="*/ 244275 h 913570"/>
                    <a:gd name="connsiteX2" fmla="*/ 423685 w 947006"/>
                    <a:gd name="connsiteY2" fmla="*/ 42 h 913570"/>
                    <a:gd name="connsiteX3" fmla="*/ 707259 w 947006"/>
                    <a:gd name="connsiteY3" fmla="*/ 230267 h 913570"/>
                    <a:gd name="connsiteX4" fmla="*/ 947006 w 947006"/>
                    <a:gd name="connsiteY4" fmla="*/ 817876 h 913570"/>
                    <a:gd name="connsiteX5" fmla="*/ 821293 w 947006"/>
                    <a:gd name="connsiteY5" fmla="*/ 885022 h 913570"/>
                    <a:gd name="connsiteX6" fmla="*/ 643254 w 947006"/>
                    <a:gd name="connsiteY6" fmla="*/ 416849 h 913570"/>
                    <a:gd name="connsiteX7" fmla="*/ 438457 w 947006"/>
                    <a:gd name="connsiteY7" fmla="*/ 183029 h 913570"/>
                    <a:gd name="connsiteX8" fmla="*/ 280993 w 947006"/>
                    <a:gd name="connsiteY8" fmla="*/ 407558 h 913570"/>
                    <a:gd name="connsiteX9" fmla="*/ 154341 w 947006"/>
                    <a:gd name="connsiteY9" fmla="*/ 892817 h 913570"/>
                    <a:gd name="connsiteX10" fmla="*/ 263 w 947006"/>
                    <a:gd name="connsiteY10" fmla="*/ 859139 h 913570"/>
                    <a:gd name="connsiteX0" fmla="*/ 535 w 947278"/>
                    <a:gd name="connsiteY0" fmla="*/ 859139 h 913570"/>
                    <a:gd name="connsiteX1" fmla="*/ 148601 w 947278"/>
                    <a:gd name="connsiteY1" fmla="*/ 226437 h 913570"/>
                    <a:gd name="connsiteX2" fmla="*/ 423957 w 947278"/>
                    <a:gd name="connsiteY2" fmla="*/ 42 h 913570"/>
                    <a:gd name="connsiteX3" fmla="*/ 707531 w 947278"/>
                    <a:gd name="connsiteY3" fmla="*/ 230267 h 913570"/>
                    <a:gd name="connsiteX4" fmla="*/ 947278 w 947278"/>
                    <a:gd name="connsiteY4" fmla="*/ 817876 h 913570"/>
                    <a:gd name="connsiteX5" fmla="*/ 821565 w 947278"/>
                    <a:gd name="connsiteY5" fmla="*/ 885022 h 913570"/>
                    <a:gd name="connsiteX6" fmla="*/ 643526 w 947278"/>
                    <a:gd name="connsiteY6" fmla="*/ 416849 h 913570"/>
                    <a:gd name="connsiteX7" fmla="*/ 438729 w 947278"/>
                    <a:gd name="connsiteY7" fmla="*/ 183029 h 913570"/>
                    <a:gd name="connsiteX8" fmla="*/ 281265 w 947278"/>
                    <a:gd name="connsiteY8" fmla="*/ 407558 h 913570"/>
                    <a:gd name="connsiteX9" fmla="*/ 154613 w 947278"/>
                    <a:gd name="connsiteY9" fmla="*/ 892817 h 913570"/>
                    <a:gd name="connsiteX10" fmla="*/ 535 w 947278"/>
                    <a:gd name="connsiteY10" fmla="*/ 859139 h 913570"/>
                    <a:gd name="connsiteX0" fmla="*/ 536 w 947279"/>
                    <a:gd name="connsiteY0" fmla="*/ 859142 h 913573"/>
                    <a:gd name="connsiteX1" fmla="*/ 148602 w 947279"/>
                    <a:gd name="connsiteY1" fmla="*/ 226440 h 913573"/>
                    <a:gd name="connsiteX2" fmla="*/ 423958 w 947279"/>
                    <a:gd name="connsiteY2" fmla="*/ 45 h 913573"/>
                    <a:gd name="connsiteX3" fmla="*/ 722319 w 947279"/>
                    <a:gd name="connsiteY3" fmla="*/ 221097 h 913573"/>
                    <a:gd name="connsiteX4" fmla="*/ 947279 w 947279"/>
                    <a:gd name="connsiteY4" fmla="*/ 817879 h 913573"/>
                    <a:gd name="connsiteX5" fmla="*/ 821566 w 947279"/>
                    <a:gd name="connsiteY5" fmla="*/ 885025 h 913573"/>
                    <a:gd name="connsiteX6" fmla="*/ 643527 w 947279"/>
                    <a:gd name="connsiteY6" fmla="*/ 416852 h 913573"/>
                    <a:gd name="connsiteX7" fmla="*/ 438730 w 947279"/>
                    <a:gd name="connsiteY7" fmla="*/ 183032 h 913573"/>
                    <a:gd name="connsiteX8" fmla="*/ 281266 w 947279"/>
                    <a:gd name="connsiteY8" fmla="*/ 407561 h 913573"/>
                    <a:gd name="connsiteX9" fmla="*/ 154614 w 947279"/>
                    <a:gd name="connsiteY9" fmla="*/ 892820 h 913573"/>
                    <a:gd name="connsiteX10" fmla="*/ 536 w 947279"/>
                    <a:gd name="connsiteY10" fmla="*/ 859142 h 913573"/>
                    <a:gd name="connsiteX0" fmla="*/ 536 w 947279"/>
                    <a:gd name="connsiteY0" fmla="*/ 859142 h 913573"/>
                    <a:gd name="connsiteX1" fmla="*/ 148602 w 947279"/>
                    <a:gd name="connsiteY1" fmla="*/ 226440 h 913573"/>
                    <a:gd name="connsiteX2" fmla="*/ 423958 w 947279"/>
                    <a:gd name="connsiteY2" fmla="*/ 45 h 913573"/>
                    <a:gd name="connsiteX3" fmla="*/ 722319 w 947279"/>
                    <a:gd name="connsiteY3" fmla="*/ 221097 h 913573"/>
                    <a:gd name="connsiteX4" fmla="*/ 947279 w 947279"/>
                    <a:gd name="connsiteY4" fmla="*/ 817879 h 913573"/>
                    <a:gd name="connsiteX5" fmla="*/ 821566 w 947279"/>
                    <a:gd name="connsiteY5" fmla="*/ 885025 h 913573"/>
                    <a:gd name="connsiteX6" fmla="*/ 606489 w 947279"/>
                    <a:gd name="connsiteY6" fmla="*/ 321808 h 913573"/>
                    <a:gd name="connsiteX7" fmla="*/ 438730 w 947279"/>
                    <a:gd name="connsiteY7" fmla="*/ 183032 h 913573"/>
                    <a:gd name="connsiteX8" fmla="*/ 281266 w 947279"/>
                    <a:gd name="connsiteY8" fmla="*/ 407561 h 913573"/>
                    <a:gd name="connsiteX9" fmla="*/ 154614 w 947279"/>
                    <a:gd name="connsiteY9" fmla="*/ 892820 h 913573"/>
                    <a:gd name="connsiteX10" fmla="*/ 536 w 947279"/>
                    <a:gd name="connsiteY10" fmla="*/ 859142 h 913573"/>
                    <a:gd name="connsiteX0" fmla="*/ 536 w 947279"/>
                    <a:gd name="connsiteY0" fmla="*/ 859142 h 913573"/>
                    <a:gd name="connsiteX1" fmla="*/ 148602 w 947279"/>
                    <a:gd name="connsiteY1" fmla="*/ 226440 h 913573"/>
                    <a:gd name="connsiteX2" fmla="*/ 423958 w 947279"/>
                    <a:gd name="connsiteY2" fmla="*/ 45 h 913573"/>
                    <a:gd name="connsiteX3" fmla="*/ 722319 w 947279"/>
                    <a:gd name="connsiteY3" fmla="*/ 221097 h 913573"/>
                    <a:gd name="connsiteX4" fmla="*/ 947279 w 947279"/>
                    <a:gd name="connsiteY4" fmla="*/ 817879 h 913573"/>
                    <a:gd name="connsiteX5" fmla="*/ 821566 w 947279"/>
                    <a:gd name="connsiteY5" fmla="*/ 885025 h 913573"/>
                    <a:gd name="connsiteX6" fmla="*/ 606489 w 947279"/>
                    <a:gd name="connsiteY6" fmla="*/ 321808 h 913573"/>
                    <a:gd name="connsiteX7" fmla="*/ 438730 w 947279"/>
                    <a:gd name="connsiteY7" fmla="*/ 183032 h 913573"/>
                    <a:gd name="connsiteX8" fmla="*/ 281266 w 947279"/>
                    <a:gd name="connsiteY8" fmla="*/ 407561 h 913573"/>
                    <a:gd name="connsiteX9" fmla="*/ 154614 w 947279"/>
                    <a:gd name="connsiteY9" fmla="*/ 892820 h 913573"/>
                    <a:gd name="connsiteX10" fmla="*/ 536 w 947279"/>
                    <a:gd name="connsiteY10" fmla="*/ 859142 h 913573"/>
                    <a:gd name="connsiteX0" fmla="*/ 536 w 947279"/>
                    <a:gd name="connsiteY0" fmla="*/ 859142 h 913573"/>
                    <a:gd name="connsiteX1" fmla="*/ 148602 w 947279"/>
                    <a:gd name="connsiteY1" fmla="*/ 226440 h 913573"/>
                    <a:gd name="connsiteX2" fmla="*/ 423958 w 947279"/>
                    <a:gd name="connsiteY2" fmla="*/ 45 h 913573"/>
                    <a:gd name="connsiteX3" fmla="*/ 722319 w 947279"/>
                    <a:gd name="connsiteY3" fmla="*/ 221097 h 913573"/>
                    <a:gd name="connsiteX4" fmla="*/ 947279 w 947279"/>
                    <a:gd name="connsiteY4" fmla="*/ 817879 h 913573"/>
                    <a:gd name="connsiteX5" fmla="*/ 821566 w 947279"/>
                    <a:gd name="connsiteY5" fmla="*/ 885025 h 913573"/>
                    <a:gd name="connsiteX6" fmla="*/ 606489 w 947279"/>
                    <a:gd name="connsiteY6" fmla="*/ 321808 h 913573"/>
                    <a:gd name="connsiteX7" fmla="*/ 438730 w 947279"/>
                    <a:gd name="connsiteY7" fmla="*/ 183032 h 913573"/>
                    <a:gd name="connsiteX8" fmla="*/ 247547 w 947279"/>
                    <a:gd name="connsiteY8" fmla="*/ 355799 h 913573"/>
                    <a:gd name="connsiteX9" fmla="*/ 154614 w 947279"/>
                    <a:gd name="connsiteY9" fmla="*/ 892820 h 913573"/>
                    <a:gd name="connsiteX10" fmla="*/ 536 w 947279"/>
                    <a:gd name="connsiteY10" fmla="*/ 859142 h 913573"/>
                    <a:gd name="connsiteX0" fmla="*/ 536 w 947279"/>
                    <a:gd name="connsiteY0" fmla="*/ 859142 h 913573"/>
                    <a:gd name="connsiteX1" fmla="*/ 148602 w 947279"/>
                    <a:gd name="connsiteY1" fmla="*/ 226440 h 913573"/>
                    <a:gd name="connsiteX2" fmla="*/ 423958 w 947279"/>
                    <a:gd name="connsiteY2" fmla="*/ 45 h 913573"/>
                    <a:gd name="connsiteX3" fmla="*/ 722319 w 947279"/>
                    <a:gd name="connsiteY3" fmla="*/ 221097 h 913573"/>
                    <a:gd name="connsiteX4" fmla="*/ 947279 w 947279"/>
                    <a:gd name="connsiteY4" fmla="*/ 817879 h 913573"/>
                    <a:gd name="connsiteX5" fmla="*/ 821566 w 947279"/>
                    <a:gd name="connsiteY5" fmla="*/ 885025 h 913573"/>
                    <a:gd name="connsiteX6" fmla="*/ 606489 w 947279"/>
                    <a:gd name="connsiteY6" fmla="*/ 321808 h 913573"/>
                    <a:gd name="connsiteX7" fmla="*/ 438730 w 947279"/>
                    <a:gd name="connsiteY7" fmla="*/ 183032 h 913573"/>
                    <a:gd name="connsiteX8" fmla="*/ 247547 w 947279"/>
                    <a:gd name="connsiteY8" fmla="*/ 355799 h 913573"/>
                    <a:gd name="connsiteX9" fmla="*/ 154614 w 947279"/>
                    <a:gd name="connsiteY9" fmla="*/ 892820 h 913573"/>
                    <a:gd name="connsiteX10" fmla="*/ 536 w 947279"/>
                    <a:gd name="connsiteY10" fmla="*/ 859142 h 913573"/>
                    <a:gd name="connsiteX0" fmla="*/ 536 w 947279"/>
                    <a:gd name="connsiteY0" fmla="*/ 859142 h 913573"/>
                    <a:gd name="connsiteX1" fmla="*/ 148602 w 947279"/>
                    <a:gd name="connsiteY1" fmla="*/ 226440 h 913573"/>
                    <a:gd name="connsiteX2" fmla="*/ 423958 w 947279"/>
                    <a:gd name="connsiteY2" fmla="*/ 45 h 913573"/>
                    <a:gd name="connsiteX3" fmla="*/ 722319 w 947279"/>
                    <a:gd name="connsiteY3" fmla="*/ 221097 h 913573"/>
                    <a:gd name="connsiteX4" fmla="*/ 947279 w 947279"/>
                    <a:gd name="connsiteY4" fmla="*/ 817879 h 913573"/>
                    <a:gd name="connsiteX5" fmla="*/ 821566 w 947279"/>
                    <a:gd name="connsiteY5" fmla="*/ 885025 h 913573"/>
                    <a:gd name="connsiteX6" fmla="*/ 606489 w 947279"/>
                    <a:gd name="connsiteY6" fmla="*/ 321808 h 913573"/>
                    <a:gd name="connsiteX7" fmla="*/ 413147 w 947279"/>
                    <a:gd name="connsiteY7" fmla="*/ 163641 h 913573"/>
                    <a:gd name="connsiteX8" fmla="*/ 247547 w 947279"/>
                    <a:gd name="connsiteY8" fmla="*/ 355799 h 913573"/>
                    <a:gd name="connsiteX9" fmla="*/ 154614 w 947279"/>
                    <a:gd name="connsiteY9" fmla="*/ 892820 h 913573"/>
                    <a:gd name="connsiteX10" fmla="*/ 536 w 947279"/>
                    <a:gd name="connsiteY10" fmla="*/ 859142 h 913573"/>
                    <a:gd name="connsiteX0" fmla="*/ 516 w 947259"/>
                    <a:gd name="connsiteY0" fmla="*/ 902582 h 957013"/>
                    <a:gd name="connsiteX1" fmla="*/ 148582 w 947259"/>
                    <a:gd name="connsiteY1" fmla="*/ 269880 h 957013"/>
                    <a:gd name="connsiteX2" fmla="*/ 401183 w 947259"/>
                    <a:gd name="connsiteY2" fmla="*/ 32 h 957013"/>
                    <a:gd name="connsiteX3" fmla="*/ 722299 w 947259"/>
                    <a:gd name="connsiteY3" fmla="*/ 264537 h 957013"/>
                    <a:gd name="connsiteX4" fmla="*/ 947259 w 947259"/>
                    <a:gd name="connsiteY4" fmla="*/ 861319 h 957013"/>
                    <a:gd name="connsiteX5" fmla="*/ 821546 w 947259"/>
                    <a:gd name="connsiteY5" fmla="*/ 928465 h 957013"/>
                    <a:gd name="connsiteX6" fmla="*/ 606469 w 947259"/>
                    <a:gd name="connsiteY6" fmla="*/ 365248 h 957013"/>
                    <a:gd name="connsiteX7" fmla="*/ 413127 w 947259"/>
                    <a:gd name="connsiteY7" fmla="*/ 207081 h 957013"/>
                    <a:gd name="connsiteX8" fmla="*/ 247527 w 947259"/>
                    <a:gd name="connsiteY8" fmla="*/ 399239 h 957013"/>
                    <a:gd name="connsiteX9" fmla="*/ 154594 w 947259"/>
                    <a:gd name="connsiteY9" fmla="*/ 936260 h 957013"/>
                    <a:gd name="connsiteX10" fmla="*/ 516 w 947259"/>
                    <a:gd name="connsiteY10" fmla="*/ 902582 h 95701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</a:cxnLst>
                  <a:rect l="l" t="t" r="r" b="b"/>
                  <a:pathLst>
                    <a:path w="947259" h="957013">
                      <a:moveTo>
                        <a:pt x="516" y="902582"/>
                      </a:moveTo>
                      <a:cubicBezTo>
                        <a:pt x="-7601" y="771779"/>
                        <a:pt x="81804" y="420305"/>
                        <a:pt x="148582" y="269880"/>
                      </a:cubicBezTo>
                      <a:cubicBezTo>
                        <a:pt x="215360" y="119455"/>
                        <a:pt x="324114" y="2367"/>
                        <a:pt x="401183" y="32"/>
                      </a:cubicBezTo>
                      <a:cubicBezTo>
                        <a:pt x="478252" y="-2303"/>
                        <a:pt x="631286" y="120989"/>
                        <a:pt x="722299" y="264537"/>
                      </a:cubicBezTo>
                      <a:cubicBezTo>
                        <a:pt x="813312" y="408085"/>
                        <a:pt x="934652" y="724707"/>
                        <a:pt x="947259" y="861319"/>
                      </a:cubicBezTo>
                      <a:cubicBezTo>
                        <a:pt x="943745" y="930261"/>
                        <a:pt x="884994" y="920846"/>
                        <a:pt x="821546" y="928465"/>
                      </a:cubicBezTo>
                      <a:cubicBezTo>
                        <a:pt x="787216" y="874251"/>
                        <a:pt x="668190" y="465672"/>
                        <a:pt x="606469" y="365248"/>
                      </a:cubicBezTo>
                      <a:cubicBezTo>
                        <a:pt x="538729" y="279236"/>
                        <a:pt x="473504" y="208629"/>
                        <a:pt x="413127" y="207081"/>
                      </a:cubicBezTo>
                      <a:cubicBezTo>
                        <a:pt x="352750" y="205533"/>
                        <a:pt x="290946" y="311928"/>
                        <a:pt x="247527" y="399239"/>
                      </a:cubicBezTo>
                      <a:cubicBezTo>
                        <a:pt x="184445" y="544753"/>
                        <a:pt x="190289" y="841212"/>
                        <a:pt x="154594" y="936260"/>
                      </a:cubicBezTo>
                      <a:cubicBezTo>
                        <a:pt x="75000" y="981319"/>
                        <a:pt x="64485" y="945109"/>
                        <a:pt x="516" y="902582"/>
                      </a:cubicBezTo>
                      <a:close/>
                    </a:path>
                  </a:pathLst>
                </a:custGeom>
                <a:solidFill>
                  <a:schemeClr val="tx1">
                    <a:lumMod val="50000"/>
                    <a:lumOff val="50000"/>
                  </a:schemeClr>
                </a:solidFill>
                <a:ln>
                  <a:solidFill>
                    <a:schemeClr val="tx2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350" b="1">
                    <a:solidFill>
                      <a:schemeClr val="bg2">
                        <a:lumMod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8" name="Block Arc 15"/>
              <p:cNvSpPr/>
              <p:nvPr/>
            </p:nvSpPr>
            <p:spPr>
              <a:xfrm rot="15661917" flipH="1">
                <a:off x="1270853" y="1717592"/>
                <a:ext cx="705901" cy="684364"/>
              </a:xfrm>
              <a:custGeom>
                <a:avLst/>
                <a:gdLst>
                  <a:gd name="connsiteX0" fmla="*/ 627 w 745516"/>
                  <a:gd name="connsiteY0" fmla="*/ 369014 h 697590"/>
                  <a:gd name="connsiteX1" fmla="*/ 184209 w 745516"/>
                  <a:gd name="connsiteY1" fmla="*/ 47911 h 697590"/>
                  <a:gd name="connsiteX2" fmla="*/ 544181 w 745516"/>
                  <a:gd name="connsiteY2" fmla="*/ 39071 h 697590"/>
                  <a:gd name="connsiteX3" fmla="*/ 745515 w 745516"/>
                  <a:gd name="connsiteY3" fmla="*/ 348795 h 697590"/>
                  <a:gd name="connsiteX4" fmla="*/ 571119 w 745516"/>
                  <a:gd name="connsiteY4" fmla="*/ 348795 h 697590"/>
                  <a:gd name="connsiteX5" fmla="*/ 459552 w 745516"/>
                  <a:gd name="connsiteY5" fmla="*/ 191978 h 697590"/>
                  <a:gd name="connsiteX6" fmla="*/ 277038 w 745516"/>
                  <a:gd name="connsiteY6" fmla="*/ 196046 h 697590"/>
                  <a:gd name="connsiteX7" fmla="*/ 174775 w 745516"/>
                  <a:gd name="connsiteY7" fmla="*/ 359552 h 697590"/>
                  <a:gd name="connsiteX8" fmla="*/ 627 w 745516"/>
                  <a:gd name="connsiteY8" fmla="*/ 369014 h 697590"/>
                  <a:gd name="connsiteX0" fmla="*/ 629 w 745517"/>
                  <a:gd name="connsiteY0" fmla="*/ 369014 h 369014"/>
                  <a:gd name="connsiteX1" fmla="*/ 184211 w 745517"/>
                  <a:gd name="connsiteY1" fmla="*/ 47911 h 369014"/>
                  <a:gd name="connsiteX2" fmla="*/ 544183 w 745517"/>
                  <a:gd name="connsiteY2" fmla="*/ 39071 h 369014"/>
                  <a:gd name="connsiteX3" fmla="*/ 745517 w 745517"/>
                  <a:gd name="connsiteY3" fmla="*/ 348795 h 369014"/>
                  <a:gd name="connsiteX4" fmla="*/ 668191 w 745517"/>
                  <a:gd name="connsiteY4" fmla="*/ 363523 h 369014"/>
                  <a:gd name="connsiteX5" fmla="*/ 459554 w 745517"/>
                  <a:gd name="connsiteY5" fmla="*/ 191978 h 369014"/>
                  <a:gd name="connsiteX6" fmla="*/ 277040 w 745517"/>
                  <a:gd name="connsiteY6" fmla="*/ 196046 h 369014"/>
                  <a:gd name="connsiteX7" fmla="*/ 174777 w 745517"/>
                  <a:gd name="connsiteY7" fmla="*/ 359552 h 369014"/>
                  <a:gd name="connsiteX8" fmla="*/ 629 w 745517"/>
                  <a:gd name="connsiteY8" fmla="*/ 369014 h 369014"/>
                  <a:gd name="connsiteX0" fmla="*/ 629 w 745517"/>
                  <a:gd name="connsiteY0" fmla="*/ 369014 h 425833"/>
                  <a:gd name="connsiteX1" fmla="*/ 184211 w 745517"/>
                  <a:gd name="connsiteY1" fmla="*/ 47911 h 425833"/>
                  <a:gd name="connsiteX2" fmla="*/ 544183 w 745517"/>
                  <a:gd name="connsiteY2" fmla="*/ 39071 h 425833"/>
                  <a:gd name="connsiteX3" fmla="*/ 745517 w 745517"/>
                  <a:gd name="connsiteY3" fmla="*/ 348795 h 425833"/>
                  <a:gd name="connsiteX4" fmla="*/ 666916 w 745517"/>
                  <a:gd name="connsiteY4" fmla="*/ 425833 h 425833"/>
                  <a:gd name="connsiteX5" fmla="*/ 459554 w 745517"/>
                  <a:gd name="connsiteY5" fmla="*/ 191978 h 425833"/>
                  <a:gd name="connsiteX6" fmla="*/ 277040 w 745517"/>
                  <a:gd name="connsiteY6" fmla="*/ 196046 h 425833"/>
                  <a:gd name="connsiteX7" fmla="*/ 174777 w 745517"/>
                  <a:gd name="connsiteY7" fmla="*/ 359552 h 425833"/>
                  <a:gd name="connsiteX8" fmla="*/ 629 w 745517"/>
                  <a:gd name="connsiteY8" fmla="*/ 369014 h 425833"/>
                  <a:gd name="connsiteX0" fmla="*/ 629 w 745517"/>
                  <a:gd name="connsiteY0" fmla="*/ 369014 h 425833"/>
                  <a:gd name="connsiteX1" fmla="*/ 184211 w 745517"/>
                  <a:gd name="connsiteY1" fmla="*/ 47911 h 425833"/>
                  <a:gd name="connsiteX2" fmla="*/ 544183 w 745517"/>
                  <a:gd name="connsiteY2" fmla="*/ 39071 h 425833"/>
                  <a:gd name="connsiteX3" fmla="*/ 745517 w 745517"/>
                  <a:gd name="connsiteY3" fmla="*/ 348795 h 425833"/>
                  <a:gd name="connsiteX4" fmla="*/ 666916 w 745517"/>
                  <a:gd name="connsiteY4" fmla="*/ 425833 h 425833"/>
                  <a:gd name="connsiteX5" fmla="*/ 448149 w 745517"/>
                  <a:gd name="connsiteY5" fmla="*/ 197842 h 425833"/>
                  <a:gd name="connsiteX6" fmla="*/ 277040 w 745517"/>
                  <a:gd name="connsiteY6" fmla="*/ 196046 h 425833"/>
                  <a:gd name="connsiteX7" fmla="*/ 174777 w 745517"/>
                  <a:gd name="connsiteY7" fmla="*/ 359552 h 425833"/>
                  <a:gd name="connsiteX8" fmla="*/ 629 w 745517"/>
                  <a:gd name="connsiteY8" fmla="*/ 369014 h 425833"/>
                  <a:gd name="connsiteX0" fmla="*/ 629 w 745517"/>
                  <a:gd name="connsiteY0" fmla="*/ 369014 h 425833"/>
                  <a:gd name="connsiteX1" fmla="*/ 184211 w 745517"/>
                  <a:gd name="connsiteY1" fmla="*/ 47911 h 425833"/>
                  <a:gd name="connsiteX2" fmla="*/ 544183 w 745517"/>
                  <a:gd name="connsiteY2" fmla="*/ 39071 h 425833"/>
                  <a:gd name="connsiteX3" fmla="*/ 745517 w 745517"/>
                  <a:gd name="connsiteY3" fmla="*/ 348795 h 425833"/>
                  <a:gd name="connsiteX4" fmla="*/ 666916 w 745517"/>
                  <a:gd name="connsiteY4" fmla="*/ 425833 h 425833"/>
                  <a:gd name="connsiteX5" fmla="*/ 465543 w 745517"/>
                  <a:gd name="connsiteY5" fmla="*/ 179451 h 425833"/>
                  <a:gd name="connsiteX6" fmla="*/ 277040 w 745517"/>
                  <a:gd name="connsiteY6" fmla="*/ 196046 h 425833"/>
                  <a:gd name="connsiteX7" fmla="*/ 174777 w 745517"/>
                  <a:gd name="connsiteY7" fmla="*/ 359552 h 425833"/>
                  <a:gd name="connsiteX8" fmla="*/ 629 w 745517"/>
                  <a:gd name="connsiteY8" fmla="*/ 369014 h 425833"/>
                  <a:gd name="connsiteX0" fmla="*/ 629 w 745517"/>
                  <a:gd name="connsiteY0" fmla="*/ 369014 h 425833"/>
                  <a:gd name="connsiteX1" fmla="*/ 184211 w 745517"/>
                  <a:gd name="connsiteY1" fmla="*/ 47911 h 425833"/>
                  <a:gd name="connsiteX2" fmla="*/ 544183 w 745517"/>
                  <a:gd name="connsiteY2" fmla="*/ 39071 h 425833"/>
                  <a:gd name="connsiteX3" fmla="*/ 745517 w 745517"/>
                  <a:gd name="connsiteY3" fmla="*/ 348795 h 425833"/>
                  <a:gd name="connsiteX4" fmla="*/ 666916 w 745517"/>
                  <a:gd name="connsiteY4" fmla="*/ 425833 h 425833"/>
                  <a:gd name="connsiteX5" fmla="*/ 465543 w 745517"/>
                  <a:gd name="connsiteY5" fmla="*/ 179451 h 425833"/>
                  <a:gd name="connsiteX6" fmla="*/ 387239 w 745517"/>
                  <a:gd name="connsiteY6" fmla="*/ 147341 h 425833"/>
                  <a:gd name="connsiteX7" fmla="*/ 174777 w 745517"/>
                  <a:gd name="connsiteY7" fmla="*/ 359552 h 425833"/>
                  <a:gd name="connsiteX8" fmla="*/ 629 w 745517"/>
                  <a:gd name="connsiteY8" fmla="*/ 369014 h 425833"/>
                  <a:gd name="connsiteX0" fmla="*/ 629 w 745517"/>
                  <a:gd name="connsiteY0" fmla="*/ 369014 h 425833"/>
                  <a:gd name="connsiteX1" fmla="*/ 184211 w 745517"/>
                  <a:gd name="connsiteY1" fmla="*/ 47911 h 425833"/>
                  <a:gd name="connsiteX2" fmla="*/ 544183 w 745517"/>
                  <a:gd name="connsiteY2" fmla="*/ 39071 h 425833"/>
                  <a:gd name="connsiteX3" fmla="*/ 745517 w 745517"/>
                  <a:gd name="connsiteY3" fmla="*/ 348795 h 425833"/>
                  <a:gd name="connsiteX4" fmla="*/ 666916 w 745517"/>
                  <a:gd name="connsiteY4" fmla="*/ 425833 h 425833"/>
                  <a:gd name="connsiteX5" fmla="*/ 465543 w 745517"/>
                  <a:gd name="connsiteY5" fmla="*/ 179451 h 425833"/>
                  <a:gd name="connsiteX6" fmla="*/ 387239 w 745517"/>
                  <a:gd name="connsiteY6" fmla="*/ 147341 h 425833"/>
                  <a:gd name="connsiteX7" fmla="*/ 174777 w 745517"/>
                  <a:gd name="connsiteY7" fmla="*/ 359552 h 425833"/>
                  <a:gd name="connsiteX8" fmla="*/ 629 w 745517"/>
                  <a:gd name="connsiteY8" fmla="*/ 369014 h 425833"/>
                  <a:gd name="connsiteX0" fmla="*/ 629 w 745517"/>
                  <a:gd name="connsiteY0" fmla="*/ 369014 h 425833"/>
                  <a:gd name="connsiteX1" fmla="*/ 184211 w 745517"/>
                  <a:gd name="connsiteY1" fmla="*/ 47911 h 425833"/>
                  <a:gd name="connsiteX2" fmla="*/ 544183 w 745517"/>
                  <a:gd name="connsiteY2" fmla="*/ 39071 h 425833"/>
                  <a:gd name="connsiteX3" fmla="*/ 745517 w 745517"/>
                  <a:gd name="connsiteY3" fmla="*/ 348795 h 425833"/>
                  <a:gd name="connsiteX4" fmla="*/ 666916 w 745517"/>
                  <a:gd name="connsiteY4" fmla="*/ 425833 h 425833"/>
                  <a:gd name="connsiteX5" fmla="*/ 465543 w 745517"/>
                  <a:gd name="connsiteY5" fmla="*/ 179451 h 425833"/>
                  <a:gd name="connsiteX6" fmla="*/ 387239 w 745517"/>
                  <a:gd name="connsiteY6" fmla="*/ 147341 h 425833"/>
                  <a:gd name="connsiteX7" fmla="*/ 174777 w 745517"/>
                  <a:gd name="connsiteY7" fmla="*/ 359552 h 425833"/>
                  <a:gd name="connsiteX8" fmla="*/ 629 w 745517"/>
                  <a:gd name="connsiteY8" fmla="*/ 369014 h 425833"/>
                  <a:gd name="connsiteX0" fmla="*/ 629 w 745517"/>
                  <a:gd name="connsiteY0" fmla="*/ 369014 h 425833"/>
                  <a:gd name="connsiteX1" fmla="*/ 184211 w 745517"/>
                  <a:gd name="connsiteY1" fmla="*/ 47911 h 425833"/>
                  <a:gd name="connsiteX2" fmla="*/ 544183 w 745517"/>
                  <a:gd name="connsiteY2" fmla="*/ 39071 h 425833"/>
                  <a:gd name="connsiteX3" fmla="*/ 745517 w 745517"/>
                  <a:gd name="connsiteY3" fmla="*/ 348795 h 425833"/>
                  <a:gd name="connsiteX4" fmla="*/ 666916 w 745517"/>
                  <a:gd name="connsiteY4" fmla="*/ 425833 h 425833"/>
                  <a:gd name="connsiteX5" fmla="*/ 465543 w 745517"/>
                  <a:gd name="connsiteY5" fmla="*/ 179451 h 425833"/>
                  <a:gd name="connsiteX6" fmla="*/ 396919 w 745517"/>
                  <a:gd name="connsiteY6" fmla="*/ 199046 h 425833"/>
                  <a:gd name="connsiteX7" fmla="*/ 174777 w 745517"/>
                  <a:gd name="connsiteY7" fmla="*/ 359552 h 425833"/>
                  <a:gd name="connsiteX8" fmla="*/ 629 w 745517"/>
                  <a:gd name="connsiteY8" fmla="*/ 369014 h 425833"/>
                  <a:gd name="connsiteX0" fmla="*/ 629 w 745517"/>
                  <a:gd name="connsiteY0" fmla="*/ 369014 h 425833"/>
                  <a:gd name="connsiteX1" fmla="*/ 184211 w 745517"/>
                  <a:gd name="connsiteY1" fmla="*/ 47911 h 425833"/>
                  <a:gd name="connsiteX2" fmla="*/ 544183 w 745517"/>
                  <a:gd name="connsiteY2" fmla="*/ 39071 h 425833"/>
                  <a:gd name="connsiteX3" fmla="*/ 745517 w 745517"/>
                  <a:gd name="connsiteY3" fmla="*/ 348795 h 425833"/>
                  <a:gd name="connsiteX4" fmla="*/ 666916 w 745517"/>
                  <a:gd name="connsiteY4" fmla="*/ 425833 h 425833"/>
                  <a:gd name="connsiteX5" fmla="*/ 396919 w 745517"/>
                  <a:gd name="connsiteY5" fmla="*/ 199046 h 425833"/>
                  <a:gd name="connsiteX6" fmla="*/ 174777 w 745517"/>
                  <a:gd name="connsiteY6" fmla="*/ 359552 h 425833"/>
                  <a:gd name="connsiteX7" fmla="*/ 629 w 745517"/>
                  <a:gd name="connsiteY7" fmla="*/ 369014 h 425833"/>
                  <a:gd name="connsiteX0" fmla="*/ 629 w 777485"/>
                  <a:gd name="connsiteY0" fmla="*/ 364465 h 421284"/>
                  <a:gd name="connsiteX1" fmla="*/ 184211 w 777485"/>
                  <a:gd name="connsiteY1" fmla="*/ 43362 h 421284"/>
                  <a:gd name="connsiteX2" fmla="*/ 544183 w 777485"/>
                  <a:gd name="connsiteY2" fmla="*/ 34522 h 421284"/>
                  <a:gd name="connsiteX3" fmla="*/ 777485 w 777485"/>
                  <a:gd name="connsiteY3" fmla="*/ 302949 h 421284"/>
                  <a:gd name="connsiteX4" fmla="*/ 666916 w 777485"/>
                  <a:gd name="connsiteY4" fmla="*/ 421284 h 421284"/>
                  <a:gd name="connsiteX5" fmla="*/ 396919 w 777485"/>
                  <a:gd name="connsiteY5" fmla="*/ 194497 h 421284"/>
                  <a:gd name="connsiteX6" fmla="*/ 174777 w 777485"/>
                  <a:gd name="connsiteY6" fmla="*/ 355003 h 421284"/>
                  <a:gd name="connsiteX7" fmla="*/ 629 w 777485"/>
                  <a:gd name="connsiteY7" fmla="*/ 364465 h 421284"/>
                  <a:gd name="connsiteX0" fmla="*/ 629 w 777485"/>
                  <a:gd name="connsiteY0" fmla="*/ 364465 h 421284"/>
                  <a:gd name="connsiteX1" fmla="*/ 184211 w 777485"/>
                  <a:gd name="connsiteY1" fmla="*/ 43362 h 421284"/>
                  <a:gd name="connsiteX2" fmla="*/ 544183 w 777485"/>
                  <a:gd name="connsiteY2" fmla="*/ 34522 h 421284"/>
                  <a:gd name="connsiteX3" fmla="*/ 777485 w 777485"/>
                  <a:gd name="connsiteY3" fmla="*/ 302949 h 421284"/>
                  <a:gd name="connsiteX4" fmla="*/ 666916 w 777485"/>
                  <a:gd name="connsiteY4" fmla="*/ 421284 h 421284"/>
                  <a:gd name="connsiteX5" fmla="*/ 396919 w 777485"/>
                  <a:gd name="connsiteY5" fmla="*/ 194497 h 421284"/>
                  <a:gd name="connsiteX6" fmla="*/ 174777 w 777485"/>
                  <a:gd name="connsiteY6" fmla="*/ 355003 h 421284"/>
                  <a:gd name="connsiteX7" fmla="*/ 629 w 777485"/>
                  <a:gd name="connsiteY7" fmla="*/ 364465 h 421284"/>
                  <a:gd name="connsiteX0" fmla="*/ 629 w 777485"/>
                  <a:gd name="connsiteY0" fmla="*/ 364465 h 421284"/>
                  <a:gd name="connsiteX1" fmla="*/ 184211 w 777485"/>
                  <a:gd name="connsiteY1" fmla="*/ 43362 h 421284"/>
                  <a:gd name="connsiteX2" fmla="*/ 544183 w 777485"/>
                  <a:gd name="connsiteY2" fmla="*/ 34522 h 421284"/>
                  <a:gd name="connsiteX3" fmla="*/ 777485 w 777485"/>
                  <a:gd name="connsiteY3" fmla="*/ 302949 h 421284"/>
                  <a:gd name="connsiteX4" fmla="*/ 666916 w 777485"/>
                  <a:gd name="connsiteY4" fmla="*/ 421284 h 421284"/>
                  <a:gd name="connsiteX5" fmla="*/ 396919 w 777485"/>
                  <a:gd name="connsiteY5" fmla="*/ 194497 h 421284"/>
                  <a:gd name="connsiteX6" fmla="*/ 102409 w 777485"/>
                  <a:gd name="connsiteY6" fmla="*/ 373814 h 421284"/>
                  <a:gd name="connsiteX7" fmla="*/ 629 w 777485"/>
                  <a:gd name="connsiteY7" fmla="*/ 364465 h 421284"/>
                  <a:gd name="connsiteX0" fmla="*/ 329 w 828090"/>
                  <a:gd name="connsiteY0" fmla="*/ 354833 h 418791"/>
                  <a:gd name="connsiteX1" fmla="*/ 234816 w 828090"/>
                  <a:gd name="connsiteY1" fmla="*/ 40869 h 418791"/>
                  <a:gd name="connsiteX2" fmla="*/ 594788 w 828090"/>
                  <a:gd name="connsiteY2" fmla="*/ 32029 h 418791"/>
                  <a:gd name="connsiteX3" fmla="*/ 828090 w 828090"/>
                  <a:gd name="connsiteY3" fmla="*/ 300456 h 418791"/>
                  <a:gd name="connsiteX4" fmla="*/ 717521 w 828090"/>
                  <a:gd name="connsiteY4" fmla="*/ 418791 h 418791"/>
                  <a:gd name="connsiteX5" fmla="*/ 447524 w 828090"/>
                  <a:gd name="connsiteY5" fmla="*/ 192004 h 418791"/>
                  <a:gd name="connsiteX6" fmla="*/ 153014 w 828090"/>
                  <a:gd name="connsiteY6" fmla="*/ 371321 h 418791"/>
                  <a:gd name="connsiteX7" fmla="*/ 329 w 828090"/>
                  <a:gd name="connsiteY7" fmla="*/ 354833 h 418791"/>
                  <a:gd name="connsiteX0" fmla="*/ 283 w 857165"/>
                  <a:gd name="connsiteY0" fmla="*/ 350149 h 418526"/>
                  <a:gd name="connsiteX1" fmla="*/ 263891 w 857165"/>
                  <a:gd name="connsiteY1" fmla="*/ 40604 h 418526"/>
                  <a:gd name="connsiteX2" fmla="*/ 623863 w 857165"/>
                  <a:gd name="connsiteY2" fmla="*/ 31764 h 418526"/>
                  <a:gd name="connsiteX3" fmla="*/ 857165 w 857165"/>
                  <a:gd name="connsiteY3" fmla="*/ 300191 h 418526"/>
                  <a:gd name="connsiteX4" fmla="*/ 746596 w 857165"/>
                  <a:gd name="connsiteY4" fmla="*/ 418526 h 418526"/>
                  <a:gd name="connsiteX5" fmla="*/ 476599 w 857165"/>
                  <a:gd name="connsiteY5" fmla="*/ 191739 h 418526"/>
                  <a:gd name="connsiteX6" fmla="*/ 182089 w 857165"/>
                  <a:gd name="connsiteY6" fmla="*/ 371056 h 418526"/>
                  <a:gd name="connsiteX7" fmla="*/ 283 w 857165"/>
                  <a:gd name="connsiteY7" fmla="*/ 350149 h 418526"/>
                  <a:gd name="connsiteX0" fmla="*/ 283 w 857165"/>
                  <a:gd name="connsiteY0" fmla="*/ 350149 h 418526"/>
                  <a:gd name="connsiteX1" fmla="*/ 263891 w 857165"/>
                  <a:gd name="connsiteY1" fmla="*/ 40604 h 418526"/>
                  <a:gd name="connsiteX2" fmla="*/ 623863 w 857165"/>
                  <a:gd name="connsiteY2" fmla="*/ 31764 h 418526"/>
                  <a:gd name="connsiteX3" fmla="*/ 857165 w 857165"/>
                  <a:gd name="connsiteY3" fmla="*/ 300191 h 418526"/>
                  <a:gd name="connsiteX4" fmla="*/ 746596 w 857165"/>
                  <a:gd name="connsiteY4" fmla="*/ 418526 h 418526"/>
                  <a:gd name="connsiteX5" fmla="*/ 476599 w 857165"/>
                  <a:gd name="connsiteY5" fmla="*/ 191739 h 418526"/>
                  <a:gd name="connsiteX6" fmla="*/ 182089 w 857165"/>
                  <a:gd name="connsiteY6" fmla="*/ 371056 h 418526"/>
                  <a:gd name="connsiteX7" fmla="*/ 283 w 857165"/>
                  <a:gd name="connsiteY7" fmla="*/ 350149 h 418526"/>
                  <a:gd name="connsiteX0" fmla="*/ 283 w 857165"/>
                  <a:gd name="connsiteY0" fmla="*/ 350149 h 418526"/>
                  <a:gd name="connsiteX1" fmla="*/ 263891 w 857165"/>
                  <a:gd name="connsiteY1" fmla="*/ 40604 h 418526"/>
                  <a:gd name="connsiteX2" fmla="*/ 623863 w 857165"/>
                  <a:gd name="connsiteY2" fmla="*/ 31764 h 418526"/>
                  <a:gd name="connsiteX3" fmla="*/ 857165 w 857165"/>
                  <a:gd name="connsiteY3" fmla="*/ 300191 h 418526"/>
                  <a:gd name="connsiteX4" fmla="*/ 746596 w 857165"/>
                  <a:gd name="connsiteY4" fmla="*/ 418526 h 418526"/>
                  <a:gd name="connsiteX5" fmla="*/ 476599 w 857165"/>
                  <a:gd name="connsiteY5" fmla="*/ 191739 h 418526"/>
                  <a:gd name="connsiteX6" fmla="*/ 182089 w 857165"/>
                  <a:gd name="connsiteY6" fmla="*/ 371056 h 418526"/>
                  <a:gd name="connsiteX7" fmla="*/ 283 w 857165"/>
                  <a:gd name="connsiteY7" fmla="*/ 350149 h 418526"/>
                  <a:gd name="connsiteX0" fmla="*/ 283 w 857165"/>
                  <a:gd name="connsiteY0" fmla="*/ 350149 h 418526"/>
                  <a:gd name="connsiteX1" fmla="*/ 263891 w 857165"/>
                  <a:gd name="connsiteY1" fmla="*/ 40604 h 418526"/>
                  <a:gd name="connsiteX2" fmla="*/ 623863 w 857165"/>
                  <a:gd name="connsiteY2" fmla="*/ 31764 h 418526"/>
                  <a:gd name="connsiteX3" fmla="*/ 857165 w 857165"/>
                  <a:gd name="connsiteY3" fmla="*/ 300191 h 418526"/>
                  <a:gd name="connsiteX4" fmla="*/ 746596 w 857165"/>
                  <a:gd name="connsiteY4" fmla="*/ 418526 h 418526"/>
                  <a:gd name="connsiteX5" fmla="*/ 476599 w 857165"/>
                  <a:gd name="connsiteY5" fmla="*/ 191739 h 418526"/>
                  <a:gd name="connsiteX6" fmla="*/ 182089 w 857165"/>
                  <a:gd name="connsiteY6" fmla="*/ 371056 h 418526"/>
                  <a:gd name="connsiteX7" fmla="*/ 283 w 857165"/>
                  <a:gd name="connsiteY7" fmla="*/ 350149 h 418526"/>
                  <a:gd name="connsiteX0" fmla="*/ 283 w 857165"/>
                  <a:gd name="connsiteY0" fmla="*/ 350149 h 418526"/>
                  <a:gd name="connsiteX1" fmla="*/ 263891 w 857165"/>
                  <a:gd name="connsiteY1" fmla="*/ 40604 h 418526"/>
                  <a:gd name="connsiteX2" fmla="*/ 623863 w 857165"/>
                  <a:gd name="connsiteY2" fmla="*/ 31764 h 418526"/>
                  <a:gd name="connsiteX3" fmla="*/ 857165 w 857165"/>
                  <a:gd name="connsiteY3" fmla="*/ 300191 h 418526"/>
                  <a:gd name="connsiteX4" fmla="*/ 746596 w 857165"/>
                  <a:gd name="connsiteY4" fmla="*/ 418526 h 418526"/>
                  <a:gd name="connsiteX5" fmla="*/ 596226 w 857165"/>
                  <a:gd name="connsiteY5" fmla="*/ 269798 h 418526"/>
                  <a:gd name="connsiteX6" fmla="*/ 476599 w 857165"/>
                  <a:gd name="connsiteY6" fmla="*/ 191739 h 418526"/>
                  <a:gd name="connsiteX7" fmla="*/ 182089 w 857165"/>
                  <a:gd name="connsiteY7" fmla="*/ 371056 h 418526"/>
                  <a:gd name="connsiteX8" fmla="*/ 283 w 857165"/>
                  <a:gd name="connsiteY8" fmla="*/ 350149 h 418526"/>
                  <a:gd name="connsiteX0" fmla="*/ 283 w 857165"/>
                  <a:gd name="connsiteY0" fmla="*/ 350149 h 418526"/>
                  <a:gd name="connsiteX1" fmla="*/ 263891 w 857165"/>
                  <a:gd name="connsiteY1" fmla="*/ 40604 h 418526"/>
                  <a:gd name="connsiteX2" fmla="*/ 623863 w 857165"/>
                  <a:gd name="connsiteY2" fmla="*/ 31764 h 418526"/>
                  <a:gd name="connsiteX3" fmla="*/ 857165 w 857165"/>
                  <a:gd name="connsiteY3" fmla="*/ 300191 h 418526"/>
                  <a:gd name="connsiteX4" fmla="*/ 746596 w 857165"/>
                  <a:gd name="connsiteY4" fmla="*/ 418526 h 418526"/>
                  <a:gd name="connsiteX5" fmla="*/ 631337 w 857165"/>
                  <a:gd name="connsiteY5" fmla="*/ 261689 h 418526"/>
                  <a:gd name="connsiteX6" fmla="*/ 476599 w 857165"/>
                  <a:gd name="connsiteY6" fmla="*/ 191739 h 418526"/>
                  <a:gd name="connsiteX7" fmla="*/ 182089 w 857165"/>
                  <a:gd name="connsiteY7" fmla="*/ 371056 h 418526"/>
                  <a:gd name="connsiteX8" fmla="*/ 283 w 857165"/>
                  <a:gd name="connsiteY8" fmla="*/ 350149 h 418526"/>
                  <a:gd name="connsiteX0" fmla="*/ 283 w 857165"/>
                  <a:gd name="connsiteY0" fmla="*/ 350149 h 418526"/>
                  <a:gd name="connsiteX1" fmla="*/ 263891 w 857165"/>
                  <a:gd name="connsiteY1" fmla="*/ 40604 h 418526"/>
                  <a:gd name="connsiteX2" fmla="*/ 623863 w 857165"/>
                  <a:gd name="connsiteY2" fmla="*/ 31764 h 418526"/>
                  <a:gd name="connsiteX3" fmla="*/ 857165 w 857165"/>
                  <a:gd name="connsiteY3" fmla="*/ 300191 h 418526"/>
                  <a:gd name="connsiteX4" fmla="*/ 746596 w 857165"/>
                  <a:gd name="connsiteY4" fmla="*/ 418526 h 418526"/>
                  <a:gd name="connsiteX5" fmla="*/ 623229 w 857165"/>
                  <a:gd name="connsiteY5" fmla="*/ 226578 h 418526"/>
                  <a:gd name="connsiteX6" fmla="*/ 476599 w 857165"/>
                  <a:gd name="connsiteY6" fmla="*/ 191739 h 418526"/>
                  <a:gd name="connsiteX7" fmla="*/ 182089 w 857165"/>
                  <a:gd name="connsiteY7" fmla="*/ 371056 h 418526"/>
                  <a:gd name="connsiteX8" fmla="*/ 283 w 857165"/>
                  <a:gd name="connsiteY8" fmla="*/ 350149 h 418526"/>
                  <a:gd name="connsiteX0" fmla="*/ 283 w 857165"/>
                  <a:gd name="connsiteY0" fmla="*/ 350149 h 418077"/>
                  <a:gd name="connsiteX1" fmla="*/ 263891 w 857165"/>
                  <a:gd name="connsiteY1" fmla="*/ 40604 h 418077"/>
                  <a:gd name="connsiteX2" fmla="*/ 623863 w 857165"/>
                  <a:gd name="connsiteY2" fmla="*/ 31764 h 418077"/>
                  <a:gd name="connsiteX3" fmla="*/ 857165 w 857165"/>
                  <a:gd name="connsiteY3" fmla="*/ 300191 h 418077"/>
                  <a:gd name="connsiteX4" fmla="*/ 751337 w 857165"/>
                  <a:gd name="connsiteY4" fmla="*/ 418077 h 418077"/>
                  <a:gd name="connsiteX5" fmla="*/ 623229 w 857165"/>
                  <a:gd name="connsiteY5" fmla="*/ 226578 h 418077"/>
                  <a:gd name="connsiteX6" fmla="*/ 476599 w 857165"/>
                  <a:gd name="connsiteY6" fmla="*/ 191739 h 418077"/>
                  <a:gd name="connsiteX7" fmla="*/ 182089 w 857165"/>
                  <a:gd name="connsiteY7" fmla="*/ 371056 h 418077"/>
                  <a:gd name="connsiteX8" fmla="*/ 283 w 857165"/>
                  <a:gd name="connsiteY8" fmla="*/ 350149 h 418077"/>
                  <a:gd name="connsiteX0" fmla="*/ 283 w 857165"/>
                  <a:gd name="connsiteY0" fmla="*/ 350149 h 418077"/>
                  <a:gd name="connsiteX1" fmla="*/ 263891 w 857165"/>
                  <a:gd name="connsiteY1" fmla="*/ 40604 h 418077"/>
                  <a:gd name="connsiteX2" fmla="*/ 623863 w 857165"/>
                  <a:gd name="connsiteY2" fmla="*/ 31764 h 418077"/>
                  <a:gd name="connsiteX3" fmla="*/ 857165 w 857165"/>
                  <a:gd name="connsiteY3" fmla="*/ 300191 h 418077"/>
                  <a:gd name="connsiteX4" fmla="*/ 751337 w 857165"/>
                  <a:gd name="connsiteY4" fmla="*/ 418077 h 418077"/>
                  <a:gd name="connsiteX5" fmla="*/ 623229 w 857165"/>
                  <a:gd name="connsiteY5" fmla="*/ 226578 h 418077"/>
                  <a:gd name="connsiteX6" fmla="*/ 355471 w 857165"/>
                  <a:gd name="connsiteY6" fmla="*/ 200816 h 418077"/>
                  <a:gd name="connsiteX7" fmla="*/ 182089 w 857165"/>
                  <a:gd name="connsiteY7" fmla="*/ 371056 h 418077"/>
                  <a:gd name="connsiteX8" fmla="*/ 283 w 857165"/>
                  <a:gd name="connsiteY8" fmla="*/ 350149 h 418077"/>
                  <a:gd name="connsiteX0" fmla="*/ 283 w 857165"/>
                  <a:gd name="connsiteY0" fmla="*/ 350149 h 418077"/>
                  <a:gd name="connsiteX1" fmla="*/ 263891 w 857165"/>
                  <a:gd name="connsiteY1" fmla="*/ 40604 h 418077"/>
                  <a:gd name="connsiteX2" fmla="*/ 623863 w 857165"/>
                  <a:gd name="connsiteY2" fmla="*/ 31764 h 418077"/>
                  <a:gd name="connsiteX3" fmla="*/ 857165 w 857165"/>
                  <a:gd name="connsiteY3" fmla="*/ 300191 h 418077"/>
                  <a:gd name="connsiteX4" fmla="*/ 751337 w 857165"/>
                  <a:gd name="connsiteY4" fmla="*/ 418077 h 418077"/>
                  <a:gd name="connsiteX5" fmla="*/ 623229 w 857165"/>
                  <a:gd name="connsiteY5" fmla="*/ 226578 h 418077"/>
                  <a:gd name="connsiteX6" fmla="*/ 355471 w 857165"/>
                  <a:gd name="connsiteY6" fmla="*/ 200816 h 418077"/>
                  <a:gd name="connsiteX7" fmla="*/ 182089 w 857165"/>
                  <a:gd name="connsiteY7" fmla="*/ 371056 h 418077"/>
                  <a:gd name="connsiteX8" fmla="*/ 283 w 857165"/>
                  <a:gd name="connsiteY8" fmla="*/ 350149 h 418077"/>
                  <a:gd name="connsiteX0" fmla="*/ 283 w 857165"/>
                  <a:gd name="connsiteY0" fmla="*/ 350149 h 418077"/>
                  <a:gd name="connsiteX1" fmla="*/ 263891 w 857165"/>
                  <a:gd name="connsiteY1" fmla="*/ 40604 h 418077"/>
                  <a:gd name="connsiteX2" fmla="*/ 623863 w 857165"/>
                  <a:gd name="connsiteY2" fmla="*/ 31764 h 418077"/>
                  <a:gd name="connsiteX3" fmla="*/ 857165 w 857165"/>
                  <a:gd name="connsiteY3" fmla="*/ 300191 h 418077"/>
                  <a:gd name="connsiteX4" fmla="*/ 751337 w 857165"/>
                  <a:gd name="connsiteY4" fmla="*/ 418077 h 418077"/>
                  <a:gd name="connsiteX5" fmla="*/ 591288 w 857165"/>
                  <a:gd name="connsiteY5" fmla="*/ 217643 h 418077"/>
                  <a:gd name="connsiteX6" fmla="*/ 355471 w 857165"/>
                  <a:gd name="connsiteY6" fmla="*/ 200816 h 418077"/>
                  <a:gd name="connsiteX7" fmla="*/ 182089 w 857165"/>
                  <a:gd name="connsiteY7" fmla="*/ 371056 h 418077"/>
                  <a:gd name="connsiteX8" fmla="*/ 283 w 857165"/>
                  <a:gd name="connsiteY8" fmla="*/ 350149 h 418077"/>
                  <a:gd name="connsiteX0" fmla="*/ 283 w 857165"/>
                  <a:gd name="connsiteY0" fmla="*/ 350149 h 418077"/>
                  <a:gd name="connsiteX1" fmla="*/ 263891 w 857165"/>
                  <a:gd name="connsiteY1" fmla="*/ 40604 h 418077"/>
                  <a:gd name="connsiteX2" fmla="*/ 623863 w 857165"/>
                  <a:gd name="connsiteY2" fmla="*/ 31764 h 418077"/>
                  <a:gd name="connsiteX3" fmla="*/ 857165 w 857165"/>
                  <a:gd name="connsiteY3" fmla="*/ 300191 h 418077"/>
                  <a:gd name="connsiteX4" fmla="*/ 751337 w 857165"/>
                  <a:gd name="connsiteY4" fmla="*/ 418077 h 418077"/>
                  <a:gd name="connsiteX5" fmla="*/ 591288 w 857165"/>
                  <a:gd name="connsiteY5" fmla="*/ 217643 h 418077"/>
                  <a:gd name="connsiteX6" fmla="*/ 355471 w 857165"/>
                  <a:gd name="connsiteY6" fmla="*/ 200816 h 418077"/>
                  <a:gd name="connsiteX7" fmla="*/ 182089 w 857165"/>
                  <a:gd name="connsiteY7" fmla="*/ 371056 h 418077"/>
                  <a:gd name="connsiteX8" fmla="*/ 283 w 857165"/>
                  <a:gd name="connsiteY8" fmla="*/ 350149 h 418077"/>
                  <a:gd name="connsiteX0" fmla="*/ 283 w 857165"/>
                  <a:gd name="connsiteY0" fmla="*/ 350149 h 418077"/>
                  <a:gd name="connsiteX1" fmla="*/ 263891 w 857165"/>
                  <a:gd name="connsiteY1" fmla="*/ 40604 h 418077"/>
                  <a:gd name="connsiteX2" fmla="*/ 623863 w 857165"/>
                  <a:gd name="connsiteY2" fmla="*/ 31764 h 418077"/>
                  <a:gd name="connsiteX3" fmla="*/ 857165 w 857165"/>
                  <a:gd name="connsiteY3" fmla="*/ 300191 h 418077"/>
                  <a:gd name="connsiteX4" fmla="*/ 751337 w 857165"/>
                  <a:gd name="connsiteY4" fmla="*/ 418077 h 418077"/>
                  <a:gd name="connsiteX5" fmla="*/ 591288 w 857165"/>
                  <a:gd name="connsiteY5" fmla="*/ 217643 h 418077"/>
                  <a:gd name="connsiteX6" fmla="*/ 355471 w 857165"/>
                  <a:gd name="connsiteY6" fmla="*/ 200816 h 418077"/>
                  <a:gd name="connsiteX7" fmla="*/ 182089 w 857165"/>
                  <a:gd name="connsiteY7" fmla="*/ 371056 h 418077"/>
                  <a:gd name="connsiteX8" fmla="*/ 283 w 857165"/>
                  <a:gd name="connsiteY8" fmla="*/ 350149 h 418077"/>
                  <a:gd name="connsiteX0" fmla="*/ 283 w 857165"/>
                  <a:gd name="connsiteY0" fmla="*/ 350149 h 418077"/>
                  <a:gd name="connsiteX1" fmla="*/ 263891 w 857165"/>
                  <a:gd name="connsiteY1" fmla="*/ 40604 h 418077"/>
                  <a:gd name="connsiteX2" fmla="*/ 623863 w 857165"/>
                  <a:gd name="connsiteY2" fmla="*/ 31764 h 418077"/>
                  <a:gd name="connsiteX3" fmla="*/ 857165 w 857165"/>
                  <a:gd name="connsiteY3" fmla="*/ 300191 h 418077"/>
                  <a:gd name="connsiteX4" fmla="*/ 751337 w 857165"/>
                  <a:gd name="connsiteY4" fmla="*/ 418077 h 418077"/>
                  <a:gd name="connsiteX5" fmla="*/ 588791 w 857165"/>
                  <a:gd name="connsiteY5" fmla="*/ 241798 h 418077"/>
                  <a:gd name="connsiteX6" fmla="*/ 355471 w 857165"/>
                  <a:gd name="connsiteY6" fmla="*/ 200816 h 418077"/>
                  <a:gd name="connsiteX7" fmla="*/ 182089 w 857165"/>
                  <a:gd name="connsiteY7" fmla="*/ 371056 h 418077"/>
                  <a:gd name="connsiteX8" fmla="*/ 283 w 857165"/>
                  <a:gd name="connsiteY8" fmla="*/ 350149 h 418077"/>
                  <a:gd name="connsiteX0" fmla="*/ 283 w 857165"/>
                  <a:gd name="connsiteY0" fmla="*/ 350149 h 418077"/>
                  <a:gd name="connsiteX1" fmla="*/ 263891 w 857165"/>
                  <a:gd name="connsiteY1" fmla="*/ 40604 h 418077"/>
                  <a:gd name="connsiteX2" fmla="*/ 623863 w 857165"/>
                  <a:gd name="connsiteY2" fmla="*/ 31764 h 418077"/>
                  <a:gd name="connsiteX3" fmla="*/ 857165 w 857165"/>
                  <a:gd name="connsiteY3" fmla="*/ 300191 h 418077"/>
                  <a:gd name="connsiteX4" fmla="*/ 751337 w 857165"/>
                  <a:gd name="connsiteY4" fmla="*/ 418077 h 418077"/>
                  <a:gd name="connsiteX5" fmla="*/ 588791 w 857165"/>
                  <a:gd name="connsiteY5" fmla="*/ 241798 h 418077"/>
                  <a:gd name="connsiteX6" fmla="*/ 313122 w 857165"/>
                  <a:gd name="connsiteY6" fmla="*/ 233528 h 418077"/>
                  <a:gd name="connsiteX7" fmla="*/ 182089 w 857165"/>
                  <a:gd name="connsiteY7" fmla="*/ 371056 h 418077"/>
                  <a:gd name="connsiteX8" fmla="*/ 283 w 857165"/>
                  <a:gd name="connsiteY8" fmla="*/ 350149 h 418077"/>
                  <a:gd name="connsiteX0" fmla="*/ 283 w 857165"/>
                  <a:gd name="connsiteY0" fmla="*/ 350149 h 418077"/>
                  <a:gd name="connsiteX1" fmla="*/ 263891 w 857165"/>
                  <a:gd name="connsiteY1" fmla="*/ 40604 h 418077"/>
                  <a:gd name="connsiteX2" fmla="*/ 623863 w 857165"/>
                  <a:gd name="connsiteY2" fmla="*/ 31764 h 418077"/>
                  <a:gd name="connsiteX3" fmla="*/ 857165 w 857165"/>
                  <a:gd name="connsiteY3" fmla="*/ 300191 h 418077"/>
                  <a:gd name="connsiteX4" fmla="*/ 751337 w 857165"/>
                  <a:gd name="connsiteY4" fmla="*/ 418077 h 418077"/>
                  <a:gd name="connsiteX5" fmla="*/ 588791 w 857165"/>
                  <a:gd name="connsiteY5" fmla="*/ 241798 h 418077"/>
                  <a:gd name="connsiteX6" fmla="*/ 313122 w 857165"/>
                  <a:gd name="connsiteY6" fmla="*/ 233528 h 418077"/>
                  <a:gd name="connsiteX7" fmla="*/ 182089 w 857165"/>
                  <a:gd name="connsiteY7" fmla="*/ 371056 h 418077"/>
                  <a:gd name="connsiteX8" fmla="*/ 283 w 857165"/>
                  <a:gd name="connsiteY8" fmla="*/ 350149 h 418077"/>
                  <a:gd name="connsiteX0" fmla="*/ 283 w 857165"/>
                  <a:gd name="connsiteY0" fmla="*/ 350149 h 418077"/>
                  <a:gd name="connsiteX1" fmla="*/ 263891 w 857165"/>
                  <a:gd name="connsiteY1" fmla="*/ 40604 h 418077"/>
                  <a:gd name="connsiteX2" fmla="*/ 623863 w 857165"/>
                  <a:gd name="connsiteY2" fmla="*/ 31764 h 418077"/>
                  <a:gd name="connsiteX3" fmla="*/ 857165 w 857165"/>
                  <a:gd name="connsiteY3" fmla="*/ 300191 h 418077"/>
                  <a:gd name="connsiteX4" fmla="*/ 751337 w 857165"/>
                  <a:gd name="connsiteY4" fmla="*/ 418077 h 418077"/>
                  <a:gd name="connsiteX5" fmla="*/ 588791 w 857165"/>
                  <a:gd name="connsiteY5" fmla="*/ 241798 h 418077"/>
                  <a:gd name="connsiteX6" fmla="*/ 323181 w 857165"/>
                  <a:gd name="connsiteY6" fmla="*/ 213440 h 418077"/>
                  <a:gd name="connsiteX7" fmla="*/ 182089 w 857165"/>
                  <a:gd name="connsiteY7" fmla="*/ 371056 h 418077"/>
                  <a:gd name="connsiteX8" fmla="*/ 283 w 857165"/>
                  <a:gd name="connsiteY8" fmla="*/ 350149 h 418077"/>
                  <a:gd name="connsiteX0" fmla="*/ 283 w 857165"/>
                  <a:gd name="connsiteY0" fmla="*/ 350149 h 418077"/>
                  <a:gd name="connsiteX1" fmla="*/ 263891 w 857165"/>
                  <a:gd name="connsiteY1" fmla="*/ 40604 h 418077"/>
                  <a:gd name="connsiteX2" fmla="*/ 623863 w 857165"/>
                  <a:gd name="connsiteY2" fmla="*/ 31764 h 418077"/>
                  <a:gd name="connsiteX3" fmla="*/ 857165 w 857165"/>
                  <a:gd name="connsiteY3" fmla="*/ 300191 h 418077"/>
                  <a:gd name="connsiteX4" fmla="*/ 751337 w 857165"/>
                  <a:gd name="connsiteY4" fmla="*/ 418077 h 418077"/>
                  <a:gd name="connsiteX5" fmla="*/ 588791 w 857165"/>
                  <a:gd name="connsiteY5" fmla="*/ 241798 h 418077"/>
                  <a:gd name="connsiteX6" fmla="*/ 323181 w 857165"/>
                  <a:gd name="connsiteY6" fmla="*/ 213440 h 418077"/>
                  <a:gd name="connsiteX7" fmla="*/ 182089 w 857165"/>
                  <a:gd name="connsiteY7" fmla="*/ 371056 h 418077"/>
                  <a:gd name="connsiteX8" fmla="*/ 283 w 857165"/>
                  <a:gd name="connsiteY8" fmla="*/ 350149 h 418077"/>
                  <a:gd name="connsiteX0" fmla="*/ 283 w 857165"/>
                  <a:gd name="connsiteY0" fmla="*/ 350149 h 418077"/>
                  <a:gd name="connsiteX1" fmla="*/ 263891 w 857165"/>
                  <a:gd name="connsiteY1" fmla="*/ 40604 h 418077"/>
                  <a:gd name="connsiteX2" fmla="*/ 623863 w 857165"/>
                  <a:gd name="connsiteY2" fmla="*/ 31764 h 418077"/>
                  <a:gd name="connsiteX3" fmla="*/ 857165 w 857165"/>
                  <a:gd name="connsiteY3" fmla="*/ 300191 h 418077"/>
                  <a:gd name="connsiteX4" fmla="*/ 751337 w 857165"/>
                  <a:gd name="connsiteY4" fmla="*/ 418077 h 418077"/>
                  <a:gd name="connsiteX5" fmla="*/ 588791 w 857165"/>
                  <a:gd name="connsiteY5" fmla="*/ 241798 h 418077"/>
                  <a:gd name="connsiteX6" fmla="*/ 323181 w 857165"/>
                  <a:gd name="connsiteY6" fmla="*/ 213440 h 418077"/>
                  <a:gd name="connsiteX7" fmla="*/ 182089 w 857165"/>
                  <a:gd name="connsiteY7" fmla="*/ 371056 h 418077"/>
                  <a:gd name="connsiteX8" fmla="*/ 283 w 857165"/>
                  <a:gd name="connsiteY8" fmla="*/ 350149 h 418077"/>
                  <a:gd name="connsiteX0" fmla="*/ 283 w 857165"/>
                  <a:gd name="connsiteY0" fmla="*/ 350149 h 471599"/>
                  <a:gd name="connsiteX1" fmla="*/ 263891 w 857165"/>
                  <a:gd name="connsiteY1" fmla="*/ 40604 h 471599"/>
                  <a:gd name="connsiteX2" fmla="*/ 623863 w 857165"/>
                  <a:gd name="connsiteY2" fmla="*/ 31764 h 471599"/>
                  <a:gd name="connsiteX3" fmla="*/ 857165 w 857165"/>
                  <a:gd name="connsiteY3" fmla="*/ 300191 h 471599"/>
                  <a:gd name="connsiteX4" fmla="*/ 768237 w 857165"/>
                  <a:gd name="connsiteY4" fmla="*/ 471599 h 471599"/>
                  <a:gd name="connsiteX5" fmla="*/ 588791 w 857165"/>
                  <a:gd name="connsiteY5" fmla="*/ 241798 h 471599"/>
                  <a:gd name="connsiteX6" fmla="*/ 323181 w 857165"/>
                  <a:gd name="connsiteY6" fmla="*/ 213440 h 471599"/>
                  <a:gd name="connsiteX7" fmla="*/ 182089 w 857165"/>
                  <a:gd name="connsiteY7" fmla="*/ 371056 h 471599"/>
                  <a:gd name="connsiteX8" fmla="*/ 283 w 857165"/>
                  <a:gd name="connsiteY8" fmla="*/ 350149 h 471599"/>
                  <a:gd name="connsiteX0" fmla="*/ 283 w 922080"/>
                  <a:gd name="connsiteY0" fmla="*/ 359002 h 486990"/>
                  <a:gd name="connsiteX1" fmla="*/ 263891 w 922080"/>
                  <a:gd name="connsiteY1" fmla="*/ 49457 h 486990"/>
                  <a:gd name="connsiteX2" fmla="*/ 623863 w 922080"/>
                  <a:gd name="connsiteY2" fmla="*/ 40617 h 486990"/>
                  <a:gd name="connsiteX3" fmla="*/ 922080 w 922080"/>
                  <a:gd name="connsiteY3" fmla="*/ 440612 h 486990"/>
                  <a:gd name="connsiteX4" fmla="*/ 768237 w 922080"/>
                  <a:gd name="connsiteY4" fmla="*/ 480452 h 486990"/>
                  <a:gd name="connsiteX5" fmla="*/ 588791 w 922080"/>
                  <a:gd name="connsiteY5" fmla="*/ 250651 h 486990"/>
                  <a:gd name="connsiteX6" fmla="*/ 323181 w 922080"/>
                  <a:gd name="connsiteY6" fmla="*/ 222293 h 486990"/>
                  <a:gd name="connsiteX7" fmla="*/ 182089 w 922080"/>
                  <a:gd name="connsiteY7" fmla="*/ 379909 h 486990"/>
                  <a:gd name="connsiteX8" fmla="*/ 283 w 922080"/>
                  <a:gd name="connsiteY8" fmla="*/ 359002 h 486990"/>
                  <a:gd name="connsiteX0" fmla="*/ 283 w 925272"/>
                  <a:gd name="connsiteY0" fmla="*/ 357772 h 480085"/>
                  <a:gd name="connsiteX1" fmla="*/ 263891 w 925272"/>
                  <a:gd name="connsiteY1" fmla="*/ 48227 h 480085"/>
                  <a:gd name="connsiteX2" fmla="*/ 623863 w 925272"/>
                  <a:gd name="connsiteY2" fmla="*/ 39387 h 480085"/>
                  <a:gd name="connsiteX3" fmla="*/ 925272 w 925272"/>
                  <a:gd name="connsiteY3" fmla="*/ 421509 h 480085"/>
                  <a:gd name="connsiteX4" fmla="*/ 768237 w 925272"/>
                  <a:gd name="connsiteY4" fmla="*/ 479222 h 480085"/>
                  <a:gd name="connsiteX5" fmla="*/ 588791 w 925272"/>
                  <a:gd name="connsiteY5" fmla="*/ 249421 h 480085"/>
                  <a:gd name="connsiteX6" fmla="*/ 323181 w 925272"/>
                  <a:gd name="connsiteY6" fmla="*/ 221063 h 480085"/>
                  <a:gd name="connsiteX7" fmla="*/ 182089 w 925272"/>
                  <a:gd name="connsiteY7" fmla="*/ 378679 h 480085"/>
                  <a:gd name="connsiteX8" fmla="*/ 283 w 925272"/>
                  <a:gd name="connsiteY8" fmla="*/ 357772 h 480085"/>
                  <a:gd name="connsiteX0" fmla="*/ 283 w 925272"/>
                  <a:gd name="connsiteY0" fmla="*/ 357772 h 479899"/>
                  <a:gd name="connsiteX1" fmla="*/ 263891 w 925272"/>
                  <a:gd name="connsiteY1" fmla="*/ 48227 h 479899"/>
                  <a:gd name="connsiteX2" fmla="*/ 623863 w 925272"/>
                  <a:gd name="connsiteY2" fmla="*/ 39387 h 479899"/>
                  <a:gd name="connsiteX3" fmla="*/ 925272 w 925272"/>
                  <a:gd name="connsiteY3" fmla="*/ 421509 h 479899"/>
                  <a:gd name="connsiteX4" fmla="*/ 768237 w 925272"/>
                  <a:gd name="connsiteY4" fmla="*/ 479222 h 479899"/>
                  <a:gd name="connsiteX5" fmla="*/ 588791 w 925272"/>
                  <a:gd name="connsiteY5" fmla="*/ 249421 h 479899"/>
                  <a:gd name="connsiteX6" fmla="*/ 323181 w 925272"/>
                  <a:gd name="connsiteY6" fmla="*/ 221063 h 479899"/>
                  <a:gd name="connsiteX7" fmla="*/ 182089 w 925272"/>
                  <a:gd name="connsiteY7" fmla="*/ 378679 h 479899"/>
                  <a:gd name="connsiteX8" fmla="*/ 283 w 925272"/>
                  <a:gd name="connsiteY8" fmla="*/ 357772 h 479899"/>
                  <a:gd name="connsiteX0" fmla="*/ 283 w 925272"/>
                  <a:gd name="connsiteY0" fmla="*/ 357772 h 479899"/>
                  <a:gd name="connsiteX1" fmla="*/ 263891 w 925272"/>
                  <a:gd name="connsiteY1" fmla="*/ 48227 h 479899"/>
                  <a:gd name="connsiteX2" fmla="*/ 623863 w 925272"/>
                  <a:gd name="connsiteY2" fmla="*/ 39387 h 479899"/>
                  <a:gd name="connsiteX3" fmla="*/ 925272 w 925272"/>
                  <a:gd name="connsiteY3" fmla="*/ 421509 h 479899"/>
                  <a:gd name="connsiteX4" fmla="*/ 768237 w 925272"/>
                  <a:gd name="connsiteY4" fmla="*/ 479222 h 479899"/>
                  <a:gd name="connsiteX5" fmla="*/ 588791 w 925272"/>
                  <a:gd name="connsiteY5" fmla="*/ 249421 h 479899"/>
                  <a:gd name="connsiteX6" fmla="*/ 323181 w 925272"/>
                  <a:gd name="connsiteY6" fmla="*/ 221063 h 479899"/>
                  <a:gd name="connsiteX7" fmla="*/ 182089 w 925272"/>
                  <a:gd name="connsiteY7" fmla="*/ 378679 h 479899"/>
                  <a:gd name="connsiteX8" fmla="*/ 283 w 925272"/>
                  <a:gd name="connsiteY8" fmla="*/ 357772 h 479899"/>
                  <a:gd name="connsiteX0" fmla="*/ 283 w 925272"/>
                  <a:gd name="connsiteY0" fmla="*/ 357772 h 479899"/>
                  <a:gd name="connsiteX1" fmla="*/ 263891 w 925272"/>
                  <a:gd name="connsiteY1" fmla="*/ 48227 h 479899"/>
                  <a:gd name="connsiteX2" fmla="*/ 623863 w 925272"/>
                  <a:gd name="connsiteY2" fmla="*/ 39387 h 479899"/>
                  <a:gd name="connsiteX3" fmla="*/ 925272 w 925272"/>
                  <a:gd name="connsiteY3" fmla="*/ 421509 h 479899"/>
                  <a:gd name="connsiteX4" fmla="*/ 768237 w 925272"/>
                  <a:gd name="connsiteY4" fmla="*/ 479222 h 479899"/>
                  <a:gd name="connsiteX5" fmla="*/ 614360 w 925272"/>
                  <a:gd name="connsiteY5" fmla="*/ 239373 h 479899"/>
                  <a:gd name="connsiteX6" fmla="*/ 323181 w 925272"/>
                  <a:gd name="connsiteY6" fmla="*/ 221063 h 479899"/>
                  <a:gd name="connsiteX7" fmla="*/ 182089 w 925272"/>
                  <a:gd name="connsiteY7" fmla="*/ 378679 h 479899"/>
                  <a:gd name="connsiteX8" fmla="*/ 283 w 925272"/>
                  <a:gd name="connsiteY8" fmla="*/ 357772 h 479899"/>
                  <a:gd name="connsiteX0" fmla="*/ 283 w 925272"/>
                  <a:gd name="connsiteY0" fmla="*/ 357772 h 478527"/>
                  <a:gd name="connsiteX1" fmla="*/ 263891 w 925272"/>
                  <a:gd name="connsiteY1" fmla="*/ 48227 h 478527"/>
                  <a:gd name="connsiteX2" fmla="*/ 623863 w 925272"/>
                  <a:gd name="connsiteY2" fmla="*/ 39387 h 478527"/>
                  <a:gd name="connsiteX3" fmla="*/ 925272 w 925272"/>
                  <a:gd name="connsiteY3" fmla="*/ 421509 h 478527"/>
                  <a:gd name="connsiteX4" fmla="*/ 784939 w 925272"/>
                  <a:gd name="connsiteY4" fmla="*/ 477575 h 478527"/>
                  <a:gd name="connsiteX5" fmla="*/ 614360 w 925272"/>
                  <a:gd name="connsiteY5" fmla="*/ 239373 h 478527"/>
                  <a:gd name="connsiteX6" fmla="*/ 323181 w 925272"/>
                  <a:gd name="connsiteY6" fmla="*/ 221063 h 478527"/>
                  <a:gd name="connsiteX7" fmla="*/ 182089 w 925272"/>
                  <a:gd name="connsiteY7" fmla="*/ 378679 h 478527"/>
                  <a:gd name="connsiteX8" fmla="*/ 283 w 925272"/>
                  <a:gd name="connsiteY8" fmla="*/ 357772 h 478527"/>
                  <a:gd name="connsiteX0" fmla="*/ 283 w 925272"/>
                  <a:gd name="connsiteY0" fmla="*/ 357772 h 478527"/>
                  <a:gd name="connsiteX1" fmla="*/ 263891 w 925272"/>
                  <a:gd name="connsiteY1" fmla="*/ 48227 h 478527"/>
                  <a:gd name="connsiteX2" fmla="*/ 623863 w 925272"/>
                  <a:gd name="connsiteY2" fmla="*/ 39387 h 478527"/>
                  <a:gd name="connsiteX3" fmla="*/ 925272 w 925272"/>
                  <a:gd name="connsiteY3" fmla="*/ 421509 h 478527"/>
                  <a:gd name="connsiteX4" fmla="*/ 784939 w 925272"/>
                  <a:gd name="connsiteY4" fmla="*/ 477575 h 478527"/>
                  <a:gd name="connsiteX5" fmla="*/ 614360 w 925272"/>
                  <a:gd name="connsiteY5" fmla="*/ 239373 h 478527"/>
                  <a:gd name="connsiteX6" fmla="*/ 323181 w 925272"/>
                  <a:gd name="connsiteY6" fmla="*/ 221063 h 478527"/>
                  <a:gd name="connsiteX7" fmla="*/ 182089 w 925272"/>
                  <a:gd name="connsiteY7" fmla="*/ 378679 h 478527"/>
                  <a:gd name="connsiteX8" fmla="*/ 283 w 925272"/>
                  <a:gd name="connsiteY8" fmla="*/ 357772 h 478527"/>
                  <a:gd name="connsiteX0" fmla="*/ 283 w 925272"/>
                  <a:gd name="connsiteY0" fmla="*/ 357772 h 557834"/>
                  <a:gd name="connsiteX1" fmla="*/ 263891 w 925272"/>
                  <a:gd name="connsiteY1" fmla="*/ 48227 h 557834"/>
                  <a:gd name="connsiteX2" fmla="*/ 623863 w 925272"/>
                  <a:gd name="connsiteY2" fmla="*/ 39387 h 557834"/>
                  <a:gd name="connsiteX3" fmla="*/ 925272 w 925272"/>
                  <a:gd name="connsiteY3" fmla="*/ 421509 h 557834"/>
                  <a:gd name="connsiteX4" fmla="*/ 784939 w 925272"/>
                  <a:gd name="connsiteY4" fmla="*/ 477575 h 557834"/>
                  <a:gd name="connsiteX5" fmla="*/ 614360 w 925272"/>
                  <a:gd name="connsiteY5" fmla="*/ 239373 h 557834"/>
                  <a:gd name="connsiteX6" fmla="*/ 323181 w 925272"/>
                  <a:gd name="connsiteY6" fmla="*/ 221063 h 557834"/>
                  <a:gd name="connsiteX7" fmla="*/ 137577 w 925272"/>
                  <a:gd name="connsiteY7" fmla="*/ 551149 h 557834"/>
                  <a:gd name="connsiteX8" fmla="*/ 283 w 925272"/>
                  <a:gd name="connsiteY8" fmla="*/ 357772 h 557834"/>
                  <a:gd name="connsiteX0" fmla="*/ 283 w 925272"/>
                  <a:gd name="connsiteY0" fmla="*/ 357772 h 505215"/>
                  <a:gd name="connsiteX1" fmla="*/ 263891 w 925272"/>
                  <a:gd name="connsiteY1" fmla="*/ 48227 h 505215"/>
                  <a:gd name="connsiteX2" fmla="*/ 623863 w 925272"/>
                  <a:gd name="connsiteY2" fmla="*/ 39387 h 505215"/>
                  <a:gd name="connsiteX3" fmla="*/ 925272 w 925272"/>
                  <a:gd name="connsiteY3" fmla="*/ 421509 h 505215"/>
                  <a:gd name="connsiteX4" fmla="*/ 784939 w 925272"/>
                  <a:gd name="connsiteY4" fmla="*/ 477575 h 505215"/>
                  <a:gd name="connsiteX5" fmla="*/ 614360 w 925272"/>
                  <a:gd name="connsiteY5" fmla="*/ 239373 h 505215"/>
                  <a:gd name="connsiteX6" fmla="*/ 323181 w 925272"/>
                  <a:gd name="connsiteY6" fmla="*/ 221063 h 505215"/>
                  <a:gd name="connsiteX7" fmla="*/ 132607 w 925272"/>
                  <a:gd name="connsiteY7" fmla="*/ 496450 h 505215"/>
                  <a:gd name="connsiteX8" fmla="*/ 283 w 925272"/>
                  <a:gd name="connsiteY8" fmla="*/ 357772 h 505215"/>
                  <a:gd name="connsiteX0" fmla="*/ 257 w 947000"/>
                  <a:gd name="connsiteY0" fmla="*/ 468818 h 523249"/>
                  <a:gd name="connsiteX1" fmla="*/ 285619 w 947000"/>
                  <a:gd name="connsiteY1" fmla="*/ 54273 h 523249"/>
                  <a:gd name="connsiteX2" fmla="*/ 645591 w 947000"/>
                  <a:gd name="connsiteY2" fmla="*/ 45433 h 523249"/>
                  <a:gd name="connsiteX3" fmla="*/ 947000 w 947000"/>
                  <a:gd name="connsiteY3" fmla="*/ 427555 h 523249"/>
                  <a:gd name="connsiteX4" fmla="*/ 806667 w 947000"/>
                  <a:gd name="connsiteY4" fmla="*/ 483621 h 523249"/>
                  <a:gd name="connsiteX5" fmla="*/ 636088 w 947000"/>
                  <a:gd name="connsiteY5" fmla="*/ 245419 h 523249"/>
                  <a:gd name="connsiteX6" fmla="*/ 344909 w 947000"/>
                  <a:gd name="connsiteY6" fmla="*/ 227109 h 523249"/>
                  <a:gd name="connsiteX7" fmla="*/ 154335 w 947000"/>
                  <a:gd name="connsiteY7" fmla="*/ 502496 h 523249"/>
                  <a:gd name="connsiteX8" fmla="*/ 257 w 947000"/>
                  <a:gd name="connsiteY8" fmla="*/ 468818 h 523249"/>
                  <a:gd name="connsiteX0" fmla="*/ 257 w 947000"/>
                  <a:gd name="connsiteY0" fmla="*/ 468818 h 523249"/>
                  <a:gd name="connsiteX1" fmla="*/ 285619 w 947000"/>
                  <a:gd name="connsiteY1" fmla="*/ 54273 h 523249"/>
                  <a:gd name="connsiteX2" fmla="*/ 645591 w 947000"/>
                  <a:gd name="connsiteY2" fmla="*/ 45433 h 523249"/>
                  <a:gd name="connsiteX3" fmla="*/ 947000 w 947000"/>
                  <a:gd name="connsiteY3" fmla="*/ 427555 h 523249"/>
                  <a:gd name="connsiteX4" fmla="*/ 806667 w 947000"/>
                  <a:gd name="connsiteY4" fmla="*/ 483621 h 523249"/>
                  <a:gd name="connsiteX5" fmla="*/ 636088 w 947000"/>
                  <a:gd name="connsiteY5" fmla="*/ 245419 h 523249"/>
                  <a:gd name="connsiteX6" fmla="*/ 296839 w 947000"/>
                  <a:gd name="connsiteY6" fmla="*/ 254428 h 523249"/>
                  <a:gd name="connsiteX7" fmla="*/ 154335 w 947000"/>
                  <a:gd name="connsiteY7" fmla="*/ 502496 h 523249"/>
                  <a:gd name="connsiteX8" fmla="*/ 257 w 947000"/>
                  <a:gd name="connsiteY8" fmla="*/ 468818 h 523249"/>
                  <a:gd name="connsiteX0" fmla="*/ 257 w 947000"/>
                  <a:gd name="connsiteY0" fmla="*/ 468818 h 523249"/>
                  <a:gd name="connsiteX1" fmla="*/ 285619 w 947000"/>
                  <a:gd name="connsiteY1" fmla="*/ 54273 h 523249"/>
                  <a:gd name="connsiteX2" fmla="*/ 645591 w 947000"/>
                  <a:gd name="connsiteY2" fmla="*/ 45433 h 523249"/>
                  <a:gd name="connsiteX3" fmla="*/ 947000 w 947000"/>
                  <a:gd name="connsiteY3" fmla="*/ 427555 h 523249"/>
                  <a:gd name="connsiteX4" fmla="*/ 806667 w 947000"/>
                  <a:gd name="connsiteY4" fmla="*/ 483621 h 523249"/>
                  <a:gd name="connsiteX5" fmla="*/ 636088 w 947000"/>
                  <a:gd name="connsiteY5" fmla="*/ 245419 h 523249"/>
                  <a:gd name="connsiteX6" fmla="*/ 296839 w 947000"/>
                  <a:gd name="connsiteY6" fmla="*/ 254428 h 523249"/>
                  <a:gd name="connsiteX7" fmla="*/ 154335 w 947000"/>
                  <a:gd name="connsiteY7" fmla="*/ 502496 h 523249"/>
                  <a:gd name="connsiteX8" fmla="*/ 257 w 947000"/>
                  <a:gd name="connsiteY8" fmla="*/ 468818 h 523249"/>
                  <a:gd name="connsiteX0" fmla="*/ 257 w 947000"/>
                  <a:gd name="connsiteY0" fmla="*/ 468818 h 523249"/>
                  <a:gd name="connsiteX1" fmla="*/ 285619 w 947000"/>
                  <a:gd name="connsiteY1" fmla="*/ 54273 h 523249"/>
                  <a:gd name="connsiteX2" fmla="*/ 645591 w 947000"/>
                  <a:gd name="connsiteY2" fmla="*/ 45433 h 523249"/>
                  <a:gd name="connsiteX3" fmla="*/ 947000 w 947000"/>
                  <a:gd name="connsiteY3" fmla="*/ 427555 h 523249"/>
                  <a:gd name="connsiteX4" fmla="*/ 806667 w 947000"/>
                  <a:gd name="connsiteY4" fmla="*/ 483621 h 523249"/>
                  <a:gd name="connsiteX5" fmla="*/ 636088 w 947000"/>
                  <a:gd name="connsiteY5" fmla="*/ 245419 h 523249"/>
                  <a:gd name="connsiteX6" fmla="*/ 296839 w 947000"/>
                  <a:gd name="connsiteY6" fmla="*/ 254428 h 523249"/>
                  <a:gd name="connsiteX7" fmla="*/ 154335 w 947000"/>
                  <a:gd name="connsiteY7" fmla="*/ 502496 h 523249"/>
                  <a:gd name="connsiteX8" fmla="*/ 257 w 947000"/>
                  <a:gd name="connsiteY8" fmla="*/ 468818 h 523249"/>
                  <a:gd name="connsiteX0" fmla="*/ 257 w 947000"/>
                  <a:gd name="connsiteY0" fmla="*/ 468818 h 523249"/>
                  <a:gd name="connsiteX1" fmla="*/ 285619 w 947000"/>
                  <a:gd name="connsiteY1" fmla="*/ 54273 h 523249"/>
                  <a:gd name="connsiteX2" fmla="*/ 645591 w 947000"/>
                  <a:gd name="connsiteY2" fmla="*/ 45433 h 523249"/>
                  <a:gd name="connsiteX3" fmla="*/ 947000 w 947000"/>
                  <a:gd name="connsiteY3" fmla="*/ 427555 h 523249"/>
                  <a:gd name="connsiteX4" fmla="*/ 806667 w 947000"/>
                  <a:gd name="connsiteY4" fmla="*/ 483621 h 523249"/>
                  <a:gd name="connsiteX5" fmla="*/ 636088 w 947000"/>
                  <a:gd name="connsiteY5" fmla="*/ 245419 h 523249"/>
                  <a:gd name="connsiteX6" fmla="*/ 279943 w 947000"/>
                  <a:gd name="connsiteY6" fmla="*/ 193567 h 523249"/>
                  <a:gd name="connsiteX7" fmla="*/ 154335 w 947000"/>
                  <a:gd name="connsiteY7" fmla="*/ 502496 h 523249"/>
                  <a:gd name="connsiteX8" fmla="*/ 257 w 947000"/>
                  <a:gd name="connsiteY8" fmla="*/ 468818 h 523249"/>
                  <a:gd name="connsiteX0" fmla="*/ 257 w 947000"/>
                  <a:gd name="connsiteY0" fmla="*/ 468818 h 523249"/>
                  <a:gd name="connsiteX1" fmla="*/ 285619 w 947000"/>
                  <a:gd name="connsiteY1" fmla="*/ 54273 h 523249"/>
                  <a:gd name="connsiteX2" fmla="*/ 645591 w 947000"/>
                  <a:gd name="connsiteY2" fmla="*/ 45433 h 523249"/>
                  <a:gd name="connsiteX3" fmla="*/ 947000 w 947000"/>
                  <a:gd name="connsiteY3" fmla="*/ 427555 h 523249"/>
                  <a:gd name="connsiteX4" fmla="*/ 806667 w 947000"/>
                  <a:gd name="connsiteY4" fmla="*/ 483621 h 523249"/>
                  <a:gd name="connsiteX5" fmla="*/ 608824 w 947000"/>
                  <a:gd name="connsiteY5" fmla="*/ 152885 h 523249"/>
                  <a:gd name="connsiteX6" fmla="*/ 279943 w 947000"/>
                  <a:gd name="connsiteY6" fmla="*/ 193567 h 523249"/>
                  <a:gd name="connsiteX7" fmla="*/ 154335 w 947000"/>
                  <a:gd name="connsiteY7" fmla="*/ 502496 h 523249"/>
                  <a:gd name="connsiteX8" fmla="*/ 257 w 947000"/>
                  <a:gd name="connsiteY8" fmla="*/ 468818 h 523249"/>
                  <a:gd name="connsiteX0" fmla="*/ 313 w 947056"/>
                  <a:gd name="connsiteY0" fmla="*/ 503452 h 557883"/>
                  <a:gd name="connsiteX1" fmla="*/ 250832 w 947056"/>
                  <a:gd name="connsiteY1" fmla="*/ 35826 h 557883"/>
                  <a:gd name="connsiteX2" fmla="*/ 645647 w 947056"/>
                  <a:gd name="connsiteY2" fmla="*/ 80067 h 557883"/>
                  <a:gd name="connsiteX3" fmla="*/ 947056 w 947056"/>
                  <a:gd name="connsiteY3" fmla="*/ 462189 h 557883"/>
                  <a:gd name="connsiteX4" fmla="*/ 806723 w 947056"/>
                  <a:gd name="connsiteY4" fmla="*/ 518255 h 557883"/>
                  <a:gd name="connsiteX5" fmla="*/ 608880 w 947056"/>
                  <a:gd name="connsiteY5" fmla="*/ 187519 h 557883"/>
                  <a:gd name="connsiteX6" fmla="*/ 279999 w 947056"/>
                  <a:gd name="connsiteY6" fmla="*/ 228201 h 557883"/>
                  <a:gd name="connsiteX7" fmla="*/ 154391 w 947056"/>
                  <a:gd name="connsiteY7" fmla="*/ 537130 h 557883"/>
                  <a:gd name="connsiteX8" fmla="*/ 313 w 947056"/>
                  <a:gd name="connsiteY8" fmla="*/ 503452 h 557883"/>
                  <a:gd name="connsiteX0" fmla="*/ 329 w 947072"/>
                  <a:gd name="connsiteY0" fmla="*/ 540777 h 595208"/>
                  <a:gd name="connsiteX1" fmla="*/ 250848 w 947072"/>
                  <a:gd name="connsiteY1" fmla="*/ 73151 h 595208"/>
                  <a:gd name="connsiteX2" fmla="*/ 691733 w 947072"/>
                  <a:gd name="connsiteY2" fmla="*/ 44653 h 595208"/>
                  <a:gd name="connsiteX3" fmla="*/ 947072 w 947072"/>
                  <a:gd name="connsiteY3" fmla="*/ 499514 h 595208"/>
                  <a:gd name="connsiteX4" fmla="*/ 806739 w 947072"/>
                  <a:gd name="connsiteY4" fmla="*/ 555580 h 595208"/>
                  <a:gd name="connsiteX5" fmla="*/ 608896 w 947072"/>
                  <a:gd name="connsiteY5" fmla="*/ 224844 h 595208"/>
                  <a:gd name="connsiteX6" fmla="*/ 280015 w 947072"/>
                  <a:gd name="connsiteY6" fmla="*/ 265526 h 595208"/>
                  <a:gd name="connsiteX7" fmla="*/ 154407 w 947072"/>
                  <a:gd name="connsiteY7" fmla="*/ 574455 h 595208"/>
                  <a:gd name="connsiteX8" fmla="*/ 329 w 947072"/>
                  <a:gd name="connsiteY8" fmla="*/ 540777 h 595208"/>
                  <a:gd name="connsiteX0" fmla="*/ 329 w 947072"/>
                  <a:gd name="connsiteY0" fmla="*/ 540777 h 595208"/>
                  <a:gd name="connsiteX1" fmla="*/ 250848 w 947072"/>
                  <a:gd name="connsiteY1" fmla="*/ 73151 h 595208"/>
                  <a:gd name="connsiteX2" fmla="*/ 691733 w 947072"/>
                  <a:gd name="connsiteY2" fmla="*/ 44653 h 595208"/>
                  <a:gd name="connsiteX3" fmla="*/ 947072 w 947072"/>
                  <a:gd name="connsiteY3" fmla="*/ 499514 h 595208"/>
                  <a:gd name="connsiteX4" fmla="*/ 806739 w 947072"/>
                  <a:gd name="connsiteY4" fmla="*/ 555580 h 595208"/>
                  <a:gd name="connsiteX5" fmla="*/ 608896 w 947072"/>
                  <a:gd name="connsiteY5" fmla="*/ 224844 h 595208"/>
                  <a:gd name="connsiteX6" fmla="*/ 311460 w 947072"/>
                  <a:gd name="connsiteY6" fmla="*/ 186083 h 595208"/>
                  <a:gd name="connsiteX7" fmla="*/ 154407 w 947072"/>
                  <a:gd name="connsiteY7" fmla="*/ 574455 h 595208"/>
                  <a:gd name="connsiteX8" fmla="*/ 329 w 947072"/>
                  <a:gd name="connsiteY8" fmla="*/ 540777 h 595208"/>
                  <a:gd name="connsiteX0" fmla="*/ 329 w 947072"/>
                  <a:gd name="connsiteY0" fmla="*/ 540777 h 595208"/>
                  <a:gd name="connsiteX1" fmla="*/ 250848 w 947072"/>
                  <a:gd name="connsiteY1" fmla="*/ 73151 h 595208"/>
                  <a:gd name="connsiteX2" fmla="*/ 691733 w 947072"/>
                  <a:gd name="connsiteY2" fmla="*/ 44653 h 595208"/>
                  <a:gd name="connsiteX3" fmla="*/ 947072 w 947072"/>
                  <a:gd name="connsiteY3" fmla="*/ 499514 h 595208"/>
                  <a:gd name="connsiteX4" fmla="*/ 806739 w 947072"/>
                  <a:gd name="connsiteY4" fmla="*/ 555580 h 595208"/>
                  <a:gd name="connsiteX5" fmla="*/ 576648 w 947072"/>
                  <a:gd name="connsiteY5" fmla="*/ 154037 h 595208"/>
                  <a:gd name="connsiteX6" fmla="*/ 311460 w 947072"/>
                  <a:gd name="connsiteY6" fmla="*/ 186083 h 595208"/>
                  <a:gd name="connsiteX7" fmla="*/ 154407 w 947072"/>
                  <a:gd name="connsiteY7" fmla="*/ 574455 h 595208"/>
                  <a:gd name="connsiteX8" fmla="*/ 329 w 947072"/>
                  <a:gd name="connsiteY8" fmla="*/ 540777 h 595208"/>
                  <a:gd name="connsiteX0" fmla="*/ 350 w 947093"/>
                  <a:gd name="connsiteY0" fmla="*/ 563834 h 618265"/>
                  <a:gd name="connsiteX1" fmla="*/ 241437 w 947093"/>
                  <a:gd name="connsiteY1" fmla="*/ 54049 h 618265"/>
                  <a:gd name="connsiteX2" fmla="*/ 691754 w 947093"/>
                  <a:gd name="connsiteY2" fmla="*/ 67710 h 618265"/>
                  <a:gd name="connsiteX3" fmla="*/ 947093 w 947093"/>
                  <a:gd name="connsiteY3" fmla="*/ 522571 h 618265"/>
                  <a:gd name="connsiteX4" fmla="*/ 806760 w 947093"/>
                  <a:gd name="connsiteY4" fmla="*/ 578637 h 618265"/>
                  <a:gd name="connsiteX5" fmla="*/ 576669 w 947093"/>
                  <a:gd name="connsiteY5" fmla="*/ 177094 h 618265"/>
                  <a:gd name="connsiteX6" fmla="*/ 311481 w 947093"/>
                  <a:gd name="connsiteY6" fmla="*/ 209140 h 618265"/>
                  <a:gd name="connsiteX7" fmla="*/ 154428 w 947093"/>
                  <a:gd name="connsiteY7" fmla="*/ 597512 h 618265"/>
                  <a:gd name="connsiteX8" fmla="*/ 350 w 947093"/>
                  <a:gd name="connsiteY8" fmla="*/ 563834 h 618265"/>
                  <a:gd name="connsiteX0" fmla="*/ 359 w 947102"/>
                  <a:gd name="connsiteY0" fmla="*/ 592621 h 647052"/>
                  <a:gd name="connsiteX1" fmla="*/ 241446 w 947102"/>
                  <a:gd name="connsiteY1" fmla="*/ 82836 h 647052"/>
                  <a:gd name="connsiteX2" fmla="*/ 710339 w 947102"/>
                  <a:gd name="connsiteY2" fmla="*/ 47536 h 647052"/>
                  <a:gd name="connsiteX3" fmla="*/ 947102 w 947102"/>
                  <a:gd name="connsiteY3" fmla="*/ 551358 h 647052"/>
                  <a:gd name="connsiteX4" fmla="*/ 806769 w 947102"/>
                  <a:gd name="connsiteY4" fmla="*/ 607424 h 647052"/>
                  <a:gd name="connsiteX5" fmla="*/ 576678 w 947102"/>
                  <a:gd name="connsiteY5" fmla="*/ 205881 h 647052"/>
                  <a:gd name="connsiteX6" fmla="*/ 311490 w 947102"/>
                  <a:gd name="connsiteY6" fmla="*/ 237927 h 647052"/>
                  <a:gd name="connsiteX7" fmla="*/ 154437 w 947102"/>
                  <a:gd name="connsiteY7" fmla="*/ 626299 h 647052"/>
                  <a:gd name="connsiteX8" fmla="*/ 359 w 947102"/>
                  <a:gd name="connsiteY8" fmla="*/ 592621 h 647052"/>
                  <a:gd name="connsiteX0" fmla="*/ 359 w 947102"/>
                  <a:gd name="connsiteY0" fmla="*/ 592622 h 647053"/>
                  <a:gd name="connsiteX1" fmla="*/ 241446 w 947102"/>
                  <a:gd name="connsiteY1" fmla="*/ 82837 h 647053"/>
                  <a:gd name="connsiteX2" fmla="*/ 710339 w 947102"/>
                  <a:gd name="connsiteY2" fmla="*/ 47537 h 647053"/>
                  <a:gd name="connsiteX3" fmla="*/ 947102 w 947102"/>
                  <a:gd name="connsiteY3" fmla="*/ 551359 h 647053"/>
                  <a:gd name="connsiteX4" fmla="*/ 806769 w 947102"/>
                  <a:gd name="connsiteY4" fmla="*/ 607425 h 647053"/>
                  <a:gd name="connsiteX5" fmla="*/ 576678 w 947102"/>
                  <a:gd name="connsiteY5" fmla="*/ 205882 h 647053"/>
                  <a:gd name="connsiteX6" fmla="*/ 322279 w 947102"/>
                  <a:gd name="connsiteY6" fmla="*/ 242145 h 647053"/>
                  <a:gd name="connsiteX7" fmla="*/ 154437 w 947102"/>
                  <a:gd name="connsiteY7" fmla="*/ 626300 h 647053"/>
                  <a:gd name="connsiteX8" fmla="*/ 359 w 947102"/>
                  <a:gd name="connsiteY8" fmla="*/ 592622 h 647053"/>
                  <a:gd name="connsiteX0" fmla="*/ 359 w 947102"/>
                  <a:gd name="connsiteY0" fmla="*/ 592622 h 647053"/>
                  <a:gd name="connsiteX1" fmla="*/ 241446 w 947102"/>
                  <a:gd name="connsiteY1" fmla="*/ 82837 h 647053"/>
                  <a:gd name="connsiteX2" fmla="*/ 710339 w 947102"/>
                  <a:gd name="connsiteY2" fmla="*/ 47537 h 647053"/>
                  <a:gd name="connsiteX3" fmla="*/ 947102 w 947102"/>
                  <a:gd name="connsiteY3" fmla="*/ 551359 h 647053"/>
                  <a:gd name="connsiteX4" fmla="*/ 806769 w 947102"/>
                  <a:gd name="connsiteY4" fmla="*/ 607425 h 647053"/>
                  <a:gd name="connsiteX5" fmla="*/ 558525 w 947102"/>
                  <a:gd name="connsiteY5" fmla="*/ 227392 h 647053"/>
                  <a:gd name="connsiteX6" fmla="*/ 322279 w 947102"/>
                  <a:gd name="connsiteY6" fmla="*/ 242145 h 647053"/>
                  <a:gd name="connsiteX7" fmla="*/ 154437 w 947102"/>
                  <a:gd name="connsiteY7" fmla="*/ 626300 h 647053"/>
                  <a:gd name="connsiteX8" fmla="*/ 359 w 947102"/>
                  <a:gd name="connsiteY8" fmla="*/ 592622 h 647053"/>
                  <a:gd name="connsiteX0" fmla="*/ 359 w 947102"/>
                  <a:gd name="connsiteY0" fmla="*/ 592622 h 647053"/>
                  <a:gd name="connsiteX1" fmla="*/ 241446 w 947102"/>
                  <a:gd name="connsiteY1" fmla="*/ 82837 h 647053"/>
                  <a:gd name="connsiteX2" fmla="*/ 710339 w 947102"/>
                  <a:gd name="connsiteY2" fmla="*/ 47537 h 647053"/>
                  <a:gd name="connsiteX3" fmla="*/ 947102 w 947102"/>
                  <a:gd name="connsiteY3" fmla="*/ 551359 h 647053"/>
                  <a:gd name="connsiteX4" fmla="*/ 806769 w 947102"/>
                  <a:gd name="connsiteY4" fmla="*/ 607425 h 647053"/>
                  <a:gd name="connsiteX5" fmla="*/ 578131 w 947102"/>
                  <a:gd name="connsiteY5" fmla="*/ 212367 h 647053"/>
                  <a:gd name="connsiteX6" fmla="*/ 322279 w 947102"/>
                  <a:gd name="connsiteY6" fmla="*/ 242145 h 647053"/>
                  <a:gd name="connsiteX7" fmla="*/ 154437 w 947102"/>
                  <a:gd name="connsiteY7" fmla="*/ 626300 h 647053"/>
                  <a:gd name="connsiteX8" fmla="*/ 359 w 947102"/>
                  <a:gd name="connsiteY8" fmla="*/ 592622 h 647053"/>
                  <a:gd name="connsiteX0" fmla="*/ 359 w 947102"/>
                  <a:gd name="connsiteY0" fmla="*/ 592622 h 647053"/>
                  <a:gd name="connsiteX1" fmla="*/ 241446 w 947102"/>
                  <a:gd name="connsiteY1" fmla="*/ 82837 h 647053"/>
                  <a:gd name="connsiteX2" fmla="*/ 710339 w 947102"/>
                  <a:gd name="connsiteY2" fmla="*/ 47537 h 647053"/>
                  <a:gd name="connsiteX3" fmla="*/ 947102 w 947102"/>
                  <a:gd name="connsiteY3" fmla="*/ 551359 h 647053"/>
                  <a:gd name="connsiteX4" fmla="*/ 806769 w 947102"/>
                  <a:gd name="connsiteY4" fmla="*/ 607425 h 647053"/>
                  <a:gd name="connsiteX5" fmla="*/ 588192 w 947102"/>
                  <a:gd name="connsiteY5" fmla="*/ 213340 h 647053"/>
                  <a:gd name="connsiteX6" fmla="*/ 322279 w 947102"/>
                  <a:gd name="connsiteY6" fmla="*/ 242145 h 647053"/>
                  <a:gd name="connsiteX7" fmla="*/ 154437 w 947102"/>
                  <a:gd name="connsiteY7" fmla="*/ 626300 h 647053"/>
                  <a:gd name="connsiteX8" fmla="*/ 359 w 947102"/>
                  <a:gd name="connsiteY8" fmla="*/ 592622 h 647053"/>
                  <a:gd name="connsiteX0" fmla="*/ 351 w 947094"/>
                  <a:gd name="connsiteY0" fmla="*/ 658398 h 712829"/>
                  <a:gd name="connsiteX1" fmla="*/ 244933 w 947094"/>
                  <a:gd name="connsiteY1" fmla="*/ 43534 h 712829"/>
                  <a:gd name="connsiteX2" fmla="*/ 710331 w 947094"/>
                  <a:gd name="connsiteY2" fmla="*/ 113313 h 712829"/>
                  <a:gd name="connsiteX3" fmla="*/ 947094 w 947094"/>
                  <a:gd name="connsiteY3" fmla="*/ 617135 h 712829"/>
                  <a:gd name="connsiteX4" fmla="*/ 806761 w 947094"/>
                  <a:gd name="connsiteY4" fmla="*/ 673201 h 712829"/>
                  <a:gd name="connsiteX5" fmla="*/ 588184 w 947094"/>
                  <a:gd name="connsiteY5" fmla="*/ 279116 h 712829"/>
                  <a:gd name="connsiteX6" fmla="*/ 322271 w 947094"/>
                  <a:gd name="connsiteY6" fmla="*/ 307921 h 712829"/>
                  <a:gd name="connsiteX7" fmla="*/ 154429 w 947094"/>
                  <a:gd name="connsiteY7" fmla="*/ 692076 h 712829"/>
                  <a:gd name="connsiteX8" fmla="*/ 351 w 947094"/>
                  <a:gd name="connsiteY8" fmla="*/ 658398 h 712829"/>
                  <a:gd name="connsiteX0" fmla="*/ 350 w 947093"/>
                  <a:gd name="connsiteY0" fmla="*/ 697187 h 751618"/>
                  <a:gd name="connsiteX1" fmla="*/ 244932 w 947093"/>
                  <a:gd name="connsiteY1" fmla="*/ 82323 h 751618"/>
                  <a:gd name="connsiteX2" fmla="*/ 707346 w 947093"/>
                  <a:gd name="connsiteY2" fmla="*/ 68315 h 751618"/>
                  <a:gd name="connsiteX3" fmla="*/ 947093 w 947093"/>
                  <a:gd name="connsiteY3" fmla="*/ 655924 h 751618"/>
                  <a:gd name="connsiteX4" fmla="*/ 806760 w 947093"/>
                  <a:gd name="connsiteY4" fmla="*/ 711990 h 751618"/>
                  <a:gd name="connsiteX5" fmla="*/ 588183 w 947093"/>
                  <a:gd name="connsiteY5" fmla="*/ 317905 h 751618"/>
                  <a:gd name="connsiteX6" fmla="*/ 322270 w 947093"/>
                  <a:gd name="connsiteY6" fmla="*/ 346710 h 751618"/>
                  <a:gd name="connsiteX7" fmla="*/ 154428 w 947093"/>
                  <a:gd name="connsiteY7" fmla="*/ 730865 h 751618"/>
                  <a:gd name="connsiteX8" fmla="*/ 350 w 947093"/>
                  <a:gd name="connsiteY8" fmla="*/ 697187 h 751618"/>
                  <a:gd name="connsiteX0" fmla="*/ 350 w 947093"/>
                  <a:gd name="connsiteY0" fmla="*/ 697187 h 751618"/>
                  <a:gd name="connsiteX1" fmla="*/ 244932 w 947093"/>
                  <a:gd name="connsiteY1" fmla="*/ 82323 h 751618"/>
                  <a:gd name="connsiteX2" fmla="*/ 707346 w 947093"/>
                  <a:gd name="connsiteY2" fmla="*/ 68315 h 751618"/>
                  <a:gd name="connsiteX3" fmla="*/ 947093 w 947093"/>
                  <a:gd name="connsiteY3" fmla="*/ 655924 h 751618"/>
                  <a:gd name="connsiteX4" fmla="*/ 806760 w 947093"/>
                  <a:gd name="connsiteY4" fmla="*/ 711990 h 751618"/>
                  <a:gd name="connsiteX5" fmla="*/ 588183 w 947093"/>
                  <a:gd name="connsiteY5" fmla="*/ 317905 h 751618"/>
                  <a:gd name="connsiteX6" fmla="*/ 360818 w 947093"/>
                  <a:gd name="connsiteY6" fmla="*/ 259462 h 751618"/>
                  <a:gd name="connsiteX7" fmla="*/ 154428 w 947093"/>
                  <a:gd name="connsiteY7" fmla="*/ 730865 h 751618"/>
                  <a:gd name="connsiteX8" fmla="*/ 350 w 947093"/>
                  <a:gd name="connsiteY8" fmla="*/ 697187 h 751618"/>
                  <a:gd name="connsiteX0" fmla="*/ 350 w 947093"/>
                  <a:gd name="connsiteY0" fmla="*/ 697187 h 751618"/>
                  <a:gd name="connsiteX1" fmla="*/ 244932 w 947093"/>
                  <a:gd name="connsiteY1" fmla="*/ 82323 h 751618"/>
                  <a:gd name="connsiteX2" fmla="*/ 707346 w 947093"/>
                  <a:gd name="connsiteY2" fmla="*/ 68315 h 751618"/>
                  <a:gd name="connsiteX3" fmla="*/ 947093 w 947093"/>
                  <a:gd name="connsiteY3" fmla="*/ 655924 h 751618"/>
                  <a:gd name="connsiteX4" fmla="*/ 806760 w 947093"/>
                  <a:gd name="connsiteY4" fmla="*/ 711990 h 751618"/>
                  <a:gd name="connsiteX5" fmla="*/ 643341 w 947093"/>
                  <a:gd name="connsiteY5" fmla="*/ 254897 h 751618"/>
                  <a:gd name="connsiteX6" fmla="*/ 360818 w 947093"/>
                  <a:gd name="connsiteY6" fmla="*/ 259462 h 751618"/>
                  <a:gd name="connsiteX7" fmla="*/ 154428 w 947093"/>
                  <a:gd name="connsiteY7" fmla="*/ 730865 h 751618"/>
                  <a:gd name="connsiteX8" fmla="*/ 350 w 947093"/>
                  <a:gd name="connsiteY8" fmla="*/ 697187 h 751618"/>
                  <a:gd name="connsiteX0" fmla="*/ 350 w 947093"/>
                  <a:gd name="connsiteY0" fmla="*/ 697187 h 751618"/>
                  <a:gd name="connsiteX1" fmla="*/ 244932 w 947093"/>
                  <a:gd name="connsiteY1" fmla="*/ 82323 h 751618"/>
                  <a:gd name="connsiteX2" fmla="*/ 707346 w 947093"/>
                  <a:gd name="connsiteY2" fmla="*/ 68315 h 751618"/>
                  <a:gd name="connsiteX3" fmla="*/ 947093 w 947093"/>
                  <a:gd name="connsiteY3" fmla="*/ 655924 h 751618"/>
                  <a:gd name="connsiteX4" fmla="*/ 806760 w 947093"/>
                  <a:gd name="connsiteY4" fmla="*/ 711990 h 751618"/>
                  <a:gd name="connsiteX5" fmla="*/ 643341 w 947093"/>
                  <a:gd name="connsiteY5" fmla="*/ 254897 h 751618"/>
                  <a:gd name="connsiteX6" fmla="*/ 346368 w 947093"/>
                  <a:gd name="connsiteY6" fmla="*/ 228128 h 751618"/>
                  <a:gd name="connsiteX7" fmla="*/ 154428 w 947093"/>
                  <a:gd name="connsiteY7" fmla="*/ 730865 h 751618"/>
                  <a:gd name="connsiteX8" fmla="*/ 350 w 947093"/>
                  <a:gd name="connsiteY8" fmla="*/ 697187 h 751618"/>
                  <a:gd name="connsiteX0" fmla="*/ 350 w 947093"/>
                  <a:gd name="connsiteY0" fmla="*/ 697187 h 751618"/>
                  <a:gd name="connsiteX1" fmla="*/ 244932 w 947093"/>
                  <a:gd name="connsiteY1" fmla="*/ 82323 h 751618"/>
                  <a:gd name="connsiteX2" fmla="*/ 707346 w 947093"/>
                  <a:gd name="connsiteY2" fmla="*/ 68315 h 751618"/>
                  <a:gd name="connsiteX3" fmla="*/ 947093 w 947093"/>
                  <a:gd name="connsiteY3" fmla="*/ 655924 h 751618"/>
                  <a:gd name="connsiteX4" fmla="*/ 821380 w 947093"/>
                  <a:gd name="connsiteY4" fmla="*/ 723070 h 751618"/>
                  <a:gd name="connsiteX5" fmla="*/ 643341 w 947093"/>
                  <a:gd name="connsiteY5" fmla="*/ 254897 h 751618"/>
                  <a:gd name="connsiteX6" fmla="*/ 346368 w 947093"/>
                  <a:gd name="connsiteY6" fmla="*/ 228128 h 751618"/>
                  <a:gd name="connsiteX7" fmla="*/ 154428 w 947093"/>
                  <a:gd name="connsiteY7" fmla="*/ 730865 h 751618"/>
                  <a:gd name="connsiteX8" fmla="*/ 350 w 947093"/>
                  <a:gd name="connsiteY8" fmla="*/ 697187 h 751618"/>
                  <a:gd name="connsiteX0" fmla="*/ 350 w 947093"/>
                  <a:gd name="connsiteY0" fmla="*/ 697187 h 751618"/>
                  <a:gd name="connsiteX1" fmla="*/ 244932 w 947093"/>
                  <a:gd name="connsiteY1" fmla="*/ 82323 h 751618"/>
                  <a:gd name="connsiteX2" fmla="*/ 707346 w 947093"/>
                  <a:gd name="connsiteY2" fmla="*/ 68315 h 751618"/>
                  <a:gd name="connsiteX3" fmla="*/ 947093 w 947093"/>
                  <a:gd name="connsiteY3" fmla="*/ 655924 h 751618"/>
                  <a:gd name="connsiteX4" fmla="*/ 821380 w 947093"/>
                  <a:gd name="connsiteY4" fmla="*/ 723070 h 751618"/>
                  <a:gd name="connsiteX5" fmla="*/ 643341 w 947093"/>
                  <a:gd name="connsiteY5" fmla="*/ 254897 h 751618"/>
                  <a:gd name="connsiteX6" fmla="*/ 346368 w 947093"/>
                  <a:gd name="connsiteY6" fmla="*/ 228128 h 751618"/>
                  <a:gd name="connsiteX7" fmla="*/ 154428 w 947093"/>
                  <a:gd name="connsiteY7" fmla="*/ 730865 h 751618"/>
                  <a:gd name="connsiteX8" fmla="*/ 350 w 947093"/>
                  <a:gd name="connsiteY8" fmla="*/ 697187 h 751618"/>
                  <a:gd name="connsiteX0" fmla="*/ 350 w 947093"/>
                  <a:gd name="connsiteY0" fmla="*/ 697187 h 751618"/>
                  <a:gd name="connsiteX1" fmla="*/ 244932 w 947093"/>
                  <a:gd name="connsiteY1" fmla="*/ 82323 h 751618"/>
                  <a:gd name="connsiteX2" fmla="*/ 707346 w 947093"/>
                  <a:gd name="connsiteY2" fmla="*/ 68315 h 751618"/>
                  <a:gd name="connsiteX3" fmla="*/ 947093 w 947093"/>
                  <a:gd name="connsiteY3" fmla="*/ 655924 h 751618"/>
                  <a:gd name="connsiteX4" fmla="*/ 821380 w 947093"/>
                  <a:gd name="connsiteY4" fmla="*/ 723070 h 751618"/>
                  <a:gd name="connsiteX5" fmla="*/ 643341 w 947093"/>
                  <a:gd name="connsiteY5" fmla="*/ 254897 h 751618"/>
                  <a:gd name="connsiteX6" fmla="*/ 346368 w 947093"/>
                  <a:gd name="connsiteY6" fmla="*/ 228128 h 751618"/>
                  <a:gd name="connsiteX7" fmla="*/ 154428 w 947093"/>
                  <a:gd name="connsiteY7" fmla="*/ 730865 h 751618"/>
                  <a:gd name="connsiteX8" fmla="*/ 350 w 947093"/>
                  <a:gd name="connsiteY8" fmla="*/ 697187 h 751618"/>
                  <a:gd name="connsiteX0" fmla="*/ 350 w 947093"/>
                  <a:gd name="connsiteY0" fmla="*/ 697187 h 751618"/>
                  <a:gd name="connsiteX1" fmla="*/ 244932 w 947093"/>
                  <a:gd name="connsiteY1" fmla="*/ 82323 h 751618"/>
                  <a:gd name="connsiteX2" fmla="*/ 707346 w 947093"/>
                  <a:gd name="connsiteY2" fmla="*/ 68315 h 751618"/>
                  <a:gd name="connsiteX3" fmla="*/ 947093 w 947093"/>
                  <a:gd name="connsiteY3" fmla="*/ 655924 h 751618"/>
                  <a:gd name="connsiteX4" fmla="*/ 821380 w 947093"/>
                  <a:gd name="connsiteY4" fmla="*/ 723070 h 751618"/>
                  <a:gd name="connsiteX5" fmla="*/ 643341 w 947093"/>
                  <a:gd name="connsiteY5" fmla="*/ 254897 h 751618"/>
                  <a:gd name="connsiteX6" fmla="*/ 281080 w 947093"/>
                  <a:gd name="connsiteY6" fmla="*/ 245606 h 751618"/>
                  <a:gd name="connsiteX7" fmla="*/ 154428 w 947093"/>
                  <a:gd name="connsiteY7" fmla="*/ 730865 h 751618"/>
                  <a:gd name="connsiteX8" fmla="*/ 350 w 947093"/>
                  <a:gd name="connsiteY8" fmla="*/ 697187 h 751618"/>
                  <a:gd name="connsiteX0" fmla="*/ 350 w 947093"/>
                  <a:gd name="connsiteY0" fmla="*/ 697187 h 751618"/>
                  <a:gd name="connsiteX1" fmla="*/ 244932 w 947093"/>
                  <a:gd name="connsiteY1" fmla="*/ 82323 h 751618"/>
                  <a:gd name="connsiteX2" fmla="*/ 707346 w 947093"/>
                  <a:gd name="connsiteY2" fmla="*/ 68315 h 751618"/>
                  <a:gd name="connsiteX3" fmla="*/ 947093 w 947093"/>
                  <a:gd name="connsiteY3" fmla="*/ 655924 h 751618"/>
                  <a:gd name="connsiteX4" fmla="*/ 821380 w 947093"/>
                  <a:gd name="connsiteY4" fmla="*/ 723070 h 751618"/>
                  <a:gd name="connsiteX5" fmla="*/ 643341 w 947093"/>
                  <a:gd name="connsiteY5" fmla="*/ 254897 h 751618"/>
                  <a:gd name="connsiteX6" fmla="*/ 414939 w 947093"/>
                  <a:gd name="connsiteY6" fmla="*/ 207000 h 751618"/>
                  <a:gd name="connsiteX7" fmla="*/ 281080 w 947093"/>
                  <a:gd name="connsiteY7" fmla="*/ 245606 h 751618"/>
                  <a:gd name="connsiteX8" fmla="*/ 154428 w 947093"/>
                  <a:gd name="connsiteY8" fmla="*/ 730865 h 751618"/>
                  <a:gd name="connsiteX9" fmla="*/ 350 w 947093"/>
                  <a:gd name="connsiteY9" fmla="*/ 697187 h 751618"/>
                  <a:gd name="connsiteX0" fmla="*/ 350 w 947093"/>
                  <a:gd name="connsiteY0" fmla="*/ 697187 h 751618"/>
                  <a:gd name="connsiteX1" fmla="*/ 244932 w 947093"/>
                  <a:gd name="connsiteY1" fmla="*/ 82323 h 751618"/>
                  <a:gd name="connsiteX2" fmla="*/ 707346 w 947093"/>
                  <a:gd name="connsiteY2" fmla="*/ 68315 h 751618"/>
                  <a:gd name="connsiteX3" fmla="*/ 947093 w 947093"/>
                  <a:gd name="connsiteY3" fmla="*/ 655924 h 751618"/>
                  <a:gd name="connsiteX4" fmla="*/ 821380 w 947093"/>
                  <a:gd name="connsiteY4" fmla="*/ 723070 h 751618"/>
                  <a:gd name="connsiteX5" fmla="*/ 643341 w 947093"/>
                  <a:gd name="connsiteY5" fmla="*/ 254897 h 751618"/>
                  <a:gd name="connsiteX6" fmla="*/ 436876 w 947093"/>
                  <a:gd name="connsiteY6" fmla="*/ 95516 h 751618"/>
                  <a:gd name="connsiteX7" fmla="*/ 281080 w 947093"/>
                  <a:gd name="connsiteY7" fmla="*/ 245606 h 751618"/>
                  <a:gd name="connsiteX8" fmla="*/ 154428 w 947093"/>
                  <a:gd name="connsiteY8" fmla="*/ 730865 h 751618"/>
                  <a:gd name="connsiteX9" fmla="*/ 350 w 947093"/>
                  <a:gd name="connsiteY9" fmla="*/ 697187 h 751618"/>
                  <a:gd name="connsiteX0" fmla="*/ 350 w 947093"/>
                  <a:gd name="connsiteY0" fmla="*/ 702809 h 757240"/>
                  <a:gd name="connsiteX1" fmla="*/ 244932 w 947093"/>
                  <a:gd name="connsiteY1" fmla="*/ 87945 h 757240"/>
                  <a:gd name="connsiteX2" fmla="*/ 416616 w 947093"/>
                  <a:gd name="connsiteY2" fmla="*/ 10077 h 757240"/>
                  <a:gd name="connsiteX3" fmla="*/ 707346 w 947093"/>
                  <a:gd name="connsiteY3" fmla="*/ 73937 h 757240"/>
                  <a:gd name="connsiteX4" fmla="*/ 947093 w 947093"/>
                  <a:gd name="connsiteY4" fmla="*/ 661546 h 757240"/>
                  <a:gd name="connsiteX5" fmla="*/ 821380 w 947093"/>
                  <a:gd name="connsiteY5" fmla="*/ 728692 h 757240"/>
                  <a:gd name="connsiteX6" fmla="*/ 643341 w 947093"/>
                  <a:gd name="connsiteY6" fmla="*/ 260519 h 757240"/>
                  <a:gd name="connsiteX7" fmla="*/ 436876 w 947093"/>
                  <a:gd name="connsiteY7" fmla="*/ 101138 h 757240"/>
                  <a:gd name="connsiteX8" fmla="*/ 281080 w 947093"/>
                  <a:gd name="connsiteY8" fmla="*/ 251228 h 757240"/>
                  <a:gd name="connsiteX9" fmla="*/ 154428 w 947093"/>
                  <a:gd name="connsiteY9" fmla="*/ 736487 h 757240"/>
                  <a:gd name="connsiteX10" fmla="*/ 350 w 947093"/>
                  <a:gd name="connsiteY10" fmla="*/ 702809 h 757240"/>
                  <a:gd name="connsiteX0" fmla="*/ 263 w 947006"/>
                  <a:gd name="connsiteY0" fmla="*/ 859139 h 913570"/>
                  <a:gd name="connsiteX1" fmla="*/ 244845 w 947006"/>
                  <a:gd name="connsiteY1" fmla="*/ 244275 h 913570"/>
                  <a:gd name="connsiteX2" fmla="*/ 423685 w 947006"/>
                  <a:gd name="connsiteY2" fmla="*/ 42 h 913570"/>
                  <a:gd name="connsiteX3" fmla="*/ 707259 w 947006"/>
                  <a:gd name="connsiteY3" fmla="*/ 230267 h 913570"/>
                  <a:gd name="connsiteX4" fmla="*/ 947006 w 947006"/>
                  <a:gd name="connsiteY4" fmla="*/ 817876 h 913570"/>
                  <a:gd name="connsiteX5" fmla="*/ 821293 w 947006"/>
                  <a:gd name="connsiteY5" fmla="*/ 885022 h 913570"/>
                  <a:gd name="connsiteX6" fmla="*/ 643254 w 947006"/>
                  <a:gd name="connsiteY6" fmla="*/ 416849 h 913570"/>
                  <a:gd name="connsiteX7" fmla="*/ 436789 w 947006"/>
                  <a:gd name="connsiteY7" fmla="*/ 257468 h 913570"/>
                  <a:gd name="connsiteX8" fmla="*/ 280993 w 947006"/>
                  <a:gd name="connsiteY8" fmla="*/ 407558 h 913570"/>
                  <a:gd name="connsiteX9" fmla="*/ 154341 w 947006"/>
                  <a:gd name="connsiteY9" fmla="*/ 892817 h 913570"/>
                  <a:gd name="connsiteX10" fmla="*/ 263 w 947006"/>
                  <a:gd name="connsiteY10" fmla="*/ 859139 h 913570"/>
                  <a:gd name="connsiteX0" fmla="*/ 263 w 947006"/>
                  <a:gd name="connsiteY0" fmla="*/ 859139 h 913570"/>
                  <a:gd name="connsiteX1" fmla="*/ 244845 w 947006"/>
                  <a:gd name="connsiteY1" fmla="*/ 244275 h 913570"/>
                  <a:gd name="connsiteX2" fmla="*/ 423685 w 947006"/>
                  <a:gd name="connsiteY2" fmla="*/ 42 h 913570"/>
                  <a:gd name="connsiteX3" fmla="*/ 707259 w 947006"/>
                  <a:gd name="connsiteY3" fmla="*/ 230267 h 913570"/>
                  <a:gd name="connsiteX4" fmla="*/ 947006 w 947006"/>
                  <a:gd name="connsiteY4" fmla="*/ 817876 h 913570"/>
                  <a:gd name="connsiteX5" fmla="*/ 821293 w 947006"/>
                  <a:gd name="connsiteY5" fmla="*/ 885022 h 913570"/>
                  <a:gd name="connsiteX6" fmla="*/ 643254 w 947006"/>
                  <a:gd name="connsiteY6" fmla="*/ 416849 h 913570"/>
                  <a:gd name="connsiteX7" fmla="*/ 438457 w 947006"/>
                  <a:gd name="connsiteY7" fmla="*/ 183029 h 913570"/>
                  <a:gd name="connsiteX8" fmla="*/ 280993 w 947006"/>
                  <a:gd name="connsiteY8" fmla="*/ 407558 h 913570"/>
                  <a:gd name="connsiteX9" fmla="*/ 154341 w 947006"/>
                  <a:gd name="connsiteY9" fmla="*/ 892817 h 913570"/>
                  <a:gd name="connsiteX10" fmla="*/ 263 w 947006"/>
                  <a:gd name="connsiteY10" fmla="*/ 859139 h 913570"/>
                  <a:gd name="connsiteX0" fmla="*/ 535 w 947278"/>
                  <a:gd name="connsiteY0" fmla="*/ 859139 h 913570"/>
                  <a:gd name="connsiteX1" fmla="*/ 148601 w 947278"/>
                  <a:gd name="connsiteY1" fmla="*/ 226437 h 913570"/>
                  <a:gd name="connsiteX2" fmla="*/ 423957 w 947278"/>
                  <a:gd name="connsiteY2" fmla="*/ 42 h 913570"/>
                  <a:gd name="connsiteX3" fmla="*/ 707531 w 947278"/>
                  <a:gd name="connsiteY3" fmla="*/ 230267 h 913570"/>
                  <a:gd name="connsiteX4" fmla="*/ 947278 w 947278"/>
                  <a:gd name="connsiteY4" fmla="*/ 817876 h 913570"/>
                  <a:gd name="connsiteX5" fmla="*/ 821565 w 947278"/>
                  <a:gd name="connsiteY5" fmla="*/ 885022 h 913570"/>
                  <a:gd name="connsiteX6" fmla="*/ 643526 w 947278"/>
                  <a:gd name="connsiteY6" fmla="*/ 416849 h 913570"/>
                  <a:gd name="connsiteX7" fmla="*/ 438729 w 947278"/>
                  <a:gd name="connsiteY7" fmla="*/ 183029 h 913570"/>
                  <a:gd name="connsiteX8" fmla="*/ 281265 w 947278"/>
                  <a:gd name="connsiteY8" fmla="*/ 407558 h 913570"/>
                  <a:gd name="connsiteX9" fmla="*/ 154613 w 947278"/>
                  <a:gd name="connsiteY9" fmla="*/ 892817 h 913570"/>
                  <a:gd name="connsiteX10" fmla="*/ 535 w 947278"/>
                  <a:gd name="connsiteY10" fmla="*/ 859139 h 913570"/>
                  <a:gd name="connsiteX0" fmla="*/ 536 w 947279"/>
                  <a:gd name="connsiteY0" fmla="*/ 859142 h 913573"/>
                  <a:gd name="connsiteX1" fmla="*/ 148602 w 947279"/>
                  <a:gd name="connsiteY1" fmla="*/ 226440 h 913573"/>
                  <a:gd name="connsiteX2" fmla="*/ 423958 w 947279"/>
                  <a:gd name="connsiteY2" fmla="*/ 45 h 913573"/>
                  <a:gd name="connsiteX3" fmla="*/ 722319 w 947279"/>
                  <a:gd name="connsiteY3" fmla="*/ 221097 h 913573"/>
                  <a:gd name="connsiteX4" fmla="*/ 947279 w 947279"/>
                  <a:gd name="connsiteY4" fmla="*/ 817879 h 913573"/>
                  <a:gd name="connsiteX5" fmla="*/ 821566 w 947279"/>
                  <a:gd name="connsiteY5" fmla="*/ 885025 h 913573"/>
                  <a:gd name="connsiteX6" fmla="*/ 643527 w 947279"/>
                  <a:gd name="connsiteY6" fmla="*/ 416852 h 913573"/>
                  <a:gd name="connsiteX7" fmla="*/ 438730 w 947279"/>
                  <a:gd name="connsiteY7" fmla="*/ 183032 h 913573"/>
                  <a:gd name="connsiteX8" fmla="*/ 281266 w 947279"/>
                  <a:gd name="connsiteY8" fmla="*/ 407561 h 913573"/>
                  <a:gd name="connsiteX9" fmla="*/ 154614 w 947279"/>
                  <a:gd name="connsiteY9" fmla="*/ 892820 h 913573"/>
                  <a:gd name="connsiteX10" fmla="*/ 536 w 947279"/>
                  <a:gd name="connsiteY10" fmla="*/ 859142 h 913573"/>
                  <a:gd name="connsiteX0" fmla="*/ 536 w 947279"/>
                  <a:gd name="connsiteY0" fmla="*/ 859142 h 913573"/>
                  <a:gd name="connsiteX1" fmla="*/ 148602 w 947279"/>
                  <a:gd name="connsiteY1" fmla="*/ 226440 h 913573"/>
                  <a:gd name="connsiteX2" fmla="*/ 423958 w 947279"/>
                  <a:gd name="connsiteY2" fmla="*/ 45 h 913573"/>
                  <a:gd name="connsiteX3" fmla="*/ 722319 w 947279"/>
                  <a:gd name="connsiteY3" fmla="*/ 221097 h 913573"/>
                  <a:gd name="connsiteX4" fmla="*/ 947279 w 947279"/>
                  <a:gd name="connsiteY4" fmla="*/ 817879 h 913573"/>
                  <a:gd name="connsiteX5" fmla="*/ 821566 w 947279"/>
                  <a:gd name="connsiteY5" fmla="*/ 885025 h 913573"/>
                  <a:gd name="connsiteX6" fmla="*/ 606489 w 947279"/>
                  <a:gd name="connsiteY6" fmla="*/ 321808 h 913573"/>
                  <a:gd name="connsiteX7" fmla="*/ 438730 w 947279"/>
                  <a:gd name="connsiteY7" fmla="*/ 183032 h 913573"/>
                  <a:gd name="connsiteX8" fmla="*/ 281266 w 947279"/>
                  <a:gd name="connsiteY8" fmla="*/ 407561 h 913573"/>
                  <a:gd name="connsiteX9" fmla="*/ 154614 w 947279"/>
                  <a:gd name="connsiteY9" fmla="*/ 892820 h 913573"/>
                  <a:gd name="connsiteX10" fmla="*/ 536 w 947279"/>
                  <a:gd name="connsiteY10" fmla="*/ 859142 h 913573"/>
                  <a:gd name="connsiteX0" fmla="*/ 536 w 947279"/>
                  <a:gd name="connsiteY0" fmla="*/ 859142 h 913573"/>
                  <a:gd name="connsiteX1" fmla="*/ 148602 w 947279"/>
                  <a:gd name="connsiteY1" fmla="*/ 226440 h 913573"/>
                  <a:gd name="connsiteX2" fmla="*/ 423958 w 947279"/>
                  <a:gd name="connsiteY2" fmla="*/ 45 h 913573"/>
                  <a:gd name="connsiteX3" fmla="*/ 722319 w 947279"/>
                  <a:gd name="connsiteY3" fmla="*/ 221097 h 913573"/>
                  <a:gd name="connsiteX4" fmla="*/ 947279 w 947279"/>
                  <a:gd name="connsiteY4" fmla="*/ 817879 h 913573"/>
                  <a:gd name="connsiteX5" fmla="*/ 821566 w 947279"/>
                  <a:gd name="connsiteY5" fmla="*/ 885025 h 913573"/>
                  <a:gd name="connsiteX6" fmla="*/ 606489 w 947279"/>
                  <a:gd name="connsiteY6" fmla="*/ 321808 h 913573"/>
                  <a:gd name="connsiteX7" fmla="*/ 438730 w 947279"/>
                  <a:gd name="connsiteY7" fmla="*/ 183032 h 913573"/>
                  <a:gd name="connsiteX8" fmla="*/ 281266 w 947279"/>
                  <a:gd name="connsiteY8" fmla="*/ 407561 h 913573"/>
                  <a:gd name="connsiteX9" fmla="*/ 154614 w 947279"/>
                  <a:gd name="connsiteY9" fmla="*/ 892820 h 913573"/>
                  <a:gd name="connsiteX10" fmla="*/ 536 w 947279"/>
                  <a:gd name="connsiteY10" fmla="*/ 859142 h 913573"/>
                  <a:gd name="connsiteX0" fmla="*/ 536 w 947279"/>
                  <a:gd name="connsiteY0" fmla="*/ 859142 h 913573"/>
                  <a:gd name="connsiteX1" fmla="*/ 148602 w 947279"/>
                  <a:gd name="connsiteY1" fmla="*/ 226440 h 913573"/>
                  <a:gd name="connsiteX2" fmla="*/ 423958 w 947279"/>
                  <a:gd name="connsiteY2" fmla="*/ 45 h 913573"/>
                  <a:gd name="connsiteX3" fmla="*/ 722319 w 947279"/>
                  <a:gd name="connsiteY3" fmla="*/ 221097 h 913573"/>
                  <a:gd name="connsiteX4" fmla="*/ 947279 w 947279"/>
                  <a:gd name="connsiteY4" fmla="*/ 817879 h 913573"/>
                  <a:gd name="connsiteX5" fmla="*/ 821566 w 947279"/>
                  <a:gd name="connsiteY5" fmla="*/ 885025 h 913573"/>
                  <a:gd name="connsiteX6" fmla="*/ 606489 w 947279"/>
                  <a:gd name="connsiteY6" fmla="*/ 321808 h 913573"/>
                  <a:gd name="connsiteX7" fmla="*/ 438730 w 947279"/>
                  <a:gd name="connsiteY7" fmla="*/ 183032 h 913573"/>
                  <a:gd name="connsiteX8" fmla="*/ 247547 w 947279"/>
                  <a:gd name="connsiteY8" fmla="*/ 355799 h 913573"/>
                  <a:gd name="connsiteX9" fmla="*/ 154614 w 947279"/>
                  <a:gd name="connsiteY9" fmla="*/ 892820 h 913573"/>
                  <a:gd name="connsiteX10" fmla="*/ 536 w 947279"/>
                  <a:gd name="connsiteY10" fmla="*/ 859142 h 913573"/>
                  <a:gd name="connsiteX0" fmla="*/ 536 w 947279"/>
                  <a:gd name="connsiteY0" fmla="*/ 859142 h 913573"/>
                  <a:gd name="connsiteX1" fmla="*/ 148602 w 947279"/>
                  <a:gd name="connsiteY1" fmla="*/ 226440 h 913573"/>
                  <a:gd name="connsiteX2" fmla="*/ 423958 w 947279"/>
                  <a:gd name="connsiteY2" fmla="*/ 45 h 913573"/>
                  <a:gd name="connsiteX3" fmla="*/ 722319 w 947279"/>
                  <a:gd name="connsiteY3" fmla="*/ 221097 h 913573"/>
                  <a:gd name="connsiteX4" fmla="*/ 947279 w 947279"/>
                  <a:gd name="connsiteY4" fmla="*/ 817879 h 913573"/>
                  <a:gd name="connsiteX5" fmla="*/ 821566 w 947279"/>
                  <a:gd name="connsiteY5" fmla="*/ 885025 h 913573"/>
                  <a:gd name="connsiteX6" fmla="*/ 606489 w 947279"/>
                  <a:gd name="connsiteY6" fmla="*/ 321808 h 913573"/>
                  <a:gd name="connsiteX7" fmla="*/ 438730 w 947279"/>
                  <a:gd name="connsiteY7" fmla="*/ 183032 h 913573"/>
                  <a:gd name="connsiteX8" fmla="*/ 247547 w 947279"/>
                  <a:gd name="connsiteY8" fmla="*/ 355799 h 913573"/>
                  <a:gd name="connsiteX9" fmla="*/ 154614 w 947279"/>
                  <a:gd name="connsiteY9" fmla="*/ 892820 h 913573"/>
                  <a:gd name="connsiteX10" fmla="*/ 536 w 947279"/>
                  <a:gd name="connsiteY10" fmla="*/ 859142 h 913573"/>
                  <a:gd name="connsiteX0" fmla="*/ 536 w 947279"/>
                  <a:gd name="connsiteY0" fmla="*/ 859142 h 913573"/>
                  <a:gd name="connsiteX1" fmla="*/ 148602 w 947279"/>
                  <a:gd name="connsiteY1" fmla="*/ 226440 h 913573"/>
                  <a:gd name="connsiteX2" fmla="*/ 423958 w 947279"/>
                  <a:gd name="connsiteY2" fmla="*/ 45 h 913573"/>
                  <a:gd name="connsiteX3" fmla="*/ 722319 w 947279"/>
                  <a:gd name="connsiteY3" fmla="*/ 221097 h 913573"/>
                  <a:gd name="connsiteX4" fmla="*/ 947279 w 947279"/>
                  <a:gd name="connsiteY4" fmla="*/ 817879 h 913573"/>
                  <a:gd name="connsiteX5" fmla="*/ 821566 w 947279"/>
                  <a:gd name="connsiteY5" fmla="*/ 885025 h 913573"/>
                  <a:gd name="connsiteX6" fmla="*/ 606489 w 947279"/>
                  <a:gd name="connsiteY6" fmla="*/ 321808 h 913573"/>
                  <a:gd name="connsiteX7" fmla="*/ 413147 w 947279"/>
                  <a:gd name="connsiteY7" fmla="*/ 163641 h 913573"/>
                  <a:gd name="connsiteX8" fmla="*/ 247547 w 947279"/>
                  <a:gd name="connsiteY8" fmla="*/ 355799 h 913573"/>
                  <a:gd name="connsiteX9" fmla="*/ 154614 w 947279"/>
                  <a:gd name="connsiteY9" fmla="*/ 892820 h 913573"/>
                  <a:gd name="connsiteX10" fmla="*/ 536 w 947279"/>
                  <a:gd name="connsiteY10" fmla="*/ 859142 h 913573"/>
                  <a:gd name="connsiteX0" fmla="*/ 516 w 947259"/>
                  <a:gd name="connsiteY0" fmla="*/ 902582 h 957013"/>
                  <a:gd name="connsiteX1" fmla="*/ 148582 w 947259"/>
                  <a:gd name="connsiteY1" fmla="*/ 269880 h 957013"/>
                  <a:gd name="connsiteX2" fmla="*/ 401183 w 947259"/>
                  <a:gd name="connsiteY2" fmla="*/ 32 h 957013"/>
                  <a:gd name="connsiteX3" fmla="*/ 722299 w 947259"/>
                  <a:gd name="connsiteY3" fmla="*/ 264537 h 957013"/>
                  <a:gd name="connsiteX4" fmla="*/ 947259 w 947259"/>
                  <a:gd name="connsiteY4" fmla="*/ 861319 h 957013"/>
                  <a:gd name="connsiteX5" fmla="*/ 821546 w 947259"/>
                  <a:gd name="connsiteY5" fmla="*/ 928465 h 957013"/>
                  <a:gd name="connsiteX6" fmla="*/ 606469 w 947259"/>
                  <a:gd name="connsiteY6" fmla="*/ 365248 h 957013"/>
                  <a:gd name="connsiteX7" fmla="*/ 413127 w 947259"/>
                  <a:gd name="connsiteY7" fmla="*/ 207081 h 957013"/>
                  <a:gd name="connsiteX8" fmla="*/ 247527 w 947259"/>
                  <a:gd name="connsiteY8" fmla="*/ 399239 h 957013"/>
                  <a:gd name="connsiteX9" fmla="*/ 154594 w 947259"/>
                  <a:gd name="connsiteY9" fmla="*/ 936260 h 957013"/>
                  <a:gd name="connsiteX10" fmla="*/ 516 w 947259"/>
                  <a:gd name="connsiteY10" fmla="*/ 902582 h 95701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</a:cxnLst>
                <a:rect l="l" t="t" r="r" b="b"/>
                <a:pathLst>
                  <a:path w="947259" h="957013">
                    <a:moveTo>
                      <a:pt x="516" y="902582"/>
                    </a:moveTo>
                    <a:cubicBezTo>
                      <a:pt x="-7601" y="771779"/>
                      <a:pt x="81804" y="420305"/>
                      <a:pt x="148582" y="269880"/>
                    </a:cubicBezTo>
                    <a:cubicBezTo>
                      <a:pt x="215360" y="119455"/>
                      <a:pt x="324114" y="2367"/>
                      <a:pt x="401183" y="32"/>
                    </a:cubicBezTo>
                    <a:cubicBezTo>
                      <a:pt x="478252" y="-2303"/>
                      <a:pt x="631286" y="120989"/>
                      <a:pt x="722299" y="264537"/>
                    </a:cubicBezTo>
                    <a:cubicBezTo>
                      <a:pt x="813312" y="408085"/>
                      <a:pt x="934652" y="724707"/>
                      <a:pt x="947259" y="861319"/>
                    </a:cubicBezTo>
                    <a:cubicBezTo>
                      <a:pt x="943745" y="930261"/>
                      <a:pt x="884994" y="920846"/>
                      <a:pt x="821546" y="928465"/>
                    </a:cubicBezTo>
                    <a:cubicBezTo>
                      <a:pt x="787216" y="874251"/>
                      <a:pt x="668190" y="465672"/>
                      <a:pt x="606469" y="365248"/>
                    </a:cubicBezTo>
                    <a:cubicBezTo>
                      <a:pt x="538729" y="279236"/>
                      <a:pt x="473504" y="208629"/>
                      <a:pt x="413127" y="207081"/>
                    </a:cubicBezTo>
                    <a:cubicBezTo>
                      <a:pt x="352750" y="205533"/>
                      <a:pt x="290946" y="311928"/>
                      <a:pt x="247527" y="399239"/>
                    </a:cubicBezTo>
                    <a:cubicBezTo>
                      <a:pt x="184445" y="544753"/>
                      <a:pt x="190289" y="841212"/>
                      <a:pt x="154594" y="936260"/>
                    </a:cubicBezTo>
                    <a:cubicBezTo>
                      <a:pt x="75000" y="981319"/>
                      <a:pt x="64485" y="945109"/>
                      <a:pt x="516" y="902582"/>
                    </a:cubicBezTo>
                    <a:close/>
                  </a:path>
                </a:pathLst>
              </a:custGeom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 b="1">
                  <a:solidFill>
                    <a:schemeClr val="bg2">
                      <a:lumMod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40" name="Rectangle 39"/>
          <p:cNvSpPr/>
          <p:nvPr/>
        </p:nvSpPr>
        <p:spPr>
          <a:xfrm>
            <a:off x="520700" y="4113875"/>
            <a:ext cx="58547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S5 figure</a:t>
            </a:r>
            <a:r>
              <a:rPr lang="en-US" sz="1000" dirty="0" smtClean="0">
                <a:latin typeface="Arial"/>
                <a:cs typeface="Arial"/>
              </a:rPr>
              <a:t>. </a:t>
            </a:r>
            <a:r>
              <a:rPr lang="en-US" sz="1000" b="1" dirty="0">
                <a:latin typeface="Arial"/>
                <a:cs typeface="Arial"/>
              </a:rPr>
              <a:t>Alternative models to explain how </a:t>
            </a:r>
            <a:r>
              <a:rPr lang="en-US" sz="1000" b="1" dirty="0" err="1">
                <a:latin typeface="Arial"/>
                <a:cs typeface="Arial"/>
              </a:rPr>
              <a:t>Env</a:t>
            </a:r>
            <a:r>
              <a:rPr lang="en-US" sz="1000" b="1" dirty="0">
                <a:latin typeface="Arial"/>
                <a:cs typeface="Arial"/>
              </a:rPr>
              <a:t> trimers may expose the CD4bs while retaining a closed TAD at the trimer apex</a:t>
            </a:r>
            <a:r>
              <a:rPr lang="en-US" sz="1000" b="1" dirty="0" smtClean="0">
                <a:latin typeface="Arial"/>
                <a:cs typeface="Arial"/>
              </a:rPr>
              <a:t>.</a:t>
            </a:r>
            <a:endParaRPr lang="en-US" sz="10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991052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6</Words>
  <Application>Microsoft Macintosh PowerPoint</Application>
  <PresentationFormat>Letter Paper (8.5x11 in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24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lapham, Paul</dc:creator>
  <cp:lastModifiedBy>Clapham, Paul</cp:lastModifiedBy>
  <cp:revision>1</cp:revision>
  <dcterms:created xsi:type="dcterms:W3CDTF">2016-10-13T18:45:56Z</dcterms:created>
  <dcterms:modified xsi:type="dcterms:W3CDTF">2016-10-13T18:46:43Z</dcterms:modified>
</cp:coreProperties>
</file>